
<file path=[Content_Types].xml><?xml version="1.0" encoding="utf-8"?>
<Types xmlns="http://schemas.openxmlformats.org/package/2006/content-types">
  <Default Extension="emf" ContentType="image/x-emf"/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49"/>
  </p:notesMasterIdLst>
  <p:sldIdLst>
    <p:sldId id="256" r:id="rId2"/>
    <p:sldId id="259" r:id="rId3"/>
    <p:sldId id="271" r:id="rId4"/>
    <p:sldId id="390" r:id="rId5"/>
    <p:sldId id="378" r:id="rId6"/>
    <p:sldId id="370" r:id="rId7"/>
    <p:sldId id="371" r:id="rId8"/>
    <p:sldId id="275" r:id="rId9"/>
    <p:sldId id="485" r:id="rId10"/>
    <p:sldId id="396" r:id="rId11"/>
    <p:sldId id="402" r:id="rId12"/>
    <p:sldId id="437" r:id="rId13"/>
    <p:sldId id="482" r:id="rId14"/>
    <p:sldId id="408" r:id="rId15"/>
    <p:sldId id="439" r:id="rId16"/>
    <p:sldId id="430" r:id="rId17"/>
    <p:sldId id="447" r:id="rId18"/>
    <p:sldId id="393" r:id="rId19"/>
    <p:sldId id="448" r:id="rId20"/>
    <p:sldId id="406" r:id="rId21"/>
    <p:sldId id="462" r:id="rId22"/>
    <p:sldId id="452" r:id="rId23"/>
    <p:sldId id="454" r:id="rId24"/>
    <p:sldId id="451" r:id="rId25"/>
    <p:sldId id="460" r:id="rId26"/>
    <p:sldId id="457" r:id="rId27"/>
    <p:sldId id="470" r:id="rId28"/>
    <p:sldId id="458" r:id="rId29"/>
    <p:sldId id="473" r:id="rId30"/>
    <p:sldId id="456" r:id="rId31"/>
    <p:sldId id="467" r:id="rId32"/>
    <p:sldId id="455" r:id="rId33"/>
    <p:sldId id="463" r:id="rId34"/>
    <p:sldId id="444" r:id="rId35"/>
    <p:sldId id="445" r:id="rId36"/>
    <p:sldId id="435" r:id="rId37"/>
    <p:sldId id="464" r:id="rId38"/>
    <p:sldId id="441" r:id="rId39"/>
    <p:sldId id="442" r:id="rId40"/>
    <p:sldId id="394" r:id="rId41"/>
    <p:sldId id="459" r:id="rId42"/>
    <p:sldId id="475" r:id="rId43"/>
    <p:sldId id="476" r:id="rId44"/>
    <p:sldId id="434" r:id="rId45"/>
    <p:sldId id="486" r:id="rId46"/>
    <p:sldId id="481" r:id="rId47"/>
    <p:sldId id="283" r:id="rId4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56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D4D4D"/>
    <a:srgbClr val="245794"/>
    <a:srgbClr val="E6A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F3DB85A-1BF1-489F-A56C-8519B9DBC129}" v="3" dt="2025-10-07T16:45:19.2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235" autoAdjust="0"/>
    <p:restoredTop sz="94661" autoAdjust="0"/>
  </p:normalViewPr>
  <p:slideViewPr>
    <p:cSldViewPr snapToGrid="0">
      <p:cViewPr varScale="1">
        <p:scale>
          <a:sx n="71" d="100"/>
          <a:sy n="71" d="100"/>
        </p:scale>
        <p:origin x="1084" y="44"/>
      </p:cViewPr>
      <p:guideLst>
        <p:guide orient="horz" pos="2256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-2514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presProps" Target="presProps.xml"/><Relationship Id="rId55" Type="http://schemas.microsoft.com/office/2015/10/relationships/revisionInfo" Target="revisionInfo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8" Type="http://schemas.openxmlformats.org/officeDocument/2006/relationships/slide" Target="slides/slide7.xml"/><Relationship Id="rId51" Type="http://schemas.openxmlformats.org/officeDocument/2006/relationships/viewProps" Target="view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ranjali Dalvi" userId="86b7d7ad-4a1d-480f-b9f9-842fcb3f03d9" providerId="ADAL" clId="{FEB30EDB-8701-480A-B511-B994013D2BBF}"/>
    <pc:docChg chg="undo custSel delSld modSld">
      <pc:chgData name="Pranjali Dalvi" userId="86b7d7ad-4a1d-480f-b9f9-842fcb3f03d9" providerId="ADAL" clId="{FEB30EDB-8701-480A-B511-B994013D2BBF}" dt="2025-10-07T16:45:54.992" v="72" actId="478"/>
      <pc:docMkLst>
        <pc:docMk/>
      </pc:docMkLst>
      <pc:sldChg chg="delSp modSp mod">
        <pc:chgData name="Pranjali Dalvi" userId="86b7d7ad-4a1d-480f-b9f9-842fcb3f03d9" providerId="ADAL" clId="{FEB30EDB-8701-480A-B511-B994013D2BBF}" dt="2025-10-07T16:17:13.701" v="5" actId="20577"/>
        <pc:sldMkLst>
          <pc:docMk/>
          <pc:sldMk cId="0" sldId="259"/>
        </pc:sldMkLst>
        <pc:spChg chg="del">
          <ac:chgData name="Pranjali Dalvi" userId="86b7d7ad-4a1d-480f-b9f9-842fcb3f03d9" providerId="ADAL" clId="{FEB30EDB-8701-480A-B511-B994013D2BBF}" dt="2025-10-07T16:16:53.292" v="0" actId="478"/>
          <ac:spMkLst>
            <pc:docMk/>
            <pc:sldMk cId="0" sldId="259"/>
            <ac:spMk id="11" creationId="{7F0B12D2-7084-4F25-A0FF-BD16049AA783}"/>
          </ac:spMkLst>
        </pc:spChg>
        <pc:spChg chg="mod">
          <ac:chgData name="Pranjali Dalvi" userId="86b7d7ad-4a1d-480f-b9f9-842fcb3f03d9" providerId="ADAL" clId="{FEB30EDB-8701-480A-B511-B994013D2BBF}" dt="2025-10-07T16:17:13.701" v="5" actId="20577"/>
          <ac:spMkLst>
            <pc:docMk/>
            <pc:sldMk cId="0" sldId="259"/>
            <ac:spMk id="22" creationId="{00000000-0000-0000-0000-000000000000}"/>
          </ac:spMkLst>
        </pc:spChg>
        <pc:graphicFrameChg chg="del">
          <ac:chgData name="Pranjali Dalvi" userId="86b7d7ad-4a1d-480f-b9f9-842fcb3f03d9" providerId="ADAL" clId="{FEB30EDB-8701-480A-B511-B994013D2BBF}" dt="2025-10-07T16:16:56.597" v="1" actId="478"/>
          <ac:graphicFrameMkLst>
            <pc:docMk/>
            <pc:sldMk cId="0" sldId="259"/>
            <ac:graphicFrameMk id="4" creationId="{5F855AAE-C98F-4B5A-996E-21678D6D93E6}"/>
          </ac:graphicFrameMkLst>
        </pc:graphicFrameChg>
      </pc:sldChg>
      <pc:sldChg chg="modSp mod">
        <pc:chgData name="Pranjali Dalvi" userId="86b7d7ad-4a1d-480f-b9f9-842fcb3f03d9" providerId="ADAL" clId="{FEB30EDB-8701-480A-B511-B994013D2BBF}" dt="2025-10-07T16:17:46.782" v="7" actId="1076"/>
        <pc:sldMkLst>
          <pc:docMk/>
          <pc:sldMk cId="0" sldId="271"/>
        </pc:sldMkLst>
        <pc:spChg chg="mod">
          <ac:chgData name="Pranjali Dalvi" userId="86b7d7ad-4a1d-480f-b9f9-842fcb3f03d9" providerId="ADAL" clId="{FEB30EDB-8701-480A-B511-B994013D2BBF}" dt="2025-10-07T16:17:46.782" v="7" actId="1076"/>
          <ac:spMkLst>
            <pc:docMk/>
            <pc:sldMk cId="0" sldId="271"/>
            <ac:spMk id="30" creationId="{DB2F3052-156E-4F02-B7DC-701F07D12B4C}"/>
          </ac:spMkLst>
        </pc:spChg>
        <pc:spChg chg="mod">
          <ac:chgData name="Pranjali Dalvi" userId="86b7d7ad-4a1d-480f-b9f9-842fcb3f03d9" providerId="ADAL" clId="{FEB30EDB-8701-480A-B511-B994013D2BBF}" dt="2025-10-07T16:17:29.153" v="6" actId="1076"/>
          <ac:spMkLst>
            <pc:docMk/>
            <pc:sldMk cId="0" sldId="271"/>
            <ac:spMk id="31" creationId="{1C96BB18-14A8-4090-B8BE-96D46CFAB5F9}"/>
          </ac:spMkLst>
        </pc:spChg>
      </pc:sldChg>
      <pc:sldChg chg="delSp mod">
        <pc:chgData name="Pranjali Dalvi" userId="86b7d7ad-4a1d-480f-b9f9-842fcb3f03d9" providerId="ADAL" clId="{FEB30EDB-8701-480A-B511-B994013D2BBF}" dt="2025-10-07T16:45:54.992" v="72" actId="478"/>
        <pc:sldMkLst>
          <pc:docMk/>
          <pc:sldMk cId="3517525370" sldId="283"/>
        </pc:sldMkLst>
        <pc:spChg chg="del">
          <ac:chgData name="Pranjali Dalvi" userId="86b7d7ad-4a1d-480f-b9f9-842fcb3f03d9" providerId="ADAL" clId="{FEB30EDB-8701-480A-B511-B994013D2BBF}" dt="2025-10-07T16:45:54.992" v="72" actId="478"/>
          <ac:spMkLst>
            <pc:docMk/>
            <pc:sldMk cId="3517525370" sldId="283"/>
            <ac:spMk id="2" creationId="{30A191BF-19D0-AA4E-9F7F-BC8792385439}"/>
          </ac:spMkLst>
        </pc:spChg>
        <pc:spChg chg="del">
          <ac:chgData name="Pranjali Dalvi" userId="86b7d7ad-4a1d-480f-b9f9-842fcb3f03d9" providerId="ADAL" clId="{FEB30EDB-8701-480A-B511-B994013D2BBF}" dt="2025-10-07T16:45:53.143" v="71" actId="478"/>
          <ac:spMkLst>
            <pc:docMk/>
            <pc:sldMk cId="3517525370" sldId="283"/>
            <ac:spMk id="3" creationId="{E41FF68F-477C-2C44-9F89-51CC120F96A2}"/>
          </ac:spMkLst>
        </pc:spChg>
      </pc:sldChg>
      <pc:sldChg chg="delSp mod">
        <pc:chgData name="Pranjali Dalvi" userId="86b7d7ad-4a1d-480f-b9f9-842fcb3f03d9" providerId="ADAL" clId="{FEB30EDB-8701-480A-B511-B994013D2BBF}" dt="2025-10-07T16:18:42.752" v="8" actId="478"/>
        <pc:sldMkLst>
          <pc:docMk/>
          <pc:sldMk cId="3266282512" sldId="371"/>
        </pc:sldMkLst>
        <pc:spChg chg="del">
          <ac:chgData name="Pranjali Dalvi" userId="86b7d7ad-4a1d-480f-b9f9-842fcb3f03d9" providerId="ADAL" clId="{FEB30EDB-8701-480A-B511-B994013D2BBF}" dt="2025-10-07T16:18:42.752" v="8" actId="478"/>
          <ac:spMkLst>
            <pc:docMk/>
            <pc:sldMk cId="3266282512" sldId="371"/>
            <ac:spMk id="14" creationId="{00000000-0000-0000-0000-000000000000}"/>
          </ac:spMkLst>
        </pc:spChg>
      </pc:sldChg>
      <pc:sldChg chg="del">
        <pc:chgData name="Pranjali Dalvi" userId="86b7d7ad-4a1d-480f-b9f9-842fcb3f03d9" providerId="ADAL" clId="{FEB30EDB-8701-480A-B511-B994013D2BBF}" dt="2025-10-07T16:18:52.115" v="9" actId="47"/>
        <pc:sldMkLst>
          <pc:docMk/>
          <pc:sldMk cId="3815052510" sldId="403"/>
        </pc:sldMkLst>
      </pc:sldChg>
      <pc:sldChg chg="addSp delSp modSp mod">
        <pc:chgData name="Pranjali Dalvi" userId="86b7d7ad-4a1d-480f-b9f9-842fcb3f03d9" providerId="ADAL" clId="{FEB30EDB-8701-480A-B511-B994013D2BBF}" dt="2025-10-07T16:45:28.655" v="67" actId="1076"/>
        <pc:sldMkLst>
          <pc:docMk/>
          <pc:sldMk cId="1780099215" sldId="434"/>
        </pc:sldMkLst>
        <pc:spChg chg="add del">
          <ac:chgData name="Pranjali Dalvi" userId="86b7d7ad-4a1d-480f-b9f9-842fcb3f03d9" providerId="ADAL" clId="{FEB30EDB-8701-480A-B511-B994013D2BBF}" dt="2025-10-07T16:43:17.664" v="45" actId="22"/>
          <ac:spMkLst>
            <pc:docMk/>
            <pc:sldMk cId="1780099215" sldId="434"/>
            <ac:spMk id="7" creationId="{D17CDD20-980B-3E47-BDA8-46A7FDE4DD86}"/>
          </ac:spMkLst>
        </pc:spChg>
        <pc:picChg chg="add del mod modCrop">
          <ac:chgData name="Pranjali Dalvi" userId="86b7d7ad-4a1d-480f-b9f9-842fcb3f03d9" providerId="ADAL" clId="{FEB30EDB-8701-480A-B511-B994013D2BBF}" dt="2025-10-07T16:45:16.693" v="65" actId="21"/>
          <ac:picMkLst>
            <pc:docMk/>
            <pc:sldMk cId="1780099215" sldId="434"/>
            <ac:picMk id="2" creationId="{C4E1EFE7-1C5F-9BBD-E1C9-16D11B19FA32}"/>
          </ac:picMkLst>
        </pc:picChg>
        <pc:picChg chg="del mod modCrop">
          <ac:chgData name="Pranjali Dalvi" userId="86b7d7ad-4a1d-480f-b9f9-842fcb3f03d9" providerId="ADAL" clId="{FEB30EDB-8701-480A-B511-B994013D2BBF}" dt="2025-10-07T16:45:16.693" v="65" actId="21"/>
          <ac:picMkLst>
            <pc:docMk/>
            <pc:sldMk cId="1780099215" sldId="434"/>
            <ac:picMk id="5" creationId="{CC5DFFBA-8678-47BF-855C-49B86CA7FFCF}"/>
          </ac:picMkLst>
        </pc:picChg>
        <pc:picChg chg="add del mod modCrop">
          <ac:chgData name="Pranjali Dalvi" userId="86b7d7ad-4a1d-480f-b9f9-842fcb3f03d9" providerId="ADAL" clId="{FEB30EDB-8701-480A-B511-B994013D2BBF}" dt="2025-10-07T16:45:16.693" v="65" actId="21"/>
          <ac:picMkLst>
            <pc:docMk/>
            <pc:sldMk cId="1780099215" sldId="434"/>
            <ac:picMk id="8" creationId="{1AF89D72-9EEC-9706-B914-042B129E2E98}"/>
          </ac:picMkLst>
        </pc:picChg>
        <pc:picChg chg="add mod">
          <ac:chgData name="Pranjali Dalvi" userId="86b7d7ad-4a1d-480f-b9f9-842fcb3f03d9" providerId="ADAL" clId="{FEB30EDB-8701-480A-B511-B994013D2BBF}" dt="2025-10-07T16:45:28.655" v="67" actId="1076"/>
          <ac:picMkLst>
            <pc:docMk/>
            <pc:sldMk cId="1780099215" sldId="434"/>
            <ac:picMk id="9" creationId="{812BE7BF-EAAE-BCFA-5E81-8481D6C6B14B}"/>
          </ac:picMkLst>
        </pc:picChg>
      </pc:sldChg>
      <pc:sldChg chg="del">
        <pc:chgData name="Pranjali Dalvi" userId="86b7d7ad-4a1d-480f-b9f9-842fcb3f03d9" providerId="ADAL" clId="{FEB30EDB-8701-480A-B511-B994013D2BBF}" dt="2025-10-07T16:18:59.502" v="10" actId="47"/>
        <pc:sldMkLst>
          <pc:docMk/>
          <pc:sldMk cId="2899200980" sldId="438"/>
        </pc:sldMkLst>
      </pc:sldChg>
      <pc:sldChg chg="del">
        <pc:chgData name="Pranjali Dalvi" userId="86b7d7ad-4a1d-480f-b9f9-842fcb3f03d9" providerId="ADAL" clId="{FEB30EDB-8701-480A-B511-B994013D2BBF}" dt="2025-10-07T16:19:18.463" v="12" actId="47"/>
        <pc:sldMkLst>
          <pc:docMk/>
          <pc:sldMk cId="442747065" sldId="440"/>
        </pc:sldMkLst>
      </pc:sldChg>
      <pc:sldChg chg="del">
        <pc:chgData name="Pranjali Dalvi" userId="86b7d7ad-4a1d-480f-b9f9-842fcb3f03d9" providerId="ADAL" clId="{FEB30EDB-8701-480A-B511-B994013D2BBF}" dt="2025-10-07T16:20:09.919" v="22" actId="47"/>
        <pc:sldMkLst>
          <pc:docMk/>
          <pc:sldMk cId="3711440133" sldId="443"/>
        </pc:sldMkLst>
      </pc:sldChg>
      <pc:sldChg chg="del">
        <pc:chgData name="Pranjali Dalvi" userId="86b7d7ad-4a1d-480f-b9f9-842fcb3f03d9" providerId="ADAL" clId="{FEB30EDB-8701-480A-B511-B994013D2BBF}" dt="2025-10-07T16:20:03.754" v="20" actId="47"/>
        <pc:sldMkLst>
          <pc:docMk/>
          <pc:sldMk cId="3761060199" sldId="446"/>
        </pc:sldMkLst>
      </pc:sldChg>
      <pc:sldChg chg="del">
        <pc:chgData name="Pranjali Dalvi" userId="86b7d7ad-4a1d-480f-b9f9-842fcb3f03d9" providerId="ADAL" clId="{FEB30EDB-8701-480A-B511-B994013D2BBF}" dt="2025-10-07T16:19:31.716" v="14" actId="47"/>
        <pc:sldMkLst>
          <pc:docMk/>
          <pc:sldMk cId="454861043" sldId="449"/>
        </pc:sldMkLst>
      </pc:sldChg>
      <pc:sldChg chg="del">
        <pc:chgData name="Pranjali Dalvi" userId="86b7d7ad-4a1d-480f-b9f9-842fcb3f03d9" providerId="ADAL" clId="{FEB30EDB-8701-480A-B511-B994013D2BBF}" dt="2025-10-07T16:19:26.025" v="13" actId="47"/>
        <pc:sldMkLst>
          <pc:docMk/>
          <pc:sldMk cId="528835892" sldId="450"/>
        </pc:sldMkLst>
      </pc:sldChg>
      <pc:sldChg chg="del">
        <pc:chgData name="Pranjali Dalvi" userId="86b7d7ad-4a1d-480f-b9f9-842fcb3f03d9" providerId="ADAL" clId="{FEB30EDB-8701-480A-B511-B994013D2BBF}" dt="2025-10-07T16:20:06.948" v="21" actId="47"/>
        <pc:sldMkLst>
          <pc:docMk/>
          <pc:sldMk cId="1865743959" sldId="465"/>
        </pc:sldMkLst>
      </pc:sldChg>
      <pc:sldChg chg="del">
        <pc:chgData name="Pranjali Dalvi" userId="86b7d7ad-4a1d-480f-b9f9-842fcb3f03d9" providerId="ADAL" clId="{FEB30EDB-8701-480A-B511-B994013D2BBF}" dt="2025-10-07T16:20:00.502" v="19" actId="47"/>
        <pc:sldMkLst>
          <pc:docMk/>
          <pc:sldMk cId="1480565424" sldId="466"/>
        </pc:sldMkLst>
      </pc:sldChg>
      <pc:sldChg chg="del">
        <pc:chgData name="Pranjali Dalvi" userId="86b7d7ad-4a1d-480f-b9f9-842fcb3f03d9" providerId="ADAL" clId="{FEB30EDB-8701-480A-B511-B994013D2BBF}" dt="2025-10-07T16:19:40.926" v="15" actId="47"/>
        <pc:sldMkLst>
          <pc:docMk/>
          <pc:sldMk cId="850902709" sldId="468"/>
        </pc:sldMkLst>
      </pc:sldChg>
      <pc:sldChg chg="del">
        <pc:chgData name="Pranjali Dalvi" userId="86b7d7ad-4a1d-480f-b9f9-842fcb3f03d9" providerId="ADAL" clId="{FEB30EDB-8701-480A-B511-B994013D2BBF}" dt="2025-10-07T16:19:49.643" v="16" actId="47"/>
        <pc:sldMkLst>
          <pc:docMk/>
          <pc:sldMk cId="2871017983" sldId="471"/>
        </pc:sldMkLst>
      </pc:sldChg>
      <pc:sldChg chg="del">
        <pc:chgData name="Pranjali Dalvi" userId="86b7d7ad-4a1d-480f-b9f9-842fcb3f03d9" providerId="ADAL" clId="{FEB30EDB-8701-480A-B511-B994013D2BBF}" dt="2025-10-07T16:19:57.301" v="18" actId="47"/>
        <pc:sldMkLst>
          <pc:docMk/>
          <pc:sldMk cId="102314139" sldId="472"/>
        </pc:sldMkLst>
      </pc:sldChg>
      <pc:sldChg chg="del">
        <pc:chgData name="Pranjali Dalvi" userId="86b7d7ad-4a1d-480f-b9f9-842fcb3f03d9" providerId="ADAL" clId="{FEB30EDB-8701-480A-B511-B994013D2BBF}" dt="2025-10-07T16:19:53.966" v="17" actId="47"/>
        <pc:sldMkLst>
          <pc:docMk/>
          <pc:sldMk cId="3691203058" sldId="474"/>
        </pc:sldMkLst>
      </pc:sldChg>
      <pc:sldChg chg="delSp modSp mod">
        <pc:chgData name="Pranjali Dalvi" userId="86b7d7ad-4a1d-480f-b9f9-842fcb3f03d9" providerId="ADAL" clId="{FEB30EDB-8701-480A-B511-B994013D2BBF}" dt="2025-10-07T16:45:41.706" v="70" actId="1076"/>
        <pc:sldMkLst>
          <pc:docMk/>
          <pc:sldMk cId="2655079665" sldId="481"/>
        </pc:sldMkLst>
        <pc:grpChg chg="mod">
          <ac:chgData name="Pranjali Dalvi" userId="86b7d7ad-4a1d-480f-b9f9-842fcb3f03d9" providerId="ADAL" clId="{FEB30EDB-8701-480A-B511-B994013D2BBF}" dt="2025-10-07T16:45:41.706" v="70" actId="1076"/>
          <ac:grpSpMkLst>
            <pc:docMk/>
            <pc:sldMk cId="2655079665" sldId="481"/>
            <ac:grpSpMk id="36" creationId="{A0ED8D4F-E9ED-4DA6-B47D-01EF0989E292}"/>
          </ac:grpSpMkLst>
        </pc:grpChg>
        <pc:grpChg chg="mod">
          <ac:chgData name="Pranjali Dalvi" userId="86b7d7ad-4a1d-480f-b9f9-842fcb3f03d9" providerId="ADAL" clId="{FEB30EDB-8701-480A-B511-B994013D2BBF}" dt="2025-10-07T16:45:39.183" v="69" actId="1076"/>
          <ac:grpSpMkLst>
            <pc:docMk/>
            <pc:sldMk cId="2655079665" sldId="481"/>
            <ac:grpSpMk id="37" creationId="{2EDCAF97-81F6-413C-A618-B62BD7498785}"/>
          </ac:grpSpMkLst>
        </pc:grpChg>
        <pc:grpChg chg="del">
          <ac:chgData name="Pranjali Dalvi" userId="86b7d7ad-4a1d-480f-b9f9-842fcb3f03d9" providerId="ADAL" clId="{FEB30EDB-8701-480A-B511-B994013D2BBF}" dt="2025-10-07T16:45:35.593" v="68" actId="478"/>
          <ac:grpSpMkLst>
            <pc:docMk/>
            <pc:sldMk cId="2655079665" sldId="481"/>
            <ac:grpSpMk id="38" creationId="{9375F1E7-ADB8-4AC7-B26A-5AD5D8E29D3C}"/>
          </ac:grpSpMkLst>
        </pc:grpChg>
      </pc:sldChg>
      <pc:sldChg chg="delSp mod">
        <pc:chgData name="Pranjali Dalvi" userId="86b7d7ad-4a1d-480f-b9f9-842fcb3f03d9" providerId="ADAL" clId="{FEB30EDB-8701-480A-B511-B994013D2BBF}" dt="2025-10-07T16:19:08.478" v="11" actId="478"/>
        <pc:sldMkLst>
          <pc:docMk/>
          <pc:sldMk cId="1309643530" sldId="482"/>
        </pc:sldMkLst>
        <pc:picChg chg="del">
          <ac:chgData name="Pranjali Dalvi" userId="86b7d7ad-4a1d-480f-b9f9-842fcb3f03d9" providerId="ADAL" clId="{FEB30EDB-8701-480A-B511-B994013D2BBF}" dt="2025-10-07T16:19:08.478" v="11" actId="478"/>
          <ac:picMkLst>
            <pc:docMk/>
            <pc:sldMk cId="1309643530" sldId="482"/>
            <ac:picMk id="4" creationId="{5052C088-E471-4C9C-A2DD-7560E0849924}"/>
          </ac:picMkLst>
        </pc:picChg>
      </pc:sldChg>
      <pc:sldChg chg="del">
        <pc:chgData name="Pranjali Dalvi" userId="86b7d7ad-4a1d-480f-b9f9-842fcb3f03d9" providerId="ADAL" clId="{FEB30EDB-8701-480A-B511-B994013D2BBF}" dt="2025-10-07T16:20:15.079" v="23" actId="47"/>
        <pc:sldMkLst>
          <pc:docMk/>
          <pc:sldMk cId="2302128814" sldId="483"/>
        </pc:sldMkLst>
      </pc:sldChg>
      <pc:sldChg chg="del">
        <pc:chgData name="Pranjali Dalvi" userId="86b7d7ad-4a1d-480f-b9f9-842fcb3f03d9" providerId="ADAL" clId="{FEB30EDB-8701-480A-B511-B994013D2BBF}" dt="2025-10-07T16:20:16.630" v="24" actId="47"/>
        <pc:sldMkLst>
          <pc:docMk/>
          <pc:sldMk cId="3273518280" sldId="484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61155A-8B9B-4938-9C39-7F2968C15032}" type="datetimeFigureOut">
              <a:rPr lang="en-US" smtClean="0"/>
              <a:pPr/>
              <a:t>10/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794473-8AB4-4979-9F22-18436951416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3679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794473-8AB4-4979-9F22-184369514166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3363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2ADCD31-4659-4B56-8612-7440AD03FA3A}" type="slidenum">
              <a:rPr lang="en-US" smtClean="0">
                <a:solidFill>
                  <a:srgbClr val="000000"/>
                </a:solidFill>
              </a:rPr>
              <a:pPr>
                <a:defRPr/>
              </a:pPr>
              <a:t>2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13393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1507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en-US">
              <a:latin typeface="Arial" charset="0"/>
            </a:endParaRPr>
          </a:p>
        </p:txBody>
      </p:sp>
      <p:sp>
        <p:nvSpPr>
          <p:cNvPr id="72708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816985A5-EDD9-49E9-B088-D5593BCABA4B}" type="slidenum">
              <a:rPr lang="en-US" smtClean="0"/>
              <a:pPr>
                <a:defRPr/>
              </a:pPr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1853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01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9DE1FE9-C529-4FD0-9458-795A56A6E78B}" type="slidenum">
              <a:rPr kumimoji="0" lang="en-US" sz="18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</a:rPr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</a:endParaRPr>
          </a:p>
        </p:txBody>
      </p:sp>
      <p:sp>
        <p:nvSpPr>
          <p:cNvPr id="5120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5120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155981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65225" y="692150"/>
            <a:ext cx="4619625" cy="3463925"/>
          </a:xfrm>
          <a:prstGeom prst="rect">
            <a:avLst/>
          </a:prstGeo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2ADCD31-4659-4B56-8612-7440AD03FA3A}" type="slidenum">
              <a:rPr lang="en-US" smtClean="0">
                <a:solidFill>
                  <a:srgbClr val="000000"/>
                </a:solidFill>
              </a:rPr>
              <a:pPr>
                <a:defRPr/>
              </a:pPr>
              <a:t>5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050064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2ADCD31-4659-4B56-8612-7440AD03FA3A}" type="slidenum">
              <a:rPr lang="en-US" smtClean="0">
                <a:solidFill>
                  <a:srgbClr val="000000"/>
                </a:solidFill>
              </a:rPr>
              <a:pPr>
                <a:defRPr/>
              </a:pPr>
              <a:t>6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9813799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2ADCD31-4659-4B56-8612-7440AD03FA3A}" type="slidenum">
              <a:rPr lang="en-US" smtClean="0">
                <a:solidFill>
                  <a:srgbClr val="000000"/>
                </a:solidFill>
              </a:rPr>
              <a:pPr>
                <a:defRPr/>
              </a:pPr>
              <a:t>7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457742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7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74755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48084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7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74755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7398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5" Type="http://schemas.openxmlformats.org/officeDocument/2006/relationships/hyperlink" Target="http://www.metabolon.com/" TargetMode="External"/><Relationship Id="rId4" Type="http://schemas.openxmlformats.org/officeDocument/2006/relationships/image" Target="../media/image6.png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bg>
      <p:bgPr>
        <a:gradFill>
          <a:gsLst>
            <a:gs pos="0">
              <a:schemeClr val="tx1"/>
            </a:gs>
            <a:gs pos="60000">
              <a:schemeClr val="accent2"/>
            </a:gs>
          </a:gsLst>
          <a:lin ang="180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EBE131F-353B-434A-9589-06456ECB33C9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3800" y="0"/>
            <a:ext cx="7950200" cy="6858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1128574-2482-C043-822D-753531DC38C7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1017" y="5843147"/>
            <a:ext cx="2302933" cy="429506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00D43EA8-D4B2-5441-BEB3-D59EAE17EE6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alphaModFix am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479" y="0"/>
            <a:ext cx="7946521" cy="6858000"/>
          </a:xfrm>
          <a:prstGeom prst="rect">
            <a:avLst/>
          </a:prstGeom>
        </p:spPr>
      </p:pic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457200" y="193956"/>
            <a:ext cx="8229600" cy="487362"/>
          </a:xfrm>
        </p:spPr>
        <p:txBody>
          <a:bodyPr>
            <a:normAutofit/>
          </a:bodyPr>
          <a:lstStyle>
            <a:lvl1pPr algn="l">
              <a:defRPr lang="en-US" sz="2900" b="1" kern="1200" baseline="0" dirty="0" smtClean="0">
                <a:solidFill>
                  <a:schemeClr val="tx2"/>
                </a:solidFill>
                <a:latin typeface="Montserrat" pitchFamily="2" charset="77"/>
                <a:ea typeface="+mj-ea"/>
                <a:cs typeface="+mj-cs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‹#›</a:t>
            </a:fld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572523F-83A6-4046-8298-E967CA82B1EA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6770" y="189714"/>
            <a:ext cx="380059" cy="274320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646E34EB-5277-4D44-8F3C-1D7732C4CE7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alphaModFix am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479" y="0"/>
            <a:ext cx="7946521" cy="6858000"/>
          </a:xfrm>
          <a:prstGeom prst="rect">
            <a:avLst/>
          </a:prstGeom>
        </p:spPr>
      </p:pic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457200" y="193956"/>
            <a:ext cx="8229600" cy="487362"/>
          </a:xfrm>
        </p:spPr>
        <p:txBody>
          <a:bodyPr>
            <a:normAutofit/>
          </a:bodyPr>
          <a:lstStyle>
            <a:lvl1pPr algn="l">
              <a:defRPr lang="en-US" sz="2900" b="1" kern="1200" baseline="0" dirty="0" smtClean="0">
                <a:solidFill>
                  <a:schemeClr val="tx2"/>
                </a:solidFill>
                <a:latin typeface="Montserrat" pitchFamily="2" charset="77"/>
                <a:ea typeface="+mj-ea"/>
                <a:cs typeface="+mj-cs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‹#›</a:t>
            </a:fld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6DC7452-C888-E148-A136-1C4C987FC7E6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6770" y="189714"/>
            <a:ext cx="380059" cy="274320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9370EE7-B533-8B4F-9158-30201A7BF5DB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alphaModFix amt="4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479" y="0"/>
            <a:ext cx="7946521" cy="6858000"/>
          </a:xfrm>
          <a:prstGeom prst="rect">
            <a:avLst/>
          </a:prstGeom>
        </p:spPr>
      </p:pic>
      <p:sp>
        <p:nvSpPr>
          <p:cNvPr id="7" name="Slide Number Placeholder 6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‹#›</a:t>
            </a:fld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FDA12CD-DCA6-9047-8C7B-9ED902DE0C51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6770" y="189714"/>
            <a:ext cx="380059" cy="274320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746870"/>
            <a:ext cx="8229600" cy="1200329"/>
          </a:xfrm>
          <a:solidFill>
            <a:schemeClr val="accent6"/>
          </a:solidFill>
        </p:spPr>
        <p:txBody>
          <a:bodyPr>
            <a:spAutoFit/>
          </a:bodyPr>
          <a:lstStyle>
            <a:lvl1pPr>
              <a:defRPr sz="1200"/>
            </a:lvl1pPr>
            <a:lvl2pPr>
              <a:defRPr sz="12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457200" y="183307"/>
            <a:ext cx="8229600" cy="487362"/>
          </a:xfrm>
        </p:spPr>
        <p:txBody>
          <a:bodyPr>
            <a:normAutofit/>
          </a:bodyPr>
          <a:lstStyle>
            <a:lvl1pPr algn="l">
              <a:defRPr lang="en-US" sz="2900" b="1" kern="1200" baseline="0" dirty="0" smtClean="0">
                <a:solidFill>
                  <a:schemeClr val="tx2"/>
                </a:solidFill>
                <a:latin typeface="Montserrat" pitchFamily="2" charset="77"/>
                <a:ea typeface="+mj-ea"/>
                <a:cs typeface="+mj-cs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‹#›</a:t>
            </a:fld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C471267-A7F0-7947-8342-9BF9A6155A08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6770" y="189714"/>
            <a:ext cx="380059" cy="274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9433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 - Thank You Slide">
    <p:bg>
      <p:bgPr>
        <a:gradFill>
          <a:gsLst>
            <a:gs pos="0">
              <a:schemeClr val="tx1"/>
            </a:gs>
            <a:gs pos="60000">
              <a:schemeClr val="accent2"/>
            </a:gs>
          </a:gsLst>
          <a:lin ang="180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6605E183-4FA1-D846-9342-A82087220E0D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3800" y="0"/>
            <a:ext cx="7950200" cy="6858000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BD323747-10D8-D747-A6BC-2330CC69FB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2355" y="682925"/>
            <a:ext cx="8254104" cy="969043"/>
          </a:xfrm>
          <a:prstGeom prst="rect">
            <a:avLst/>
          </a:prstGeom>
        </p:spPr>
        <p:txBody>
          <a:bodyPr anchor="b">
            <a:normAutofit/>
          </a:bodyPr>
          <a:lstStyle>
            <a:lvl1pPr>
              <a:defRPr sz="2800" b="1" spc="-150">
                <a:solidFill>
                  <a:schemeClr val="bg1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C9021AA8-DCA2-F14E-8875-A424FC87B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392355" y="1694998"/>
            <a:ext cx="8254104" cy="1846659"/>
          </a:xfrm>
        </p:spPr>
        <p:txBody>
          <a:bodyPr>
            <a:normAutofit/>
          </a:bodyPr>
          <a:lstStyle>
            <a:lvl1pPr marL="0" indent="0">
              <a:buNone/>
              <a:defRPr sz="1600">
                <a:solidFill>
                  <a:schemeClr val="bg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DE00232-0233-4348-80C8-35705A1AC868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867" y="4725713"/>
            <a:ext cx="3073000" cy="57312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72B5157-C1D0-EF42-BF77-945E6839E183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867" y="5460205"/>
            <a:ext cx="2711789" cy="16934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CF10A25-85FB-E348-8F79-8667F80225EE}"/>
              </a:ext>
            </a:extLst>
          </p:cNvPr>
          <p:cNvSpPr txBox="1"/>
          <p:nvPr userDrawn="1"/>
        </p:nvSpPr>
        <p:spPr>
          <a:xfrm>
            <a:off x="381896" y="5947397"/>
            <a:ext cx="22806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617 Davis Drive, Suite 100</a:t>
            </a:r>
            <a:br>
              <a:rPr lang="en-US" sz="120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</a:br>
            <a:r>
              <a:rPr lang="en-US" sz="120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Morrisville, NC 2756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BAFCA9D-C326-5F4D-85CE-F65843B63F47}"/>
              </a:ext>
            </a:extLst>
          </p:cNvPr>
          <p:cNvSpPr txBox="1"/>
          <p:nvPr userDrawn="1"/>
        </p:nvSpPr>
        <p:spPr>
          <a:xfrm>
            <a:off x="2869015" y="5947397"/>
            <a:ext cx="19287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hr-HR" sz="1200" b="1" dirty="0" err="1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phone</a:t>
            </a:r>
            <a:r>
              <a:rPr lang="hr-HR" sz="1200" b="1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 </a:t>
            </a:r>
            <a:r>
              <a:rPr lang="hr-HR" sz="1200" b="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(</a:t>
            </a:r>
            <a:r>
              <a:rPr lang="hr-HR" sz="120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919)</a:t>
            </a:r>
            <a:r>
              <a:rPr lang="hr-HR" sz="1200" baseline="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 </a:t>
            </a:r>
            <a:r>
              <a:rPr lang="hr-HR" sz="120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572-1711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hr-HR" sz="1200" b="1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fax </a:t>
            </a:r>
            <a:r>
              <a:rPr lang="hr-HR" sz="1200" b="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(</a:t>
            </a:r>
            <a:r>
              <a:rPr lang="hr-HR" sz="120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919)</a:t>
            </a:r>
            <a:r>
              <a:rPr lang="hr-HR" sz="1200" baseline="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 </a:t>
            </a:r>
            <a:r>
              <a:rPr lang="hr-HR" sz="1200" dirty="0">
                <a:solidFill>
                  <a:schemeClr val="bg1"/>
                </a:solidFill>
                <a:latin typeface="Montserrat" charset="0"/>
                <a:ea typeface="Montserrat" charset="0"/>
                <a:cs typeface="Montserrat" charset="0"/>
              </a:rPr>
              <a:t>572-1721</a:t>
            </a:r>
            <a:endParaRPr lang="en-US" sz="1200" dirty="0">
              <a:solidFill>
                <a:schemeClr val="bg1"/>
              </a:solidFill>
              <a:latin typeface="Montserrat" charset="0"/>
              <a:ea typeface="Montserrat" charset="0"/>
              <a:cs typeface="Montserrat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14E6E47-0168-C84A-821A-B55704C931F3}"/>
              </a:ext>
            </a:extLst>
          </p:cNvPr>
          <p:cNvSpPr txBox="1"/>
          <p:nvPr userDrawn="1"/>
        </p:nvSpPr>
        <p:spPr>
          <a:xfrm>
            <a:off x="5004270" y="5904367"/>
            <a:ext cx="2509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schemeClr val="accent6"/>
                </a:solidFill>
                <a:latin typeface="Montserrat" charset="0"/>
                <a:ea typeface="Montserrat" charset="0"/>
                <a:cs typeface="Montserrat" charset="0"/>
                <a:hlinkClick r:id="rId5"/>
              </a:rPr>
              <a:t>www.metabolon.com</a:t>
            </a:r>
            <a:endParaRPr lang="en-US" sz="1200" b="1" dirty="0">
              <a:solidFill>
                <a:schemeClr val="accent6"/>
              </a:solidFill>
              <a:latin typeface="Montserrat" charset="0"/>
              <a:ea typeface="Montserrat" charset="0"/>
              <a:cs typeface="Montserrat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748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3528" y="116632"/>
            <a:ext cx="8640960" cy="595456"/>
          </a:xfrm>
        </p:spPr>
        <p:txBody>
          <a:bodyPr>
            <a:normAutofit/>
          </a:bodyPr>
          <a:lstStyle>
            <a:lvl1pPr>
              <a:defRPr sz="2800">
                <a:solidFill>
                  <a:srgbClr val="3F4D59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3568" y="5905558"/>
            <a:ext cx="8136904" cy="790750"/>
          </a:xfrm>
          <a:prstGeom prst="rect">
            <a:avLst/>
          </a:prstGeom>
        </p:spPr>
        <p:txBody>
          <a:bodyPr/>
          <a:lstStyle>
            <a:lvl1pPr>
              <a:buClr>
                <a:srgbClr val="DC8215"/>
              </a:buClr>
              <a:defRPr sz="1800">
                <a:solidFill>
                  <a:srgbClr val="3F4D59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85800" indent="-228600">
              <a:buClr>
                <a:srgbClr val="DC8215"/>
              </a:buClr>
              <a:buFont typeface="Arial" panose="020B0604020202020204" pitchFamily="34" charset="0"/>
              <a:buChar char="–"/>
              <a:defRPr sz="1600">
                <a:solidFill>
                  <a:srgbClr val="3F4D59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buClr>
                <a:srgbClr val="DC8215"/>
              </a:buClr>
              <a:defRPr sz="1400">
                <a:solidFill>
                  <a:srgbClr val="3F4D59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buClr>
                <a:srgbClr val="DC8215"/>
              </a:buClr>
              <a:buFont typeface="Arial" panose="020B0604020202020204" pitchFamily="34" charset="0"/>
              <a:buChar char="–"/>
              <a:defRPr sz="1200">
                <a:solidFill>
                  <a:srgbClr val="3F4D59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buClr>
                <a:srgbClr val="DC8215"/>
              </a:buClr>
              <a:buFont typeface="Arial" panose="020B0604020202020204" pitchFamily="34" charset="0"/>
              <a:buChar char="»"/>
              <a:defRPr sz="1200">
                <a:solidFill>
                  <a:srgbClr val="3F4D59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260346" y="6356351"/>
            <a:ext cx="617105" cy="365125"/>
          </a:xfrm>
          <a:prstGeom prst="rect">
            <a:avLst/>
          </a:prstGeom>
        </p:spPr>
        <p:txBody>
          <a:bodyPr anchor="ctr"/>
          <a:lstStyle>
            <a:lvl1pPr algn="l">
              <a:defRPr sz="900" baseline="0">
                <a:solidFill>
                  <a:srgbClr val="3F4D59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en-US" kern="0" dirty="0"/>
          </a:p>
        </p:txBody>
      </p:sp>
    </p:spTree>
    <p:extLst>
      <p:ext uri="{BB962C8B-B14F-4D97-AF65-F5344CB8AC3E}">
        <p14:creationId xmlns:p14="http://schemas.microsoft.com/office/powerpoint/2010/main" val="1390387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  <a:latin typeface="Montserrat" pitchFamily="2" charset="77"/>
              </a:defRPr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  <a:latin typeface="Montserrat" pitchFamily="2" charset="77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  <a:latin typeface="Montserrat" pitchFamily="2" charset="77"/>
              </a:defRPr>
            </a:lvl1pPr>
          </a:lstStyle>
          <a:p>
            <a:fld id="{0D62520C-6070-49E2-B459-CDB0BDCBA57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4" r:id="rId3"/>
    <p:sldLayoutId id="2147483655" r:id="rId4"/>
    <p:sldLayoutId id="2147483656" r:id="rId5"/>
    <p:sldLayoutId id="2147483657" r:id="rId6"/>
    <p:sldLayoutId id="2147483658" r:id="rId7"/>
  </p:sldLayoutIdLst>
  <p:hf hdr="0" ftr="0" dt="0"/>
  <p:txStyles>
    <p:titleStyle>
      <a:lvl1pPr algn="l" defTabSz="914400" rtl="0" eaLnBrk="1" latinLnBrk="0" hangingPunct="1">
        <a:spcBef>
          <a:spcPct val="0"/>
        </a:spcBef>
        <a:buNone/>
        <a:defRPr sz="3600" b="1" kern="1200">
          <a:solidFill>
            <a:schemeClr val="tx1"/>
          </a:solidFill>
          <a:latin typeface="Montserrat" pitchFamily="2" charset="77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Montserrat" pitchFamily="2" charset="77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Montserrat" pitchFamily="2" charset="77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Montserrat" pitchFamily="2" charset="77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Montserrat" pitchFamily="2" charset="77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1600" kern="1200">
          <a:solidFill>
            <a:schemeClr val="tx1"/>
          </a:solidFill>
          <a:latin typeface="Montserrat" pitchFamily="2" charset="77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18.png"/></Relationships>
</file>

<file path=ppt/slides/_rels/slide1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5" Type="http://schemas.microsoft.com/office/2007/relationships/hdphoto" Target="../media/hdphoto4.wdp"/><Relationship Id="rId4" Type="http://schemas.openxmlformats.org/officeDocument/2006/relationships/image" Target="../media/image20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7" Type="http://schemas.openxmlformats.org/officeDocument/2006/relationships/image" Target="../media/image28.emf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7" Type="http://schemas.openxmlformats.org/officeDocument/2006/relationships/image" Target="../media/image34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emf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3" Type="http://schemas.openxmlformats.org/officeDocument/2006/relationships/image" Target="../media/image36.emf"/><Relationship Id="rId7" Type="http://schemas.openxmlformats.org/officeDocument/2006/relationships/image" Target="../media/image40.emf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emf"/><Relationship Id="rId5" Type="http://schemas.openxmlformats.org/officeDocument/2006/relationships/image" Target="../media/image38.emf"/><Relationship Id="rId4" Type="http://schemas.openxmlformats.org/officeDocument/2006/relationships/image" Target="../media/image37.emf"/><Relationship Id="rId9" Type="http://schemas.openxmlformats.org/officeDocument/2006/relationships/image" Target="../media/image42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7" Type="http://schemas.openxmlformats.org/officeDocument/2006/relationships/image" Target="../media/image47.emf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emf"/><Relationship Id="rId5" Type="http://schemas.openxmlformats.org/officeDocument/2006/relationships/image" Target="../media/image45.emf"/><Relationship Id="rId4" Type="http://schemas.openxmlformats.org/officeDocument/2006/relationships/image" Target="../media/image44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52.emf"/><Relationship Id="rId5" Type="http://schemas.openxmlformats.org/officeDocument/2006/relationships/image" Target="../media/image51.emf"/><Relationship Id="rId4" Type="http://schemas.openxmlformats.org/officeDocument/2006/relationships/image" Target="../media/image50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emf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56.emf"/><Relationship Id="rId5" Type="http://schemas.openxmlformats.org/officeDocument/2006/relationships/image" Target="../media/image55.emf"/><Relationship Id="rId4" Type="http://schemas.openxmlformats.org/officeDocument/2006/relationships/image" Target="../media/image54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emf"/><Relationship Id="rId7" Type="http://schemas.openxmlformats.org/officeDocument/2006/relationships/image" Target="../media/image62.emf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1.emf"/><Relationship Id="rId5" Type="http://schemas.openxmlformats.org/officeDocument/2006/relationships/image" Target="../media/image60.emf"/><Relationship Id="rId4" Type="http://schemas.openxmlformats.org/officeDocument/2006/relationships/image" Target="../media/image59.em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emf"/><Relationship Id="rId7" Type="http://schemas.openxmlformats.org/officeDocument/2006/relationships/image" Target="../media/image67.emf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emf"/><Relationship Id="rId5" Type="http://schemas.openxmlformats.org/officeDocument/2006/relationships/image" Target="../media/image65.emf"/><Relationship Id="rId4" Type="http://schemas.openxmlformats.org/officeDocument/2006/relationships/image" Target="../media/image64.em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png"/><Relationship Id="rId7" Type="http://schemas.openxmlformats.org/officeDocument/2006/relationships/image" Target="../media/image73.emf"/><Relationship Id="rId2" Type="http://schemas.openxmlformats.org/officeDocument/2006/relationships/image" Target="../media/image6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2.emf"/><Relationship Id="rId5" Type="http://schemas.openxmlformats.org/officeDocument/2006/relationships/image" Target="../media/image71.emf"/><Relationship Id="rId4" Type="http://schemas.openxmlformats.org/officeDocument/2006/relationships/image" Target="../media/image70.em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png"/><Relationship Id="rId7" Type="http://schemas.openxmlformats.org/officeDocument/2006/relationships/image" Target="../media/image79.emf"/><Relationship Id="rId2" Type="http://schemas.openxmlformats.org/officeDocument/2006/relationships/image" Target="../media/image7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8.emf"/><Relationship Id="rId5" Type="http://schemas.openxmlformats.org/officeDocument/2006/relationships/image" Target="../media/image77.emf"/><Relationship Id="rId4" Type="http://schemas.openxmlformats.org/officeDocument/2006/relationships/image" Target="../media/image76.emf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emf"/><Relationship Id="rId2" Type="http://schemas.openxmlformats.org/officeDocument/2006/relationships/image" Target="../media/image8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4.emf"/><Relationship Id="rId5" Type="http://schemas.openxmlformats.org/officeDocument/2006/relationships/image" Target="../media/image83.emf"/><Relationship Id="rId4" Type="http://schemas.openxmlformats.org/officeDocument/2006/relationships/image" Target="../media/image82.emf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emf"/><Relationship Id="rId2" Type="http://schemas.openxmlformats.org/officeDocument/2006/relationships/image" Target="../media/image8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7.emf"/><Relationship Id="rId4" Type="http://schemas.openxmlformats.org/officeDocument/2006/relationships/image" Target="../media/image87.emf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emf"/><Relationship Id="rId2" Type="http://schemas.openxmlformats.org/officeDocument/2006/relationships/image" Target="../media/image88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1.png"/><Relationship Id="rId4" Type="http://schemas.openxmlformats.org/officeDocument/2006/relationships/image" Target="../media/image90.emf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emf"/><Relationship Id="rId2" Type="http://schemas.openxmlformats.org/officeDocument/2006/relationships/image" Target="../media/image92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5.png"/><Relationship Id="rId4" Type="http://schemas.openxmlformats.org/officeDocument/2006/relationships/image" Target="../media/image94.emf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png"/><Relationship Id="rId2" Type="http://schemas.openxmlformats.org/officeDocument/2006/relationships/image" Target="../media/image9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0.emf"/><Relationship Id="rId5" Type="http://schemas.openxmlformats.org/officeDocument/2006/relationships/image" Target="../media/image99.emf"/><Relationship Id="rId4" Type="http://schemas.openxmlformats.org/officeDocument/2006/relationships/image" Target="../media/image98.emf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png"/><Relationship Id="rId2" Type="http://schemas.openxmlformats.org/officeDocument/2006/relationships/image" Target="../media/image10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4.emf"/><Relationship Id="rId5" Type="http://schemas.openxmlformats.org/officeDocument/2006/relationships/image" Target="../media/image103.emf"/><Relationship Id="rId4" Type="http://schemas.openxmlformats.org/officeDocument/2006/relationships/image" Target="../media/image10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9.gif"/><Relationship Id="rId4" Type="http://schemas.openxmlformats.org/officeDocument/2006/relationships/image" Target="../media/image8.jpe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6.png"/><Relationship Id="rId2" Type="http://schemas.openxmlformats.org/officeDocument/2006/relationships/image" Target="../media/image10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9.emf"/><Relationship Id="rId5" Type="http://schemas.openxmlformats.org/officeDocument/2006/relationships/image" Target="../media/image108.emf"/><Relationship Id="rId4" Type="http://schemas.openxmlformats.org/officeDocument/2006/relationships/image" Target="../media/image107.emf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1.emf"/><Relationship Id="rId2" Type="http://schemas.openxmlformats.org/officeDocument/2006/relationships/image" Target="../media/image11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4.png"/><Relationship Id="rId5" Type="http://schemas.openxmlformats.org/officeDocument/2006/relationships/image" Target="../media/image113.emf"/><Relationship Id="rId4" Type="http://schemas.openxmlformats.org/officeDocument/2006/relationships/image" Target="../media/image112.emf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6.emf"/><Relationship Id="rId2" Type="http://schemas.openxmlformats.org/officeDocument/2006/relationships/image" Target="../media/image1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9.png"/><Relationship Id="rId5" Type="http://schemas.openxmlformats.org/officeDocument/2006/relationships/image" Target="../media/image118.emf"/><Relationship Id="rId4" Type="http://schemas.openxmlformats.org/officeDocument/2006/relationships/image" Target="../media/image117.emf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emf"/><Relationship Id="rId2" Type="http://schemas.openxmlformats.org/officeDocument/2006/relationships/image" Target="../media/image12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4.png"/><Relationship Id="rId5" Type="http://schemas.openxmlformats.org/officeDocument/2006/relationships/image" Target="../media/image123.emf"/><Relationship Id="rId4" Type="http://schemas.openxmlformats.org/officeDocument/2006/relationships/image" Target="../media/image122.emf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6.emf"/><Relationship Id="rId2" Type="http://schemas.openxmlformats.org/officeDocument/2006/relationships/image" Target="../media/image1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9.emf"/><Relationship Id="rId5" Type="http://schemas.openxmlformats.org/officeDocument/2006/relationships/image" Target="../media/image128.emf"/><Relationship Id="rId4" Type="http://schemas.openxmlformats.org/officeDocument/2006/relationships/image" Target="../media/image127.emf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0.emf"/><Relationship Id="rId2" Type="http://schemas.openxmlformats.org/officeDocument/2006/relationships/image" Target="../media/image1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3.emf"/><Relationship Id="rId5" Type="http://schemas.openxmlformats.org/officeDocument/2006/relationships/image" Target="../media/image132.emf"/><Relationship Id="rId4" Type="http://schemas.openxmlformats.org/officeDocument/2006/relationships/image" Target="../media/image131.emf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5.png"/><Relationship Id="rId7" Type="http://schemas.openxmlformats.org/officeDocument/2006/relationships/image" Target="../media/image139.emf"/><Relationship Id="rId2" Type="http://schemas.openxmlformats.org/officeDocument/2006/relationships/image" Target="../media/image13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8.emf"/><Relationship Id="rId5" Type="http://schemas.openxmlformats.org/officeDocument/2006/relationships/image" Target="../media/image137.emf"/><Relationship Id="rId4" Type="http://schemas.openxmlformats.org/officeDocument/2006/relationships/image" Target="../media/image136.emf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5.png"/><Relationship Id="rId7" Type="http://schemas.openxmlformats.org/officeDocument/2006/relationships/image" Target="../media/image144.emf"/><Relationship Id="rId2" Type="http://schemas.openxmlformats.org/officeDocument/2006/relationships/image" Target="../media/image14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3.emf"/><Relationship Id="rId5" Type="http://schemas.openxmlformats.org/officeDocument/2006/relationships/image" Target="../media/image142.emf"/><Relationship Id="rId4" Type="http://schemas.openxmlformats.org/officeDocument/2006/relationships/image" Target="../media/image141.emf"/></Relationships>
</file>

<file path=ppt/slides/_rels/slide3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1.emf"/><Relationship Id="rId3" Type="http://schemas.openxmlformats.org/officeDocument/2006/relationships/image" Target="../media/image146.png"/><Relationship Id="rId7" Type="http://schemas.openxmlformats.org/officeDocument/2006/relationships/image" Target="../media/image150.emf"/><Relationship Id="rId2" Type="http://schemas.openxmlformats.org/officeDocument/2006/relationships/image" Target="../media/image1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9.emf"/><Relationship Id="rId5" Type="http://schemas.openxmlformats.org/officeDocument/2006/relationships/image" Target="../media/image148.emf"/><Relationship Id="rId4" Type="http://schemas.openxmlformats.org/officeDocument/2006/relationships/image" Target="../media/image147.emf"/><Relationship Id="rId9" Type="http://schemas.openxmlformats.org/officeDocument/2006/relationships/image" Target="../media/image152.emf"/></Relationships>
</file>

<file path=ppt/slides/_rels/slide3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8.emf"/><Relationship Id="rId3" Type="http://schemas.openxmlformats.org/officeDocument/2006/relationships/image" Target="../media/image153.emf"/><Relationship Id="rId7" Type="http://schemas.openxmlformats.org/officeDocument/2006/relationships/image" Target="../media/image157.emf"/><Relationship Id="rId2" Type="http://schemas.openxmlformats.org/officeDocument/2006/relationships/image" Target="../media/image1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6.emf"/><Relationship Id="rId5" Type="http://schemas.openxmlformats.org/officeDocument/2006/relationships/image" Target="../media/image155.emf"/><Relationship Id="rId4" Type="http://schemas.openxmlformats.org/officeDocument/2006/relationships/image" Target="../media/image154.emf"/><Relationship Id="rId9" Type="http://schemas.openxmlformats.org/officeDocument/2006/relationships/image" Target="../media/image15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1.png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1.emf"/><Relationship Id="rId2" Type="http://schemas.openxmlformats.org/officeDocument/2006/relationships/image" Target="../media/image160.pn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163.emf"/><Relationship Id="rId4" Type="http://schemas.openxmlformats.org/officeDocument/2006/relationships/image" Target="../media/image162.emf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5.emf"/><Relationship Id="rId2" Type="http://schemas.openxmlformats.org/officeDocument/2006/relationships/image" Target="../media/image164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168.emf"/><Relationship Id="rId5" Type="http://schemas.openxmlformats.org/officeDocument/2006/relationships/image" Target="../media/image167.emf"/><Relationship Id="rId4" Type="http://schemas.openxmlformats.org/officeDocument/2006/relationships/image" Target="../media/image166.emf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9.png"/><Relationship Id="rId2" Type="http://schemas.openxmlformats.org/officeDocument/2006/relationships/image" Target="../media/image160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172.emf"/><Relationship Id="rId5" Type="http://schemas.openxmlformats.org/officeDocument/2006/relationships/image" Target="../media/image171.emf"/><Relationship Id="rId4" Type="http://schemas.openxmlformats.org/officeDocument/2006/relationships/image" Target="../media/image170.emf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3.emf"/><Relationship Id="rId2" Type="http://schemas.openxmlformats.org/officeDocument/2006/relationships/image" Target="../media/image164.pn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175.emf"/><Relationship Id="rId4" Type="http://schemas.openxmlformats.org/officeDocument/2006/relationships/image" Target="../media/image174.emf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6.png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7.png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8.pn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5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10988" y="4415118"/>
            <a:ext cx="810250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hangingPunct="0">
              <a:defRPr/>
            </a:pPr>
            <a:r>
              <a:rPr lang="en-US" sz="2000" dirty="0" err="1">
                <a:solidFill>
                  <a:schemeClr val="bg1"/>
                </a:solidFill>
                <a:effectLst>
                  <a:outerShdw dist="38100" sx="1000" sy="1000" algn="tl">
                    <a:srgbClr val="C0C0C0"/>
                  </a:outerShdw>
                </a:effectLst>
                <a:latin typeface="Montserrat" pitchFamily="2" charset="77"/>
              </a:rPr>
              <a:t>Teneobio</a:t>
            </a:r>
            <a:endParaRPr lang="en-US" sz="2000" dirty="0">
              <a:solidFill>
                <a:schemeClr val="bg1"/>
              </a:solidFill>
              <a:effectLst>
                <a:outerShdw dist="38100" sx="1000" sy="1000" algn="tl">
                  <a:srgbClr val="C0C0C0"/>
                </a:outerShdw>
              </a:effectLst>
              <a:latin typeface="Montserrat" pitchFamily="2" charset="77"/>
            </a:endParaRPr>
          </a:p>
          <a:p>
            <a:pPr eaLnBrk="0" hangingPunct="0">
              <a:defRPr/>
            </a:pPr>
            <a:r>
              <a:rPr lang="en-US" sz="2000" dirty="0">
                <a:solidFill>
                  <a:schemeClr val="bg1"/>
                </a:solidFill>
                <a:effectLst>
                  <a:outerShdw dist="38100" sx="1000" sy="1000" algn="tl">
                    <a:srgbClr val="C0C0C0"/>
                  </a:outerShdw>
                </a:effectLst>
                <a:latin typeface="Montserrat" pitchFamily="2" charset="77"/>
              </a:rPr>
              <a:t>TENE-03-21VS</a:t>
            </a:r>
          </a:p>
        </p:txBody>
      </p:sp>
      <p:sp>
        <p:nvSpPr>
          <p:cNvPr id="3" name="Rectangle 2"/>
          <p:cNvSpPr txBox="1">
            <a:spLocks noChangeArrowheads="1"/>
          </p:cNvSpPr>
          <p:nvPr/>
        </p:nvSpPr>
        <p:spPr>
          <a:xfrm>
            <a:off x="510988" y="986199"/>
            <a:ext cx="8042288" cy="2243562"/>
          </a:xfrm>
          <a:prstGeom prst="rect">
            <a:avLst/>
          </a:prstGeom>
          <a:effectLst>
            <a:outerShdw dist="35921" sx="1000" sy="1000" algn="ctr" rotWithShape="0">
              <a:schemeClr val="bg2"/>
            </a:outerShdw>
          </a:effectLst>
        </p:spPr>
        <p:txBody>
          <a:bodyPr/>
          <a:lstStyle/>
          <a:p>
            <a:r>
              <a:rPr lang="en-US" sz="4500" b="1" dirty="0">
                <a:solidFill>
                  <a:schemeClr val="bg1"/>
                </a:solidFill>
                <a:latin typeface="Montserrat" pitchFamily="2" charset="77"/>
              </a:rPr>
              <a:t>Metabolomic Analysis of Mouse Liver, Lung, and Heart Tissue</a:t>
            </a:r>
            <a:endParaRPr lang="en-US" sz="4500" dirty="0">
              <a:solidFill>
                <a:schemeClr val="bg1"/>
              </a:solidFill>
              <a:latin typeface="Montserrat" pitchFamily="2" charset="77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10</a:t>
            </a:fld>
            <a:endParaRPr lang="en-US" kern="0" dirty="0"/>
          </a:p>
        </p:txBody>
      </p:sp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503238" y="2997200"/>
            <a:ext cx="8640762" cy="595313"/>
          </a:xfrm>
        </p:spPr>
        <p:txBody>
          <a:bodyPr>
            <a:normAutofit fontScale="90000"/>
          </a:bodyPr>
          <a:lstStyle/>
          <a:p>
            <a:r>
              <a:rPr lang="en-US" cap="all" dirty="0">
                <a:solidFill>
                  <a:schemeClr val="tx2"/>
                </a:solidFill>
              </a:rPr>
              <a:t>Interpretation of data</a:t>
            </a:r>
          </a:p>
        </p:txBody>
      </p:sp>
    </p:spTree>
    <p:extLst>
      <p:ext uri="{BB962C8B-B14F-4D97-AF65-F5344CB8AC3E}">
        <p14:creationId xmlns:p14="http://schemas.microsoft.com/office/powerpoint/2010/main" val="170869672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AE3094-DADA-445C-A3AF-2A966B9590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rincipal Component Analysis - Liver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9C76DAE-22BC-49A0-BA89-7793F1DABF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11</a:t>
            </a:fld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8E1B777-8D46-4453-BD5C-94F9D6FF30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7200" y="1485224"/>
            <a:ext cx="4206980" cy="34747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C355E6D-8E58-49CB-AA25-725E30586AC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56163" y="1485224"/>
            <a:ext cx="4140822" cy="3474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23662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AE3094-DADA-445C-A3AF-2A966B9590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Principal Component Analysis - Lung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9C76DAE-22BC-49A0-BA89-7793F1DABF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12</a:t>
            </a:fld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B458058-B891-41A0-A555-7773070AB8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97785" y="1691715"/>
            <a:ext cx="4306185" cy="35661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B1DF88F-C946-43C5-85EA-982DCFFBDB5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45874" y="1691715"/>
            <a:ext cx="4341090" cy="3566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96128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D1E2E8-2DA8-46F5-A047-63CF966A34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Statistical Summary Count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56B1CBDD-1D9F-4F50-9B88-D7855F9BC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13</a:t>
            </a:fld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BA70DC7-1F53-4FC7-B36F-E417488519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5223" y="1086704"/>
            <a:ext cx="2753257" cy="233387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5878A14-7FCF-48A2-9C36-751B4F768E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4420" y="1086705"/>
            <a:ext cx="2766244" cy="2333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964353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33A3CC-79D1-467E-8E99-7569FFC375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84899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Nicotinate and Nicotinamide Metabolism - Liver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8DE632A-BF09-4978-AD01-A033F596B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14</a:t>
            </a:fld>
            <a:endParaRPr lang="en-US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519AFAEC-B200-458B-8D4F-FE5BD89556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75046" y="671355"/>
            <a:ext cx="5009552" cy="294179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1689ED4-BC72-4DB7-8159-89D49BB299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403" y="696853"/>
            <a:ext cx="3415644" cy="297027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57E2FAE-BC9D-4793-B00B-4E68921BC5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9756" y="3756025"/>
            <a:ext cx="2107904" cy="21031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24D5D75-C59B-476F-8112-50F2D66BED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2078" y="3756025"/>
            <a:ext cx="2107904" cy="21031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2D9B9DB-1348-4404-8C9D-41CD2710912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58240" y="3756025"/>
            <a:ext cx="2107904" cy="21031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9D9D864-87B4-49D9-AAE7-5BE8662D78A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45917" y="3756025"/>
            <a:ext cx="2107904" cy="2103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165546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33A3CC-79D1-467E-8E99-7569FFC375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84899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Nicotinate and Nicotinamide Metabolism - Lung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8DE632A-BF09-4978-AD01-A033F596B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15</a:t>
            </a:fld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90B2F3C-C1B6-4D07-BD33-3CF29EF571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175" y="696085"/>
            <a:ext cx="3867150" cy="302872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C330118-DC1B-471B-A4C9-04D798CC0D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24325" y="838200"/>
            <a:ext cx="4769486" cy="280250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94A7934-3145-4258-985A-909266970F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42406" y="3735198"/>
            <a:ext cx="2107904" cy="210312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C79D394-6CCF-42EF-87D4-E012103DE7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0826" y="3735198"/>
            <a:ext cx="2107904" cy="21031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8391607-342A-44E2-B635-4A1CDEE2701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93196" y="3735198"/>
            <a:ext cx="2107904" cy="21031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3A36A51-7032-405C-BEAE-B50853B7515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91616" y="3735198"/>
            <a:ext cx="2107904" cy="2103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63156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B50DA-0090-48AC-9BD0-379A13213D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91404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Glycolysis and Glycogen Metabolism - Liver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5ECD97C3-14D8-48EB-BB5D-3ADB3F831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16</a:t>
            </a:fld>
            <a:endParaRPr lang="en-US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DAE6832-4F4D-4E39-B88A-CEF0A13EDA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2703" y="673940"/>
            <a:ext cx="3896795" cy="244080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079AB7C-6903-4641-91ED-2AECFCFE10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626" y="673940"/>
            <a:ext cx="3593892" cy="426058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7F09C67-6234-4279-AF2C-C44EACA625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32044" y="3069887"/>
            <a:ext cx="1836820" cy="1828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AAB995B-0537-4581-B449-F045902AC01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20987" y="3069887"/>
            <a:ext cx="1836820" cy="1828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EF50862-564D-461A-BD64-C69486264A3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4493" y="4950581"/>
            <a:ext cx="1744979" cy="17373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4173E6A-907B-4322-A335-87CFC3DD6DE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93436" y="4950581"/>
            <a:ext cx="1744979" cy="17373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34D678D-2196-4D8B-883E-109ACF0164D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82379" y="4950581"/>
            <a:ext cx="1744979" cy="17373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0BC05BC-6597-432B-855F-A957DD9B585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71322" y="4950581"/>
            <a:ext cx="1744979" cy="1737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237743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B50DA-0090-48AC-9BD0-379A13213D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91404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Glycolysis and Glycogen Metabolism - Lung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5ECD97C3-14D8-48EB-BB5D-3ADB3F831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17</a:t>
            </a:fld>
            <a:endParaRPr lang="en-US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DAE6832-4F4D-4E39-B88A-CEF0A13EDA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2977" y="1229313"/>
            <a:ext cx="4515581" cy="282839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704C721-6CDA-407C-AD24-476572414F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006" y="772193"/>
            <a:ext cx="3338971" cy="36770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5E32910-7517-4CE7-9674-658A2C1845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0028" y="4479744"/>
            <a:ext cx="1836820" cy="1828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55C2A52-8743-4B8B-B894-98B43BBA056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40598" y="4479744"/>
            <a:ext cx="1836820" cy="1828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6335086-E45B-46A5-8659-EF03E9961BD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31168" y="4479744"/>
            <a:ext cx="1836820" cy="18288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24A12BB-0AB6-437D-B485-8FB56D315C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21738" y="4479744"/>
            <a:ext cx="1836820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538254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18</a:t>
            </a:fld>
            <a:endParaRPr lang="en-US" kern="0" dirty="0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9FB8000A-9674-41A9-B3E0-1E235B030F8C}"/>
              </a:ext>
            </a:extLst>
          </p:cNvPr>
          <p:cNvSpPr txBox="1">
            <a:spLocks/>
          </p:cNvSpPr>
          <p:nvPr/>
        </p:nvSpPr>
        <p:spPr>
          <a:xfrm>
            <a:off x="457200" y="118455"/>
            <a:ext cx="8229600" cy="4873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/>
                </a:solidFill>
                <a:latin typeface="Montserrat" pitchFamily="2" charset="77"/>
                <a:ea typeface="+mj-ea"/>
                <a:cs typeface="+mj-cs"/>
              </a:defRPr>
            </a:lvl1pPr>
          </a:lstStyle>
          <a:p>
            <a:r>
              <a:rPr lang="en-US" sz="2800" dirty="0"/>
              <a:t>TCA Cycle - Liver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1AD608D-D045-4524-9CF5-B3FA7BE06304}"/>
              </a:ext>
            </a:extLst>
          </p:cNvPr>
          <p:cNvGrpSpPr/>
          <p:nvPr/>
        </p:nvGrpSpPr>
        <p:grpSpPr>
          <a:xfrm>
            <a:off x="1115023" y="831229"/>
            <a:ext cx="6913955" cy="3325634"/>
            <a:chOff x="896619" y="831229"/>
            <a:chExt cx="6913955" cy="332563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2216B1F-B9C7-4622-98F1-A8960C895C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43749" y="831230"/>
              <a:ext cx="3166825" cy="3325633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1C5BAD0-265B-49C2-B4D2-4CE2DE33326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96619" y="831229"/>
              <a:ext cx="3675381" cy="3325633"/>
            </a:xfrm>
            <a:prstGeom prst="rect">
              <a:avLst/>
            </a:prstGeom>
          </p:spPr>
        </p:pic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0B290889-488B-41F3-9F54-86A4BDB753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2635" y="4198807"/>
            <a:ext cx="2296025" cy="228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53F3DB2-7990-4CCB-B39A-D3994C2948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2262" y="4198807"/>
            <a:ext cx="2296025" cy="2286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90B0F30-B73F-4203-B561-A63DEFD1E38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41889" y="4198807"/>
            <a:ext cx="2296025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734395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19</a:t>
            </a:fld>
            <a:endParaRPr lang="en-US" kern="0" dirty="0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9FB8000A-9674-41A9-B3E0-1E235B030F8C}"/>
              </a:ext>
            </a:extLst>
          </p:cNvPr>
          <p:cNvSpPr txBox="1">
            <a:spLocks/>
          </p:cNvSpPr>
          <p:nvPr/>
        </p:nvSpPr>
        <p:spPr>
          <a:xfrm>
            <a:off x="457200" y="118455"/>
            <a:ext cx="8229600" cy="4873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/>
                </a:solidFill>
                <a:latin typeface="Montserrat" pitchFamily="2" charset="77"/>
                <a:ea typeface="+mj-ea"/>
                <a:cs typeface="+mj-cs"/>
              </a:defRPr>
            </a:lvl1pPr>
          </a:lstStyle>
          <a:p>
            <a:r>
              <a:rPr lang="en-US" sz="2800" dirty="0"/>
              <a:t>TCA Cycle - Lung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870DA5D-FA1E-4762-B2FE-E0FE7BCB5DEE}"/>
              </a:ext>
            </a:extLst>
          </p:cNvPr>
          <p:cNvGrpSpPr/>
          <p:nvPr/>
        </p:nvGrpSpPr>
        <p:grpSpPr>
          <a:xfrm>
            <a:off x="1075212" y="772507"/>
            <a:ext cx="6993576" cy="3212264"/>
            <a:chOff x="732371" y="831230"/>
            <a:chExt cx="6386727" cy="2859927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2216B1F-B9C7-4622-98F1-A8960C895C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95742" y="831231"/>
              <a:ext cx="2723356" cy="2859926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E68FB5C-D0AC-4FE9-9EB4-D41342C3BBF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32371" y="831230"/>
              <a:ext cx="3663371" cy="2859926"/>
            </a:xfrm>
            <a:prstGeom prst="rect">
              <a:avLst/>
            </a:prstGeom>
          </p:spPr>
        </p:pic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EB6D5581-F642-43C1-9B72-2C26C82A10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8757" y="3984770"/>
            <a:ext cx="2296025" cy="2286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3C0BD9F-1644-4ED5-A13E-ED6124D12DA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4192" y="3984770"/>
            <a:ext cx="2296025" cy="2286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E43D705-900D-40D3-B8A3-734731B9567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79628" y="3984770"/>
            <a:ext cx="2296025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46134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R="0" lvl="0" algn="l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3000" noProof="0" dirty="0">
                <a:solidFill>
                  <a:schemeClr val="tx2"/>
                </a:solidFill>
              </a:rPr>
              <a:t>Study Overview</a:t>
            </a:r>
            <a:endParaRPr kumimoji="0" lang="en-US" sz="3000" i="0" u="none" strike="noStrike" kern="1200" cap="none" spc="0" normalizeH="0" baseline="0" noProof="0" dirty="0">
              <a:ln>
                <a:noFill/>
              </a:ln>
              <a:solidFill>
                <a:schemeClr val="tx2"/>
              </a:solidFill>
              <a:effectLst/>
              <a:uLnTx/>
              <a:uFillTx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81530" y="2265053"/>
            <a:ext cx="18053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dirty="0">
                <a:solidFill>
                  <a:schemeClr val="accent6">
                    <a:lumMod val="90000"/>
                  </a:schemeClr>
                </a:solidFill>
                <a:latin typeface="Montserrat" pitchFamily="2" charset="77"/>
              </a:rPr>
              <a:t>Study Design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82803" y="752794"/>
            <a:ext cx="2116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accent6">
                    <a:lumMod val="90000"/>
                  </a:schemeClr>
                </a:solidFill>
                <a:latin typeface="Montserrat" pitchFamily="2" charset="77"/>
              </a:rPr>
              <a:t>Study Objectiv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914400" y="1037722"/>
            <a:ext cx="738201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e goal of this metabolomic study was to determine if anti-CD38 antibody treatment causes significant up/downregulation of known and novel metabolites within the known target-tissues of mice.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910253" y="2587103"/>
            <a:ext cx="74040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iver (20), lung (20) samples were delivered to Metabolon on April 28th, 2021. </a:t>
            </a:r>
            <a:endParaRPr lang="en-US" sz="16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2</a:t>
            </a:fld>
            <a:endParaRPr lang="en-US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2FF1FDD-F23C-49F8-ACAB-14EFA98D37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7616419"/>
              </p:ext>
            </p:extLst>
          </p:nvPr>
        </p:nvGraphicFramePr>
        <p:xfrm>
          <a:off x="2863127" y="3576410"/>
          <a:ext cx="3484562" cy="890778"/>
        </p:xfrm>
        <a:graphic>
          <a:graphicData uri="http://schemas.openxmlformats.org/drawingml/2006/table">
            <a:tbl>
              <a:tblPr firstRow="1" firstCol="1" bandRow="1"/>
              <a:tblGrid>
                <a:gridCol w="931862">
                  <a:extLst>
                    <a:ext uri="{9D8B030D-6E8A-4147-A177-3AD203B41FA5}">
                      <a16:colId xmlns:a16="http://schemas.microsoft.com/office/drawing/2014/main" val="1568540910"/>
                    </a:ext>
                  </a:extLst>
                </a:gridCol>
                <a:gridCol w="1771650">
                  <a:extLst>
                    <a:ext uri="{9D8B030D-6E8A-4147-A177-3AD203B41FA5}">
                      <a16:colId xmlns:a16="http://schemas.microsoft.com/office/drawing/2014/main" val="4030384631"/>
                    </a:ext>
                  </a:extLst>
                </a:gridCol>
                <a:gridCol w="781050">
                  <a:extLst>
                    <a:ext uri="{9D8B030D-6E8A-4147-A177-3AD203B41FA5}">
                      <a16:colId xmlns:a16="http://schemas.microsoft.com/office/drawing/2014/main" val="1698539235"/>
                    </a:ext>
                  </a:extLst>
                </a:gridCol>
              </a:tblGrid>
              <a:tr h="2584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6899343"/>
                  </a:ext>
                </a:extLst>
              </a:tr>
              <a:tr h="2584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B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3003312"/>
                  </a:ext>
                </a:extLst>
              </a:tr>
              <a:tr h="2584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NB73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721003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04B03C3-DF60-4723-9089-BAD08F0C8C5E}"/>
              </a:ext>
            </a:extLst>
          </p:cNvPr>
          <p:cNvSpPr txBox="1"/>
          <p:nvPr/>
        </p:nvSpPr>
        <p:spPr>
          <a:xfrm>
            <a:off x="2769844" y="3264812"/>
            <a:ext cx="16022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/>
              <a:t>Liver &amp; Lung:</a:t>
            </a:r>
          </a:p>
        </p:txBody>
      </p:sp>
    </p:spTree>
  </p:cSld>
  <p:clrMapOvr>
    <a:masterClrMapping/>
  </p:clrMapOvr>
  <p:transition/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5BEE2-0624-4B83-8CC2-4B61D60F0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Fatty Acid Metabolism - Liver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990332B-10AB-422A-A68B-21C4603161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6364" y="672929"/>
            <a:ext cx="3605342" cy="210312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53F79BF-13D4-4475-852A-8AF6B3C61B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1437" y="672928"/>
            <a:ext cx="3543117" cy="578727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253A31E-C508-4644-968D-2ABFF3595E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4418" y="2784531"/>
            <a:ext cx="1836820" cy="1828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6699259-A7DD-4C95-8C18-22B31489C0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74781" y="2784531"/>
            <a:ext cx="1836820" cy="1828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1FB0516-5A5F-4EA3-91F7-501BD80B9C7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74781" y="4598713"/>
            <a:ext cx="1836820" cy="1828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48AC595-503D-41C0-BE46-D5B0BFC97D5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14418" y="4598713"/>
            <a:ext cx="1836820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724093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5BEE2-0624-4B83-8CC2-4B61D60F0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84899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Fatty Acid Metabolism - Lung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990332B-10AB-422A-A68B-21C4603161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1999" y="605817"/>
            <a:ext cx="3816991" cy="222658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7CBEEBD-28D1-45D9-BA7D-F9B2F699CD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5400" y="605817"/>
            <a:ext cx="3066600" cy="599631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E7BA1C6-65C4-49E2-85CF-6F346770DF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93331" y="2824010"/>
            <a:ext cx="1836820" cy="1828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D3818CD-DBEB-453D-9BC4-E567365E95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55354" y="2824010"/>
            <a:ext cx="1836820" cy="1828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C9BE8D1-4041-49DD-8070-66AFA05B79E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93331" y="4723313"/>
            <a:ext cx="1836820" cy="1828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7EFAF7D-93B5-4081-A1C1-6F5FC789109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55354" y="4723313"/>
            <a:ext cx="1836820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303580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5BEE2-0624-4B83-8CC2-4B61D60F0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Omega-oxidation - Liver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9845CD9-1310-4B6A-A7C1-3700DA9DE3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1208" y="605817"/>
            <a:ext cx="4037007" cy="365126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02BD5A9-A0A5-4271-9C7B-19C292654E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98215" y="612391"/>
            <a:ext cx="3128300" cy="364469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574912F-0AB0-47EF-ACB7-984BB34A07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7018" y="4273862"/>
            <a:ext cx="2020502" cy="201168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E4F173A-BD7C-4FE5-B807-E5B30E915A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2133" y="4273862"/>
            <a:ext cx="2020502" cy="201168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B3F2B46-8CC9-432E-B8AE-7AA433CA406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67248" y="4273862"/>
            <a:ext cx="2020502" cy="20116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11CF8A8-2682-434C-80F9-5F4C847C161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62364" y="4273862"/>
            <a:ext cx="2020502" cy="2011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840615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5BEE2-0624-4B83-8CC2-4B61D60F0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Omega-oxidation - Lung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F9DAF664-349F-4443-84F9-C314ADBBD3E0}"/>
              </a:ext>
            </a:extLst>
          </p:cNvPr>
          <p:cNvGrpSpPr/>
          <p:nvPr/>
        </p:nvGrpSpPr>
        <p:grpSpPr>
          <a:xfrm>
            <a:off x="1227552" y="765208"/>
            <a:ext cx="6688896" cy="3102117"/>
            <a:chOff x="1358188" y="605817"/>
            <a:chExt cx="6688896" cy="310211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F1FE6A8-D29F-4D31-AEC9-859C64A904B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58188" y="605817"/>
              <a:ext cx="3961441" cy="3102117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2520C54-E72B-48EB-9F49-CA116F064F8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85904" y="605818"/>
              <a:ext cx="2661180" cy="3102116"/>
            </a:xfrm>
            <a:prstGeom prst="rect">
              <a:avLst/>
            </a:prstGeom>
          </p:spPr>
        </p:pic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112F1481-2C5D-45E1-947B-3F9FD9D62D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88604" y="3959603"/>
            <a:ext cx="1928661" cy="192024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EF5D789-7C25-4BF6-8D94-009D8C0DF8F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1697" y="3959603"/>
            <a:ext cx="1928661" cy="19202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9ACF617-EA6D-41FA-BDA6-E5EE2167C17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23999" y="3959603"/>
            <a:ext cx="1928661" cy="192024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4F36D35-D025-4D16-9C98-AEA8477C7C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56301" y="3959603"/>
            <a:ext cx="1928661" cy="1920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259049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11A727-A2A6-4F40-A56D-D1DBA1FF13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0066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Sugar Metabolism - Liver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153360F-C603-4198-8E06-59A414C4F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24</a:t>
            </a:fld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8331FDB-AB65-4A1B-8224-F04332A3E6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2665" y="597428"/>
            <a:ext cx="4466290" cy="374440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F804777-B72C-4B89-8DAD-78B5C3F875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87776" y="1270672"/>
            <a:ext cx="2204184" cy="21945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8A66E82-4D45-4D75-AA30-7C241CC336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2664" y="4428938"/>
            <a:ext cx="2204184" cy="21945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F42EAFE-14F8-491B-9001-01743ED990A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45220" y="4428938"/>
            <a:ext cx="2204184" cy="21945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526AA70-0770-4AA8-8571-9CBFFD5322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87776" y="4428938"/>
            <a:ext cx="2204184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111109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11A727-A2A6-4F40-A56D-D1DBA1FF13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Sugar Metabolism - Lung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153360F-C603-4198-8E06-59A414C4F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25</a:t>
            </a:fld>
            <a:endParaRPr lang="en-US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28366E3F-375B-43EC-8035-91F7CFBA0594}"/>
              </a:ext>
            </a:extLst>
          </p:cNvPr>
          <p:cNvGrpSpPr/>
          <p:nvPr/>
        </p:nvGrpSpPr>
        <p:grpSpPr>
          <a:xfrm>
            <a:off x="1545928" y="714874"/>
            <a:ext cx="6052144" cy="5874372"/>
            <a:chOff x="956306" y="681318"/>
            <a:chExt cx="6052144" cy="587437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739EA3A-0D3B-4204-A4D6-E1B81E62B0F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56306" y="681318"/>
              <a:ext cx="3213023" cy="310102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29831EB-A1F1-40CD-A76B-B03CFD172E2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53220" y="838200"/>
              <a:ext cx="2755230" cy="27432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F5F1EDB-AB3E-4CB8-927D-39A953028F9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53220" y="3812490"/>
              <a:ext cx="2755230" cy="27432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86E29BD-D4B5-44F7-AB33-B6F9236E9A4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85202" y="3812490"/>
              <a:ext cx="2755230" cy="27432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7446479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5BEE2-0624-4B83-8CC2-4B61D60F0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Complex Lipid Metabolism - Liver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E64E6B2-D49B-45E5-8F39-06877B1C8D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9826" y="798987"/>
            <a:ext cx="3619089" cy="528303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9855740-2549-4CEE-B34E-C46490C82A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8915" y="3521279"/>
            <a:ext cx="2387866" cy="23774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452427E-6088-482C-A7C9-64456829F2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54646" y="3521277"/>
            <a:ext cx="2387866" cy="237744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E9E9F8F-1E39-42BD-A5D4-D336C43AE96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04649" y="798986"/>
            <a:ext cx="4637863" cy="2621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116969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5BEE2-0624-4B83-8CC2-4B61D60F0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Complex Lipid Metabolism - Lung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2E44104-B6C5-4AC1-B89A-754E859606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7534" y="1000100"/>
            <a:ext cx="3672205" cy="515315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1228917-783C-453D-9E79-1E604D0D4A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0677" y="3752789"/>
            <a:ext cx="2153482" cy="214408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5B1B6BD-10F3-4F30-BE2D-DB8D3EA1F9B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74159" y="3752789"/>
            <a:ext cx="2153483" cy="214408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F9FE6DF-988F-44B6-A2B0-78D48F42945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04906" y="1042043"/>
            <a:ext cx="4298768" cy="24289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676361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3255C-CC6D-4223-8C92-727EDC4C5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Bile Acid Metabolism - Liver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1D4535B-D62D-4C0B-AE6E-155924EDC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28</a:t>
            </a:fld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17E7CAC-01F2-49CE-9BC0-7B1D1664A8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1542" y="648515"/>
            <a:ext cx="3422810" cy="357398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2E1E60D-A8E3-41D0-92E1-7CE696551F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4352" y="648515"/>
            <a:ext cx="3662755" cy="357398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DFD3870-DF34-4C24-A6BA-D648DFA7F8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5086" y="4240569"/>
            <a:ext cx="2296025" cy="228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24CC689-4508-4DC8-B6D7-E4E43895D5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2292" y="4240569"/>
            <a:ext cx="2296025" cy="2286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F209D2B-C2AF-4753-82BB-639138FA5A2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79498" y="4240569"/>
            <a:ext cx="2296025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7071991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3255C-CC6D-4223-8C92-727EDC4C5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Bile Acid Metabolism - Lung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1D4535B-D62D-4C0B-AE6E-155924EDC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29</a:t>
            </a:fld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EEDBDAE-1B70-4561-93F4-3CFC510515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1904" y="648515"/>
            <a:ext cx="2974000" cy="358791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ABCF6E4-53B5-4348-B5B0-D837BF78A0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65904" y="648514"/>
            <a:ext cx="3677036" cy="358791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CE5C1C2-2673-4B50-90A6-7A69A18F73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4847" y="4241754"/>
            <a:ext cx="2204184" cy="21945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D95410D-A88E-457C-8C9C-A98CC05F25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3112" y="4241754"/>
            <a:ext cx="2204184" cy="21945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6D66ACB-D272-4D36-88BB-A5F453ED204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31377" y="4241754"/>
            <a:ext cx="2204184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30021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3</a:t>
            </a:fld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9EC9CC5D-6825-49D0-A164-2A7DCD4D9D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Metabolon Platform Technology</a:t>
            </a:r>
          </a:p>
        </p:txBody>
      </p:sp>
      <p:sp>
        <p:nvSpPr>
          <p:cNvPr id="7" name="Rectangle 3">
            <a:extLst>
              <a:ext uri="{FF2B5EF4-FFF2-40B4-BE49-F238E27FC236}">
                <a16:creationId xmlns:a16="http://schemas.microsoft.com/office/drawing/2014/main" id="{2C7EE2DB-9B14-4CE4-AE2C-833E4E5148A0}"/>
              </a:ext>
            </a:extLst>
          </p:cNvPr>
          <p:cNvSpPr txBox="1">
            <a:spLocks noChangeArrowheads="1"/>
          </p:cNvSpPr>
          <p:nvPr/>
        </p:nvSpPr>
        <p:spPr>
          <a:xfrm>
            <a:off x="-214346" y="857232"/>
            <a:ext cx="7868603" cy="4297680"/>
          </a:xfrm>
          <a:prstGeom prst="rect">
            <a:avLst/>
          </a:prstGeom>
        </p:spPr>
        <p:txBody>
          <a:bodyPr/>
          <a:lstStyle/>
          <a:p>
            <a:pPr marL="231775" indent="-231775">
              <a:spcBef>
                <a:spcPct val="30000"/>
              </a:spcBef>
              <a:buClr>
                <a:srgbClr val="F79646"/>
              </a:buClr>
              <a:buFont typeface="Wingdings" pitchFamily="2" charset="2"/>
              <a:buChar char="§"/>
              <a:defRPr/>
            </a:pPr>
            <a:endParaRPr lang="en-US" sz="2400" kern="0" baseline="0" dirty="0">
              <a:solidFill>
                <a:srgbClr val="3C4096"/>
              </a:solidFill>
              <a:latin typeface="Corbel" pitchFamily="34" charset="0"/>
            </a:endParaRPr>
          </a:p>
        </p:txBody>
      </p:sp>
      <p:pic>
        <p:nvPicPr>
          <p:cNvPr id="8" name="Picture 7" descr="http://www.limsource.com/images/Informatics-Thermo.jpg">
            <a:extLst>
              <a:ext uri="{FF2B5EF4-FFF2-40B4-BE49-F238E27FC236}">
                <a16:creationId xmlns:a16="http://schemas.microsoft.com/office/drawing/2014/main" id="{17888F2F-ED1E-4319-9565-49DD3318CA4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lum bright="70000" contrast="-70000"/>
          </a:blip>
          <a:srcRect/>
          <a:stretch>
            <a:fillRect/>
          </a:stretch>
        </p:blipFill>
        <p:spPr bwMode="auto">
          <a:xfrm>
            <a:off x="6686892" y="1851374"/>
            <a:ext cx="2286000" cy="222021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10" name="Rectangle 2">
            <a:extLst>
              <a:ext uri="{FF2B5EF4-FFF2-40B4-BE49-F238E27FC236}">
                <a16:creationId xmlns:a16="http://schemas.microsoft.com/office/drawing/2014/main" id="{BF530CA6-BD4D-4F02-BB52-2F17B3EEEC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0242" y="2111723"/>
            <a:ext cx="7462838" cy="40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>
              <a:lnSpc>
                <a:spcPct val="90000"/>
              </a:lnSpc>
              <a:defRPr/>
            </a:pPr>
            <a:r>
              <a:rPr lang="en-US" sz="3200" b="1" kern="0" baseline="0" dirty="0">
                <a:solidFill>
                  <a:srgbClr val="1B5691"/>
                </a:solidFill>
                <a:effectLst>
                  <a:outerShdw blurRad="38100" dist="38100" dir="2700000" algn="tl">
                    <a:srgbClr val="C0C0C0"/>
                  </a:outerShdw>
                </a:effectLst>
                <a:latin typeface="Tahoma"/>
                <a:cs typeface="Arial" charset="0"/>
              </a:rPr>
              <a:t>                     </a:t>
            </a:r>
          </a:p>
        </p:txBody>
      </p:sp>
      <p:sp>
        <p:nvSpPr>
          <p:cNvPr id="11" name="AutoShape 22">
            <a:extLst>
              <a:ext uri="{FF2B5EF4-FFF2-40B4-BE49-F238E27FC236}">
                <a16:creationId xmlns:a16="http://schemas.microsoft.com/office/drawing/2014/main" id="{16B09852-B5BF-474E-9BAD-8D90F3C187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0741" y="1756124"/>
            <a:ext cx="1828800" cy="685800"/>
          </a:xfrm>
          <a:prstGeom prst="roundRect">
            <a:avLst>
              <a:gd name="adj" fmla="val 16667"/>
            </a:avLst>
          </a:prstGeom>
          <a:noFill/>
          <a:ln w="9525">
            <a:noFill/>
            <a:round/>
            <a:headEnd/>
            <a:tailEnd/>
          </a:ln>
          <a:effectLst/>
        </p:spPr>
        <p:txBody>
          <a:bodyPr anchor="ctr"/>
          <a:lstStyle/>
          <a:p>
            <a:pPr algn="ctr" eaLnBrk="0" hangingPunct="0"/>
            <a:r>
              <a:rPr lang="en-US" sz="1600" b="1" baseline="0" dirty="0">
                <a:solidFill>
                  <a:srgbClr val="333399">
                    <a:lumMod val="75000"/>
                  </a:srgbClr>
                </a:solidFill>
                <a:latin typeface="Arial" charset="0"/>
                <a:cs typeface="Arial" charset="0"/>
              </a:rPr>
              <a:t>Metabolyzer™</a:t>
            </a:r>
          </a:p>
        </p:txBody>
      </p:sp>
      <p:grpSp>
        <p:nvGrpSpPr>
          <p:cNvPr id="12" name="Group 52">
            <a:extLst>
              <a:ext uri="{FF2B5EF4-FFF2-40B4-BE49-F238E27FC236}">
                <a16:creationId xmlns:a16="http://schemas.microsoft.com/office/drawing/2014/main" id="{30651E9C-E1FC-467B-B0D1-408B0B8F51FF}"/>
              </a:ext>
            </a:extLst>
          </p:cNvPr>
          <p:cNvGrpSpPr/>
          <p:nvPr/>
        </p:nvGrpSpPr>
        <p:grpSpPr>
          <a:xfrm>
            <a:off x="7017600" y="2384773"/>
            <a:ext cx="1619250" cy="1447800"/>
            <a:chOff x="7010399" y="742951"/>
            <a:chExt cx="1619250" cy="1447800"/>
          </a:xfrm>
        </p:grpSpPr>
        <p:sp>
          <p:nvSpPr>
            <p:cNvPr id="13" name="AutoShape 22">
              <a:extLst>
                <a:ext uri="{FF2B5EF4-FFF2-40B4-BE49-F238E27FC236}">
                  <a16:creationId xmlns:a16="http://schemas.microsoft.com/office/drawing/2014/main" id="{6C3A8E11-7177-4C22-8D72-AB97DD90CD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0399" y="742951"/>
              <a:ext cx="1619250" cy="228600"/>
            </a:xfrm>
            <a:prstGeom prst="roundRect">
              <a:avLst>
                <a:gd name="adj" fmla="val 16667"/>
              </a:avLst>
            </a:prstGeom>
            <a:noFill/>
            <a:ln w="9525">
              <a:noFill/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1400" b="1" baseline="0" dirty="0">
                  <a:solidFill>
                    <a:srgbClr val="000000"/>
                  </a:solidFill>
                  <a:latin typeface="Tahoma" pitchFamily="34" charset="0"/>
                  <a:cs typeface="Arial" charset="0"/>
                </a:rPr>
                <a:t>Eliminate Noise</a:t>
              </a:r>
            </a:p>
          </p:txBody>
        </p:sp>
        <p:sp>
          <p:nvSpPr>
            <p:cNvPr id="14" name="AutoShape 23">
              <a:extLst>
                <a:ext uri="{FF2B5EF4-FFF2-40B4-BE49-F238E27FC236}">
                  <a16:creationId xmlns:a16="http://schemas.microsoft.com/office/drawing/2014/main" id="{15C81B87-CDBE-4F9F-BC9E-31AB90F950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0399" y="1047751"/>
              <a:ext cx="1619250" cy="228600"/>
            </a:xfrm>
            <a:prstGeom prst="roundRect">
              <a:avLst>
                <a:gd name="adj" fmla="val 16667"/>
              </a:avLst>
            </a:prstGeom>
            <a:noFill/>
            <a:ln w="9525">
              <a:noFill/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1400" b="1" baseline="0" dirty="0">
                  <a:solidFill>
                    <a:srgbClr val="000000"/>
                  </a:solidFill>
                  <a:latin typeface="Tahoma" pitchFamily="34" charset="0"/>
                  <a:cs typeface="Arial" charset="0"/>
                </a:rPr>
                <a:t>Data Reduction</a:t>
              </a:r>
            </a:p>
          </p:txBody>
        </p:sp>
        <p:sp>
          <p:nvSpPr>
            <p:cNvPr id="15" name="AutoShape 24">
              <a:extLst>
                <a:ext uri="{FF2B5EF4-FFF2-40B4-BE49-F238E27FC236}">
                  <a16:creationId xmlns:a16="http://schemas.microsoft.com/office/drawing/2014/main" id="{3BC6699E-A5E2-46AF-B5B3-1EF338C91B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0399" y="1352551"/>
              <a:ext cx="1619250" cy="533400"/>
            </a:xfrm>
            <a:prstGeom prst="roundRect">
              <a:avLst>
                <a:gd name="adj" fmla="val 16667"/>
              </a:avLst>
            </a:prstGeom>
            <a:solidFill>
              <a:srgbClr val="D2DDF1"/>
            </a:solidFill>
            <a:ln>
              <a:solidFill>
                <a:schemeClr val="accent1"/>
              </a:solidFill>
              <a:headEnd/>
              <a:tailEnd/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wrap="none" anchor="ctr"/>
            <a:lstStyle/>
            <a:p>
              <a:pPr algn="ctr">
                <a:defRPr/>
              </a:pPr>
              <a:r>
                <a:rPr lang="en-US" sz="1400" u="sng" baseline="0" dirty="0">
                  <a:solidFill>
                    <a:schemeClr val="tx1">
                      <a:lumMod val="75000"/>
                    </a:schemeClr>
                  </a:solidFill>
                </a:rPr>
                <a:t>Library Search</a:t>
              </a:r>
            </a:p>
            <a:p>
              <a:pPr algn="ctr">
                <a:defRPr/>
              </a:pPr>
              <a:r>
                <a:rPr lang="en-US" sz="1200" baseline="0" dirty="0">
                  <a:solidFill>
                    <a:schemeClr val="tx1">
                      <a:lumMod val="75000"/>
                    </a:schemeClr>
                  </a:solidFill>
                </a:rPr>
                <a:t>RT, Mass, MS/MS</a:t>
              </a:r>
            </a:p>
          </p:txBody>
        </p:sp>
        <p:sp>
          <p:nvSpPr>
            <p:cNvPr id="16" name="AutoShape 25">
              <a:extLst>
                <a:ext uri="{FF2B5EF4-FFF2-40B4-BE49-F238E27FC236}">
                  <a16:creationId xmlns:a16="http://schemas.microsoft.com/office/drawing/2014/main" id="{2125DDD6-3779-4C1B-994C-A4E4C965F1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0399" y="1962151"/>
              <a:ext cx="1619250" cy="228600"/>
            </a:xfrm>
            <a:prstGeom prst="roundRect">
              <a:avLst>
                <a:gd name="adj" fmla="val 16667"/>
              </a:avLst>
            </a:prstGeom>
            <a:noFill/>
            <a:ln w="9525">
              <a:noFill/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1400" baseline="0" dirty="0">
                  <a:solidFill>
                    <a:srgbClr val="000000"/>
                  </a:solidFill>
                  <a:latin typeface="Tahoma" pitchFamily="34" charset="0"/>
                  <a:cs typeface="Arial" charset="0"/>
                </a:rPr>
                <a:t>QA/QC</a:t>
              </a:r>
            </a:p>
          </p:txBody>
        </p:sp>
      </p:grpSp>
      <p:pic>
        <p:nvPicPr>
          <p:cNvPr id="17" name="Picture 16" descr="P:\marketing\Photos\Equipment_11.07\_MG_0458.jpg">
            <a:extLst>
              <a:ext uri="{FF2B5EF4-FFF2-40B4-BE49-F238E27FC236}">
                <a16:creationId xmlns:a16="http://schemas.microsoft.com/office/drawing/2014/main" id="{92F0F5A3-3188-4A19-B690-8F6CB7DA6B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lum bright="70000" contrast="-70000"/>
          </a:blip>
          <a:srcRect/>
          <a:stretch>
            <a:fillRect/>
          </a:stretch>
        </p:blipFill>
        <p:spPr bwMode="auto">
          <a:xfrm>
            <a:off x="2019641" y="1756123"/>
            <a:ext cx="4457964" cy="241300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18" name="Picture 2" descr="http://www.dartmouth.edu/~chemlab/techniques/graphics/vol_flask/vol_flask3.gif">
            <a:extLst>
              <a:ext uri="{FF2B5EF4-FFF2-40B4-BE49-F238E27FC236}">
                <a16:creationId xmlns:a16="http://schemas.microsoft.com/office/drawing/2014/main" id="{EF3D5E68-18D2-4FFE-BAA2-DA4881009B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lum bright="70000" contrast="-70000"/>
          </a:blip>
          <a:srcRect/>
          <a:stretch>
            <a:fillRect/>
          </a:stretch>
        </p:blipFill>
        <p:spPr bwMode="auto">
          <a:xfrm>
            <a:off x="124167" y="1803747"/>
            <a:ext cx="1809750" cy="2316123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19" name="Rectangle 2">
            <a:extLst>
              <a:ext uri="{FF2B5EF4-FFF2-40B4-BE49-F238E27FC236}">
                <a16:creationId xmlns:a16="http://schemas.microsoft.com/office/drawing/2014/main" id="{1FED2D90-3B62-430B-A638-A79F88AB74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792" y="2292697"/>
            <a:ext cx="7462838" cy="40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>
              <a:lnSpc>
                <a:spcPct val="90000"/>
              </a:lnSpc>
              <a:defRPr/>
            </a:pPr>
            <a:r>
              <a:rPr lang="en-US" sz="3200" b="1" kern="0" baseline="0" dirty="0">
                <a:solidFill>
                  <a:srgbClr val="1B5691"/>
                </a:solidFill>
                <a:effectLst>
                  <a:outerShdw blurRad="38100" dist="38100" dir="2700000" algn="tl">
                    <a:srgbClr val="C0C0C0"/>
                  </a:outerShdw>
                </a:effectLst>
                <a:latin typeface="Tahoma"/>
                <a:cs typeface="+mn-cs"/>
              </a:rPr>
              <a:t>                     </a:t>
            </a:r>
          </a:p>
        </p:txBody>
      </p:sp>
      <p:sp>
        <p:nvSpPr>
          <p:cNvPr id="20" name="Text Box 15">
            <a:extLst>
              <a:ext uri="{FF2B5EF4-FFF2-40B4-BE49-F238E27FC236}">
                <a16:creationId xmlns:a16="http://schemas.microsoft.com/office/drawing/2014/main" id="{23981517-0B4E-46D0-BE43-B2B91DFE32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681" y="2749103"/>
            <a:ext cx="1428596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eaLnBrk="0" hangingPunct="0"/>
            <a:r>
              <a:rPr lang="en-US" baseline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chemical</a:t>
            </a:r>
          </a:p>
          <a:p>
            <a:pPr algn="ctr" eaLnBrk="0" hangingPunct="0"/>
            <a:r>
              <a:rPr lang="en-US" baseline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raction</a:t>
            </a:r>
          </a:p>
        </p:txBody>
      </p:sp>
      <p:cxnSp>
        <p:nvCxnSpPr>
          <p:cNvPr id="21" name="AutoShape 20">
            <a:extLst>
              <a:ext uri="{FF2B5EF4-FFF2-40B4-BE49-F238E27FC236}">
                <a16:creationId xmlns:a16="http://schemas.microsoft.com/office/drawing/2014/main" id="{B4F1157C-9FA7-40DE-8EFF-E978428849D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698721" y="3014693"/>
            <a:ext cx="453721" cy="4763"/>
          </a:xfrm>
          <a:prstGeom prst="straightConnector1">
            <a:avLst/>
          </a:prstGeom>
          <a:noFill/>
          <a:ln w="76200">
            <a:solidFill>
              <a:srgbClr val="1B5691"/>
            </a:solidFill>
            <a:round/>
            <a:headEnd/>
            <a:tailEnd type="triangle" w="med" len="med"/>
          </a:ln>
          <a:effectLst/>
        </p:spPr>
      </p:cxnSp>
      <p:cxnSp>
        <p:nvCxnSpPr>
          <p:cNvPr id="22" name="AutoShape 23">
            <a:extLst>
              <a:ext uri="{FF2B5EF4-FFF2-40B4-BE49-F238E27FC236}">
                <a16:creationId xmlns:a16="http://schemas.microsoft.com/office/drawing/2014/main" id="{89227D92-F0E0-4D53-937D-06116897D219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758212" y="3553924"/>
            <a:ext cx="1062311" cy="269874"/>
          </a:xfrm>
          <a:prstGeom prst="bentConnector3">
            <a:avLst>
              <a:gd name="adj1" fmla="val 50000"/>
            </a:avLst>
          </a:prstGeom>
          <a:noFill/>
          <a:ln w="76200">
            <a:solidFill>
              <a:srgbClr val="1B5691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23" name="AutoShape 26">
            <a:extLst>
              <a:ext uri="{FF2B5EF4-FFF2-40B4-BE49-F238E27FC236}">
                <a16:creationId xmlns:a16="http://schemas.microsoft.com/office/drawing/2014/main" id="{16DC9FB4-28EC-416B-94AC-B6A237EBF36D}"/>
              </a:ext>
            </a:extLst>
          </p:cNvPr>
          <p:cNvCxnSpPr>
            <a:cxnSpLocks noChangeShapeType="1"/>
            <a:endCxn id="36" idx="1"/>
          </p:cNvCxnSpPr>
          <p:nvPr/>
        </p:nvCxnSpPr>
        <p:spPr bwMode="auto">
          <a:xfrm flipV="1">
            <a:off x="1943442" y="2163524"/>
            <a:ext cx="1211583" cy="853074"/>
          </a:xfrm>
          <a:prstGeom prst="bentConnector3">
            <a:avLst>
              <a:gd name="adj1" fmla="val 50000"/>
            </a:avLst>
          </a:prstGeom>
          <a:noFill/>
          <a:ln w="76200">
            <a:solidFill>
              <a:srgbClr val="1B5691"/>
            </a:solidFill>
            <a:round/>
            <a:headEnd/>
            <a:tailEnd type="triangle" w="med" len="med"/>
          </a:ln>
          <a:effectLst/>
        </p:spPr>
      </p:cxnSp>
      <p:cxnSp>
        <p:nvCxnSpPr>
          <p:cNvPr id="24" name="AutoShape 27">
            <a:extLst>
              <a:ext uri="{FF2B5EF4-FFF2-40B4-BE49-F238E27FC236}">
                <a16:creationId xmlns:a16="http://schemas.microsoft.com/office/drawing/2014/main" id="{F5F2370D-994C-47AA-A457-B14193E2769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943442" y="3013423"/>
            <a:ext cx="1211582" cy="797927"/>
          </a:xfrm>
          <a:prstGeom prst="bentConnector3">
            <a:avLst>
              <a:gd name="adj1" fmla="val 50000"/>
            </a:avLst>
          </a:prstGeom>
          <a:noFill/>
          <a:ln w="76200">
            <a:solidFill>
              <a:srgbClr val="1B5691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25" name="Text Box 29">
            <a:extLst>
              <a:ext uri="{FF2B5EF4-FFF2-40B4-BE49-F238E27FC236}">
                <a16:creationId xmlns:a16="http://schemas.microsoft.com/office/drawing/2014/main" id="{81F049F5-B27F-403E-8142-49333C97FC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55024" y="3689698"/>
            <a:ext cx="2664574" cy="338554"/>
          </a:xfrm>
          <a:prstGeom prst="rect">
            <a:avLst/>
          </a:prstGeom>
          <a:solidFill>
            <a:schemeClr val="bg2"/>
          </a:solidFill>
          <a:ln w="9525">
            <a:noFill/>
            <a:miter lim="800000"/>
            <a:headEnd/>
            <a:tailE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wrap="square">
            <a:spAutoFit/>
          </a:bodyPr>
          <a:lstStyle/>
          <a:p>
            <a:pPr algn="ctr" eaLnBrk="0" hangingPunct="0"/>
            <a:r>
              <a:rPr lang="en-US" sz="1600" baseline="0" dirty="0">
                <a:solidFill>
                  <a:prstClr val="black"/>
                </a:solidFill>
                <a:latin typeface="Tahoma" pitchFamily="34" charset="0"/>
                <a:cs typeface="Tahoma" pitchFamily="34" charset="0"/>
              </a:rPr>
              <a:t>UHPLC (HILIC)-MS/MS </a:t>
            </a:r>
          </a:p>
        </p:txBody>
      </p:sp>
      <p:cxnSp>
        <p:nvCxnSpPr>
          <p:cNvPr id="26" name="AutoShape 20">
            <a:extLst>
              <a:ext uri="{FF2B5EF4-FFF2-40B4-BE49-F238E27FC236}">
                <a16:creationId xmlns:a16="http://schemas.microsoft.com/office/drawing/2014/main" id="{6604EFE7-6E96-400E-A981-893F647CD98A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513417" y="2756231"/>
            <a:ext cx="640080" cy="4763"/>
          </a:xfrm>
          <a:prstGeom prst="straightConnector1">
            <a:avLst/>
          </a:prstGeom>
          <a:noFill/>
          <a:ln w="76200">
            <a:solidFill>
              <a:srgbClr val="1B5691"/>
            </a:solidFill>
            <a:round/>
            <a:headEnd/>
            <a:tailEnd type="triangle" w="med" len="med"/>
          </a:ln>
          <a:effectLst/>
        </p:spPr>
      </p:cxnSp>
      <p:cxnSp>
        <p:nvCxnSpPr>
          <p:cNvPr id="27" name="AutoShape 20">
            <a:extLst>
              <a:ext uri="{FF2B5EF4-FFF2-40B4-BE49-F238E27FC236}">
                <a16:creationId xmlns:a16="http://schemas.microsoft.com/office/drawing/2014/main" id="{3534E9ED-D5F7-4CE6-B117-F66BBA75F91B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732502" y="2751468"/>
            <a:ext cx="1097280" cy="4763"/>
          </a:xfrm>
          <a:prstGeom prst="straightConnector1">
            <a:avLst/>
          </a:prstGeom>
          <a:noFill/>
          <a:ln w="76200">
            <a:solidFill>
              <a:srgbClr val="1B5691"/>
            </a:solidFill>
            <a:round/>
            <a:headEnd/>
            <a:tailEnd type="triangle" w="med" len="med"/>
          </a:ln>
          <a:effectLst/>
        </p:spPr>
      </p:cxnSp>
      <p:grpSp>
        <p:nvGrpSpPr>
          <p:cNvPr id="28" name="Group 48">
            <a:extLst>
              <a:ext uri="{FF2B5EF4-FFF2-40B4-BE49-F238E27FC236}">
                <a16:creationId xmlns:a16="http://schemas.microsoft.com/office/drawing/2014/main" id="{70A05B67-A111-4A8F-B07F-F4ECCB659CFE}"/>
              </a:ext>
            </a:extLst>
          </p:cNvPr>
          <p:cNvGrpSpPr/>
          <p:nvPr/>
        </p:nvGrpSpPr>
        <p:grpSpPr>
          <a:xfrm>
            <a:off x="6922744" y="2160951"/>
            <a:ext cx="1779486" cy="1045187"/>
            <a:chOff x="6595752" y="2342969"/>
            <a:chExt cx="1779486" cy="1045187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659A94E-16C0-4479-B28A-28178EB4B4CA}"/>
                </a:ext>
              </a:extLst>
            </p:cNvPr>
            <p:cNvSpPr txBox="1"/>
            <p:nvPr/>
          </p:nvSpPr>
          <p:spPr>
            <a:xfrm>
              <a:off x="6657975" y="2819400"/>
              <a:ext cx="16914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baseline="0" dirty="0">
                  <a:solidFill>
                    <a:srgbClr val="000000"/>
                  </a:solidFill>
                  <a:latin typeface="Tahoma" pitchFamily="34" charset="0"/>
                  <a:cs typeface="+mn-cs"/>
                </a:rPr>
                <a:t>40,000 ion features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B2F3052-156E-4F02-B7DC-701F07D12B4C}"/>
                </a:ext>
              </a:extLst>
            </p:cNvPr>
            <p:cNvSpPr txBox="1"/>
            <p:nvPr/>
          </p:nvSpPr>
          <p:spPr>
            <a:xfrm>
              <a:off x="6595752" y="2536641"/>
              <a:ext cx="1691489" cy="851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800" b="1" baseline="0" dirty="0">
                <a:solidFill>
                  <a:srgbClr val="000000"/>
                </a:solidFill>
                <a:latin typeface="Tahoma" pitchFamily="34" charset="0"/>
                <a:cs typeface="+mn-cs"/>
              </a:endParaRPr>
            </a:p>
            <a:p>
              <a:r>
                <a:rPr lang="en-US" sz="1200" b="1" baseline="0" dirty="0">
                  <a:solidFill>
                    <a:srgbClr val="000000"/>
                  </a:solidFill>
                  <a:latin typeface="Tahoma" pitchFamily="34" charset="0"/>
                  <a:cs typeface="+mn-cs"/>
                </a:rPr>
                <a:t>40,000 ion features</a:t>
              </a:r>
            </a:p>
            <a:p>
              <a:endParaRPr lang="en-US" sz="800" b="1" dirty="0">
                <a:solidFill>
                  <a:srgbClr val="000000"/>
                </a:solidFill>
                <a:latin typeface="Tahoma" pitchFamily="34" charset="0"/>
              </a:endParaRPr>
            </a:p>
            <a:p>
              <a:r>
                <a:rPr lang="en-US" sz="1200" b="1" baseline="0" dirty="0">
                  <a:solidFill>
                    <a:srgbClr val="000000"/>
                  </a:solidFill>
                  <a:latin typeface="Tahoma" pitchFamily="34" charset="0"/>
                </a:rPr>
                <a:t>40,000 ion features</a:t>
              </a:r>
            </a:p>
            <a:p>
              <a:endParaRPr lang="en-US" sz="1200" b="1" baseline="0" dirty="0">
                <a:solidFill>
                  <a:srgbClr val="000000"/>
                </a:solidFill>
                <a:latin typeface="Tahoma" pitchFamily="34" charset="0"/>
                <a:cs typeface="+mn-cs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C96BB18-14A8-4090-B8BE-96D46CFAB5F9}"/>
                </a:ext>
              </a:extLst>
            </p:cNvPr>
            <p:cNvSpPr txBox="1"/>
            <p:nvPr/>
          </p:nvSpPr>
          <p:spPr>
            <a:xfrm>
              <a:off x="6683749" y="2342969"/>
              <a:ext cx="16914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baseline="0" dirty="0">
                  <a:solidFill>
                    <a:srgbClr val="000000"/>
                  </a:solidFill>
                  <a:latin typeface="Tahoma" pitchFamily="34" charset="0"/>
                  <a:cs typeface="+mn-cs"/>
                </a:rPr>
                <a:t>40,000 ion features</a:t>
              </a:r>
            </a:p>
          </p:txBody>
        </p:sp>
      </p:grpSp>
      <p:sp>
        <p:nvSpPr>
          <p:cNvPr id="32" name="Text Box 28">
            <a:extLst>
              <a:ext uri="{FF2B5EF4-FFF2-40B4-BE49-F238E27FC236}">
                <a16:creationId xmlns:a16="http://schemas.microsoft.com/office/drawing/2014/main" id="{0B2ADDC6-5500-4B6F-BA09-01E2F0BA91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40406" y="2567318"/>
            <a:ext cx="2679192" cy="338554"/>
          </a:xfrm>
          <a:prstGeom prst="rect">
            <a:avLst/>
          </a:prstGeom>
          <a:solidFill>
            <a:schemeClr val="bg2"/>
          </a:solidFill>
          <a:ln w="9525">
            <a:noFill/>
            <a:miter lim="800000"/>
            <a:headEnd/>
            <a:tailE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wrap="square">
            <a:spAutoFit/>
          </a:bodyPr>
          <a:lstStyle/>
          <a:p>
            <a:pPr eaLnBrk="0" hangingPunct="0"/>
            <a:r>
              <a:rPr lang="en-US" sz="1600" baseline="0" dirty="0">
                <a:solidFill>
                  <a:prstClr val="black"/>
                </a:solidFill>
                <a:latin typeface="Tahoma" pitchFamily="34" charset="0"/>
                <a:cs typeface="Tahoma" pitchFamily="34" charset="0"/>
              </a:rPr>
              <a:t>     UHPLC-MS/MS (+ESI) 2       </a:t>
            </a:r>
          </a:p>
        </p:txBody>
      </p:sp>
      <p:cxnSp>
        <p:nvCxnSpPr>
          <p:cNvPr id="33" name="AutoShape 20">
            <a:extLst>
              <a:ext uri="{FF2B5EF4-FFF2-40B4-BE49-F238E27FC236}">
                <a16:creationId xmlns:a16="http://schemas.microsoft.com/office/drawing/2014/main" id="{F1E771B8-624C-4BB4-B62A-004B3C70F7AD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566366" y="3289104"/>
            <a:ext cx="585216" cy="4763"/>
          </a:xfrm>
          <a:prstGeom prst="straightConnector1">
            <a:avLst/>
          </a:prstGeom>
          <a:noFill/>
          <a:ln w="76200">
            <a:solidFill>
              <a:srgbClr val="1B5691"/>
            </a:solidFill>
            <a:round/>
            <a:headEnd/>
            <a:tailEnd type="triangle" w="med" len="med"/>
          </a:ln>
          <a:effectLst/>
        </p:spPr>
      </p:cxnSp>
      <p:cxnSp>
        <p:nvCxnSpPr>
          <p:cNvPr id="34" name="AutoShape 20">
            <a:extLst>
              <a:ext uri="{FF2B5EF4-FFF2-40B4-BE49-F238E27FC236}">
                <a16:creationId xmlns:a16="http://schemas.microsoft.com/office/drawing/2014/main" id="{79E2D722-5B42-442E-B00F-A3BA8ED028B8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749745" y="3281698"/>
            <a:ext cx="1097280" cy="4763"/>
          </a:xfrm>
          <a:prstGeom prst="straightConnector1">
            <a:avLst/>
          </a:prstGeom>
          <a:noFill/>
          <a:ln w="76200">
            <a:solidFill>
              <a:srgbClr val="1B5691"/>
            </a:solidFill>
            <a:round/>
            <a:headEnd/>
            <a:tailEnd type="triangle" w="med" len="med"/>
          </a:ln>
          <a:effectLst/>
        </p:spPr>
      </p:cxnSp>
      <p:cxnSp>
        <p:nvCxnSpPr>
          <p:cNvPr id="35" name="AutoShape 23">
            <a:extLst>
              <a:ext uri="{FF2B5EF4-FFF2-40B4-BE49-F238E27FC236}">
                <a16:creationId xmlns:a16="http://schemas.microsoft.com/office/drawing/2014/main" id="{0A48BBBB-AC3E-4368-A1AB-8E3ED8F3B59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758212" y="2184727"/>
            <a:ext cx="1062311" cy="269874"/>
          </a:xfrm>
          <a:prstGeom prst="bentConnector3">
            <a:avLst>
              <a:gd name="adj1" fmla="val 50000"/>
            </a:avLst>
          </a:prstGeom>
          <a:noFill/>
          <a:ln w="76200">
            <a:solidFill>
              <a:srgbClr val="1B5691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36" name="Text Box 25">
            <a:extLst>
              <a:ext uri="{FF2B5EF4-FFF2-40B4-BE49-F238E27FC236}">
                <a16:creationId xmlns:a16="http://schemas.microsoft.com/office/drawing/2014/main" id="{792AA595-5667-47B8-BFD6-B3ACE72DB3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55025" y="1994247"/>
            <a:ext cx="2726965" cy="338554"/>
          </a:xfrm>
          <a:prstGeom prst="rect">
            <a:avLst/>
          </a:prstGeom>
          <a:solidFill>
            <a:schemeClr val="bg2"/>
          </a:solidFill>
          <a:ln w="9525">
            <a:noFill/>
            <a:miter lim="800000"/>
            <a:headEnd/>
            <a:tailE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wrap="none">
            <a:spAutoFit/>
          </a:bodyPr>
          <a:lstStyle/>
          <a:p>
            <a:pPr eaLnBrk="0" hangingPunct="0"/>
            <a:r>
              <a:rPr lang="en-US" sz="1600" baseline="0" dirty="0">
                <a:solidFill>
                  <a:prstClr val="black"/>
                </a:solidFill>
                <a:latin typeface="Tahoma" pitchFamily="34" charset="0"/>
                <a:cs typeface="Tahoma" pitchFamily="34" charset="0"/>
              </a:rPr>
              <a:t>     UHPLC-MS/MS (+ESI) 1 </a:t>
            </a:r>
          </a:p>
        </p:txBody>
      </p:sp>
      <p:sp>
        <p:nvSpPr>
          <p:cNvPr id="37" name="Text Box 28">
            <a:extLst>
              <a:ext uri="{FF2B5EF4-FFF2-40B4-BE49-F238E27FC236}">
                <a16:creationId xmlns:a16="http://schemas.microsoft.com/office/drawing/2014/main" id="{A5674729-7340-4C27-A252-0768991E38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46557" y="3132057"/>
            <a:ext cx="2673041" cy="338554"/>
          </a:xfrm>
          <a:prstGeom prst="rect">
            <a:avLst/>
          </a:prstGeom>
          <a:solidFill>
            <a:schemeClr val="bg2"/>
          </a:solidFill>
          <a:ln w="9525">
            <a:noFill/>
            <a:miter lim="800000"/>
            <a:headEnd/>
            <a:tailE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wrap="square">
            <a:spAutoFit/>
          </a:bodyPr>
          <a:lstStyle/>
          <a:p>
            <a:pPr eaLnBrk="0" hangingPunct="0"/>
            <a:r>
              <a:rPr lang="en-US" sz="1600" baseline="0" dirty="0">
                <a:solidFill>
                  <a:prstClr val="black"/>
                </a:solidFill>
                <a:latin typeface="Tahoma" pitchFamily="34" charset="0"/>
                <a:cs typeface="Tahoma" pitchFamily="34" charset="0"/>
              </a:rPr>
              <a:t>   UHPLC-MS/MS (-ESI)   </a:t>
            </a:r>
          </a:p>
        </p:txBody>
      </p:sp>
    </p:spTree>
  </p:cSld>
  <p:clrMapOvr>
    <a:masterClrMapping/>
  </p:clrMapOvr>
  <p:transition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7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3" presetClass="exit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blinds(horizontal)">
                                      <p:cBhvr>
                                        <p:cTn id="11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3" presetClass="entr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5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3255C-CC6D-4223-8C92-727EDC4C5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0066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Ceramide Metabolism - Liver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1D4535B-D62D-4C0B-AE6E-155924EDC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30</a:t>
            </a:fld>
            <a:endParaRPr lang="en-US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297195C9-A46C-4BFB-AF5E-246EB5450845}"/>
              </a:ext>
            </a:extLst>
          </p:cNvPr>
          <p:cNvGrpSpPr/>
          <p:nvPr/>
        </p:nvGrpSpPr>
        <p:grpSpPr>
          <a:xfrm>
            <a:off x="1478080" y="687588"/>
            <a:ext cx="6187841" cy="5884275"/>
            <a:chOff x="1237376" y="687588"/>
            <a:chExt cx="6187841" cy="588427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A59EA70-41C3-4AFF-8385-890CF83698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37376" y="687588"/>
              <a:ext cx="4168149" cy="3712237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705B6B6-777E-4271-8FD2-07529AAB2E5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37376" y="4399825"/>
              <a:ext cx="4168149" cy="2172038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6A25C89-2409-497F-B7BA-3E20826C35C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496556" y="687588"/>
              <a:ext cx="1928661" cy="192024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DB2E9E2-DF45-44C8-B47A-03F184ADA80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496556" y="4617516"/>
              <a:ext cx="1928661" cy="192024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A94F153-6A66-42F4-9132-E3EE56F2747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96556" y="2652552"/>
              <a:ext cx="1928661" cy="19202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6765609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3255C-CC6D-4223-8C92-727EDC4C5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93288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Ceramide Metabolism - Lung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1D4535B-D62D-4C0B-AE6E-155924EDC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31</a:t>
            </a:fld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518E94C-BF3A-4032-AEA6-D06BE5A045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8665" y="681318"/>
            <a:ext cx="4075182" cy="307926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78A98CF-A0A1-4621-A554-6F4D454620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45679" y="681318"/>
            <a:ext cx="1928661" cy="19202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BB2B35A-13D2-4363-AD9C-7AB011519A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45679" y="4609266"/>
            <a:ext cx="1928661" cy="192024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2E94EB7-6074-4CC1-9A79-01B8DDE190B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45679" y="2645292"/>
            <a:ext cx="1928661" cy="19202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F932BF4-DFB3-4D66-8A0E-2ACF792227F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28666" y="4079367"/>
            <a:ext cx="4075182" cy="2121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0076152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3255C-CC6D-4223-8C92-727EDC4C5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01677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Plasmalogen Metabolism - Liver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1D4535B-D62D-4C0B-AE6E-155924EDC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32</a:t>
            </a:fld>
            <a:endParaRPr lang="en-US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9D7058B7-BC71-4F13-80F9-6162BFB6468A}"/>
              </a:ext>
            </a:extLst>
          </p:cNvPr>
          <p:cNvGrpSpPr/>
          <p:nvPr/>
        </p:nvGrpSpPr>
        <p:grpSpPr>
          <a:xfrm>
            <a:off x="1067183" y="743091"/>
            <a:ext cx="7009634" cy="5265637"/>
            <a:chOff x="1029049" y="692757"/>
            <a:chExt cx="7009634" cy="526563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4372A20-8130-4AE2-8232-149690E2826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29049" y="692758"/>
              <a:ext cx="4281182" cy="242397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E8EEEB3-B8E7-40CD-B0F4-BCC822F028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67136" y="692757"/>
              <a:ext cx="2479707" cy="246888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3D0D6A9-9A8B-4076-92B9-B66A91590BE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06458" y="3282133"/>
              <a:ext cx="2571548" cy="256032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B8FF7C1-2273-4961-B2AE-F70F3DCE533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467135" y="3282133"/>
              <a:ext cx="2571548" cy="256032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0F8BBC1-E303-429F-81AC-43410551DCD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97157" y="3161637"/>
              <a:ext cx="1428332" cy="279675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4858611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3255C-CC6D-4223-8C92-727EDC4C5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Plasmalogen Metabolism - Lung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1D4535B-D62D-4C0B-AE6E-155924EDC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33</a:t>
            </a:fld>
            <a:endParaRPr lang="en-US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9D21D2BB-DFB4-4283-B076-774142A99D78}"/>
              </a:ext>
            </a:extLst>
          </p:cNvPr>
          <p:cNvGrpSpPr/>
          <p:nvPr/>
        </p:nvGrpSpPr>
        <p:grpSpPr>
          <a:xfrm>
            <a:off x="1030205" y="820900"/>
            <a:ext cx="7083591" cy="5535450"/>
            <a:chOff x="1111542" y="820900"/>
            <a:chExt cx="7083591" cy="553545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3A3F218-6FFF-4692-9F2D-D81E218F16E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11542" y="820900"/>
              <a:ext cx="4237425" cy="2697934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82F74E0-9B1F-44EF-8AE9-7FD38E1B906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31744" y="820900"/>
              <a:ext cx="2663389" cy="265176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39FA068-AFFA-4418-A117-56EF7299F20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31744" y="3704590"/>
              <a:ext cx="2663389" cy="265176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BD214CA-5A71-4681-8AC6-3E3BF9FB1EC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685578" y="3704590"/>
              <a:ext cx="2663389" cy="265176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1592360-F107-44AD-98DF-A130B55F7DA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67602" y="3518834"/>
              <a:ext cx="1426588" cy="279830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51493373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CF87A-CC0D-4321-B8BA-EAFD4AEE66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08231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Indicators of Redox Homeostasis - Liver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7ED7A62-D4CD-4FA8-B959-CCC64D651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34</a:t>
            </a:fld>
            <a:endParaRPr lang="en-US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48D1B2E3-1FED-4C54-B580-49F098FB31A6}"/>
              </a:ext>
            </a:extLst>
          </p:cNvPr>
          <p:cNvGrpSpPr/>
          <p:nvPr/>
        </p:nvGrpSpPr>
        <p:grpSpPr>
          <a:xfrm>
            <a:off x="1491161" y="597428"/>
            <a:ext cx="6161679" cy="6188892"/>
            <a:chOff x="1521779" y="597428"/>
            <a:chExt cx="6161679" cy="618889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EE42171-02EE-42F7-BC5D-0A85F71B9E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76306" y="597428"/>
              <a:ext cx="2807152" cy="4310132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DF2E6EF-69C6-449D-852F-C19B1251999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21779" y="597428"/>
              <a:ext cx="3354527" cy="4310132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96ED2B9-D0BF-4EB1-9CA1-E9DFEA3CE1F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47614" y="4911800"/>
              <a:ext cx="1882734" cy="187452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3EBBEAA-4002-4620-BAAA-CCEFEECABC9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02603" y="4911800"/>
              <a:ext cx="1882735" cy="187452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1B553FC-6DEF-4F31-8BB3-35372056373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757593" y="4911800"/>
              <a:ext cx="1882735" cy="187452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49287905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CF87A-CC0D-4321-B8BA-EAFD4AEE66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Indicators of Redox Homeostasis - Lung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7ED7A62-D4CD-4FA8-B959-CCC64D651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35</a:t>
            </a:fld>
            <a:endParaRPr lang="en-US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54AB56E-54A0-46E6-8472-4D749539E5B2}"/>
              </a:ext>
            </a:extLst>
          </p:cNvPr>
          <p:cNvGrpSpPr/>
          <p:nvPr/>
        </p:nvGrpSpPr>
        <p:grpSpPr>
          <a:xfrm>
            <a:off x="1484293" y="664540"/>
            <a:ext cx="6175414" cy="5692637"/>
            <a:chOff x="1422179" y="664540"/>
            <a:chExt cx="6175414" cy="5692637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DF493688-DB85-4511-B8D7-43C298F47A8E}"/>
                </a:ext>
              </a:extLst>
            </p:cNvPr>
            <p:cNvGrpSpPr/>
            <p:nvPr/>
          </p:nvGrpSpPr>
          <p:grpSpPr>
            <a:xfrm>
              <a:off x="1690637" y="664540"/>
              <a:ext cx="5762727" cy="3664179"/>
              <a:chOff x="1108018" y="681318"/>
              <a:chExt cx="6357837" cy="4335299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4EE42171-02EE-42F7-BC5D-0A85F71B9E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642312" y="681318"/>
                <a:ext cx="2823543" cy="4335299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B82FA465-226B-41D9-BB6F-AD79734123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08018" y="681318"/>
                <a:ext cx="3492557" cy="4335299"/>
              </a:xfrm>
              <a:prstGeom prst="rect">
                <a:avLst/>
              </a:prstGeom>
            </p:spPr>
          </p:pic>
        </p:grp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40E8279-C425-49C5-BAAC-4F9CB2E951C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22179" y="4345497"/>
              <a:ext cx="2020502" cy="201168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46072D8-2611-4155-BA13-6867A6B68A2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99635" y="4345497"/>
              <a:ext cx="2020502" cy="201168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DF540FD-6203-41B2-BC07-072EDDFAB60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577091" y="4345497"/>
              <a:ext cx="2020502" cy="201168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0004727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5BEE2-0624-4B83-8CC2-4B61D60F0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0066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Readouts of Inflammation - Liver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7D3BEF8-3317-475E-908A-570FAABE72F3}"/>
              </a:ext>
            </a:extLst>
          </p:cNvPr>
          <p:cNvGrpSpPr/>
          <p:nvPr/>
        </p:nvGrpSpPr>
        <p:grpSpPr>
          <a:xfrm>
            <a:off x="529992" y="597428"/>
            <a:ext cx="8084017" cy="6170810"/>
            <a:chOff x="585562" y="597428"/>
            <a:chExt cx="8084017" cy="6170810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832888D4-CBB9-42C5-985F-BE6795132485}"/>
                </a:ext>
              </a:extLst>
            </p:cNvPr>
            <p:cNvGrpSpPr/>
            <p:nvPr/>
          </p:nvGrpSpPr>
          <p:grpSpPr>
            <a:xfrm>
              <a:off x="795298" y="597428"/>
              <a:ext cx="7553405" cy="4159130"/>
              <a:chOff x="1264305" y="597428"/>
              <a:chExt cx="7422495" cy="4070613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7E720C01-1C96-44DD-A958-6B2C317D6C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64305" y="597428"/>
                <a:ext cx="2738311" cy="4070613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8A1BCEBE-844E-4BE9-BD9E-487392A66E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002616" y="1084790"/>
                <a:ext cx="4684184" cy="3085339"/>
              </a:xfrm>
              <a:prstGeom prst="rect">
                <a:avLst/>
              </a:prstGeom>
            </p:spPr>
          </p:pic>
        </p:grp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1FA112F-D9A9-4CCA-8B05-A53DBE5B7E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85562" y="4756558"/>
              <a:ext cx="2020502" cy="201168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D078473-2552-4796-9E81-274E32D1BCC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606734" y="4756558"/>
              <a:ext cx="2020502" cy="201168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1F95B30-52C8-4F2C-98E1-D4557E671A0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27906" y="4756558"/>
              <a:ext cx="2020502" cy="201168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FC95E38-AE39-43BA-9F46-00F47C16704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649077" y="4756558"/>
              <a:ext cx="2020502" cy="201168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562127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5BEE2-0624-4B83-8CC2-4B61D60F0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8455"/>
            <a:ext cx="8229600" cy="487362"/>
          </a:xfrm>
        </p:spPr>
        <p:txBody>
          <a:bodyPr>
            <a:noAutofit/>
          </a:bodyPr>
          <a:lstStyle/>
          <a:p>
            <a:r>
              <a:rPr lang="en-US" sz="2400" dirty="0"/>
              <a:t>Readouts of Inflammation - Lung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4CA14B3-2763-4342-88E4-58E084AD94BD}"/>
              </a:ext>
            </a:extLst>
          </p:cNvPr>
          <p:cNvGrpSpPr/>
          <p:nvPr/>
        </p:nvGrpSpPr>
        <p:grpSpPr>
          <a:xfrm>
            <a:off x="297939" y="632230"/>
            <a:ext cx="8548122" cy="6134953"/>
            <a:chOff x="352597" y="632230"/>
            <a:chExt cx="8548122" cy="613495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8F2D091-8EC7-4529-99BE-E59CD759615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3881" y="632230"/>
              <a:ext cx="3302120" cy="3982958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B43E10B-AEF3-4A4E-85EE-8859EA45351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56001" y="899502"/>
              <a:ext cx="5244718" cy="3454546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AC41A7F-C08B-4CEC-ABE7-1B4E5483A87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2597" y="4664063"/>
              <a:ext cx="2112343" cy="210312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83ADD84-DD2E-4B69-81F8-F817E80CCD4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89235" y="4664063"/>
              <a:ext cx="2112343" cy="210312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06314C3-F595-44F9-A6F9-EA2B7D71BA3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762512" y="4664063"/>
              <a:ext cx="2112343" cy="210312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3B53E569-B10E-4764-B5CD-5E925CA2C5B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625873" y="4664063"/>
              <a:ext cx="2112343" cy="210312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21768075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46D725-289F-46A1-825E-4B0481D0C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84899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Markers of Protein Homeostasis - Liver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7E9602F-3468-4122-AC0C-E164FC008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850371" y="6437408"/>
            <a:ext cx="2133600" cy="365125"/>
          </a:xfrm>
        </p:spPr>
        <p:txBody>
          <a:bodyPr/>
          <a:lstStyle/>
          <a:p>
            <a:fld id="{0D62520C-6070-49E2-B459-CDB0BDCBA57E}" type="slidenum">
              <a:rPr lang="en-US" smtClean="0"/>
              <a:pPr/>
              <a:t>38</a:t>
            </a:fld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CBACCF2-C90D-4289-846B-3DBFFB4BE9C3}"/>
              </a:ext>
            </a:extLst>
          </p:cNvPr>
          <p:cNvGrpSpPr/>
          <p:nvPr/>
        </p:nvGrpSpPr>
        <p:grpSpPr>
          <a:xfrm>
            <a:off x="728175" y="597429"/>
            <a:ext cx="7687650" cy="6021487"/>
            <a:chOff x="696285" y="572262"/>
            <a:chExt cx="7687650" cy="602148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15E9CD1-0955-46EA-9F72-EB3201C6496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81184" y="600676"/>
              <a:ext cx="2945055" cy="2176404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04905F7-BCFB-4409-AAEF-DA8E07A8476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96285" y="572262"/>
              <a:ext cx="3163155" cy="403116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FB9CE87-6A05-4B04-8478-4C8EE8743EE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97969" y="2774621"/>
              <a:ext cx="1836820" cy="18288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7C45832-A5E6-41E1-8A82-050BFBD64C1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900071" y="2774621"/>
              <a:ext cx="1836820" cy="18288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F2175AF-BDED-4089-B2CE-5AD033769EE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07019" y="4673509"/>
              <a:ext cx="1928661" cy="192024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EBA1590-9EBA-487A-99FA-7E0BD393EBA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623104" y="4673509"/>
              <a:ext cx="1928661" cy="192024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27354B0D-9426-4A0C-AA62-1DA647F4B6B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539189" y="4673509"/>
              <a:ext cx="1928661" cy="192024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9A7FF7CF-DF72-49B9-AA33-2FCB74ED7F7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455274" y="4673509"/>
              <a:ext cx="1928661" cy="19202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92852623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46D725-289F-46A1-825E-4B0481D0C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01677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Markers of Protein Homeostasis - Lung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7E9602F-3468-4122-AC0C-E164FC008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39</a:t>
            </a:fld>
            <a:endParaRPr lang="en-US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B065E9CE-3817-4C6D-A998-2669AB3494FA}"/>
              </a:ext>
            </a:extLst>
          </p:cNvPr>
          <p:cNvGrpSpPr/>
          <p:nvPr/>
        </p:nvGrpSpPr>
        <p:grpSpPr>
          <a:xfrm>
            <a:off x="895133" y="677116"/>
            <a:ext cx="7353735" cy="5899091"/>
            <a:chOff x="964800" y="677116"/>
            <a:chExt cx="7353735" cy="589909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4891646-B6F5-4075-8C12-6C80E7BF9A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50872" y="677116"/>
              <a:ext cx="2908278" cy="214922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2869437-044B-4072-B31D-0750BE6B4D7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90569" y="681318"/>
              <a:ext cx="3204594" cy="404931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7A25301-CB0B-4D4A-91AB-1AF0D45B363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267683" y="2830530"/>
              <a:ext cx="1836820" cy="18288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D32E472-1441-4CEE-8B83-48A6A2D3D14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63013" y="2830530"/>
              <a:ext cx="1836820" cy="18288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B80276F-660E-48E4-9D13-4A0B64DE705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64800" y="4747407"/>
              <a:ext cx="1836820" cy="18288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C7BAED9-84FC-460A-A59C-FAE663866E7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803772" y="4747407"/>
              <a:ext cx="1836820" cy="18288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5E43615-5FED-48D4-9DE0-991C737C631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642744" y="4747407"/>
              <a:ext cx="1836820" cy="18288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6C6D565-EBF2-4F7D-A7A5-B44E268CDAD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481715" y="4747407"/>
              <a:ext cx="1836820" cy="1828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158285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2254" name="Rectangle 302"/>
          <p:cNvSpPr>
            <a:spLocks noGrp="1" noChangeArrowheads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eaLnBrk="1" hangingPunct="1">
              <a:defRPr/>
            </a:pPr>
            <a:r>
              <a:rPr lang="en-US" sz="2800" b="0" dirty="0"/>
              <a:t>Automated Metabolite Identification</a:t>
            </a:r>
          </a:p>
        </p:txBody>
      </p:sp>
      <p:sp>
        <p:nvSpPr>
          <p:cNvPr id="265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4</a:t>
            </a:fld>
            <a:endParaRPr lang="en-US" kern="0" dirty="0"/>
          </a:p>
        </p:txBody>
      </p:sp>
      <p:sp>
        <p:nvSpPr>
          <p:cNvPr id="50178" name="Rectangle 2"/>
          <p:cNvSpPr>
            <a:spLocks noChangeArrowheads="1"/>
          </p:cNvSpPr>
          <p:nvPr/>
        </p:nvSpPr>
        <p:spPr bwMode="auto">
          <a:xfrm>
            <a:off x="6300788" y="6308726"/>
            <a:ext cx="2843212" cy="549275"/>
          </a:xfrm>
          <a:prstGeom prst="rect">
            <a:avLst/>
          </a:prstGeom>
          <a:solidFill>
            <a:srgbClr val="FFFFFF"/>
          </a:solidFill>
          <a:ln w="9525" algn="ctr">
            <a:noFill/>
            <a:miter lim="800000"/>
            <a:headEnd/>
            <a:tailEnd/>
          </a:ln>
        </p:spPr>
        <p:txBody>
          <a:bodyPr wrap="none" lIns="91435" tIns="45718" rIns="91435" bIns="45718" anchor="ctr"/>
          <a:lstStyle/>
          <a:p>
            <a:pPr marL="0" marR="0" lvl="0" indent="0" defTabSz="91440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pic>
        <p:nvPicPr>
          <p:cNvPr id="102195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294563" y="-12528550"/>
            <a:ext cx="1828800" cy="13620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0180" name="Rectangle 4"/>
          <p:cNvSpPr>
            <a:spLocks noChangeArrowheads="1"/>
          </p:cNvSpPr>
          <p:nvPr/>
        </p:nvSpPr>
        <p:spPr bwMode="auto">
          <a:xfrm>
            <a:off x="1346200" y="1239839"/>
            <a:ext cx="5761038" cy="1958975"/>
          </a:xfrm>
          <a:prstGeom prst="rect">
            <a:avLst/>
          </a:prstGeom>
          <a:solidFill>
            <a:srgbClr val="1B5691"/>
          </a:solidFill>
          <a:ln w="9525">
            <a:noFill/>
            <a:miter lim="800000"/>
            <a:headEnd/>
            <a:tailEnd/>
          </a:ln>
        </p:spPr>
        <p:txBody>
          <a:bodyPr wrap="none" lIns="91435" tIns="45718" rIns="91435" bIns="45718"/>
          <a:lstStyle/>
          <a:p>
            <a:pPr marL="0" marR="0" lvl="0" indent="0" algn="ctr" defTabSz="91440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0" cap="none" spc="0" normalizeH="0" baseline="0" noProof="0" dirty="0" err="1">
                <a:ln>
                  <a:noFill/>
                </a:ln>
                <a:solidFill>
                  <a:srgbClr val="FFFFCC"/>
                </a:solidFill>
                <a:effectLst/>
                <a:uLnTx/>
                <a:uFillTx/>
                <a:latin typeface="Arial" charset="0"/>
                <a:cs typeface="+mn-cs"/>
              </a:rPr>
              <a:t>Metabolyzer</a:t>
            </a:r>
            <a:r>
              <a: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rgbClr val="FFFFCC"/>
                </a:solidFill>
                <a:effectLst/>
                <a:uLnTx/>
                <a:uFillTx/>
                <a:latin typeface="Arial" charset="0"/>
                <a:cs typeface="+mn-cs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FFFFCC"/>
                </a:solidFill>
                <a:effectLst/>
                <a:uLnTx/>
                <a:uFillTx/>
                <a:latin typeface="Arial" charset="0"/>
                <a:cs typeface="+mn-cs"/>
              </a:rPr>
              <a:t> </a:t>
            </a:r>
            <a:r>
              <a: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rgbClr val="FFFFCC"/>
                </a:solidFill>
                <a:effectLst/>
                <a:uLnTx/>
                <a:uFillTx/>
                <a:latin typeface="Arial" charset="0"/>
                <a:cs typeface="+mn-cs"/>
              </a:rPr>
              <a:t>Software</a:t>
            </a: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srgbClr val="FFFFCC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181" name="Line 5"/>
          <p:cNvSpPr>
            <a:spLocks noChangeShapeType="1"/>
          </p:cNvSpPr>
          <p:nvPr/>
        </p:nvSpPr>
        <p:spPr bwMode="auto">
          <a:xfrm>
            <a:off x="1173164" y="6149975"/>
            <a:ext cx="6092825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0" name="Line 14"/>
          <p:cNvSpPr>
            <a:spLocks noChangeShapeType="1"/>
          </p:cNvSpPr>
          <p:nvPr/>
        </p:nvSpPr>
        <p:spPr bwMode="auto">
          <a:xfrm>
            <a:off x="241458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1" name="Line 15"/>
          <p:cNvSpPr>
            <a:spLocks noChangeShapeType="1"/>
          </p:cNvSpPr>
          <p:nvPr/>
        </p:nvSpPr>
        <p:spPr bwMode="auto">
          <a:xfrm>
            <a:off x="251618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2" name="Line 16"/>
          <p:cNvSpPr>
            <a:spLocks noChangeShapeType="1"/>
          </p:cNvSpPr>
          <p:nvPr/>
        </p:nvSpPr>
        <p:spPr bwMode="auto">
          <a:xfrm>
            <a:off x="261302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3" name="Line 17"/>
          <p:cNvSpPr>
            <a:spLocks noChangeShapeType="1"/>
          </p:cNvSpPr>
          <p:nvPr/>
        </p:nvSpPr>
        <p:spPr bwMode="auto">
          <a:xfrm>
            <a:off x="271462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4" name="Line 18"/>
          <p:cNvSpPr>
            <a:spLocks noChangeShapeType="1"/>
          </p:cNvSpPr>
          <p:nvPr/>
        </p:nvSpPr>
        <p:spPr bwMode="auto">
          <a:xfrm>
            <a:off x="2913064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5" name="Line 19"/>
          <p:cNvSpPr>
            <a:spLocks noChangeShapeType="1"/>
          </p:cNvSpPr>
          <p:nvPr/>
        </p:nvSpPr>
        <p:spPr bwMode="auto">
          <a:xfrm>
            <a:off x="3014664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6" name="Line 20"/>
          <p:cNvSpPr>
            <a:spLocks noChangeShapeType="1"/>
          </p:cNvSpPr>
          <p:nvPr/>
        </p:nvSpPr>
        <p:spPr bwMode="auto">
          <a:xfrm>
            <a:off x="3116264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7" name="Line 21"/>
          <p:cNvSpPr>
            <a:spLocks noChangeShapeType="1"/>
          </p:cNvSpPr>
          <p:nvPr/>
        </p:nvSpPr>
        <p:spPr bwMode="auto">
          <a:xfrm>
            <a:off x="3213100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8" name="Line 22"/>
          <p:cNvSpPr>
            <a:spLocks noChangeShapeType="1"/>
          </p:cNvSpPr>
          <p:nvPr/>
        </p:nvSpPr>
        <p:spPr bwMode="auto">
          <a:xfrm>
            <a:off x="3416300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199" name="Line 23"/>
          <p:cNvSpPr>
            <a:spLocks noChangeShapeType="1"/>
          </p:cNvSpPr>
          <p:nvPr/>
        </p:nvSpPr>
        <p:spPr bwMode="auto">
          <a:xfrm>
            <a:off x="3517900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0" name="Line 24"/>
          <p:cNvSpPr>
            <a:spLocks noChangeShapeType="1"/>
          </p:cNvSpPr>
          <p:nvPr/>
        </p:nvSpPr>
        <p:spPr bwMode="auto">
          <a:xfrm>
            <a:off x="361473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1" name="Line 25"/>
          <p:cNvSpPr>
            <a:spLocks noChangeShapeType="1"/>
          </p:cNvSpPr>
          <p:nvPr/>
        </p:nvSpPr>
        <p:spPr bwMode="auto">
          <a:xfrm>
            <a:off x="371633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2" name="Line 26"/>
          <p:cNvSpPr>
            <a:spLocks noChangeShapeType="1"/>
          </p:cNvSpPr>
          <p:nvPr/>
        </p:nvSpPr>
        <p:spPr bwMode="auto">
          <a:xfrm>
            <a:off x="391477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3" name="Line 27"/>
          <p:cNvSpPr>
            <a:spLocks noChangeShapeType="1"/>
          </p:cNvSpPr>
          <p:nvPr/>
        </p:nvSpPr>
        <p:spPr bwMode="auto">
          <a:xfrm>
            <a:off x="401637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4" name="Line 28"/>
          <p:cNvSpPr>
            <a:spLocks noChangeShapeType="1"/>
          </p:cNvSpPr>
          <p:nvPr/>
        </p:nvSpPr>
        <p:spPr bwMode="auto">
          <a:xfrm>
            <a:off x="411797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5" name="Line 29"/>
          <p:cNvSpPr>
            <a:spLocks noChangeShapeType="1"/>
          </p:cNvSpPr>
          <p:nvPr/>
        </p:nvSpPr>
        <p:spPr bwMode="auto">
          <a:xfrm>
            <a:off x="421322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6" name="Line 30"/>
          <p:cNvSpPr>
            <a:spLocks noChangeShapeType="1"/>
          </p:cNvSpPr>
          <p:nvPr/>
        </p:nvSpPr>
        <p:spPr bwMode="auto">
          <a:xfrm>
            <a:off x="4418014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7" name="Line 31"/>
          <p:cNvSpPr>
            <a:spLocks noChangeShapeType="1"/>
          </p:cNvSpPr>
          <p:nvPr/>
        </p:nvSpPr>
        <p:spPr bwMode="auto">
          <a:xfrm>
            <a:off x="4513264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8" name="Line 32"/>
          <p:cNvSpPr>
            <a:spLocks noChangeShapeType="1"/>
          </p:cNvSpPr>
          <p:nvPr/>
        </p:nvSpPr>
        <p:spPr bwMode="auto">
          <a:xfrm>
            <a:off x="4616450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09" name="Line 33"/>
          <p:cNvSpPr>
            <a:spLocks noChangeShapeType="1"/>
          </p:cNvSpPr>
          <p:nvPr/>
        </p:nvSpPr>
        <p:spPr bwMode="auto">
          <a:xfrm>
            <a:off x="4718050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0" name="Line 34"/>
          <p:cNvSpPr>
            <a:spLocks noChangeShapeType="1"/>
          </p:cNvSpPr>
          <p:nvPr/>
        </p:nvSpPr>
        <p:spPr bwMode="auto">
          <a:xfrm>
            <a:off x="4914900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1" name="Line 35"/>
          <p:cNvSpPr>
            <a:spLocks noChangeShapeType="1"/>
          </p:cNvSpPr>
          <p:nvPr/>
        </p:nvSpPr>
        <p:spPr bwMode="auto">
          <a:xfrm>
            <a:off x="501808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2" name="Line 36"/>
          <p:cNvSpPr>
            <a:spLocks noChangeShapeType="1"/>
          </p:cNvSpPr>
          <p:nvPr/>
        </p:nvSpPr>
        <p:spPr bwMode="auto">
          <a:xfrm>
            <a:off x="511333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3" name="Line 37"/>
          <p:cNvSpPr>
            <a:spLocks noChangeShapeType="1"/>
          </p:cNvSpPr>
          <p:nvPr/>
        </p:nvSpPr>
        <p:spPr bwMode="auto">
          <a:xfrm>
            <a:off x="521493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4" name="Line 38"/>
          <p:cNvSpPr>
            <a:spLocks noChangeShapeType="1"/>
          </p:cNvSpPr>
          <p:nvPr/>
        </p:nvSpPr>
        <p:spPr bwMode="auto">
          <a:xfrm>
            <a:off x="541337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5" name="Line 39"/>
          <p:cNvSpPr>
            <a:spLocks noChangeShapeType="1"/>
          </p:cNvSpPr>
          <p:nvPr/>
        </p:nvSpPr>
        <p:spPr bwMode="auto">
          <a:xfrm>
            <a:off x="551497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6" name="Line 40"/>
          <p:cNvSpPr>
            <a:spLocks noChangeShapeType="1"/>
          </p:cNvSpPr>
          <p:nvPr/>
        </p:nvSpPr>
        <p:spPr bwMode="auto">
          <a:xfrm>
            <a:off x="561657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7" name="Line 41"/>
          <p:cNvSpPr>
            <a:spLocks noChangeShapeType="1"/>
          </p:cNvSpPr>
          <p:nvPr/>
        </p:nvSpPr>
        <p:spPr bwMode="auto">
          <a:xfrm>
            <a:off x="5713414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8" name="Line 42"/>
          <p:cNvSpPr>
            <a:spLocks noChangeShapeType="1"/>
          </p:cNvSpPr>
          <p:nvPr/>
        </p:nvSpPr>
        <p:spPr bwMode="auto">
          <a:xfrm>
            <a:off x="5916614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19" name="Line 43"/>
          <p:cNvSpPr>
            <a:spLocks noChangeShapeType="1"/>
          </p:cNvSpPr>
          <p:nvPr/>
        </p:nvSpPr>
        <p:spPr bwMode="auto">
          <a:xfrm>
            <a:off x="6013450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0" name="Line 44"/>
          <p:cNvSpPr>
            <a:spLocks noChangeShapeType="1"/>
          </p:cNvSpPr>
          <p:nvPr/>
        </p:nvSpPr>
        <p:spPr bwMode="auto">
          <a:xfrm>
            <a:off x="6115050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1" name="Line 45"/>
          <p:cNvSpPr>
            <a:spLocks noChangeShapeType="1"/>
          </p:cNvSpPr>
          <p:nvPr/>
        </p:nvSpPr>
        <p:spPr bwMode="auto">
          <a:xfrm>
            <a:off x="6216650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2" name="Line 46"/>
          <p:cNvSpPr>
            <a:spLocks noChangeShapeType="1"/>
          </p:cNvSpPr>
          <p:nvPr/>
        </p:nvSpPr>
        <p:spPr bwMode="auto">
          <a:xfrm>
            <a:off x="641508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3" name="Line 47"/>
          <p:cNvSpPr>
            <a:spLocks noChangeShapeType="1"/>
          </p:cNvSpPr>
          <p:nvPr/>
        </p:nvSpPr>
        <p:spPr bwMode="auto">
          <a:xfrm>
            <a:off x="651668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4" name="Line 48"/>
          <p:cNvSpPr>
            <a:spLocks noChangeShapeType="1"/>
          </p:cNvSpPr>
          <p:nvPr/>
        </p:nvSpPr>
        <p:spPr bwMode="auto">
          <a:xfrm>
            <a:off x="6611939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5" name="Line 49"/>
          <p:cNvSpPr>
            <a:spLocks noChangeShapeType="1"/>
          </p:cNvSpPr>
          <p:nvPr/>
        </p:nvSpPr>
        <p:spPr bwMode="auto">
          <a:xfrm>
            <a:off x="671512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6" name="Line 50"/>
          <p:cNvSpPr>
            <a:spLocks noChangeShapeType="1"/>
          </p:cNvSpPr>
          <p:nvPr/>
        </p:nvSpPr>
        <p:spPr bwMode="auto">
          <a:xfrm>
            <a:off x="691197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7" name="Line 51"/>
          <p:cNvSpPr>
            <a:spLocks noChangeShapeType="1"/>
          </p:cNvSpPr>
          <p:nvPr/>
        </p:nvSpPr>
        <p:spPr bwMode="auto">
          <a:xfrm>
            <a:off x="7013575" y="6149976"/>
            <a:ext cx="1588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8" name="Line 52"/>
          <p:cNvSpPr>
            <a:spLocks noChangeShapeType="1"/>
          </p:cNvSpPr>
          <p:nvPr/>
        </p:nvSpPr>
        <p:spPr bwMode="auto">
          <a:xfrm>
            <a:off x="7116764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29" name="Line 53"/>
          <p:cNvSpPr>
            <a:spLocks noChangeShapeType="1"/>
          </p:cNvSpPr>
          <p:nvPr/>
        </p:nvSpPr>
        <p:spPr bwMode="auto">
          <a:xfrm>
            <a:off x="7212014" y="6149976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59" name="Line 83"/>
          <p:cNvSpPr>
            <a:spLocks noChangeShapeType="1"/>
          </p:cNvSpPr>
          <p:nvPr/>
        </p:nvSpPr>
        <p:spPr bwMode="auto">
          <a:xfrm>
            <a:off x="23431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0" name="Line 84"/>
          <p:cNvSpPr>
            <a:spLocks noChangeShapeType="1"/>
          </p:cNvSpPr>
          <p:nvPr/>
        </p:nvSpPr>
        <p:spPr bwMode="auto">
          <a:xfrm>
            <a:off x="23669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1" name="Line 85"/>
          <p:cNvSpPr>
            <a:spLocks noChangeShapeType="1"/>
          </p:cNvSpPr>
          <p:nvPr/>
        </p:nvSpPr>
        <p:spPr bwMode="auto">
          <a:xfrm>
            <a:off x="23907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2" name="Line 86"/>
          <p:cNvSpPr>
            <a:spLocks noChangeShapeType="1"/>
          </p:cNvSpPr>
          <p:nvPr/>
        </p:nvSpPr>
        <p:spPr bwMode="auto">
          <a:xfrm>
            <a:off x="24384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3" name="Line 87"/>
          <p:cNvSpPr>
            <a:spLocks noChangeShapeType="1"/>
          </p:cNvSpPr>
          <p:nvPr/>
        </p:nvSpPr>
        <p:spPr bwMode="auto">
          <a:xfrm>
            <a:off x="24622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4" name="Line 88"/>
          <p:cNvSpPr>
            <a:spLocks noChangeShapeType="1"/>
          </p:cNvSpPr>
          <p:nvPr/>
        </p:nvSpPr>
        <p:spPr bwMode="auto">
          <a:xfrm>
            <a:off x="24923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5" name="Line 89"/>
          <p:cNvSpPr>
            <a:spLocks noChangeShapeType="1"/>
          </p:cNvSpPr>
          <p:nvPr/>
        </p:nvSpPr>
        <p:spPr bwMode="auto">
          <a:xfrm>
            <a:off x="25415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6" name="Line 90"/>
          <p:cNvSpPr>
            <a:spLocks noChangeShapeType="1"/>
          </p:cNvSpPr>
          <p:nvPr/>
        </p:nvSpPr>
        <p:spPr bwMode="auto">
          <a:xfrm>
            <a:off x="25654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7" name="Line 91"/>
          <p:cNvSpPr>
            <a:spLocks noChangeShapeType="1"/>
          </p:cNvSpPr>
          <p:nvPr/>
        </p:nvSpPr>
        <p:spPr bwMode="auto">
          <a:xfrm>
            <a:off x="25892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8" name="Line 92"/>
          <p:cNvSpPr>
            <a:spLocks noChangeShapeType="1"/>
          </p:cNvSpPr>
          <p:nvPr/>
        </p:nvSpPr>
        <p:spPr bwMode="auto">
          <a:xfrm>
            <a:off x="26431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69" name="Line 93"/>
          <p:cNvSpPr>
            <a:spLocks noChangeShapeType="1"/>
          </p:cNvSpPr>
          <p:nvPr/>
        </p:nvSpPr>
        <p:spPr bwMode="auto">
          <a:xfrm>
            <a:off x="26670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0" name="Line 94"/>
          <p:cNvSpPr>
            <a:spLocks noChangeShapeType="1"/>
          </p:cNvSpPr>
          <p:nvPr/>
        </p:nvSpPr>
        <p:spPr bwMode="auto">
          <a:xfrm>
            <a:off x="26908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1" name="Line 95"/>
          <p:cNvSpPr>
            <a:spLocks noChangeShapeType="1"/>
          </p:cNvSpPr>
          <p:nvPr/>
        </p:nvSpPr>
        <p:spPr bwMode="auto">
          <a:xfrm>
            <a:off x="27384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2" name="Line 96"/>
          <p:cNvSpPr>
            <a:spLocks noChangeShapeType="1"/>
          </p:cNvSpPr>
          <p:nvPr/>
        </p:nvSpPr>
        <p:spPr bwMode="auto">
          <a:xfrm>
            <a:off x="27622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3" name="Line 97"/>
          <p:cNvSpPr>
            <a:spLocks noChangeShapeType="1"/>
          </p:cNvSpPr>
          <p:nvPr/>
        </p:nvSpPr>
        <p:spPr bwMode="auto">
          <a:xfrm>
            <a:off x="27924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4" name="Line 98"/>
          <p:cNvSpPr>
            <a:spLocks noChangeShapeType="1"/>
          </p:cNvSpPr>
          <p:nvPr/>
        </p:nvSpPr>
        <p:spPr bwMode="auto">
          <a:xfrm>
            <a:off x="28400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5" name="Line 99"/>
          <p:cNvSpPr>
            <a:spLocks noChangeShapeType="1"/>
          </p:cNvSpPr>
          <p:nvPr/>
        </p:nvSpPr>
        <p:spPr bwMode="auto">
          <a:xfrm>
            <a:off x="28654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6" name="Line 100"/>
          <p:cNvSpPr>
            <a:spLocks noChangeShapeType="1"/>
          </p:cNvSpPr>
          <p:nvPr/>
        </p:nvSpPr>
        <p:spPr bwMode="auto">
          <a:xfrm>
            <a:off x="28892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7" name="Line 101"/>
          <p:cNvSpPr>
            <a:spLocks noChangeShapeType="1"/>
          </p:cNvSpPr>
          <p:nvPr/>
        </p:nvSpPr>
        <p:spPr bwMode="auto">
          <a:xfrm>
            <a:off x="29432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8" name="Line 102"/>
          <p:cNvSpPr>
            <a:spLocks noChangeShapeType="1"/>
          </p:cNvSpPr>
          <p:nvPr/>
        </p:nvSpPr>
        <p:spPr bwMode="auto">
          <a:xfrm>
            <a:off x="29670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79" name="Line 103"/>
          <p:cNvSpPr>
            <a:spLocks noChangeShapeType="1"/>
          </p:cNvSpPr>
          <p:nvPr/>
        </p:nvSpPr>
        <p:spPr bwMode="auto">
          <a:xfrm>
            <a:off x="29908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0" name="Line 104"/>
          <p:cNvSpPr>
            <a:spLocks noChangeShapeType="1"/>
          </p:cNvSpPr>
          <p:nvPr/>
        </p:nvSpPr>
        <p:spPr bwMode="auto">
          <a:xfrm>
            <a:off x="30384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1" name="Line 105"/>
          <p:cNvSpPr>
            <a:spLocks noChangeShapeType="1"/>
          </p:cNvSpPr>
          <p:nvPr/>
        </p:nvSpPr>
        <p:spPr bwMode="auto">
          <a:xfrm>
            <a:off x="30622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2" name="Line 106"/>
          <p:cNvSpPr>
            <a:spLocks noChangeShapeType="1"/>
          </p:cNvSpPr>
          <p:nvPr/>
        </p:nvSpPr>
        <p:spPr bwMode="auto">
          <a:xfrm>
            <a:off x="30924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3" name="Line 107"/>
          <p:cNvSpPr>
            <a:spLocks noChangeShapeType="1"/>
          </p:cNvSpPr>
          <p:nvPr/>
        </p:nvSpPr>
        <p:spPr bwMode="auto">
          <a:xfrm>
            <a:off x="31400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4" name="Line 108"/>
          <p:cNvSpPr>
            <a:spLocks noChangeShapeType="1"/>
          </p:cNvSpPr>
          <p:nvPr/>
        </p:nvSpPr>
        <p:spPr bwMode="auto">
          <a:xfrm>
            <a:off x="31638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5" name="Line 109"/>
          <p:cNvSpPr>
            <a:spLocks noChangeShapeType="1"/>
          </p:cNvSpPr>
          <p:nvPr/>
        </p:nvSpPr>
        <p:spPr bwMode="auto">
          <a:xfrm>
            <a:off x="31877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6" name="Line 110"/>
          <p:cNvSpPr>
            <a:spLocks noChangeShapeType="1"/>
          </p:cNvSpPr>
          <p:nvPr/>
        </p:nvSpPr>
        <p:spPr bwMode="auto">
          <a:xfrm>
            <a:off x="32416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7" name="Line 111"/>
          <p:cNvSpPr>
            <a:spLocks noChangeShapeType="1"/>
          </p:cNvSpPr>
          <p:nvPr/>
        </p:nvSpPr>
        <p:spPr bwMode="auto">
          <a:xfrm>
            <a:off x="32670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8" name="Line 112"/>
          <p:cNvSpPr>
            <a:spLocks noChangeShapeType="1"/>
          </p:cNvSpPr>
          <p:nvPr/>
        </p:nvSpPr>
        <p:spPr bwMode="auto">
          <a:xfrm>
            <a:off x="32908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89" name="Line 113"/>
          <p:cNvSpPr>
            <a:spLocks noChangeShapeType="1"/>
          </p:cNvSpPr>
          <p:nvPr/>
        </p:nvSpPr>
        <p:spPr bwMode="auto">
          <a:xfrm>
            <a:off x="33385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0" name="Line 114"/>
          <p:cNvSpPr>
            <a:spLocks noChangeShapeType="1"/>
          </p:cNvSpPr>
          <p:nvPr/>
        </p:nvSpPr>
        <p:spPr bwMode="auto">
          <a:xfrm>
            <a:off x="33623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1" name="Line 115"/>
          <p:cNvSpPr>
            <a:spLocks noChangeShapeType="1"/>
          </p:cNvSpPr>
          <p:nvPr/>
        </p:nvSpPr>
        <p:spPr bwMode="auto">
          <a:xfrm>
            <a:off x="33924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2" name="Line 116"/>
          <p:cNvSpPr>
            <a:spLocks noChangeShapeType="1"/>
          </p:cNvSpPr>
          <p:nvPr/>
        </p:nvSpPr>
        <p:spPr bwMode="auto">
          <a:xfrm>
            <a:off x="34401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3" name="Line 117"/>
          <p:cNvSpPr>
            <a:spLocks noChangeShapeType="1"/>
          </p:cNvSpPr>
          <p:nvPr/>
        </p:nvSpPr>
        <p:spPr bwMode="auto">
          <a:xfrm>
            <a:off x="34639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4" name="Line 118"/>
          <p:cNvSpPr>
            <a:spLocks noChangeShapeType="1"/>
          </p:cNvSpPr>
          <p:nvPr/>
        </p:nvSpPr>
        <p:spPr bwMode="auto">
          <a:xfrm>
            <a:off x="34877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5" name="Line 119"/>
          <p:cNvSpPr>
            <a:spLocks noChangeShapeType="1"/>
          </p:cNvSpPr>
          <p:nvPr/>
        </p:nvSpPr>
        <p:spPr bwMode="auto">
          <a:xfrm>
            <a:off x="35417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6" name="Line 120"/>
          <p:cNvSpPr>
            <a:spLocks noChangeShapeType="1"/>
          </p:cNvSpPr>
          <p:nvPr/>
        </p:nvSpPr>
        <p:spPr bwMode="auto">
          <a:xfrm>
            <a:off x="35655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7" name="Line 121"/>
          <p:cNvSpPr>
            <a:spLocks noChangeShapeType="1"/>
          </p:cNvSpPr>
          <p:nvPr/>
        </p:nvSpPr>
        <p:spPr bwMode="auto">
          <a:xfrm>
            <a:off x="35909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8" name="Line 122"/>
          <p:cNvSpPr>
            <a:spLocks noChangeShapeType="1"/>
          </p:cNvSpPr>
          <p:nvPr/>
        </p:nvSpPr>
        <p:spPr bwMode="auto">
          <a:xfrm>
            <a:off x="36385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299" name="Line 123"/>
          <p:cNvSpPr>
            <a:spLocks noChangeShapeType="1"/>
          </p:cNvSpPr>
          <p:nvPr/>
        </p:nvSpPr>
        <p:spPr bwMode="auto">
          <a:xfrm>
            <a:off x="36687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0" name="Line 124"/>
          <p:cNvSpPr>
            <a:spLocks noChangeShapeType="1"/>
          </p:cNvSpPr>
          <p:nvPr/>
        </p:nvSpPr>
        <p:spPr bwMode="auto">
          <a:xfrm>
            <a:off x="36925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1" name="Line 125"/>
          <p:cNvSpPr>
            <a:spLocks noChangeShapeType="1"/>
          </p:cNvSpPr>
          <p:nvPr/>
        </p:nvSpPr>
        <p:spPr bwMode="auto">
          <a:xfrm>
            <a:off x="37401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2" name="Line 126"/>
          <p:cNvSpPr>
            <a:spLocks noChangeShapeType="1"/>
          </p:cNvSpPr>
          <p:nvPr/>
        </p:nvSpPr>
        <p:spPr bwMode="auto">
          <a:xfrm>
            <a:off x="37639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3" name="Line 127"/>
          <p:cNvSpPr>
            <a:spLocks noChangeShapeType="1"/>
          </p:cNvSpPr>
          <p:nvPr/>
        </p:nvSpPr>
        <p:spPr bwMode="auto">
          <a:xfrm>
            <a:off x="37877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4" name="Line 128"/>
          <p:cNvSpPr>
            <a:spLocks noChangeShapeType="1"/>
          </p:cNvSpPr>
          <p:nvPr/>
        </p:nvSpPr>
        <p:spPr bwMode="auto">
          <a:xfrm>
            <a:off x="38417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5" name="Line 129"/>
          <p:cNvSpPr>
            <a:spLocks noChangeShapeType="1"/>
          </p:cNvSpPr>
          <p:nvPr/>
        </p:nvSpPr>
        <p:spPr bwMode="auto">
          <a:xfrm>
            <a:off x="38655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6" name="Line 130"/>
          <p:cNvSpPr>
            <a:spLocks noChangeShapeType="1"/>
          </p:cNvSpPr>
          <p:nvPr/>
        </p:nvSpPr>
        <p:spPr bwMode="auto">
          <a:xfrm>
            <a:off x="38893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7" name="Line 131"/>
          <p:cNvSpPr>
            <a:spLocks noChangeShapeType="1"/>
          </p:cNvSpPr>
          <p:nvPr/>
        </p:nvSpPr>
        <p:spPr bwMode="auto">
          <a:xfrm>
            <a:off x="39385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8" name="Line 132"/>
          <p:cNvSpPr>
            <a:spLocks noChangeShapeType="1"/>
          </p:cNvSpPr>
          <p:nvPr/>
        </p:nvSpPr>
        <p:spPr bwMode="auto">
          <a:xfrm>
            <a:off x="39687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09" name="Line 133"/>
          <p:cNvSpPr>
            <a:spLocks noChangeShapeType="1"/>
          </p:cNvSpPr>
          <p:nvPr/>
        </p:nvSpPr>
        <p:spPr bwMode="auto">
          <a:xfrm>
            <a:off x="39925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0" name="Line 134"/>
          <p:cNvSpPr>
            <a:spLocks noChangeShapeType="1"/>
          </p:cNvSpPr>
          <p:nvPr/>
        </p:nvSpPr>
        <p:spPr bwMode="auto">
          <a:xfrm>
            <a:off x="40401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1" name="Line 135"/>
          <p:cNvSpPr>
            <a:spLocks noChangeShapeType="1"/>
          </p:cNvSpPr>
          <p:nvPr/>
        </p:nvSpPr>
        <p:spPr bwMode="auto">
          <a:xfrm>
            <a:off x="40640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2" name="Line 136"/>
          <p:cNvSpPr>
            <a:spLocks noChangeShapeType="1"/>
          </p:cNvSpPr>
          <p:nvPr/>
        </p:nvSpPr>
        <p:spPr bwMode="auto">
          <a:xfrm>
            <a:off x="40878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3" name="Line 137"/>
          <p:cNvSpPr>
            <a:spLocks noChangeShapeType="1"/>
          </p:cNvSpPr>
          <p:nvPr/>
        </p:nvSpPr>
        <p:spPr bwMode="auto">
          <a:xfrm>
            <a:off x="41417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4" name="Line 138"/>
          <p:cNvSpPr>
            <a:spLocks noChangeShapeType="1"/>
          </p:cNvSpPr>
          <p:nvPr/>
        </p:nvSpPr>
        <p:spPr bwMode="auto">
          <a:xfrm>
            <a:off x="41656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5" name="Line 139"/>
          <p:cNvSpPr>
            <a:spLocks noChangeShapeType="1"/>
          </p:cNvSpPr>
          <p:nvPr/>
        </p:nvSpPr>
        <p:spPr bwMode="auto">
          <a:xfrm>
            <a:off x="41894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6" name="Line 140"/>
          <p:cNvSpPr>
            <a:spLocks noChangeShapeType="1"/>
          </p:cNvSpPr>
          <p:nvPr/>
        </p:nvSpPr>
        <p:spPr bwMode="auto">
          <a:xfrm>
            <a:off x="42386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7" name="Line 141"/>
          <p:cNvSpPr>
            <a:spLocks noChangeShapeType="1"/>
          </p:cNvSpPr>
          <p:nvPr/>
        </p:nvSpPr>
        <p:spPr bwMode="auto">
          <a:xfrm>
            <a:off x="42672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8" name="Line 142"/>
          <p:cNvSpPr>
            <a:spLocks noChangeShapeType="1"/>
          </p:cNvSpPr>
          <p:nvPr/>
        </p:nvSpPr>
        <p:spPr bwMode="auto">
          <a:xfrm>
            <a:off x="42926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19" name="Line 143"/>
          <p:cNvSpPr>
            <a:spLocks noChangeShapeType="1"/>
          </p:cNvSpPr>
          <p:nvPr/>
        </p:nvSpPr>
        <p:spPr bwMode="auto">
          <a:xfrm>
            <a:off x="43402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0" name="Line 144"/>
          <p:cNvSpPr>
            <a:spLocks noChangeShapeType="1"/>
          </p:cNvSpPr>
          <p:nvPr/>
        </p:nvSpPr>
        <p:spPr bwMode="auto">
          <a:xfrm>
            <a:off x="43640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1" name="Line 145"/>
          <p:cNvSpPr>
            <a:spLocks noChangeShapeType="1"/>
          </p:cNvSpPr>
          <p:nvPr/>
        </p:nvSpPr>
        <p:spPr bwMode="auto">
          <a:xfrm>
            <a:off x="43878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2" name="Line 146"/>
          <p:cNvSpPr>
            <a:spLocks noChangeShapeType="1"/>
          </p:cNvSpPr>
          <p:nvPr/>
        </p:nvSpPr>
        <p:spPr bwMode="auto">
          <a:xfrm>
            <a:off x="44418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3" name="Line 147"/>
          <p:cNvSpPr>
            <a:spLocks noChangeShapeType="1"/>
          </p:cNvSpPr>
          <p:nvPr/>
        </p:nvSpPr>
        <p:spPr bwMode="auto">
          <a:xfrm>
            <a:off x="44656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4" name="Line 148"/>
          <p:cNvSpPr>
            <a:spLocks noChangeShapeType="1"/>
          </p:cNvSpPr>
          <p:nvPr/>
        </p:nvSpPr>
        <p:spPr bwMode="auto">
          <a:xfrm>
            <a:off x="44894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5" name="Line 149"/>
          <p:cNvSpPr>
            <a:spLocks noChangeShapeType="1"/>
          </p:cNvSpPr>
          <p:nvPr/>
        </p:nvSpPr>
        <p:spPr bwMode="auto">
          <a:xfrm>
            <a:off x="45370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6" name="Line 150"/>
          <p:cNvSpPr>
            <a:spLocks noChangeShapeType="1"/>
          </p:cNvSpPr>
          <p:nvPr/>
        </p:nvSpPr>
        <p:spPr bwMode="auto">
          <a:xfrm>
            <a:off x="45672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7" name="Line 151"/>
          <p:cNvSpPr>
            <a:spLocks noChangeShapeType="1"/>
          </p:cNvSpPr>
          <p:nvPr/>
        </p:nvSpPr>
        <p:spPr bwMode="auto">
          <a:xfrm>
            <a:off x="45910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8" name="Line 152"/>
          <p:cNvSpPr>
            <a:spLocks noChangeShapeType="1"/>
          </p:cNvSpPr>
          <p:nvPr/>
        </p:nvSpPr>
        <p:spPr bwMode="auto">
          <a:xfrm>
            <a:off x="46402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29" name="Line 153"/>
          <p:cNvSpPr>
            <a:spLocks noChangeShapeType="1"/>
          </p:cNvSpPr>
          <p:nvPr/>
        </p:nvSpPr>
        <p:spPr bwMode="auto">
          <a:xfrm>
            <a:off x="46640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0" name="Line 154"/>
          <p:cNvSpPr>
            <a:spLocks noChangeShapeType="1"/>
          </p:cNvSpPr>
          <p:nvPr/>
        </p:nvSpPr>
        <p:spPr bwMode="auto">
          <a:xfrm>
            <a:off x="46878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1" name="Line 155"/>
          <p:cNvSpPr>
            <a:spLocks noChangeShapeType="1"/>
          </p:cNvSpPr>
          <p:nvPr/>
        </p:nvSpPr>
        <p:spPr bwMode="auto">
          <a:xfrm>
            <a:off x="47418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2" name="Line 156"/>
          <p:cNvSpPr>
            <a:spLocks noChangeShapeType="1"/>
          </p:cNvSpPr>
          <p:nvPr/>
        </p:nvSpPr>
        <p:spPr bwMode="auto">
          <a:xfrm>
            <a:off x="47656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3" name="Line 157"/>
          <p:cNvSpPr>
            <a:spLocks noChangeShapeType="1"/>
          </p:cNvSpPr>
          <p:nvPr/>
        </p:nvSpPr>
        <p:spPr bwMode="auto">
          <a:xfrm>
            <a:off x="47894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4" name="Line 158"/>
          <p:cNvSpPr>
            <a:spLocks noChangeShapeType="1"/>
          </p:cNvSpPr>
          <p:nvPr/>
        </p:nvSpPr>
        <p:spPr bwMode="auto">
          <a:xfrm>
            <a:off x="48371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5" name="Line 159"/>
          <p:cNvSpPr>
            <a:spLocks noChangeShapeType="1"/>
          </p:cNvSpPr>
          <p:nvPr/>
        </p:nvSpPr>
        <p:spPr bwMode="auto">
          <a:xfrm>
            <a:off x="48672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6" name="Line 160"/>
          <p:cNvSpPr>
            <a:spLocks noChangeShapeType="1"/>
          </p:cNvSpPr>
          <p:nvPr/>
        </p:nvSpPr>
        <p:spPr bwMode="auto">
          <a:xfrm>
            <a:off x="48910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7" name="Line 161"/>
          <p:cNvSpPr>
            <a:spLocks noChangeShapeType="1"/>
          </p:cNvSpPr>
          <p:nvPr/>
        </p:nvSpPr>
        <p:spPr bwMode="auto">
          <a:xfrm>
            <a:off x="49403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8" name="Line 162"/>
          <p:cNvSpPr>
            <a:spLocks noChangeShapeType="1"/>
          </p:cNvSpPr>
          <p:nvPr/>
        </p:nvSpPr>
        <p:spPr bwMode="auto">
          <a:xfrm>
            <a:off x="49641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39" name="Line 163"/>
          <p:cNvSpPr>
            <a:spLocks noChangeShapeType="1"/>
          </p:cNvSpPr>
          <p:nvPr/>
        </p:nvSpPr>
        <p:spPr bwMode="auto">
          <a:xfrm>
            <a:off x="49879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0" name="Line 164"/>
          <p:cNvSpPr>
            <a:spLocks noChangeShapeType="1"/>
          </p:cNvSpPr>
          <p:nvPr/>
        </p:nvSpPr>
        <p:spPr bwMode="auto">
          <a:xfrm>
            <a:off x="50419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1" name="Line 165"/>
          <p:cNvSpPr>
            <a:spLocks noChangeShapeType="1"/>
          </p:cNvSpPr>
          <p:nvPr/>
        </p:nvSpPr>
        <p:spPr bwMode="auto">
          <a:xfrm>
            <a:off x="50657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2" name="Line 166"/>
          <p:cNvSpPr>
            <a:spLocks noChangeShapeType="1"/>
          </p:cNvSpPr>
          <p:nvPr/>
        </p:nvSpPr>
        <p:spPr bwMode="auto">
          <a:xfrm>
            <a:off x="50895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3" name="Line 167"/>
          <p:cNvSpPr>
            <a:spLocks noChangeShapeType="1"/>
          </p:cNvSpPr>
          <p:nvPr/>
        </p:nvSpPr>
        <p:spPr bwMode="auto">
          <a:xfrm>
            <a:off x="51371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4" name="Line 168"/>
          <p:cNvSpPr>
            <a:spLocks noChangeShapeType="1"/>
          </p:cNvSpPr>
          <p:nvPr/>
        </p:nvSpPr>
        <p:spPr bwMode="auto">
          <a:xfrm>
            <a:off x="51673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5" name="Line 169"/>
          <p:cNvSpPr>
            <a:spLocks noChangeShapeType="1"/>
          </p:cNvSpPr>
          <p:nvPr/>
        </p:nvSpPr>
        <p:spPr bwMode="auto">
          <a:xfrm>
            <a:off x="51911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6" name="Line 170"/>
          <p:cNvSpPr>
            <a:spLocks noChangeShapeType="1"/>
          </p:cNvSpPr>
          <p:nvPr/>
        </p:nvSpPr>
        <p:spPr bwMode="auto">
          <a:xfrm>
            <a:off x="52387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7" name="Line 171"/>
          <p:cNvSpPr>
            <a:spLocks noChangeShapeType="1"/>
          </p:cNvSpPr>
          <p:nvPr/>
        </p:nvSpPr>
        <p:spPr bwMode="auto">
          <a:xfrm>
            <a:off x="52625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8" name="Line 172"/>
          <p:cNvSpPr>
            <a:spLocks noChangeShapeType="1"/>
          </p:cNvSpPr>
          <p:nvPr/>
        </p:nvSpPr>
        <p:spPr bwMode="auto">
          <a:xfrm>
            <a:off x="52879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49" name="Line 173"/>
          <p:cNvSpPr>
            <a:spLocks noChangeShapeType="1"/>
          </p:cNvSpPr>
          <p:nvPr/>
        </p:nvSpPr>
        <p:spPr bwMode="auto">
          <a:xfrm>
            <a:off x="53419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0" name="Line 174"/>
          <p:cNvSpPr>
            <a:spLocks noChangeShapeType="1"/>
          </p:cNvSpPr>
          <p:nvPr/>
        </p:nvSpPr>
        <p:spPr bwMode="auto">
          <a:xfrm>
            <a:off x="53657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1" name="Line 175"/>
          <p:cNvSpPr>
            <a:spLocks noChangeShapeType="1"/>
          </p:cNvSpPr>
          <p:nvPr/>
        </p:nvSpPr>
        <p:spPr bwMode="auto">
          <a:xfrm>
            <a:off x="53895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2" name="Line 176"/>
          <p:cNvSpPr>
            <a:spLocks noChangeShapeType="1"/>
          </p:cNvSpPr>
          <p:nvPr/>
        </p:nvSpPr>
        <p:spPr bwMode="auto">
          <a:xfrm>
            <a:off x="54371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3" name="Line 177"/>
          <p:cNvSpPr>
            <a:spLocks noChangeShapeType="1"/>
          </p:cNvSpPr>
          <p:nvPr/>
        </p:nvSpPr>
        <p:spPr bwMode="auto">
          <a:xfrm>
            <a:off x="54673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4" name="Line 178"/>
          <p:cNvSpPr>
            <a:spLocks noChangeShapeType="1"/>
          </p:cNvSpPr>
          <p:nvPr/>
        </p:nvSpPr>
        <p:spPr bwMode="auto">
          <a:xfrm>
            <a:off x="54911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5" name="Line 179"/>
          <p:cNvSpPr>
            <a:spLocks noChangeShapeType="1"/>
          </p:cNvSpPr>
          <p:nvPr/>
        </p:nvSpPr>
        <p:spPr bwMode="auto">
          <a:xfrm>
            <a:off x="55387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6" name="Line 180"/>
          <p:cNvSpPr>
            <a:spLocks noChangeShapeType="1"/>
          </p:cNvSpPr>
          <p:nvPr/>
        </p:nvSpPr>
        <p:spPr bwMode="auto">
          <a:xfrm>
            <a:off x="55626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7" name="Line 181"/>
          <p:cNvSpPr>
            <a:spLocks noChangeShapeType="1"/>
          </p:cNvSpPr>
          <p:nvPr/>
        </p:nvSpPr>
        <p:spPr bwMode="auto">
          <a:xfrm>
            <a:off x="55864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8" name="Line 182"/>
          <p:cNvSpPr>
            <a:spLocks noChangeShapeType="1"/>
          </p:cNvSpPr>
          <p:nvPr/>
        </p:nvSpPr>
        <p:spPr bwMode="auto">
          <a:xfrm>
            <a:off x="56403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59" name="Line 183"/>
          <p:cNvSpPr>
            <a:spLocks noChangeShapeType="1"/>
          </p:cNvSpPr>
          <p:nvPr/>
        </p:nvSpPr>
        <p:spPr bwMode="auto">
          <a:xfrm>
            <a:off x="56657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0" name="Line 184"/>
          <p:cNvSpPr>
            <a:spLocks noChangeShapeType="1"/>
          </p:cNvSpPr>
          <p:nvPr/>
        </p:nvSpPr>
        <p:spPr bwMode="auto">
          <a:xfrm>
            <a:off x="56896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1" name="Line 185"/>
          <p:cNvSpPr>
            <a:spLocks noChangeShapeType="1"/>
          </p:cNvSpPr>
          <p:nvPr/>
        </p:nvSpPr>
        <p:spPr bwMode="auto">
          <a:xfrm>
            <a:off x="57372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2" name="Line 186"/>
          <p:cNvSpPr>
            <a:spLocks noChangeShapeType="1"/>
          </p:cNvSpPr>
          <p:nvPr/>
        </p:nvSpPr>
        <p:spPr bwMode="auto">
          <a:xfrm>
            <a:off x="57673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3" name="Line 187"/>
          <p:cNvSpPr>
            <a:spLocks noChangeShapeType="1"/>
          </p:cNvSpPr>
          <p:nvPr/>
        </p:nvSpPr>
        <p:spPr bwMode="auto">
          <a:xfrm>
            <a:off x="57912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4" name="Line 188"/>
          <p:cNvSpPr>
            <a:spLocks noChangeShapeType="1"/>
          </p:cNvSpPr>
          <p:nvPr/>
        </p:nvSpPr>
        <p:spPr bwMode="auto">
          <a:xfrm>
            <a:off x="58388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5" name="Line 189"/>
          <p:cNvSpPr>
            <a:spLocks noChangeShapeType="1"/>
          </p:cNvSpPr>
          <p:nvPr/>
        </p:nvSpPr>
        <p:spPr bwMode="auto">
          <a:xfrm>
            <a:off x="58626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6" name="Line 190"/>
          <p:cNvSpPr>
            <a:spLocks noChangeShapeType="1"/>
          </p:cNvSpPr>
          <p:nvPr/>
        </p:nvSpPr>
        <p:spPr bwMode="auto">
          <a:xfrm>
            <a:off x="58928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7" name="Line 191"/>
          <p:cNvSpPr>
            <a:spLocks noChangeShapeType="1"/>
          </p:cNvSpPr>
          <p:nvPr/>
        </p:nvSpPr>
        <p:spPr bwMode="auto">
          <a:xfrm>
            <a:off x="59404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8" name="Line 192"/>
          <p:cNvSpPr>
            <a:spLocks noChangeShapeType="1"/>
          </p:cNvSpPr>
          <p:nvPr/>
        </p:nvSpPr>
        <p:spPr bwMode="auto">
          <a:xfrm>
            <a:off x="59642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69" name="Line 193"/>
          <p:cNvSpPr>
            <a:spLocks noChangeShapeType="1"/>
          </p:cNvSpPr>
          <p:nvPr/>
        </p:nvSpPr>
        <p:spPr bwMode="auto">
          <a:xfrm>
            <a:off x="59896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0" name="Line 194"/>
          <p:cNvSpPr>
            <a:spLocks noChangeShapeType="1"/>
          </p:cNvSpPr>
          <p:nvPr/>
        </p:nvSpPr>
        <p:spPr bwMode="auto">
          <a:xfrm>
            <a:off x="60436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1" name="Line 195"/>
          <p:cNvSpPr>
            <a:spLocks noChangeShapeType="1"/>
          </p:cNvSpPr>
          <p:nvPr/>
        </p:nvSpPr>
        <p:spPr bwMode="auto">
          <a:xfrm>
            <a:off x="60674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2" name="Line 196"/>
          <p:cNvSpPr>
            <a:spLocks noChangeShapeType="1"/>
          </p:cNvSpPr>
          <p:nvPr/>
        </p:nvSpPr>
        <p:spPr bwMode="auto">
          <a:xfrm>
            <a:off x="60912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3" name="Line 197"/>
          <p:cNvSpPr>
            <a:spLocks noChangeShapeType="1"/>
          </p:cNvSpPr>
          <p:nvPr/>
        </p:nvSpPr>
        <p:spPr bwMode="auto">
          <a:xfrm>
            <a:off x="61388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4" name="Line 198"/>
          <p:cNvSpPr>
            <a:spLocks noChangeShapeType="1"/>
          </p:cNvSpPr>
          <p:nvPr/>
        </p:nvSpPr>
        <p:spPr bwMode="auto">
          <a:xfrm>
            <a:off x="61626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5" name="Line 199"/>
          <p:cNvSpPr>
            <a:spLocks noChangeShapeType="1"/>
          </p:cNvSpPr>
          <p:nvPr/>
        </p:nvSpPr>
        <p:spPr bwMode="auto">
          <a:xfrm>
            <a:off x="61928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6" name="Line 200"/>
          <p:cNvSpPr>
            <a:spLocks noChangeShapeType="1"/>
          </p:cNvSpPr>
          <p:nvPr/>
        </p:nvSpPr>
        <p:spPr bwMode="auto">
          <a:xfrm>
            <a:off x="62404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7" name="Line 201"/>
          <p:cNvSpPr>
            <a:spLocks noChangeShapeType="1"/>
          </p:cNvSpPr>
          <p:nvPr/>
        </p:nvSpPr>
        <p:spPr bwMode="auto">
          <a:xfrm>
            <a:off x="62642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8" name="Line 202"/>
          <p:cNvSpPr>
            <a:spLocks noChangeShapeType="1"/>
          </p:cNvSpPr>
          <p:nvPr/>
        </p:nvSpPr>
        <p:spPr bwMode="auto">
          <a:xfrm>
            <a:off x="62880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79" name="Line 203"/>
          <p:cNvSpPr>
            <a:spLocks noChangeShapeType="1"/>
          </p:cNvSpPr>
          <p:nvPr/>
        </p:nvSpPr>
        <p:spPr bwMode="auto">
          <a:xfrm>
            <a:off x="63420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0" name="Line 204"/>
          <p:cNvSpPr>
            <a:spLocks noChangeShapeType="1"/>
          </p:cNvSpPr>
          <p:nvPr/>
        </p:nvSpPr>
        <p:spPr bwMode="auto">
          <a:xfrm>
            <a:off x="63674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1" name="Line 205"/>
          <p:cNvSpPr>
            <a:spLocks noChangeShapeType="1"/>
          </p:cNvSpPr>
          <p:nvPr/>
        </p:nvSpPr>
        <p:spPr bwMode="auto">
          <a:xfrm>
            <a:off x="63912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2" name="Line 206"/>
          <p:cNvSpPr>
            <a:spLocks noChangeShapeType="1"/>
          </p:cNvSpPr>
          <p:nvPr/>
        </p:nvSpPr>
        <p:spPr bwMode="auto">
          <a:xfrm>
            <a:off x="64389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3" name="Line 207"/>
          <p:cNvSpPr>
            <a:spLocks noChangeShapeType="1"/>
          </p:cNvSpPr>
          <p:nvPr/>
        </p:nvSpPr>
        <p:spPr bwMode="auto">
          <a:xfrm>
            <a:off x="64627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4" name="Line 208"/>
          <p:cNvSpPr>
            <a:spLocks noChangeShapeType="1"/>
          </p:cNvSpPr>
          <p:nvPr/>
        </p:nvSpPr>
        <p:spPr bwMode="auto">
          <a:xfrm>
            <a:off x="64928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5" name="Line 209"/>
          <p:cNvSpPr>
            <a:spLocks noChangeShapeType="1"/>
          </p:cNvSpPr>
          <p:nvPr/>
        </p:nvSpPr>
        <p:spPr bwMode="auto">
          <a:xfrm>
            <a:off x="65405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6" name="Line 210"/>
          <p:cNvSpPr>
            <a:spLocks noChangeShapeType="1"/>
          </p:cNvSpPr>
          <p:nvPr/>
        </p:nvSpPr>
        <p:spPr bwMode="auto">
          <a:xfrm>
            <a:off x="65643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7" name="Line 211"/>
          <p:cNvSpPr>
            <a:spLocks noChangeShapeType="1"/>
          </p:cNvSpPr>
          <p:nvPr/>
        </p:nvSpPr>
        <p:spPr bwMode="auto">
          <a:xfrm>
            <a:off x="658812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8" name="Line 212"/>
          <p:cNvSpPr>
            <a:spLocks noChangeShapeType="1"/>
          </p:cNvSpPr>
          <p:nvPr/>
        </p:nvSpPr>
        <p:spPr bwMode="auto">
          <a:xfrm>
            <a:off x="66421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89" name="Line 213"/>
          <p:cNvSpPr>
            <a:spLocks noChangeShapeType="1"/>
          </p:cNvSpPr>
          <p:nvPr/>
        </p:nvSpPr>
        <p:spPr bwMode="auto">
          <a:xfrm>
            <a:off x="66659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0" name="Line 214"/>
          <p:cNvSpPr>
            <a:spLocks noChangeShapeType="1"/>
          </p:cNvSpPr>
          <p:nvPr/>
        </p:nvSpPr>
        <p:spPr bwMode="auto">
          <a:xfrm>
            <a:off x="66913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1" name="Line 215"/>
          <p:cNvSpPr>
            <a:spLocks noChangeShapeType="1"/>
          </p:cNvSpPr>
          <p:nvPr/>
        </p:nvSpPr>
        <p:spPr bwMode="auto">
          <a:xfrm>
            <a:off x="67389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2" name="Line 216"/>
          <p:cNvSpPr>
            <a:spLocks noChangeShapeType="1"/>
          </p:cNvSpPr>
          <p:nvPr/>
        </p:nvSpPr>
        <p:spPr bwMode="auto">
          <a:xfrm>
            <a:off x="67627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3" name="Line 217"/>
          <p:cNvSpPr>
            <a:spLocks noChangeShapeType="1"/>
          </p:cNvSpPr>
          <p:nvPr/>
        </p:nvSpPr>
        <p:spPr bwMode="auto">
          <a:xfrm>
            <a:off x="679291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4" name="Line 218"/>
          <p:cNvSpPr>
            <a:spLocks noChangeShapeType="1"/>
          </p:cNvSpPr>
          <p:nvPr/>
        </p:nvSpPr>
        <p:spPr bwMode="auto">
          <a:xfrm>
            <a:off x="68405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5" name="Line 219"/>
          <p:cNvSpPr>
            <a:spLocks noChangeShapeType="1"/>
          </p:cNvSpPr>
          <p:nvPr/>
        </p:nvSpPr>
        <p:spPr bwMode="auto">
          <a:xfrm>
            <a:off x="68643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6" name="Line 220"/>
          <p:cNvSpPr>
            <a:spLocks noChangeShapeType="1"/>
          </p:cNvSpPr>
          <p:nvPr/>
        </p:nvSpPr>
        <p:spPr bwMode="auto">
          <a:xfrm>
            <a:off x="68881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7" name="Line 221"/>
          <p:cNvSpPr>
            <a:spLocks noChangeShapeType="1"/>
          </p:cNvSpPr>
          <p:nvPr/>
        </p:nvSpPr>
        <p:spPr bwMode="auto">
          <a:xfrm>
            <a:off x="694213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8" name="Line 222"/>
          <p:cNvSpPr>
            <a:spLocks noChangeShapeType="1"/>
          </p:cNvSpPr>
          <p:nvPr/>
        </p:nvSpPr>
        <p:spPr bwMode="auto">
          <a:xfrm>
            <a:off x="69659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399" name="Line 223"/>
          <p:cNvSpPr>
            <a:spLocks noChangeShapeType="1"/>
          </p:cNvSpPr>
          <p:nvPr/>
        </p:nvSpPr>
        <p:spPr bwMode="auto">
          <a:xfrm>
            <a:off x="6989764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00" name="Line 224"/>
          <p:cNvSpPr>
            <a:spLocks noChangeShapeType="1"/>
          </p:cNvSpPr>
          <p:nvPr/>
        </p:nvSpPr>
        <p:spPr bwMode="auto">
          <a:xfrm>
            <a:off x="70389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01" name="Line 225"/>
          <p:cNvSpPr>
            <a:spLocks noChangeShapeType="1"/>
          </p:cNvSpPr>
          <p:nvPr/>
        </p:nvSpPr>
        <p:spPr bwMode="auto">
          <a:xfrm>
            <a:off x="70627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02" name="Line 226"/>
          <p:cNvSpPr>
            <a:spLocks noChangeShapeType="1"/>
          </p:cNvSpPr>
          <p:nvPr/>
        </p:nvSpPr>
        <p:spPr bwMode="auto">
          <a:xfrm>
            <a:off x="709295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03" name="Line 227"/>
          <p:cNvSpPr>
            <a:spLocks noChangeShapeType="1"/>
          </p:cNvSpPr>
          <p:nvPr/>
        </p:nvSpPr>
        <p:spPr bwMode="auto">
          <a:xfrm>
            <a:off x="71405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04" name="Line 228"/>
          <p:cNvSpPr>
            <a:spLocks noChangeShapeType="1"/>
          </p:cNvSpPr>
          <p:nvPr/>
        </p:nvSpPr>
        <p:spPr bwMode="auto">
          <a:xfrm>
            <a:off x="7164389" y="6149976"/>
            <a:ext cx="1587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05" name="Line 229"/>
          <p:cNvSpPr>
            <a:spLocks noChangeShapeType="1"/>
          </p:cNvSpPr>
          <p:nvPr/>
        </p:nvSpPr>
        <p:spPr bwMode="auto">
          <a:xfrm>
            <a:off x="7188200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06" name="Line 230"/>
          <p:cNvSpPr>
            <a:spLocks noChangeShapeType="1"/>
          </p:cNvSpPr>
          <p:nvPr/>
        </p:nvSpPr>
        <p:spPr bwMode="auto">
          <a:xfrm>
            <a:off x="7242175" y="6149976"/>
            <a:ext cx="1588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09" name="Line 233"/>
          <p:cNvSpPr>
            <a:spLocks noChangeShapeType="1"/>
          </p:cNvSpPr>
          <p:nvPr/>
        </p:nvSpPr>
        <p:spPr bwMode="auto">
          <a:xfrm>
            <a:off x="2312989" y="6149976"/>
            <a:ext cx="1587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10" name="Rectangle 234"/>
          <p:cNvSpPr>
            <a:spLocks noChangeArrowheads="1"/>
          </p:cNvSpPr>
          <p:nvPr/>
        </p:nvSpPr>
        <p:spPr bwMode="auto">
          <a:xfrm>
            <a:off x="2262188" y="6210300"/>
            <a:ext cx="5715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5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11" name="Line 235"/>
          <p:cNvSpPr>
            <a:spLocks noChangeShapeType="1"/>
          </p:cNvSpPr>
          <p:nvPr/>
        </p:nvSpPr>
        <p:spPr bwMode="auto">
          <a:xfrm>
            <a:off x="2816225" y="6149976"/>
            <a:ext cx="1588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12" name="Rectangle 236"/>
          <p:cNvSpPr>
            <a:spLocks noChangeArrowheads="1"/>
          </p:cNvSpPr>
          <p:nvPr/>
        </p:nvSpPr>
        <p:spPr bwMode="auto">
          <a:xfrm>
            <a:off x="2765425" y="6210300"/>
            <a:ext cx="5715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6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13" name="Line 237"/>
          <p:cNvSpPr>
            <a:spLocks noChangeShapeType="1"/>
          </p:cNvSpPr>
          <p:nvPr/>
        </p:nvSpPr>
        <p:spPr bwMode="auto">
          <a:xfrm>
            <a:off x="3314700" y="6149976"/>
            <a:ext cx="1588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14" name="Rectangle 238"/>
          <p:cNvSpPr>
            <a:spLocks noChangeArrowheads="1"/>
          </p:cNvSpPr>
          <p:nvPr/>
        </p:nvSpPr>
        <p:spPr bwMode="auto">
          <a:xfrm>
            <a:off x="3263900" y="6210300"/>
            <a:ext cx="5715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7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15" name="Line 239"/>
          <p:cNvSpPr>
            <a:spLocks noChangeShapeType="1"/>
          </p:cNvSpPr>
          <p:nvPr/>
        </p:nvSpPr>
        <p:spPr bwMode="auto">
          <a:xfrm>
            <a:off x="3817939" y="6149976"/>
            <a:ext cx="1587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16" name="Rectangle 240"/>
          <p:cNvSpPr>
            <a:spLocks noChangeArrowheads="1"/>
          </p:cNvSpPr>
          <p:nvPr/>
        </p:nvSpPr>
        <p:spPr bwMode="auto">
          <a:xfrm>
            <a:off x="3767138" y="6210300"/>
            <a:ext cx="5715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8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17" name="Line 241"/>
          <p:cNvSpPr>
            <a:spLocks noChangeShapeType="1"/>
          </p:cNvSpPr>
          <p:nvPr/>
        </p:nvSpPr>
        <p:spPr bwMode="auto">
          <a:xfrm>
            <a:off x="4316414" y="6149976"/>
            <a:ext cx="1587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18" name="Rectangle 242"/>
          <p:cNvSpPr>
            <a:spLocks noChangeArrowheads="1"/>
          </p:cNvSpPr>
          <p:nvPr/>
        </p:nvSpPr>
        <p:spPr bwMode="auto">
          <a:xfrm>
            <a:off x="4265613" y="6210300"/>
            <a:ext cx="5715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9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19" name="Line 243"/>
          <p:cNvSpPr>
            <a:spLocks noChangeShapeType="1"/>
          </p:cNvSpPr>
          <p:nvPr/>
        </p:nvSpPr>
        <p:spPr bwMode="auto">
          <a:xfrm>
            <a:off x="4813300" y="6149976"/>
            <a:ext cx="1588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20" name="Rectangle 244"/>
          <p:cNvSpPr>
            <a:spLocks noChangeArrowheads="1"/>
          </p:cNvSpPr>
          <p:nvPr/>
        </p:nvSpPr>
        <p:spPr bwMode="auto">
          <a:xfrm>
            <a:off x="4735513" y="6210300"/>
            <a:ext cx="11430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0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21" name="Line 245"/>
          <p:cNvSpPr>
            <a:spLocks noChangeShapeType="1"/>
          </p:cNvSpPr>
          <p:nvPr/>
        </p:nvSpPr>
        <p:spPr bwMode="auto">
          <a:xfrm>
            <a:off x="5316539" y="6149976"/>
            <a:ext cx="1587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22" name="Rectangle 246"/>
          <p:cNvSpPr>
            <a:spLocks noChangeArrowheads="1"/>
          </p:cNvSpPr>
          <p:nvPr/>
        </p:nvSpPr>
        <p:spPr bwMode="auto">
          <a:xfrm>
            <a:off x="5238750" y="6210300"/>
            <a:ext cx="11430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1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23" name="Line 247"/>
          <p:cNvSpPr>
            <a:spLocks noChangeShapeType="1"/>
          </p:cNvSpPr>
          <p:nvPr/>
        </p:nvSpPr>
        <p:spPr bwMode="auto">
          <a:xfrm>
            <a:off x="5815014" y="6149976"/>
            <a:ext cx="1587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24" name="Rectangle 248"/>
          <p:cNvSpPr>
            <a:spLocks noChangeArrowheads="1"/>
          </p:cNvSpPr>
          <p:nvPr/>
        </p:nvSpPr>
        <p:spPr bwMode="auto">
          <a:xfrm>
            <a:off x="5737225" y="6210300"/>
            <a:ext cx="11430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2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25" name="Line 249"/>
          <p:cNvSpPr>
            <a:spLocks noChangeShapeType="1"/>
          </p:cNvSpPr>
          <p:nvPr/>
        </p:nvSpPr>
        <p:spPr bwMode="auto">
          <a:xfrm>
            <a:off x="6313489" y="6149976"/>
            <a:ext cx="1587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26" name="Rectangle 250"/>
          <p:cNvSpPr>
            <a:spLocks noChangeArrowheads="1"/>
          </p:cNvSpPr>
          <p:nvPr/>
        </p:nvSpPr>
        <p:spPr bwMode="auto">
          <a:xfrm>
            <a:off x="6235700" y="6210300"/>
            <a:ext cx="11430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3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27" name="Line 251"/>
          <p:cNvSpPr>
            <a:spLocks noChangeShapeType="1"/>
          </p:cNvSpPr>
          <p:nvPr/>
        </p:nvSpPr>
        <p:spPr bwMode="auto">
          <a:xfrm>
            <a:off x="6816725" y="6149976"/>
            <a:ext cx="1588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28" name="Rectangle 252"/>
          <p:cNvSpPr>
            <a:spLocks noChangeArrowheads="1"/>
          </p:cNvSpPr>
          <p:nvPr/>
        </p:nvSpPr>
        <p:spPr bwMode="auto">
          <a:xfrm>
            <a:off x="6738938" y="6210300"/>
            <a:ext cx="114300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4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29" name="Rectangle 253"/>
          <p:cNvSpPr>
            <a:spLocks noChangeArrowheads="1"/>
          </p:cNvSpPr>
          <p:nvPr/>
        </p:nvSpPr>
        <p:spPr bwMode="auto">
          <a:xfrm>
            <a:off x="3962400" y="6335714"/>
            <a:ext cx="484188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Time (min)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30" name="Freeform 254"/>
          <p:cNvSpPr>
            <a:spLocks/>
          </p:cNvSpPr>
          <p:nvPr/>
        </p:nvSpPr>
        <p:spPr bwMode="auto">
          <a:xfrm>
            <a:off x="1317625" y="3887788"/>
            <a:ext cx="5948363" cy="2220912"/>
          </a:xfrm>
          <a:custGeom>
            <a:avLst/>
            <a:gdLst>
              <a:gd name="T0" fmla="*/ 2147483647 w 992"/>
              <a:gd name="T1" fmla="*/ 2147483647 h 371"/>
              <a:gd name="T2" fmla="*/ 2147483647 w 992"/>
              <a:gd name="T3" fmla="*/ 2147483647 h 371"/>
              <a:gd name="T4" fmla="*/ 2147483647 w 992"/>
              <a:gd name="T5" fmla="*/ 2147483647 h 371"/>
              <a:gd name="T6" fmla="*/ 2147483647 w 992"/>
              <a:gd name="T7" fmla="*/ 2147483647 h 371"/>
              <a:gd name="T8" fmla="*/ 2147483647 w 992"/>
              <a:gd name="T9" fmla="*/ 2147483647 h 371"/>
              <a:gd name="T10" fmla="*/ 2147483647 w 992"/>
              <a:gd name="T11" fmla="*/ 2147483647 h 371"/>
              <a:gd name="T12" fmla="*/ 2147483647 w 992"/>
              <a:gd name="T13" fmla="*/ 2147483647 h 371"/>
              <a:gd name="T14" fmla="*/ 2147483647 w 992"/>
              <a:gd name="T15" fmla="*/ 2147483647 h 371"/>
              <a:gd name="T16" fmla="*/ 2147483647 w 992"/>
              <a:gd name="T17" fmla="*/ 2147483647 h 371"/>
              <a:gd name="T18" fmla="*/ 2147483647 w 992"/>
              <a:gd name="T19" fmla="*/ 2147483647 h 371"/>
              <a:gd name="T20" fmla="*/ 2147483647 w 992"/>
              <a:gd name="T21" fmla="*/ 2147483647 h 371"/>
              <a:gd name="T22" fmla="*/ 2147483647 w 992"/>
              <a:gd name="T23" fmla="*/ 2147483647 h 371"/>
              <a:gd name="T24" fmla="*/ 2147483647 w 992"/>
              <a:gd name="T25" fmla="*/ 2147483647 h 371"/>
              <a:gd name="T26" fmla="*/ 2147483647 w 992"/>
              <a:gd name="T27" fmla="*/ 2147483647 h 371"/>
              <a:gd name="T28" fmla="*/ 2147483647 w 992"/>
              <a:gd name="T29" fmla="*/ 2147483647 h 371"/>
              <a:gd name="T30" fmla="*/ 2147483647 w 992"/>
              <a:gd name="T31" fmla="*/ 2147483647 h 371"/>
              <a:gd name="T32" fmla="*/ 2147483647 w 992"/>
              <a:gd name="T33" fmla="*/ 2147483647 h 371"/>
              <a:gd name="T34" fmla="*/ 2147483647 w 992"/>
              <a:gd name="T35" fmla="*/ 2147483647 h 371"/>
              <a:gd name="T36" fmla="*/ 2147483647 w 992"/>
              <a:gd name="T37" fmla="*/ 2147483647 h 371"/>
              <a:gd name="T38" fmla="*/ 2147483647 w 992"/>
              <a:gd name="T39" fmla="*/ 2147483647 h 371"/>
              <a:gd name="T40" fmla="*/ 2147483647 w 992"/>
              <a:gd name="T41" fmla="*/ 2147483647 h 371"/>
              <a:gd name="T42" fmla="*/ 2147483647 w 992"/>
              <a:gd name="T43" fmla="*/ 2147483647 h 371"/>
              <a:gd name="T44" fmla="*/ 2147483647 w 992"/>
              <a:gd name="T45" fmla="*/ 2147483647 h 371"/>
              <a:gd name="T46" fmla="*/ 2147483647 w 992"/>
              <a:gd name="T47" fmla="*/ 2147483647 h 371"/>
              <a:gd name="T48" fmla="*/ 2147483647 w 992"/>
              <a:gd name="T49" fmla="*/ 2147483647 h 371"/>
              <a:gd name="T50" fmla="*/ 2147483647 w 992"/>
              <a:gd name="T51" fmla="*/ 2147483647 h 371"/>
              <a:gd name="T52" fmla="*/ 2147483647 w 992"/>
              <a:gd name="T53" fmla="*/ 2147483647 h 371"/>
              <a:gd name="T54" fmla="*/ 2147483647 w 992"/>
              <a:gd name="T55" fmla="*/ 2147483647 h 371"/>
              <a:gd name="T56" fmla="*/ 2147483647 w 992"/>
              <a:gd name="T57" fmla="*/ 2147483647 h 371"/>
              <a:gd name="T58" fmla="*/ 2147483647 w 992"/>
              <a:gd name="T59" fmla="*/ 2147483647 h 371"/>
              <a:gd name="T60" fmla="*/ 2147483647 w 992"/>
              <a:gd name="T61" fmla="*/ 2147483647 h 371"/>
              <a:gd name="T62" fmla="*/ 2147483647 w 992"/>
              <a:gd name="T63" fmla="*/ 2147483647 h 371"/>
              <a:gd name="T64" fmla="*/ 2147483647 w 992"/>
              <a:gd name="T65" fmla="*/ 2147483647 h 371"/>
              <a:gd name="T66" fmla="*/ 2147483647 w 992"/>
              <a:gd name="T67" fmla="*/ 2147483647 h 371"/>
              <a:gd name="T68" fmla="*/ 2147483647 w 992"/>
              <a:gd name="T69" fmla="*/ 2147483647 h 371"/>
              <a:gd name="T70" fmla="*/ 2147483647 w 992"/>
              <a:gd name="T71" fmla="*/ 2147483647 h 371"/>
              <a:gd name="T72" fmla="*/ 2147483647 w 992"/>
              <a:gd name="T73" fmla="*/ 2147483647 h 371"/>
              <a:gd name="T74" fmla="*/ 2147483647 w 992"/>
              <a:gd name="T75" fmla="*/ 2147483647 h 371"/>
              <a:gd name="T76" fmla="*/ 2147483647 w 992"/>
              <a:gd name="T77" fmla="*/ 2147483647 h 371"/>
              <a:gd name="T78" fmla="*/ 2147483647 w 992"/>
              <a:gd name="T79" fmla="*/ 2147483647 h 371"/>
              <a:gd name="T80" fmla="*/ 2147483647 w 992"/>
              <a:gd name="T81" fmla="*/ 2147483647 h 371"/>
              <a:gd name="T82" fmla="*/ 2147483647 w 992"/>
              <a:gd name="T83" fmla="*/ 2147483647 h 371"/>
              <a:gd name="T84" fmla="*/ 2147483647 w 992"/>
              <a:gd name="T85" fmla="*/ 2147483647 h 371"/>
              <a:gd name="T86" fmla="*/ 2147483647 w 992"/>
              <a:gd name="T87" fmla="*/ 2147483647 h 371"/>
              <a:gd name="T88" fmla="*/ 2147483647 w 992"/>
              <a:gd name="T89" fmla="*/ 2147483647 h 371"/>
              <a:gd name="T90" fmla="*/ 2147483647 w 992"/>
              <a:gd name="T91" fmla="*/ 2147483647 h 371"/>
              <a:gd name="T92" fmla="*/ 2147483647 w 992"/>
              <a:gd name="T93" fmla="*/ 2147483647 h 371"/>
              <a:gd name="T94" fmla="*/ 2147483647 w 992"/>
              <a:gd name="T95" fmla="*/ 2147483647 h 371"/>
              <a:gd name="T96" fmla="*/ 2147483647 w 992"/>
              <a:gd name="T97" fmla="*/ 2147483647 h 371"/>
              <a:gd name="T98" fmla="*/ 2147483647 w 992"/>
              <a:gd name="T99" fmla="*/ 2147483647 h 371"/>
              <a:gd name="T100" fmla="*/ 2147483647 w 992"/>
              <a:gd name="T101" fmla="*/ 2147483647 h 371"/>
              <a:gd name="T102" fmla="*/ 2147483647 w 992"/>
              <a:gd name="T103" fmla="*/ 2147483647 h 371"/>
              <a:gd name="T104" fmla="*/ 2147483647 w 992"/>
              <a:gd name="T105" fmla="*/ 2147483647 h 371"/>
              <a:gd name="T106" fmla="*/ 2147483647 w 992"/>
              <a:gd name="T107" fmla="*/ 2147483647 h 371"/>
              <a:gd name="T108" fmla="*/ 2147483647 w 992"/>
              <a:gd name="T109" fmla="*/ 2147483647 h 371"/>
              <a:gd name="T110" fmla="*/ 2147483647 w 992"/>
              <a:gd name="T111" fmla="*/ 2147483647 h 371"/>
              <a:gd name="T112" fmla="*/ 2147483647 w 992"/>
              <a:gd name="T113" fmla="*/ 2147483647 h 371"/>
              <a:gd name="T114" fmla="*/ 2147483647 w 992"/>
              <a:gd name="T115" fmla="*/ 2147483647 h 371"/>
              <a:gd name="T116" fmla="*/ 2147483647 w 992"/>
              <a:gd name="T117" fmla="*/ 2147483647 h 371"/>
              <a:gd name="T118" fmla="*/ 2147483647 w 992"/>
              <a:gd name="T119" fmla="*/ 2147483647 h 371"/>
              <a:gd name="T120" fmla="*/ 2147483647 w 992"/>
              <a:gd name="T121" fmla="*/ 2147483647 h 371"/>
              <a:gd name="T122" fmla="*/ 2147483647 w 992"/>
              <a:gd name="T123" fmla="*/ 2147483647 h 371"/>
              <a:gd name="T124" fmla="*/ 2147483647 w 992"/>
              <a:gd name="T125" fmla="*/ 2147483647 h 371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  <a:gd name="T165" fmla="*/ 0 60000 65536"/>
              <a:gd name="T166" fmla="*/ 0 60000 65536"/>
              <a:gd name="T167" fmla="*/ 0 60000 65536"/>
              <a:gd name="T168" fmla="*/ 0 60000 65536"/>
              <a:gd name="T169" fmla="*/ 0 60000 65536"/>
              <a:gd name="T170" fmla="*/ 0 60000 65536"/>
              <a:gd name="T171" fmla="*/ 0 60000 65536"/>
              <a:gd name="T172" fmla="*/ 0 60000 65536"/>
              <a:gd name="T173" fmla="*/ 0 60000 65536"/>
              <a:gd name="T174" fmla="*/ 0 60000 65536"/>
              <a:gd name="T175" fmla="*/ 0 60000 65536"/>
              <a:gd name="T176" fmla="*/ 0 60000 65536"/>
              <a:gd name="T177" fmla="*/ 0 60000 65536"/>
              <a:gd name="T178" fmla="*/ 0 60000 65536"/>
              <a:gd name="T179" fmla="*/ 0 60000 65536"/>
              <a:gd name="T180" fmla="*/ 0 60000 65536"/>
              <a:gd name="T181" fmla="*/ 0 60000 65536"/>
              <a:gd name="T182" fmla="*/ 0 60000 65536"/>
              <a:gd name="T183" fmla="*/ 0 60000 65536"/>
              <a:gd name="T184" fmla="*/ 0 60000 65536"/>
              <a:gd name="T185" fmla="*/ 0 60000 65536"/>
              <a:gd name="T186" fmla="*/ 0 60000 65536"/>
              <a:gd name="T187" fmla="*/ 0 60000 65536"/>
              <a:gd name="T188" fmla="*/ 0 60000 65536"/>
              <a:gd name="T189" fmla="*/ 0 w 992"/>
              <a:gd name="T190" fmla="*/ 0 h 371"/>
              <a:gd name="T191" fmla="*/ 992 w 992"/>
              <a:gd name="T192" fmla="*/ 371 h 371"/>
            </a:gdLst>
            <a:ahLst/>
            <a:cxnLst>
              <a:cxn ang="T126">
                <a:pos x="T0" y="T1"/>
              </a:cxn>
              <a:cxn ang="T127">
                <a:pos x="T2" y="T3"/>
              </a:cxn>
              <a:cxn ang="T128">
                <a:pos x="T4" y="T5"/>
              </a:cxn>
              <a:cxn ang="T129">
                <a:pos x="T6" y="T7"/>
              </a:cxn>
              <a:cxn ang="T130">
                <a:pos x="T8" y="T9"/>
              </a:cxn>
              <a:cxn ang="T131">
                <a:pos x="T10" y="T11"/>
              </a:cxn>
              <a:cxn ang="T132">
                <a:pos x="T12" y="T13"/>
              </a:cxn>
              <a:cxn ang="T133">
                <a:pos x="T14" y="T15"/>
              </a:cxn>
              <a:cxn ang="T134">
                <a:pos x="T16" y="T17"/>
              </a:cxn>
              <a:cxn ang="T135">
                <a:pos x="T18" y="T19"/>
              </a:cxn>
              <a:cxn ang="T136">
                <a:pos x="T20" y="T21"/>
              </a:cxn>
              <a:cxn ang="T137">
                <a:pos x="T22" y="T23"/>
              </a:cxn>
              <a:cxn ang="T138">
                <a:pos x="T24" y="T25"/>
              </a:cxn>
              <a:cxn ang="T139">
                <a:pos x="T26" y="T27"/>
              </a:cxn>
              <a:cxn ang="T140">
                <a:pos x="T28" y="T29"/>
              </a:cxn>
              <a:cxn ang="T141">
                <a:pos x="T30" y="T31"/>
              </a:cxn>
              <a:cxn ang="T142">
                <a:pos x="T32" y="T33"/>
              </a:cxn>
              <a:cxn ang="T143">
                <a:pos x="T34" y="T35"/>
              </a:cxn>
              <a:cxn ang="T144">
                <a:pos x="T36" y="T37"/>
              </a:cxn>
              <a:cxn ang="T145">
                <a:pos x="T38" y="T39"/>
              </a:cxn>
              <a:cxn ang="T146">
                <a:pos x="T40" y="T41"/>
              </a:cxn>
              <a:cxn ang="T147">
                <a:pos x="T42" y="T43"/>
              </a:cxn>
              <a:cxn ang="T148">
                <a:pos x="T44" y="T45"/>
              </a:cxn>
              <a:cxn ang="T149">
                <a:pos x="T46" y="T47"/>
              </a:cxn>
              <a:cxn ang="T150">
                <a:pos x="T48" y="T49"/>
              </a:cxn>
              <a:cxn ang="T151">
                <a:pos x="T50" y="T51"/>
              </a:cxn>
              <a:cxn ang="T152">
                <a:pos x="T52" y="T53"/>
              </a:cxn>
              <a:cxn ang="T153">
                <a:pos x="T54" y="T55"/>
              </a:cxn>
              <a:cxn ang="T154">
                <a:pos x="T56" y="T57"/>
              </a:cxn>
              <a:cxn ang="T155">
                <a:pos x="T58" y="T59"/>
              </a:cxn>
              <a:cxn ang="T156">
                <a:pos x="T60" y="T61"/>
              </a:cxn>
              <a:cxn ang="T157">
                <a:pos x="T62" y="T63"/>
              </a:cxn>
              <a:cxn ang="T158">
                <a:pos x="T64" y="T65"/>
              </a:cxn>
              <a:cxn ang="T159">
                <a:pos x="T66" y="T67"/>
              </a:cxn>
              <a:cxn ang="T160">
                <a:pos x="T68" y="T69"/>
              </a:cxn>
              <a:cxn ang="T161">
                <a:pos x="T70" y="T71"/>
              </a:cxn>
              <a:cxn ang="T162">
                <a:pos x="T72" y="T73"/>
              </a:cxn>
              <a:cxn ang="T163">
                <a:pos x="T74" y="T75"/>
              </a:cxn>
              <a:cxn ang="T164">
                <a:pos x="T76" y="T77"/>
              </a:cxn>
              <a:cxn ang="T165">
                <a:pos x="T78" y="T79"/>
              </a:cxn>
              <a:cxn ang="T166">
                <a:pos x="T80" y="T81"/>
              </a:cxn>
              <a:cxn ang="T167">
                <a:pos x="T82" y="T83"/>
              </a:cxn>
              <a:cxn ang="T168">
                <a:pos x="T84" y="T85"/>
              </a:cxn>
              <a:cxn ang="T169">
                <a:pos x="T86" y="T87"/>
              </a:cxn>
              <a:cxn ang="T170">
                <a:pos x="T88" y="T89"/>
              </a:cxn>
              <a:cxn ang="T171">
                <a:pos x="T90" y="T91"/>
              </a:cxn>
              <a:cxn ang="T172">
                <a:pos x="T92" y="T93"/>
              </a:cxn>
              <a:cxn ang="T173">
                <a:pos x="T94" y="T95"/>
              </a:cxn>
              <a:cxn ang="T174">
                <a:pos x="T96" y="T97"/>
              </a:cxn>
              <a:cxn ang="T175">
                <a:pos x="T98" y="T99"/>
              </a:cxn>
              <a:cxn ang="T176">
                <a:pos x="T100" y="T101"/>
              </a:cxn>
              <a:cxn ang="T177">
                <a:pos x="T102" y="T103"/>
              </a:cxn>
              <a:cxn ang="T178">
                <a:pos x="T104" y="T105"/>
              </a:cxn>
              <a:cxn ang="T179">
                <a:pos x="T106" y="T107"/>
              </a:cxn>
              <a:cxn ang="T180">
                <a:pos x="T108" y="T109"/>
              </a:cxn>
              <a:cxn ang="T181">
                <a:pos x="T110" y="T111"/>
              </a:cxn>
              <a:cxn ang="T182">
                <a:pos x="T112" y="T113"/>
              </a:cxn>
              <a:cxn ang="T183">
                <a:pos x="T114" y="T115"/>
              </a:cxn>
              <a:cxn ang="T184">
                <a:pos x="T116" y="T117"/>
              </a:cxn>
              <a:cxn ang="T185">
                <a:pos x="T118" y="T119"/>
              </a:cxn>
              <a:cxn ang="T186">
                <a:pos x="T120" y="T121"/>
              </a:cxn>
              <a:cxn ang="T187">
                <a:pos x="T122" y="T123"/>
              </a:cxn>
              <a:cxn ang="T188">
                <a:pos x="T124" y="T125"/>
              </a:cxn>
            </a:cxnLst>
            <a:rect l="T189" t="T190" r="T191" b="T192"/>
            <a:pathLst>
              <a:path w="992" h="371">
                <a:moveTo>
                  <a:pt x="0" y="238"/>
                </a:moveTo>
                <a:lnTo>
                  <a:pt x="0" y="349"/>
                </a:lnTo>
                <a:lnTo>
                  <a:pt x="1" y="366"/>
                </a:lnTo>
                <a:lnTo>
                  <a:pt x="1" y="362"/>
                </a:lnTo>
                <a:lnTo>
                  <a:pt x="2" y="359"/>
                </a:lnTo>
                <a:lnTo>
                  <a:pt x="2" y="360"/>
                </a:lnTo>
                <a:lnTo>
                  <a:pt x="3" y="360"/>
                </a:lnTo>
                <a:lnTo>
                  <a:pt x="3" y="353"/>
                </a:lnTo>
                <a:lnTo>
                  <a:pt x="4" y="337"/>
                </a:lnTo>
                <a:lnTo>
                  <a:pt x="4" y="347"/>
                </a:lnTo>
                <a:lnTo>
                  <a:pt x="5" y="360"/>
                </a:lnTo>
                <a:lnTo>
                  <a:pt x="5" y="367"/>
                </a:lnTo>
                <a:lnTo>
                  <a:pt x="6" y="367"/>
                </a:lnTo>
                <a:lnTo>
                  <a:pt x="7" y="368"/>
                </a:lnTo>
                <a:lnTo>
                  <a:pt x="8" y="368"/>
                </a:lnTo>
                <a:lnTo>
                  <a:pt x="8" y="367"/>
                </a:lnTo>
                <a:lnTo>
                  <a:pt x="9" y="367"/>
                </a:lnTo>
                <a:lnTo>
                  <a:pt x="9" y="361"/>
                </a:lnTo>
                <a:lnTo>
                  <a:pt x="10" y="359"/>
                </a:lnTo>
                <a:lnTo>
                  <a:pt x="10" y="367"/>
                </a:lnTo>
                <a:lnTo>
                  <a:pt x="11" y="368"/>
                </a:lnTo>
                <a:lnTo>
                  <a:pt x="11" y="366"/>
                </a:lnTo>
                <a:lnTo>
                  <a:pt x="12" y="365"/>
                </a:lnTo>
                <a:lnTo>
                  <a:pt x="12" y="356"/>
                </a:lnTo>
                <a:lnTo>
                  <a:pt x="13" y="356"/>
                </a:lnTo>
                <a:lnTo>
                  <a:pt x="13" y="361"/>
                </a:lnTo>
                <a:lnTo>
                  <a:pt x="14" y="362"/>
                </a:lnTo>
                <a:lnTo>
                  <a:pt x="14" y="334"/>
                </a:lnTo>
                <a:lnTo>
                  <a:pt x="15" y="336"/>
                </a:lnTo>
                <a:lnTo>
                  <a:pt x="15" y="366"/>
                </a:lnTo>
                <a:lnTo>
                  <a:pt x="16" y="368"/>
                </a:lnTo>
                <a:lnTo>
                  <a:pt x="16" y="369"/>
                </a:lnTo>
                <a:lnTo>
                  <a:pt x="17" y="369"/>
                </a:lnTo>
                <a:lnTo>
                  <a:pt x="18" y="369"/>
                </a:lnTo>
                <a:lnTo>
                  <a:pt x="18" y="368"/>
                </a:lnTo>
                <a:lnTo>
                  <a:pt x="19" y="368"/>
                </a:lnTo>
                <a:lnTo>
                  <a:pt x="19" y="369"/>
                </a:lnTo>
                <a:lnTo>
                  <a:pt x="20" y="369"/>
                </a:lnTo>
                <a:lnTo>
                  <a:pt x="21" y="368"/>
                </a:lnTo>
                <a:lnTo>
                  <a:pt x="22" y="368"/>
                </a:lnTo>
                <a:lnTo>
                  <a:pt x="23" y="368"/>
                </a:lnTo>
                <a:lnTo>
                  <a:pt x="23" y="367"/>
                </a:lnTo>
                <a:lnTo>
                  <a:pt x="24" y="367"/>
                </a:lnTo>
                <a:lnTo>
                  <a:pt x="25" y="367"/>
                </a:lnTo>
                <a:lnTo>
                  <a:pt x="25" y="369"/>
                </a:lnTo>
                <a:lnTo>
                  <a:pt x="26" y="369"/>
                </a:lnTo>
                <a:lnTo>
                  <a:pt x="26" y="367"/>
                </a:lnTo>
                <a:lnTo>
                  <a:pt x="27" y="365"/>
                </a:lnTo>
                <a:lnTo>
                  <a:pt x="27" y="368"/>
                </a:lnTo>
                <a:lnTo>
                  <a:pt x="28" y="369"/>
                </a:lnTo>
                <a:lnTo>
                  <a:pt x="28" y="368"/>
                </a:lnTo>
                <a:lnTo>
                  <a:pt x="29" y="368"/>
                </a:lnTo>
                <a:lnTo>
                  <a:pt x="29" y="369"/>
                </a:lnTo>
                <a:lnTo>
                  <a:pt x="30" y="369"/>
                </a:lnTo>
                <a:lnTo>
                  <a:pt x="31" y="369"/>
                </a:lnTo>
                <a:lnTo>
                  <a:pt x="32" y="369"/>
                </a:lnTo>
                <a:lnTo>
                  <a:pt x="32" y="370"/>
                </a:lnTo>
                <a:lnTo>
                  <a:pt x="33" y="369"/>
                </a:lnTo>
                <a:lnTo>
                  <a:pt x="34" y="369"/>
                </a:lnTo>
                <a:lnTo>
                  <a:pt x="35" y="369"/>
                </a:lnTo>
                <a:lnTo>
                  <a:pt x="35" y="370"/>
                </a:lnTo>
                <a:lnTo>
                  <a:pt x="36" y="370"/>
                </a:lnTo>
                <a:lnTo>
                  <a:pt x="37" y="369"/>
                </a:lnTo>
                <a:lnTo>
                  <a:pt x="38" y="369"/>
                </a:lnTo>
                <a:lnTo>
                  <a:pt x="38" y="370"/>
                </a:lnTo>
                <a:lnTo>
                  <a:pt x="39" y="369"/>
                </a:lnTo>
                <a:lnTo>
                  <a:pt x="39" y="370"/>
                </a:lnTo>
                <a:lnTo>
                  <a:pt x="40" y="370"/>
                </a:lnTo>
                <a:lnTo>
                  <a:pt x="41" y="369"/>
                </a:lnTo>
                <a:lnTo>
                  <a:pt x="41" y="361"/>
                </a:lnTo>
                <a:lnTo>
                  <a:pt x="42" y="358"/>
                </a:lnTo>
                <a:lnTo>
                  <a:pt x="42" y="355"/>
                </a:lnTo>
                <a:lnTo>
                  <a:pt x="43" y="351"/>
                </a:lnTo>
                <a:lnTo>
                  <a:pt x="43" y="343"/>
                </a:lnTo>
                <a:lnTo>
                  <a:pt x="44" y="350"/>
                </a:lnTo>
                <a:lnTo>
                  <a:pt x="44" y="367"/>
                </a:lnTo>
                <a:lnTo>
                  <a:pt x="45" y="367"/>
                </a:lnTo>
                <a:lnTo>
                  <a:pt x="46" y="367"/>
                </a:lnTo>
                <a:lnTo>
                  <a:pt x="47" y="367"/>
                </a:lnTo>
                <a:lnTo>
                  <a:pt x="47" y="366"/>
                </a:lnTo>
                <a:lnTo>
                  <a:pt x="48" y="366"/>
                </a:lnTo>
                <a:lnTo>
                  <a:pt x="48" y="368"/>
                </a:lnTo>
                <a:lnTo>
                  <a:pt x="49" y="369"/>
                </a:lnTo>
                <a:lnTo>
                  <a:pt x="50" y="369"/>
                </a:lnTo>
                <a:lnTo>
                  <a:pt x="51" y="370"/>
                </a:lnTo>
                <a:lnTo>
                  <a:pt x="52" y="370"/>
                </a:lnTo>
                <a:lnTo>
                  <a:pt x="53" y="370"/>
                </a:lnTo>
                <a:lnTo>
                  <a:pt x="53" y="368"/>
                </a:lnTo>
                <a:lnTo>
                  <a:pt x="54" y="366"/>
                </a:lnTo>
                <a:lnTo>
                  <a:pt x="54" y="367"/>
                </a:lnTo>
                <a:lnTo>
                  <a:pt x="55" y="369"/>
                </a:lnTo>
                <a:lnTo>
                  <a:pt x="55" y="370"/>
                </a:lnTo>
                <a:lnTo>
                  <a:pt x="56" y="370"/>
                </a:lnTo>
                <a:lnTo>
                  <a:pt x="57" y="370"/>
                </a:lnTo>
                <a:lnTo>
                  <a:pt x="57" y="368"/>
                </a:lnTo>
                <a:lnTo>
                  <a:pt x="58" y="362"/>
                </a:lnTo>
                <a:lnTo>
                  <a:pt x="58" y="336"/>
                </a:lnTo>
                <a:lnTo>
                  <a:pt x="59" y="335"/>
                </a:lnTo>
                <a:lnTo>
                  <a:pt x="59" y="363"/>
                </a:lnTo>
                <a:lnTo>
                  <a:pt x="60" y="368"/>
                </a:lnTo>
                <a:lnTo>
                  <a:pt x="60" y="369"/>
                </a:lnTo>
                <a:lnTo>
                  <a:pt x="61" y="369"/>
                </a:lnTo>
                <a:lnTo>
                  <a:pt x="61" y="368"/>
                </a:lnTo>
                <a:lnTo>
                  <a:pt x="62" y="369"/>
                </a:lnTo>
                <a:lnTo>
                  <a:pt x="62" y="370"/>
                </a:lnTo>
                <a:lnTo>
                  <a:pt x="63" y="370"/>
                </a:lnTo>
                <a:lnTo>
                  <a:pt x="64" y="370"/>
                </a:lnTo>
                <a:lnTo>
                  <a:pt x="64" y="368"/>
                </a:lnTo>
                <a:lnTo>
                  <a:pt x="65" y="368"/>
                </a:lnTo>
                <a:lnTo>
                  <a:pt x="65" y="370"/>
                </a:lnTo>
                <a:lnTo>
                  <a:pt x="66" y="370"/>
                </a:lnTo>
                <a:lnTo>
                  <a:pt x="67" y="370"/>
                </a:lnTo>
                <a:lnTo>
                  <a:pt x="68" y="370"/>
                </a:lnTo>
                <a:lnTo>
                  <a:pt x="69" y="370"/>
                </a:lnTo>
                <a:lnTo>
                  <a:pt x="69" y="368"/>
                </a:lnTo>
                <a:lnTo>
                  <a:pt x="70" y="367"/>
                </a:lnTo>
                <a:lnTo>
                  <a:pt x="70" y="369"/>
                </a:lnTo>
                <a:lnTo>
                  <a:pt x="71" y="370"/>
                </a:lnTo>
                <a:lnTo>
                  <a:pt x="72" y="370"/>
                </a:lnTo>
                <a:lnTo>
                  <a:pt x="73" y="370"/>
                </a:lnTo>
                <a:lnTo>
                  <a:pt x="74" y="370"/>
                </a:lnTo>
                <a:lnTo>
                  <a:pt x="75" y="370"/>
                </a:lnTo>
                <a:lnTo>
                  <a:pt x="76" y="370"/>
                </a:lnTo>
                <a:lnTo>
                  <a:pt x="77" y="370"/>
                </a:lnTo>
                <a:lnTo>
                  <a:pt x="77" y="368"/>
                </a:lnTo>
                <a:lnTo>
                  <a:pt x="78" y="368"/>
                </a:lnTo>
                <a:lnTo>
                  <a:pt x="79" y="368"/>
                </a:lnTo>
                <a:lnTo>
                  <a:pt x="79" y="366"/>
                </a:lnTo>
                <a:lnTo>
                  <a:pt x="80" y="367"/>
                </a:lnTo>
                <a:lnTo>
                  <a:pt x="80" y="363"/>
                </a:lnTo>
                <a:lnTo>
                  <a:pt x="81" y="347"/>
                </a:lnTo>
                <a:lnTo>
                  <a:pt x="81" y="314"/>
                </a:lnTo>
                <a:lnTo>
                  <a:pt x="82" y="266"/>
                </a:lnTo>
                <a:lnTo>
                  <a:pt x="82" y="144"/>
                </a:lnTo>
                <a:lnTo>
                  <a:pt x="83" y="94"/>
                </a:lnTo>
                <a:lnTo>
                  <a:pt x="83" y="20"/>
                </a:lnTo>
                <a:lnTo>
                  <a:pt x="84" y="0"/>
                </a:lnTo>
                <a:lnTo>
                  <a:pt x="84" y="349"/>
                </a:lnTo>
                <a:lnTo>
                  <a:pt x="85" y="365"/>
                </a:lnTo>
                <a:lnTo>
                  <a:pt x="85" y="368"/>
                </a:lnTo>
                <a:lnTo>
                  <a:pt x="86" y="368"/>
                </a:lnTo>
                <a:lnTo>
                  <a:pt x="86" y="369"/>
                </a:lnTo>
                <a:lnTo>
                  <a:pt x="87" y="367"/>
                </a:lnTo>
                <a:lnTo>
                  <a:pt x="87" y="365"/>
                </a:lnTo>
                <a:lnTo>
                  <a:pt x="88" y="368"/>
                </a:lnTo>
                <a:lnTo>
                  <a:pt x="88" y="370"/>
                </a:lnTo>
                <a:lnTo>
                  <a:pt x="89" y="370"/>
                </a:lnTo>
                <a:lnTo>
                  <a:pt x="89" y="368"/>
                </a:lnTo>
                <a:lnTo>
                  <a:pt x="90" y="364"/>
                </a:lnTo>
                <a:lnTo>
                  <a:pt x="90" y="359"/>
                </a:lnTo>
                <a:lnTo>
                  <a:pt x="91" y="355"/>
                </a:lnTo>
                <a:lnTo>
                  <a:pt x="91" y="364"/>
                </a:lnTo>
                <a:lnTo>
                  <a:pt x="92" y="367"/>
                </a:lnTo>
                <a:lnTo>
                  <a:pt x="92" y="369"/>
                </a:lnTo>
                <a:lnTo>
                  <a:pt x="93" y="369"/>
                </a:lnTo>
                <a:lnTo>
                  <a:pt x="93" y="370"/>
                </a:lnTo>
                <a:lnTo>
                  <a:pt x="94" y="369"/>
                </a:lnTo>
                <a:lnTo>
                  <a:pt x="94" y="370"/>
                </a:lnTo>
                <a:lnTo>
                  <a:pt x="95" y="369"/>
                </a:lnTo>
                <a:lnTo>
                  <a:pt x="95" y="366"/>
                </a:lnTo>
                <a:lnTo>
                  <a:pt x="96" y="365"/>
                </a:lnTo>
                <a:lnTo>
                  <a:pt x="96" y="368"/>
                </a:lnTo>
                <a:lnTo>
                  <a:pt x="97" y="369"/>
                </a:lnTo>
                <a:lnTo>
                  <a:pt x="97" y="370"/>
                </a:lnTo>
                <a:lnTo>
                  <a:pt x="98" y="370"/>
                </a:lnTo>
                <a:lnTo>
                  <a:pt x="99" y="369"/>
                </a:lnTo>
                <a:lnTo>
                  <a:pt x="99" y="370"/>
                </a:lnTo>
                <a:lnTo>
                  <a:pt x="100" y="369"/>
                </a:lnTo>
                <a:lnTo>
                  <a:pt x="100" y="370"/>
                </a:lnTo>
                <a:lnTo>
                  <a:pt x="101" y="370"/>
                </a:lnTo>
                <a:lnTo>
                  <a:pt x="101" y="369"/>
                </a:lnTo>
                <a:lnTo>
                  <a:pt x="102" y="369"/>
                </a:lnTo>
                <a:lnTo>
                  <a:pt x="102" y="368"/>
                </a:lnTo>
                <a:lnTo>
                  <a:pt x="103" y="369"/>
                </a:lnTo>
                <a:lnTo>
                  <a:pt x="104" y="367"/>
                </a:lnTo>
                <a:lnTo>
                  <a:pt x="104" y="368"/>
                </a:lnTo>
                <a:lnTo>
                  <a:pt x="105" y="368"/>
                </a:lnTo>
                <a:lnTo>
                  <a:pt x="105" y="369"/>
                </a:lnTo>
                <a:lnTo>
                  <a:pt x="106" y="369"/>
                </a:lnTo>
                <a:lnTo>
                  <a:pt x="107" y="369"/>
                </a:lnTo>
                <a:lnTo>
                  <a:pt x="108" y="369"/>
                </a:lnTo>
                <a:lnTo>
                  <a:pt x="109" y="369"/>
                </a:lnTo>
                <a:lnTo>
                  <a:pt x="110" y="369"/>
                </a:lnTo>
                <a:lnTo>
                  <a:pt x="111" y="369"/>
                </a:lnTo>
                <a:lnTo>
                  <a:pt x="111" y="356"/>
                </a:lnTo>
                <a:lnTo>
                  <a:pt x="112" y="336"/>
                </a:lnTo>
                <a:lnTo>
                  <a:pt x="112" y="267"/>
                </a:lnTo>
                <a:lnTo>
                  <a:pt x="113" y="235"/>
                </a:lnTo>
                <a:lnTo>
                  <a:pt x="113" y="168"/>
                </a:lnTo>
                <a:lnTo>
                  <a:pt x="114" y="127"/>
                </a:lnTo>
                <a:lnTo>
                  <a:pt x="114" y="71"/>
                </a:lnTo>
                <a:lnTo>
                  <a:pt x="115" y="150"/>
                </a:lnTo>
                <a:lnTo>
                  <a:pt x="115" y="248"/>
                </a:lnTo>
                <a:lnTo>
                  <a:pt x="116" y="279"/>
                </a:lnTo>
                <a:lnTo>
                  <a:pt x="116" y="367"/>
                </a:lnTo>
                <a:lnTo>
                  <a:pt x="117" y="368"/>
                </a:lnTo>
                <a:lnTo>
                  <a:pt x="117" y="369"/>
                </a:lnTo>
                <a:lnTo>
                  <a:pt x="118" y="369"/>
                </a:lnTo>
                <a:lnTo>
                  <a:pt x="118" y="370"/>
                </a:lnTo>
                <a:lnTo>
                  <a:pt x="119" y="370"/>
                </a:lnTo>
                <a:lnTo>
                  <a:pt x="120" y="370"/>
                </a:lnTo>
                <a:lnTo>
                  <a:pt x="121" y="370"/>
                </a:lnTo>
                <a:lnTo>
                  <a:pt x="121" y="369"/>
                </a:lnTo>
                <a:lnTo>
                  <a:pt x="122" y="368"/>
                </a:lnTo>
                <a:lnTo>
                  <a:pt x="122" y="364"/>
                </a:lnTo>
                <a:lnTo>
                  <a:pt x="123" y="364"/>
                </a:lnTo>
                <a:lnTo>
                  <a:pt x="123" y="369"/>
                </a:lnTo>
                <a:lnTo>
                  <a:pt x="124" y="370"/>
                </a:lnTo>
                <a:lnTo>
                  <a:pt x="125" y="370"/>
                </a:lnTo>
                <a:lnTo>
                  <a:pt x="125" y="369"/>
                </a:lnTo>
                <a:lnTo>
                  <a:pt x="126" y="369"/>
                </a:lnTo>
                <a:lnTo>
                  <a:pt x="127" y="368"/>
                </a:lnTo>
                <a:lnTo>
                  <a:pt x="127" y="343"/>
                </a:lnTo>
                <a:lnTo>
                  <a:pt x="128" y="310"/>
                </a:lnTo>
                <a:lnTo>
                  <a:pt x="128" y="223"/>
                </a:lnTo>
                <a:lnTo>
                  <a:pt x="129" y="230"/>
                </a:lnTo>
                <a:lnTo>
                  <a:pt x="129" y="321"/>
                </a:lnTo>
                <a:lnTo>
                  <a:pt x="130" y="363"/>
                </a:lnTo>
                <a:lnTo>
                  <a:pt x="130" y="369"/>
                </a:lnTo>
                <a:lnTo>
                  <a:pt x="131" y="370"/>
                </a:lnTo>
                <a:lnTo>
                  <a:pt x="132" y="370"/>
                </a:lnTo>
                <a:lnTo>
                  <a:pt x="133" y="370"/>
                </a:lnTo>
                <a:lnTo>
                  <a:pt x="134" y="370"/>
                </a:lnTo>
                <a:lnTo>
                  <a:pt x="135" y="370"/>
                </a:lnTo>
                <a:lnTo>
                  <a:pt x="136" y="370"/>
                </a:lnTo>
                <a:lnTo>
                  <a:pt x="137" y="370"/>
                </a:lnTo>
                <a:lnTo>
                  <a:pt x="138" y="370"/>
                </a:lnTo>
                <a:lnTo>
                  <a:pt x="139" y="370"/>
                </a:lnTo>
                <a:lnTo>
                  <a:pt x="140" y="370"/>
                </a:lnTo>
                <a:lnTo>
                  <a:pt x="141" y="370"/>
                </a:lnTo>
                <a:lnTo>
                  <a:pt x="142" y="370"/>
                </a:lnTo>
                <a:lnTo>
                  <a:pt x="142" y="369"/>
                </a:lnTo>
                <a:lnTo>
                  <a:pt x="143" y="367"/>
                </a:lnTo>
                <a:lnTo>
                  <a:pt x="143" y="368"/>
                </a:lnTo>
                <a:lnTo>
                  <a:pt x="144" y="370"/>
                </a:lnTo>
                <a:lnTo>
                  <a:pt x="145" y="368"/>
                </a:lnTo>
                <a:lnTo>
                  <a:pt x="145" y="367"/>
                </a:lnTo>
                <a:lnTo>
                  <a:pt x="146" y="368"/>
                </a:lnTo>
                <a:lnTo>
                  <a:pt x="146" y="370"/>
                </a:lnTo>
                <a:lnTo>
                  <a:pt x="147" y="370"/>
                </a:lnTo>
                <a:lnTo>
                  <a:pt x="148" y="370"/>
                </a:lnTo>
                <a:lnTo>
                  <a:pt x="149" y="370"/>
                </a:lnTo>
                <a:lnTo>
                  <a:pt x="150" y="370"/>
                </a:lnTo>
                <a:lnTo>
                  <a:pt x="151" y="370"/>
                </a:lnTo>
                <a:lnTo>
                  <a:pt x="152" y="370"/>
                </a:lnTo>
                <a:lnTo>
                  <a:pt x="153" y="370"/>
                </a:lnTo>
                <a:lnTo>
                  <a:pt x="154" y="370"/>
                </a:lnTo>
                <a:lnTo>
                  <a:pt x="155" y="370"/>
                </a:lnTo>
                <a:lnTo>
                  <a:pt x="156" y="370"/>
                </a:lnTo>
                <a:lnTo>
                  <a:pt x="157" y="370"/>
                </a:lnTo>
                <a:lnTo>
                  <a:pt x="158" y="370"/>
                </a:lnTo>
                <a:lnTo>
                  <a:pt x="159" y="370"/>
                </a:lnTo>
                <a:lnTo>
                  <a:pt x="159" y="369"/>
                </a:lnTo>
                <a:lnTo>
                  <a:pt x="160" y="367"/>
                </a:lnTo>
                <a:lnTo>
                  <a:pt x="160" y="364"/>
                </a:lnTo>
                <a:lnTo>
                  <a:pt x="161" y="365"/>
                </a:lnTo>
                <a:lnTo>
                  <a:pt x="161" y="369"/>
                </a:lnTo>
                <a:lnTo>
                  <a:pt x="162" y="370"/>
                </a:lnTo>
                <a:lnTo>
                  <a:pt x="163" y="370"/>
                </a:lnTo>
                <a:lnTo>
                  <a:pt x="164" y="369"/>
                </a:lnTo>
                <a:lnTo>
                  <a:pt x="165" y="367"/>
                </a:lnTo>
                <a:lnTo>
                  <a:pt x="165" y="366"/>
                </a:lnTo>
                <a:lnTo>
                  <a:pt x="166" y="366"/>
                </a:lnTo>
                <a:lnTo>
                  <a:pt x="166" y="367"/>
                </a:lnTo>
                <a:lnTo>
                  <a:pt x="167" y="368"/>
                </a:lnTo>
                <a:lnTo>
                  <a:pt x="167" y="370"/>
                </a:lnTo>
                <a:lnTo>
                  <a:pt x="168" y="370"/>
                </a:lnTo>
                <a:lnTo>
                  <a:pt x="169" y="368"/>
                </a:lnTo>
                <a:lnTo>
                  <a:pt x="169" y="362"/>
                </a:lnTo>
                <a:lnTo>
                  <a:pt x="170" y="362"/>
                </a:lnTo>
                <a:lnTo>
                  <a:pt x="170" y="368"/>
                </a:lnTo>
                <a:lnTo>
                  <a:pt x="171" y="370"/>
                </a:lnTo>
                <a:lnTo>
                  <a:pt x="172" y="370"/>
                </a:lnTo>
                <a:lnTo>
                  <a:pt x="173" y="370"/>
                </a:lnTo>
                <a:lnTo>
                  <a:pt x="174" y="370"/>
                </a:lnTo>
                <a:lnTo>
                  <a:pt x="175" y="370"/>
                </a:lnTo>
                <a:lnTo>
                  <a:pt x="176" y="370"/>
                </a:lnTo>
                <a:lnTo>
                  <a:pt x="177" y="370"/>
                </a:lnTo>
                <a:lnTo>
                  <a:pt x="178" y="370"/>
                </a:lnTo>
                <a:lnTo>
                  <a:pt x="179" y="370"/>
                </a:lnTo>
                <a:lnTo>
                  <a:pt x="180" y="370"/>
                </a:lnTo>
                <a:lnTo>
                  <a:pt x="180" y="369"/>
                </a:lnTo>
                <a:lnTo>
                  <a:pt x="181" y="368"/>
                </a:lnTo>
                <a:lnTo>
                  <a:pt x="181" y="361"/>
                </a:lnTo>
                <a:lnTo>
                  <a:pt x="182" y="361"/>
                </a:lnTo>
                <a:lnTo>
                  <a:pt x="182" y="368"/>
                </a:lnTo>
                <a:lnTo>
                  <a:pt x="183" y="370"/>
                </a:lnTo>
                <a:lnTo>
                  <a:pt x="184" y="370"/>
                </a:lnTo>
                <a:lnTo>
                  <a:pt x="185" y="371"/>
                </a:lnTo>
                <a:lnTo>
                  <a:pt x="185" y="370"/>
                </a:lnTo>
                <a:lnTo>
                  <a:pt x="186" y="370"/>
                </a:lnTo>
                <a:lnTo>
                  <a:pt x="186" y="368"/>
                </a:lnTo>
                <a:lnTo>
                  <a:pt x="187" y="363"/>
                </a:lnTo>
                <a:lnTo>
                  <a:pt x="187" y="357"/>
                </a:lnTo>
                <a:lnTo>
                  <a:pt x="188" y="361"/>
                </a:lnTo>
                <a:lnTo>
                  <a:pt x="188" y="367"/>
                </a:lnTo>
                <a:lnTo>
                  <a:pt x="189" y="369"/>
                </a:lnTo>
                <a:lnTo>
                  <a:pt x="189" y="370"/>
                </a:lnTo>
                <a:lnTo>
                  <a:pt x="190" y="370"/>
                </a:lnTo>
                <a:lnTo>
                  <a:pt x="190" y="368"/>
                </a:lnTo>
                <a:lnTo>
                  <a:pt x="191" y="364"/>
                </a:lnTo>
                <a:lnTo>
                  <a:pt x="191" y="359"/>
                </a:lnTo>
                <a:lnTo>
                  <a:pt x="192" y="364"/>
                </a:lnTo>
                <a:lnTo>
                  <a:pt x="192" y="370"/>
                </a:lnTo>
                <a:lnTo>
                  <a:pt x="193" y="370"/>
                </a:lnTo>
                <a:lnTo>
                  <a:pt x="194" y="367"/>
                </a:lnTo>
                <a:lnTo>
                  <a:pt x="194" y="340"/>
                </a:lnTo>
                <a:lnTo>
                  <a:pt x="195" y="311"/>
                </a:lnTo>
                <a:lnTo>
                  <a:pt x="195" y="338"/>
                </a:lnTo>
                <a:lnTo>
                  <a:pt x="196" y="361"/>
                </a:lnTo>
                <a:lnTo>
                  <a:pt x="196" y="370"/>
                </a:lnTo>
                <a:lnTo>
                  <a:pt x="197" y="370"/>
                </a:lnTo>
                <a:lnTo>
                  <a:pt x="198" y="370"/>
                </a:lnTo>
                <a:lnTo>
                  <a:pt x="199" y="370"/>
                </a:lnTo>
                <a:lnTo>
                  <a:pt x="199" y="369"/>
                </a:lnTo>
                <a:lnTo>
                  <a:pt x="200" y="367"/>
                </a:lnTo>
                <a:lnTo>
                  <a:pt x="200" y="365"/>
                </a:lnTo>
                <a:lnTo>
                  <a:pt x="201" y="368"/>
                </a:lnTo>
                <a:lnTo>
                  <a:pt x="201" y="369"/>
                </a:lnTo>
                <a:lnTo>
                  <a:pt x="202" y="369"/>
                </a:lnTo>
                <a:lnTo>
                  <a:pt x="202" y="370"/>
                </a:lnTo>
                <a:lnTo>
                  <a:pt x="203" y="370"/>
                </a:lnTo>
                <a:lnTo>
                  <a:pt x="204" y="370"/>
                </a:lnTo>
                <a:lnTo>
                  <a:pt x="205" y="370"/>
                </a:lnTo>
                <a:lnTo>
                  <a:pt x="206" y="370"/>
                </a:lnTo>
                <a:lnTo>
                  <a:pt x="207" y="370"/>
                </a:lnTo>
                <a:lnTo>
                  <a:pt x="208" y="371"/>
                </a:lnTo>
                <a:lnTo>
                  <a:pt x="208" y="370"/>
                </a:lnTo>
                <a:lnTo>
                  <a:pt x="209" y="371"/>
                </a:lnTo>
                <a:lnTo>
                  <a:pt x="210" y="371"/>
                </a:lnTo>
                <a:lnTo>
                  <a:pt x="211" y="371"/>
                </a:lnTo>
                <a:lnTo>
                  <a:pt x="211" y="370"/>
                </a:lnTo>
                <a:lnTo>
                  <a:pt x="212" y="370"/>
                </a:lnTo>
                <a:lnTo>
                  <a:pt x="212" y="369"/>
                </a:lnTo>
                <a:lnTo>
                  <a:pt x="213" y="369"/>
                </a:lnTo>
                <a:lnTo>
                  <a:pt x="213" y="370"/>
                </a:lnTo>
                <a:lnTo>
                  <a:pt x="214" y="370"/>
                </a:lnTo>
                <a:lnTo>
                  <a:pt x="215" y="370"/>
                </a:lnTo>
                <a:lnTo>
                  <a:pt x="215" y="371"/>
                </a:lnTo>
                <a:lnTo>
                  <a:pt x="216" y="371"/>
                </a:lnTo>
                <a:lnTo>
                  <a:pt x="217" y="370"/>
                </a:lnTo>
                <a:lnTo>
                  <a:pt x="218" y="370"/>
                </a:lnTo>
                <a:lnTo>
                  <a:pt x="219" y="370"/>
                </a:lnTo>
                <a:lnTo>
                  <a:pt x="219" y="367"/>
                </a:lnTo>
                <a:lnTo>
                  <a:pt x="220" y="365"/>
                </a:lnTo>
                <a:lnTo>
                  <a:pt x="220" y="362"/>
                </a:lnTo>
                <a:lnTo>
                  <a:pt x="221" y="360"/>
                </a:lnTo>
                <a:lnTo>
                  <a:pt x="221" y="358"/>
                </a:lnTo>
                <a:lnTo>
                  <a:pt x="222" y="362"/>
                </a:lnTo>
                <a:lnTo>
                  <a:pt x="222" y="369"/>
                </a:lnTo>
                <a:lnTo>
                  <a:pt x="223" y="370"/>
                </a:lnTo>
                <a:lnTo>
                  <a:pt x="224" y="370"/>
                </a:lnTo>
                <a:lnTo>
                  <a:pt x="225" y="370"/>
                </a:lnTo>
                <a:lnTo>
                  <a:pt x="226" y="370"/>
                </a:lnTo>
                <a:lnTo>
                  <a:pt x="227" y="370"/>
                </a:lnTo>
                <a:lnTo>
                  <a:pt x="228" y="370"/>
                </a:lnTo>
                <a:lnTo>
                  <a:pt x="229" y="370"/>
                </a:lnTo>
                <a:lnTo>
                  <a:pt x="230" y="369"/>
                </a:lnTo>
                <a:lnTo>
                  <a:pt x="230" y="365"/>
                </a:lnTo>
                <a:lnTo>
                  <a:pt x="231" y="364"/>
                </a:lnTo>
                <a:lnTo>
                  <a:pt x="232" y="360"/>
                </a:lnTo>
                <a:lnTo>
                  <a:pt x="232" y="327"/>
                </a:lnTo>
                <a:lnTo>
                  <a:pt x="233" y="304"/>
                </a:lnTo>
                <a:lnTo>
                  <a:pt x="233" y="236"/>
                </a:lnTo>
                <a:lnTo>
                  <a:pt x="234" y="191"/>
                </a:lnTo>
                <a:lnTo>
                  <a:pt x="234" y="97"/>
                </a:lnTo>
                <a:lnTo>
                  <a:pt x="235" y="59"/>
                </a:lnTo>
                <a:lnTo>
                  <a:pt x="235" y="21"/>
                </a:lnTo>
                <a:lnTo>
                  <a:pt x="236" y="13"/>
                </a:lnTo>
                <a:lnTo>
                  <a:pt x="236" y="12"/>
                </a:lnTo>
                <a:lnTo>
                  <a:pt x="237" y="107"/>
                </a:lnTo>
                <a:lnTo>
                  <a:pt x="237" y="360"/>
                </a:lnTo>
                <a:lnTo>
                  <a:pt x="238" y="364"/>
                </a:lnTo>
                <a:lnTo>
                  <a:pt x="238" y="366"/>
                </a:lnTo>
                <a:lnTo>
                  <a:pt x="239" y="367"/>
                </a:lnTo>
                <a:lnTo>
                  <a:pt x="239" y="368"/>
                </a:lnTo>
                <a:lnTo>
                  <a:pt x="240" y="369"/>
                </a:lnTo>
                <a:lnTo>
                  <a:pt x="241" y="369"/>
                </a:lnTo>
                <a:lnTo>
                  <a:pt x="242" y="369"/>
                </a:lnTo>
                <a:lnTo>
                  <a:pt x="243" y="370"/>
                </a:lnTo>
                <a:lnTo>
                  <a:pt x="244" y="370"/>
                </a:lnTo>
                <a:lnTo>
                  <a:pt x="245" y="369"/>
                </a:lnTo>
                <a:lnTo>
                  <a:pt x="246" y="370"/>
                </a:lnTo>
                <a:lnTo>
                  <a:pt x="247" y="370"/>
                </a:lnTo>
                <a:lnTo>
                  <a:pt x="248" y="370"/>
                </a:lnTo>
                <a:lnTo>
                  <a:pt x="248" y="368"/>
                </a:lnTo>
                <a:lnTo>
                  <a:pt x="249" y="363"/>
                </a:lnTo>
                <a:lnTo>
                  <a:pt x="249" y="335"/>
                </a:lnTo>
                <a:lnTo>
                  <a:pt x="250" y="329"/>
                </a:lnTo>
                <a:lnTo>
                  <a:pt x="250" y="362"/>
                </a:lnTo>
                <a:lnTo>
                  <a:pt x="251" y="368"/>
                </a:lnTo>
                <a:lnTo>
                  <a:pt x="251" y="369"/>
                </a:lnTo>
                <a:lnTo>
                  <a:pt x="252" y="369"/>
                </a:lnTo>
                <a:lnTo>
                  <a:pt x="252" y="354"/>
                </a:lnTo>
                <a:lnTo>
                  <a:pt x="253" y="334"/>
                </a:lnTo>
                <a:lnTo>
                  <a:pt x="253" y="289"/>
                </a:lnTo>
                <a:lnTo>
                  <a:pt x="254" y="310"/>
                </a:lnTo>
                <a:lnTo>
                  <a:pt x="254" y="365"/>
                </a:lnTo>
                <a:lnTo>
                  <a:pt x="255" y="368"/>
                </a:lnTo>
                <a:lnTo>
                  <a:pt x="256" y="367"/>
                </a:lnTo>
                <a:lnTo>
                  <a:pt x="257" y="369"/>
                </a:lnTo>
                <a:lnTo>
                  <a:pt x="257" y="368"/>
                </a:lnTo>
                <a:lnTo>
                  <a:pt x="258" y="363"/>
                </a:lnTo>
                <a:lnTo>
                  <a:pt x="258" y="345"/>
                </a:lnTo>
                <a:lnTo>
                  <a:pt x="259" y="347"/>
                </a:lnTo>
                <a:lnTo>
                  <a:pt x="259" y="367"/>
                </a:lnTo>
                <a:lnTo>
                  <a:pt x="260" y="369"/>
                </a:lnTo>
                <a:lnTo>
                  <a:pt x="260" y="370"/>
                </a:lnTo>
                <a:lnTo>
                  <a:pt x="261" y="370"/>
                </a:lnTo>
                <a:lnTo>
                  <a:pt x="261" y="369"/>
                </a:lnTo>
                <a:lnTo>
                  <a:pt x="262" y="368"/>
                </a:lnTo>
                <a:lnTo>
                  <a:pt x="263" y="367"/>
                </a:lnTo>
                <a:lnTo>
                  <a:pt x="263" y="365"/>
                </a:lnTo>
                <a:lnTo>
                  <a:pt x="264" y="367"/>
                </a:lnTo>
                <a:lnTo>
                  <a:pt x="264" y="370"/>
                </a:lnTo>
                <a:lnTo>
                  <a:pt x="265" y="370"/>
                </a:lnTo>
                <a:lnTo>
                  <a:pt x="266" y="370"/>
                </a:lnTo>
                <a:lnTo>
                  <a:pt x="267" y="370"/>
                </a:lnTo>
                <a:lnTo>
                  <a:pt x="268" y="370"/>
                </a:lnTo>
                <a:lnTo>
                  <a:pt x="268" y="369"/>
                </a:lnTo>
                <a:lnTo>
                  <a:pt x="269" y="369"/>
                </a:lnTo>
                <a:lnTo>
                  <a:pt x="269" y="370"/>
                </a:lnTo>
                <a:lnTo>
                  <a:pt x="270" y="370"/>
                </a:lnTo>
                <a:lnTo>
                  <a:pt x="271" y="370"/>
                </a:lnTo>
                <a:lnTo>
                  <a:pt x="272" y="370"/>
                </a:lnTo>
                <a:lnTo>
                  <a:pt x="272" y="369"/>
                </a:lnTo>
                <a:lnTo>
                  <a:pt x="273" y="370"/>
                </a:lnTo>
                <a:lnTo>
                  <a:pt x="274" y="370"/>
                </a:lnTo>
                <a:lnTo>
                  <a:pt x="275" y="370"/>
                </a:lnTo>
                <a:lnTo>
                  <a:pt x="276" y="370"/>
                </a:lnTo>
                <a:lnTo>
                  <a:pt x="277" y="370"/>
                </a:lnTo>
                <a:lnTo>
                  <a:pt x="278" y="370"/>
                </a:lnTo>
                <a:lnTo>
                  <a:pt x="278" y="369"/>
                </a:lnTo>
                <a:lnTo>
                  <a:pt x="279" y="368"/>
                </a:lnTo>
                <a:lnTo>
                  <a:pt x="280" y="367"/>
                </a:lnTo>
                <a:lnTo>
                  <a:pt x="281" y="369"/>
                </a:lnTo>
                <a:lnTo>
                  <a:pt x="282" y="368"/>
                </a:lnTo>
                <a:lnTo>
                  <a:pt x="282" y="369"/>
                </a:lnTo>
                <a:lnTo>
                  <a:pt x="283" y="370"/>
                </a:lnTo>
                <a:lnTo>
                  <a:pt x="284" y="370"/>
                </a:lnTo>
                <a:lnTo>
                  <a:pt x="285" y="370"/>
                </a:lnTo>
                <a:lnTo>
                  <a:pt x="286" y="370"/>
                </a:lnTo>
                <a:lnTo>
                  <a:pt x="287" y="370"/>
                </a:lnTo>
                <a:lnTo>
                  <a:pt x="287" y="367"/>
                </a:lnTo>
                <a:lnTo>
                  <a:pt x="288" y="365"/>
                </a:lnTo>
                <a:lnTo>
                  <a:pt x="288" y="368"/>
                </a:lnTo>
                <a:lnTo>
                  <a:pt x="289" y="369"/>
                </a:lnTo>
                <a:lnTo>
                  <a:pt x="289" y="370"/>
                </a:lnTo>
                <a:lnTo>
                  <a:pt x="290" y="370"/>
                </a:lnTo>
                <a:lnTo>
                  <a:pt x="290" y="369"/>
                </a:lnTo>
                <a:lnTo>
                  <a:pt x="291" y="370"/>
                </a:lnTo>
                <a:lnTo>
                  <a:pt x="291" y="369"/>
                </a:lnTo>
                <a:lnTo>
                  <a:pt x="292" y="367"/>
                </a:lnTo>
                <a:lnTo>
                  <a:pt x="292" y="340"/>
                </a:lnTo>
                <a:lnTo>
                  <a:pt x="293" y="309"/>
                </a:lnTo>
                <a:lnTo>
                  <a:pt x="293" y="227"/>
                </a:lnTo>
                <a:lnTo>
                  <a:pt x="294" y="234"/>
                </a:lnTo>
                <a:lnTo>
                  <a:pt x="294" y="316"/>
                </a:lnTo>
                <a:lnTo>
                  <a:pt x="295" y="361"/>
                </a:lnTo>
                <a:lnTo>
                  <a:pt x="295" y="369"/>
                </a:lnTo>
                <a:lnTo>
                  <a:pt x="296" y="369"/>
                </a:lnTo>
                <a:lnTo>
                  <a:pt x="296" y="370"/>
                </a:lnTo>
                <a:lnTo>
                  <a:pt x="297" y="370"/>
                </a:lnTo>
                <a:lnTo>
                  <a:pt x="298" y="369"/>
                </a:lnTo>
                <a:lnTo>
                  <a:pt x="298" y="370"/>
                </a:lnTo>
                <a:lnTo>
                  <a:pt x="299" y="370"/>
                </a:lnTo>
                <a:lnTo>
                  <a:pt x="300" y="370"/>
                </a:lnTo>
                <a:lnTo>
                  <a:pt x="301" y="370"/>
                </a:lnTo>
                <a:lnTo>
                  <a:pt x="302" y="370"/>
                </a:lnTo>
                <a:lnTo>
                  <a:pt x="303" y="370"/>
                </a:lnTo>
                <a:lnTo>
                  <a:pt x="304" y="370"/>
                </a:lnTo>
                <a:lnTo>
                  <a:pt x="305" y="370"/>
                </a:lnTo>
                <a:lnTo>
                  <a:pt x="306" y="370"/>
                </a:lnTo>
                <a:lnTo>
                  <a:pt x="307" y="369"/>
                </a:lnTo>
                <a:lnTo>
                  <a:pt x="307" y="368"/>
                </a:lnTo>
                <a:lnTo>
                  <a:pt x="308" y="369"/>
                </a:lnTo>
                <a:lnTo>
                  <a:pt x="308" y="367"/>
                </a:lnTo>
                <a:lnTo>
                  <a:pt x="309" y="361"/>
                </a:lnTo>
                <a:lnTo>
                  <a:pt x="309" y="317"/>
                </a:lnTo>
                <a:lnTo>
                  <a:pt x="310" y="277"/>
                </a:lnTo>
                <a:lnTo>
                  <a:pt x="310" y="237"/>
                </a:lnTo>
                <a:lnTo>
                  <a:pt x="311" y="307"/>
                </a:lnTo>
                <a:lnTo>
                  <a:pt x="311" y="368"/>
                </a:lnTo>
                <a:lnTo>
                  <a:pt x="312" y="370"/>
                </a:lnTo>
                <a:lnTo>
                  <a:pt x="313" y="370"/>
                </a:lnTo>
                <a:lnTo>
                  <a:pt x="314" y="370"/>
                </a:lnTo>
                <a:lnTo>
                  <a:pt x="315" y="370"/>
                </a:lnTo>
                <a:lnTo>
                  <a:pt x="316" y="370"/>
                </a:lnTo>
                <a:lnTo>
                  <a:pt x="317" y="369"/>
                </a:lnTo>
                <a:lnTo>
                  <a:pt x="317" y="370"/>
                </a:lnTo>
                <a:lnTo>
                  <a:pt x="318" y="370"/>
                </a:lnTo>
                <a:lnTo>
                  <a:pt x="319" y="370"/>
                </a:lnTo>
                <a:lnTo>
                  <a:pt x="320" y="370"/>
                </a:lnTo>
                <a:lnTo>
                  <a:pt x="321" y="370"/>
                </a:lnTo>
                <a:lnTo>
                  <a:pt x="322" y="370"/>
                </a:lnTo>
                <a:lnTo>
                  <a:pt x="323" y="370"/>
                </a:lnTo>
                <a:lnTo>
                  <a:pt x="324" y="370"/>
                </a:lnTo>
                <a:lnTo>
                  <a:pt x="325" y="370"/>
                </a:lnTo>
                <a:lnTo>
                  <a:pt x="326" y="370"/>
                </a:lnTo>
                <a:lnTo>
                  <a:pt x="327" y="370"/>
                </a:lnTo>
                <a:lnTo>
                  <a:pt x="328" y="370"/>
                </a:lnTo>
                <a:lnTo>
                  <a:pt x="328" y="369"/>
                </a:lnTo>
                <a:lnTo>
                  <a:pt x="329" y="369"/>
                </a:lnTo>
                <a:lnTo>
                  <a:pt x="329" y="370"/>
                </a:lnTo>
                <a:lnTo>
                  <a:pt x="330" y="370"/>
                </a:lnTo>
                <a:lnTo>
                  <a:pt x="331" y="370"/>
                </a:lnTo>
                <a:lnTo>
                  <a:pt x="332" y="370"/>
                </a:lnTo>
                <a:lnTo>
                  <a:pt x="333" y="370"/>
                </a:lnTo>
                <a:lnTo>
                  <a:pt x="334" y="370"/>
                </a:lnTo>
                <a:lnTo>
                  <a:pt x="335" y="370"/>
                </a:lnTo>
                <a:lnTo>
                  <a:pt x="336" y="370"/>
                </a:lnTo>
                <a:lnTo>
                  <a:pt x="336" y="369"/>
                </a:lnTo>
                <a:lnTo>
                  <a:pt x="337" y="369"/>
                </a:lnTo>
                <a:lnTo>
                  <a:pt x="337" y="370"/>
                </a:lnTo>
                <a:lnTo>
                  <a:pt x="338" y="370"/>
                </a:lnTo>
                <a:lnTo>
                  <a:pt x="339" y="370"/>
                </a:lnTo>
                <a:lnTo>
                  <a:pt x="340" y="370"/>
                </a:lnTo>
                <a:lnTo>
                  <a:pt x="341" y="370"/>
                </a:lnTo>
                <a:lnTo>
                  <a:pt x="342" y="370"/>
                </a:lnTo>
                <a:lnTo>
                  <a:pt x="343" y="370"/>
                </a:lnTo>
                <a:lnTo>
                  <a:pt x="344" y="370"/>
                </a:lnTo>
                <a:lnTo>
                  <a:pt x="345" y="370"/>
                </a:lnTo>
                <a:lnTo>
                  <a:pt x="345" y="369"/>
                </a:lnTo>
                <a:lnTo>
                  <a:pt x="346" y="370"/>
                </a:lnTo>
                <a:lnTo>
                  <a:pt x="347" y="370"/>
                </a:lnTo>
                <a:lnTo>
                  <a:pt x="348" y="370"/>
                </a:lnTo>
                <a:lnTo>
                  <a:pt x="349" y="370"/>
                </a:lnTo>
                <a:lnTo>
                  <a:pt x="350" y="370"/>
                </a:lnTo>
                <a:lnTo>
                  <a:pt x="351" y="370"/>
                </a:lnTo>
                <a:lnTo>
                  <a:pt x="352" y="370"/>
                </a:lnTo>
                <a:lnTo>
                  <a:pt x="353" y="370"/>
                </a:lnTo>
                <a:lnTo>
                  <a:pt x="354" y="369"/>
                </a:lnTo>
                <a:lnTo>
                  <a:pt x="355" y="370"/>
                </a:lnTo>
                <a:lnTo>
                  <a:pt x="356" y="370"/>
                </a:lnTo>
                <a:lnTo>
                  <a:pt x="357" y="370"/>
                </a:lnTo>
                <a:lnTo>
                  <a:pt x="358" y="370"/>
                </a:lnTo>
                <a:lnTo>
                  <a:pt x="359" y="370"/>
                </a:lnTo>
                <a:lnTo>
                  <a:pt x="360" y="370"/>
                </a:lnTo>
                <a:lnTo>
                  <a:pt x="361" y="370"/>
                </a:lnTo>
                <a:lnTo>
                  <a:pt x="361" y="369"/>
                </a:lnTo>
                <a:lnTo>
                  <a:pt x="362" y="368"/>
                </a:lnTo>
                <a:lnTo>
                  <a:pt x="362" y="367"/>
                </a:lnTo>
                <a:lnTo>
                  <a:pt x="363" y="367"/>
                </a:lnTo>
                <a:lnTo>
                  <a:pt x="363" y="368"/>
                </a:lnTo>
                <a:lnTo>
                  <a:pt x="364" y="369"/>
                </a:lnTo>
                <a:lnTo>
                  <a:pt x="364" y="370"/>
                </a:lnTo>
                <a:lnTo>
                  <a:pt x="365" y="370"/>
                </a:lnTo>
                <a:lnTo>
                  <a:pt x="366" y="369"/>
                </a:lnTo>
                <a:lnTo>
                  <a:pt x="367" y="369"/>
                </a:lnTo>
                <a:lnTo>
                  <a:pt x="367" y="367"/>
                </a:lnTo>
                <a:lnTo>
                  <a:pt x="368" y="367"/>
                </a:lnTo>
                <a:lnTo>
                  <a:pt x="369" y="365"/>
                </a:lnTo>
                <a:lnTo>
                  <a:pt x="369" y="366"/>
                </a:lnTo>
                <a:lnTo>
                  <a:pt x="370" y="367"/>
                </a:lnTo>
                <a:lnTo>
                  <a:pt x="371" y="368"/>
                </a:lnTo>
                <a:lnTo>
                  <a:pt x="371" y="369"/>
                </a:lnTo>
                <a:lnTo>
                  <a:pt x="372" y="370"/>
                </a:lnTo>
                <a:lnTo>
                  <a:pt x="373" y="369"/>
                </a:lnTo>
                <a:lnTo>
                  <a:pt x="373" y="365"/>
                </a:lnTo>
                <a:lnTo>
                  <a:pt x="374" y="358"/>
                </a:lnTo>
                <a:lnTo>
                  <a:pt x="374" y="324"/>
                </a:lnTo>
                <a:lnTo>
                  <a:pt x="375" y="298"/>
                </a:lnTo>
                <a:lnTo>
                  <a:pt x="375" y="331"/>
                </a:lnTo>
                <a:lnTo>
                  <a:pt x="376" y="360"/>
                </a:lnTo>
                <a:lnTo>
                  <a:pt x="376" y="370"/>
                </a:lnTo>
                <a:lnTo>
                  <a:pt x="377" y="370"/>
                </a:lnTo>
                <a:lnTo>
                  <a:pt x="378" y="370"/>
                </a:lnTo>
                <a:lnTo>
                  <a:pt x="379" y="370"/>
                </a:lnTo>
                <a:lnTo>
                  <a:pt x="380" y="370"/>
                </a:lnTo>
                <a:lnTo>
                  <a:pt x="381" y="370"/>
                </a:lnTo>
                <a:lnTo>
                  <a:pt x="382" y="370"/>
                </a:lnTo>
                <a:lnTo>
                  <a:pt x="383" y="370"/>
                </a:lnTo>
                <a:lnTo>
                  <a:pt x="384" y="370"/>
                </a:lnTo>
                <a:lnTo>
                  <a:pt x="384" y="369"/>
                </a:lnTo>
                <a:lnTo>
                  <a:pt x="385" y="368"/>
                </a:lnTo>
                <a:lnTo>
                  <a:pt x="385" y="365"/>
                </a:lnTo>
                <a:lnTo>
                  <a:pt x="386" y="365"/>
                </a:lnTo>
                <a:lnTo>
                  <a:pt x="386" y="368"/>
                </a:lnTo>
                <a:lnTo>
                  <a:pt x="387" y="369"/>
                </a:lnTo>
                <a:lnTo>
                  <a:pt x="387" y="370"/>
                </a:lnTo>
                <a:lnTo>
                  <a:pt x="388" y="369"/>
                </a:lnTo>
                <a:lnTo>
                  <a:pt x="388" y="368"/>
                </a:lnTo>
                <a:lnTo>
                  <a:pt x="389" y="368"/>
                </a:lnTo>
                <a:lnTo>
                  <a:pt x="389" y="360"/>
                </a:lnTo>
                <a:lnTo>
                  <a:pt x="390" y="352"/>
                </a:lnTo>
                <a:lnTo>
                  <a:pt x="390" y="347"/>
                </a:lnTo>
                <a:lnTo>
                  <a:pt x="391" y="359"/>
                </a:lnTo>
                <a:lnTo>
                  <a:pt x="391" y="366"/>
                </a:lnTo>
                <a:lnTo>
                  <a:pt x="392" y="368"/>
                </a:lnTo>
                <a:lnTo>
                  <a:pt x="392" y="369"/>
                </a:lnTo>
                <a:lnTo>
                  <a:pt x="393" y="369"/>
                </a:lnTo>
                <a:lnTo>
                  <a:pt x="393" y="362"/>
                </a:lnTo>
                <a:lnTo>
                  <a:pt x="394" y="349"/>
                </a:lnTo>
                <a:lnTo>
                  <a:pt x="394" y="293"/>
                </a:lnTo>
                <a:lnTo>
                  <a:pt x="395" y="242"/>
                </a:lnTo>
                <a:lnTo>
                  <a:pt x="395" y="295"/>
                </a:lnTo>
                <a:lnTo>
                  <a:pt x="396" y="340"/>
                </a:lnTo>
                <a:lnTo>
                  <a:pt x="396" y="348"/>
                </a:lnTo>
                <a:lnTo>
                  <a:pt x="397" y="325"/>
                </a:lnTo>
                <a:lnTo>
                  <a:pt x="397" y="316"/>
                </a:lnTo>
                <a:lnTo>
                  <a:pt x="398" y="343"/>
                </a:lnTo>
                <a:lnTo>
                  <a:pt x="398" y="365"/>
                </a:lnTo>
                <a:lnTo>
                  <a:pt x="399" y="368"/>
                </a:lnTo>
                <a:lnTo>
                  <a:pt x="399" y="369"/>
                </a:lnTo>
                <a:lnTo>
                  <a:pt x="400" y="369"/>
                </a:lnTo>
                <a:lnTo>
                  <a:pt x="401" y="370"/>
                </a:lnTo>
                <a:lnTo>
                  <a:pt x="401" y="369"/>
                </a:lnTo>
                <a:lnTo>
                  <a:pt x="402" y="369"/>
                </a:lnTo>
                <a:lnTo>
                  <a:pt x="402" y="366"/>
                </a:lnTo>
                <a:lnTo>
                  <a:pt x="403" y="365"/>
                </a:lnTo>
                <a:lnTo>
                  <a:pt x="403" y="367"/>
                </a:lnTo>
                <a:lnTo>
                  <a:pt x="404" y="368"/>
                </a:lnTo>
                <a:lnTo>
                  <a:pt x="404" y="369"/>
                </a:lnTo>
                <a:lnTo>
                  <a:pt x="405" y="369"/>
                </a:lnTo>
                <a:lnTo>
                  <a:pt x="406" y="369"/>
                </a:lnTo>
                <a:lnTo>
                  <a:pt x="406" y="367"/>
                </a:lnTo>
                <a:lnTo>
                  <a:pt x="407" y="365"/>
                </a:lnTo>
                <a:lnTo>
                  <a:pt x="407" y="367"/>
                </a:lnTo>
                <a:lnTo>
                  <a:pt x="408" y="368"/>
                </a:lnTo>
                <a:lnTo>
                  <a:pt x="409" y="369"/>
                </a:lnTo>
                <a:lnTo>
                  <a:pt x="410" y="369"/>
                </a:lnTo>
                <a:lnTo>
                  <a:pt x="411" y="369"/>
                </a:lnTo>
                <a:lnTo>
                  <a:pt x="412" y="369"/>
                </a:lnTo>
                <a:lnTo>
                  <a:pt x="412" y="370"/>
                </a:lnTo>
                <a:lnTo>
                  <a:pt x="413" y="369"/>
                </a:lnTo>
                <a:lnTo>
                  <a:pt x="414" y="369"/>
                </a:lnTo>
                <a:lnTo>
                  <a:pt x="414" y="366"/>
                </a:lnTo>
                <a:lnTo>
                  <a:pt x="415" y="360"/>
                </a:lnTo>
                <a:lnTo>
                  <a:pt x="415" y="314"/>
                </a:lnTo>
                <a:lnTo>
                  <a:pt x="416" y="257"/>
                </a:lnTo>
                <a:lnTo>
                  <a:pt x="416" y="288"/>
                </a:lnTo>
                <a:lnTo>
                  <a:pt x="417" y="340"/>
                </a:lnTo>
                <a:lnTo>
                  <a:pt x="417" y="368"/>
                </a:lnTo>
                <a:lnTo>
                  <a:pt x="418" y="369"/>
                </a:lnTo>
                <a:lnTo>
                  <a:pt x="419" y="369"/>
                </a:lnTo>
                <a:lnTo>
                  <a:pt x="420" y="370"/>
                </a:lnTo>
                <a:lnTo>
                  <a:pt x="420" y="369"/>
                </a:lnTo>
                <a:lnTo>
                  <a:pt x="421" y="369"/>
                </a:lnTo>
                <a:lnTo>
                  <a:pt x="421" y="370"/>
                </a:lnTo>
                <a:lnTo>
                  <a:pt x="422" y="369"/>
                </a:lnTo>
                <a:lnTo>
                  <a:pt x="423" y="369"/>
                </a:lnTo>
                <a:lnTo>
                  <a:pt x="423" y="370"/>
                </a:lnTo>
                <a:lnTo>
                  <a:pt x="424" y="370"/>
                </a:lnTo>
                <a:lnTo>
                  <a:pt x="424" y="369"/>
                </a:lnTo>
                <a:lnTo>
                  <a:pt x="425" y="369"/>
                </a:lnTo>
                <a:lnTo>
                  <a:pt x="426" y="369"/>
                </a:lnTo>
                <a:lnTo>
                  <a:pt x="426" y="368"/>
                </a:lnTo>
                <a:lnTo>
                  <a:pt x="427" y="367"/>
                </a:lnTo>
                <a:lnTo>
                  <a:pt x="427" y="368"/>
                </a:lnTo>
                <a:lnTo>
                  <a:pt x="428" y="368"/>
                </a:lnTo>
                <a:lnTo>
                  <a:pt x="428" y="369"/>
                </a:lnTo>
                <a:lnTo>
                  <a:pt x="429" y="369"/>
                </a:lnTo>
                <a:lnTo>
                  <a:pt x="430" y="368"/>
                </a:lnTo>
                <a:lnTo>
                  <a:pt x="431" y="368"/>
                </a:lnTo>
                <a:lnTo>
                  <a:pt x="431" y="369"/>
                </a:lnTo>
                <a:lnTo>
                  <a:pt x="432" y="369"/>
                </a:lnTo>
                <a:lnTo>
                  <a:pt x="433" y="369"/>
                </a:lnTo>
                <a:lnTo>
                  <a:pt x="434" y="370"/>
                </a:lnTo>
                <a:lnTo>
                  <a:pt x="434" y="369"/>
                </a:lnTo>
                <a:lnTo>
                  <a:pt x="435" y="369"/>
                </a:lnTo>
                <a:lnTo>
                  <a:pt x="436" y="369"/>
                </a:lnTo>
                <a:lnTo>
                  <a:pt x="436" y="367"/>
                </a:lnTo>
                <a:lnTo>
                  <a:pt x="437" y="367"/>
                </a:lnTo>
                <a:lnTo>
                  <a:pt x="437" y="368"/>
                </a:lnTo>
                <a:lnTo>
                  <a:pt x="438" y="369"/>
                </a:lnTo>
                <a:lnTo>
                  <a:pt x="439" y="368"/>
                </a:lnTo>
                <a:lnTo>
                  <a:pt x="440" y="367"/>
                </a:lnTo>
                <a:lnTo>
                  <a:pt x="441" y="367"/>
                </a:lnTo>
                <a:lnTo>
                  <a:pt x="441" y="366"/>
                </a:lnTo>
                <a:lnTo>
                  <a:pt x="442" y="366"/>
                </a:lnTo>
                <a:lnTo>
                  <a:pt x="442" y="364"/>
                </a:lnTo>
                <a:lnTo>
                  <a:pt x="443" y="363"/>
                </a:lnTo>
                <a:lnTo>
                  <a:pt x="443" y="366"/>
                </a:lnTo>
                <a:lnTo>
                  <a:pt x="444" y="367"/>
                </a:lnTo>
                <a:lnTo>
                  <a:pt x="444" y="368"/>
                </a:lnTo>
                <a:lnTo>
                  <a:pt x="445" y="368"/>
                </a:lnTo>
                <a:lnTo>
                  <a:pt x="445" y="369"/>
                </a:lnTo>
                <a:lnTo>
                  <a:pt x="446" y="368"/>
                </a:lnTo>
                <a:lnTo>
                  <a:pt x="447" y="369"/>
                </a:lnTo>
                <a:lnTo>
                  <a:pt x="447" y="368"/>
                </a:lnTo>
                <a:lnTo>
                  <a:pt x="448" y="369"/>
                </a:lnTo>
                <a:lnTo>
                  <a:pt x="449" y="368"/>
                </a:lnTo>
                <a:lnTo>
                  <a:pt x="450" y="367"/>
                </a:lnTo>
                <a:lnTo>
                  <a:pt x="450" y="360"/>
                </a:lnTo>
                <a:lnTo>
                  <a:pt x="451" y="357"/>
                </a:lnTo>
                <a:lnTo>
                  <a:pt x="451" y="360"/>
                </a:lnTo>
                <a:lnTo>
                  <a:pt x="452" y="359"/>
                </a:lnTo>
                <a:lnTo>
                  <a:pt x="452" y="342"/>
                </a:lnTo>
                <a:lnTo>
                  <a:pt x="453" y="325"/>
                </a:lnTo>
                <a:lnTo>
                  <a:pt x="453" y="270"/>
                </a:lnTo>
                <a:lnTo>
                  <a:pt x="454" y="232"/>
                </a:lnTo>
                <a:lnTo>
                  <a:pt x="454" y="155"/>
                </a:lnTo>
                <a:lnTo>
                  <a:pt x="455" y="124"/>
                </a:lnTo>
                <a:lnTo>
                  <a:pt x="455" y="319"/>
                </a:lnTo>
                <a:lnTo>
                  <a:pt x="456" y="363"/>
                </a:lnTo>
                <a:lnTo>
                  <a:pt x="456" y="368"/>
                </a:lnTo>
                <a:lnTo>
                  <a:pt x="457" y="368"/>
                </a:lnTo>
                <a:lnTo>
                  <a:pt x="457" y="364"/>
                </a:lnTo>
                <a:lnTo>
                  <a:pt x="458" y="358"/>
                </a:lnTo>
                <a:lnTo>
                  <a:pt x="458" y="347"/>
                </a:lnTo>
                <a:lnTo>
                  <a:pt x="459" y="335"/>
                </a:lnTo>
                <a:lnTo>
                  <a:pt x="459" y="348"/>
                </a:lnTo>
                <a:lnTo>
                  <a:pt x="460" y="362"/>
                </a:lnTo>
                <a:lnTo>
                  <a:pt x="460" y="368"/>
                </a:lnTo>
                <a:lnTo>
                  <a:pt x="461" y="368"/>
                </a:lnTo>
                <a:lnTo>
                  <a:pt x="461" y="369"/>
                </a:lnTo>
                <a:lnTo>
                  <a:pt x="462" y="370"/>
                </a:lnTo>
                <a:lnTo>
                  <a:pt x="462" y="369"/>
                </a:lnTo>
                <a:lnTo>
                  <a:pt x="463" y="369"/>
                </a:lnTo>
                <a:lnTo>
                  <a:pt x="464" y="370"/>
                </a:lnTo>
                <a:lnTo>
                  <a:pt x="465" y="370"/>
                </a:lnTo>
                <a:lnTo>
                  <a:pt x="466" y="370"/>
                </a:lnTo>
                <a:lnTo>
                  <a:pt x="466" y="369"/>
                </a:lnTo>
                <a:lnTo>
                  <a:pt x="467" y="369"/>
                </a:lnTo>
                <a:lnTo>
                  <a:pt x="468" y="369"/>
                </a:lnTo>
                <a:lnTo>
                  <a:pt x="469" y="369"/>
                </a:lnTo>
                <a:lnTo>
                  <a:pt x="469" y="370"/>
                </a:lnTo>
                <a:lnTo>
                  <a:pt x="470" y="370"/>
                </a:lnTo>
                <a:lnTo>
                  <a:pt x="470" y="369"/>
                </a:lnTo>
                <a:lnTo>
                  <a:pt x="471" y="369"/>
                </a:lnTo>
                <a:lnTo>
                  <a:pt x="471" y="368"/>
                </a:lnTo>
                <a:lnTo>
                  <a:pt x="472" y="369"/>
                </a:lnTo>
                <a:lnTo>
                  <a:pt x="472" y="370"/>
                </a:lnTo>
                <a:lnTo>
                  <a:pt x="473" y="369"/>
                </a:lnTo>
                <a:lnTo>
                  <a:pt x="473" y="363"/>
                </a:lnTo>
                <a:lnTo>
                  <a:pt x="474" y="359"/>
                </a:lnTo>
                <a:lnTo>
                  <a:pt x="474" y="356"/>
                </a:lnTo>
                <a:lnTo>
                  <a:pt x="475" y="361"/>
                </a:lnTo>
                <a:lnTo>
                  <a:pt x="475" y="367"/>
                </a:lnTo>
                <a:lnTo>
                  <a:pt x="476" y="369"/>
                </a:lnTo>
                <a:lnTo>
                  <a:pt x="477" y="369"/>
                </a:lnTo>
                <a:lnTo>
                  <a:pt x="478" y="368"/>
                </a:lnTo>
                <a:lnTo>
                  <a:pt x="478" y="366"/>
                </a:lnTo>
                <a:lnTo>
                  <a:pt x="479" y="361"/>
                </a:lnTo>
                <a:lnTo>
                  <a:pt x="479" y="342"/>
                </a:lnTo>
                <a:lnTo>
                  <a:pt x="480" y="342"/>
                </a:lnTo>
                <a:lnTo>
                  <a:pt x="480" y="362"/>
                </a:lnTo>
                <a:lnTo>
                  <a:pt x="481" y="363"/>
                </a:lnTo>
                <a:lnTo>
                  <a:pt x="481" y="359"/>
                </a:lnTo>
                <a:lnTo>
                  <a:pt x="482" y="361"/>
                </a:lnTo>
                <a:lnTo>
                  <a:pt x="482" y="369"/>
                </a:lnTo>
                <a:lnTo>
                  <a:pt x="483" y="370"/>
                </a:lnTo>
                <a:lnTo>
                  <a:pt x="483" y="368"/>
                </a:lnTo>
                <a:lnTo>
                  <a:pt x="484" y="366"/>
                </a:lnTo>
                <a:lnTo>
                  <a:pt x="484" y="364"/>
                </a:lnTo>
                <a:lnTo>
                  <a:pt x="485" y="367"/>
                </a:lnTo>
                <a:lnTo>
                  <a:pt x="485" y="370"/>
                </a:lnTo>
                <a:lnTo>
                  <a:pt x="486" y="370"/>
                </a:lnTo>
                <a:lnTo>
                  <a:pt x="486" y="369"/>
                </a:lnTo>
                <a:lnTo>
                  <a:pt x="487" y="368"/>
                </a:lnTo>
                <a:lnTo>
                  <a:pt x="487" y="366"/>
                </a:lnTo>
                <a:lnTo>
                  <a:pt x="488" y="367"/>
                </a:lnTo>
                <a:lnTo>
                  <a:pt x="488" y="369"/>
                </a:lnTo>
                <a:lnTo>
                  <a:pt x="489" y="370"/>
                </a:lnTo>
                <a:lnTo>
                  <a:pt x="490" y="370"/>
                </a:lnTo>
                <a:lnTo>
                  <a:pt x="491" y="369"/>
                </a:lnTo>
                <a:lnTo>
                  <a:pt x="491" y="366"/>
                </a:lnTo>
                <a:lnTo>
                  <a:pt x="492" y="366"/>
                </a:lnTo>
                <a:lnTo>
                  <a:pt x="492" y="369"/>
                </a:lnTo>
                <a:lnTo>
                  <a:pt x="493" y="370"/>
                </a:lnTo>
                <a:lnTo>
                  <a:pt x="494" y="370"/>
                </a:lnTo>
                <a:lnTo>
                  <a:pt x="494" y="369"/>
                </a:lnTo>
                <a:lnTo>
                  <a:pt x="495" y="369"/>
                </a:lnTo>
                <a:lnTo>
                  <a:pt x="495" y="368"/>
                </a:lnTo>
                <a:lnTo>
                  <a:pt x="496" y="366"/>
                </a:lnTo>
                <a:lnTo>
                  <a:pt x="496" y="364"/>
                </a:lnTo>
                <a:lnTo>
                  <a:pt x="497" y="368"/>
                </a:lnTo>
                <a:lnTo>
                  <a:pt x="497" y="369"/>
                </a:lnTo>
                <a:lnTo>
                  <a:pt x="498" y="370"/>
                </a:lnTo>
                <a:lnTo>
                  <a:pt x="499" y="369"/>
                </a:lnTo>
                <a:lnTo>
                  <a:pt x="499" y="363"/>
                </a:lnTo>
                <a:lnTo>
                  <a:pt x="500" y="357"/>
                </a:lnTo>
                <a:lnTo>
                  <a:pt x="500" y="359"/>
                </a:lnTo>
                <a:lnTo>
                  <a:pt x="501" y="364"/>
                </a:lnTo>
                <a:lnTo>
                  <a:pt x="501" y="366"/>
                </a:lnTo>
                <a:lnTo>
                  <a:pt x="502" y="365"/>
                </a:lnTo>
                <a:lnTo>
                  <a:pt x="503" y="367"/>
                </a:lnTo>
                <a:lnTo>
                  <a:pt x="503" y="369"/>
                </a:lnTo>
                <a:lnTo>
                  <a:pt x="504" y="369"/>
                </a:lnTo>
                <a:lnTo>
                  <a:pt x="504" y="368"/>
                </a:lnTo>
                <a:lnTo>
                  <a:pt x="505" y="368"/>
                </a:lnTo>
                <a:lnTo>
                  <a:pt x="505" y="361"/>
                </a:lnTo>
                <a:lnTo>
                  <a:pt x="506" y="353"/>
                </a:lnTo>
                <a:lnTo>
                  <a:pt x="506" y="346"/>
                </a:lnTo>
                <a:lnTo>
                  <a:pt x="507" y="358"/>
                </a:lnTo>
                <a:lnTo>
                  <a:pt x="507" y="364"/>
                </a:lnTo>
                <a:lnTo>
                  <a:pt x="508" y="367"/>
                </a:lnTo>
                <a:lnTo>
                  <a:pt x="508" y="369"/>
                </a:lnTo>
                <a:lnTo>
                  <a:pt x="509" y="369"/>
                </a:lnTo>
                <a:lnTo>
                  <a:pt x="509" y="367"/>
                </a:lnTo>
                <a:lnTo>
                  <a:pt x="510" y="365"/>
                </a:lnTo>
                <a:lnTo>
                  <a:pt x="510" y="364"/>
                </a:lnTo>
                <a:lnTo>
                  <a:pt x="511" y="366"/>
                </a:lnTo>
                <a:lnTo>
                  <a:pt x="511" y="368"/>
                </a:lnTo>
                <a:lnTo>
                  <a:pt x="512" y="369"/>
                </a:lnTo>
                <a:lnTo>
                  <a:pt x="513" y="369"/>
                </a:lnTo>
                <a:lnTo>
                  <a:pt x="513" y="367"/>
                </a:lnTo>
                <a:lnTo>
                  <a:pt x="514" y="366"/>
                </a:lnTo>
                <a:lnTo>
                  <a:pt x="514" y="365"/>
                </a:lnTo>
                <a:lnTo>
                  <a:pt x="515" y="367"/>
                </a:lnTo>
                <a:lnTo>
                  <a:pt x="515" y="369"/>
                </a:lnTo>
                <a:lnTo>
                  <a:pt x="516" y="370"/>
                </a:lnTo>
                <a:lnTo>
                  <a:pt x="516" y="369"/>
                </a:lnTo>
                <a:lnTo>
                  <a:pt x="517" y="369"/>
                </a:lnTo>
                <a:lnTo>
                  <a:pt x="517" y="368"/>
                </a:lnTo>
                <a:lnTo>
                  <a:pt x="518" y="369"/>
                </a:lnTo>
                <a:lnTo>
                  <a:pt x="518" y="370"/>
                </a:lnTo>
                <a:lnTo>
                  <a:pt x="519" y="370"/>
                </a:lnTo>
                <a:lnTo>
                  <a:pt x="519" y="369"/>
                </a:lnTo>
                <a:lnTo>
                  <a:pt x="520" y="368"/>
                </a:lnTo>
                <a:lnTo>
                  <a:pt x="520" y="369"/>
                </a:lnTo>
                <a:lnTo>
                  <a:pt x="521" y="369"/>
                </a:lnTo>
                <a:lnTo>
                  <a:pt x="522" y="370"/>
                </a:lnTo>
                <a:lnTo>
                  <a:pt x="523" y="370"/>
                </a:lnTo>
                <a:lnTo>
                  <a:pt x="524" y="370"/>
                </a:lnTo>
                <a:lnTo>
                  <a:pt x="525" y="369"/>
                </a:lnTo>
                <a:lnTo>
                  <a:pt x="525" y="368"/>
                </a:lnTo>
                <a:lnTo>
                  <a:pt x="526" y="366"/>
                </a:lnTo>
                <a:lnTo>
                  <a:pt x="526" y="360"/>
                </a:lnTo>
                <a:lnTo>
                  <a:pt x="527" y="349"/>
                </a:lnTo>
                <a:lnTo>
                  <a:pt x="527" y="301"/>
                </a:lnTo>
                <a:lnTo>
                  <a:pt x="528" y="251"/>
                </a:lnTo>
                <a:lnTo>
                  <a:pt x="528" y="289"/>
                </a:lnTo>
                <a:lnTo>
                  <a:pt x="529" y="345"/>
                </a:lnTo>
                <a:lnTo>
                  <a:pt x="529" y="358"/>
                </a:lnTo>
                <a:lnTo>
                  <a:pt x="530" y="335"/>
                </a:lnTo>
                <a:lnTo>
                  <a:pt x="530" y="309"/>
                </a:lnTo>
                <a:lnTo>
                  <a:pt x="531" y="321"/>
                </a:lnTo>
                <a:lnTo>
                  <a:pt x="531" y="361"/>
                </a:lnTo>
                <a:lnTo>
                  <a:pt x="532" y="366"/>
                </a:lnTo>
                <a:lnTo>
                  <a:pt x="532" y="368"/>
                </a:lnTo>
                <a:lnTo>
                  <a:pt x="533" y="369"/>
                </a:lnTo>
                <a:lnTo>
                  <a:pt x="534" y="369"/>
                </a:lnTo>
                <a:lnTo>
                  <a:pt x="535" y="369"/>
                </a:lnTo>
                <a:lnTo>
                  <a:pt x="536" y="369"/>
                </a:lnTo>
                <a:lnTo>
                  <a:pt x="536" y="368"/>
                </a:lnTo>
                <a:lnTo>
                  <a:pt x="537" y="365"/>
                </a:lnTo>
                <a:lnTo>
                  <a:pt x="537" y="360"/>
                </a:lnTo>
                <a:lnTo>
                  <a:pt x="538" y="352"/>
                </a:lnTo>
                <a:lnTo>
                  <a:pt x="538" y="324"/>
                </a:lnTo>
                <a:lnTo>
                  <a:pt x="539" y="306"/>
                </a:lnTo>
                <a:lnTo>
                  <a:pt x="539" y="292"/>
                </a:lnTo>
                <a:lnTo>
                  <a:pt x="540" y="344"/>
                </a:lnTo>
                <a:lnTo>
                  <a:pt x="540" y="368"/>
                </a:lnTo>
                <a:lnTo>
                  <a:pt x="541" y="369"/>
                </a:lnTo>
                <a:lnTo>
                  <a:pt x="542" y="369"/>
                </a:lnTo>
                <a:lnTo>
                  <a:pt x="542" y="368"/>
                </a:lnTo>
                <a:lnTo>
                  <a:pt x="543" y="368"/>
                </a:lnTo>
                <a:lnTo>
                  <a:pt x="543" y="369"/>
                </a:lnTo>
                <a:lnTo>
                  <a:pt x="544" y="367"/>
                </a:lnTo>
                <a:lnTo>
                  <a:pt x="544" y="361"/>
                </a:lnTo>
                <a:lnTo>
                  <a:pt x="545" y="360"/>
                </a:lnTo>
                <a:lnTo>
                  <a:pt x="545" y="368"/>
                </a:lnTo>
                <a:lnTo>
                  <a:pt x="546" y="369"/>
                </a:lnTo>
                <a:lnTo>
                  <a:pt x="546" y="370"/>
                </a:lnTo>
                <a:lnTo>
                  <a:pt x="547" y="370"/>
                </a:lnTo>
                <a:lnTo>
                  <a:pt x="548" y="370"/>
                </a:lnTo>
                <a:lnTo>
                  <a:pt x="549" y="370"/>
                </a:lnTo>
                <a:lnTo>
                  <a:pt x="550" y="370"/>
                </a:lnTo>
                <a:lnTo>
                  <a:pt x="550" y="369"/>
                </a:lnTo>
                <a:lnTo>
                  <a:pt x="551" y="369"/>
                </a:lnTo>
                <a:lnTo>
                  <a:pt x="551" y="368"/>
                </a:lnTo>
                <a:lnTo>
                  <a:pt x="552" y="366"/>
                </a:lnTo>
                <a:lnTo>
                  <a:pt x="552" y="362"/>
                </a:lnTo>
                <a:lnTo>
                  <a:pt x="553" y="363"/>
                </a:lnTo>
                <a:lnTo>
                  <a:pt x="553" y="365"/>
                </a:lnTo>
                <a:lnTo>
                  <a:pt x="554" y="367"/>
                </a:lnTo>
                <a:lnTo>
                  <a:pt x="554" y="370"/>
                </a:lnTo>
                <a:lnTo>
                  <a:pt x="555" y="370"/>
                </a:lnTo>
                <a:lnTo>
                  <a:pt x="555" y="366"/>
                </a:lnTo>
                <a:lnTo>
                  <a:pt x="556" y="359"/>
                </a:lnTo>
                <a:lnTo>
                  <a:pt x="556" y="350"/>
                </a:lnTo>
                <a:lnTo>
                  <a:pt x="557" y="343"/>
                </a:lnTo>
                <a:lnTo>
                  <a:pt x="557" y="348"/>
                </a:lnTo>
                <a:lnTo>
                  <a:pt x="558" y="357"/>
                </a:lnTo>
                <a:lnTo>
                  <a:pt x="558" y="365"/>
                </a:lnTo>
                <a:lnTo>
                  <a:pt x="559" y="364"/>
                </a:lnTo>
                <a:lnTo>
                  <a:pt x="559" y="351"/>
                </a:lnTo>
                <a:lnTo>
                  <a:pt x="560" y="348"/>
                </a:lnTo>
                <a:lnTo>
                  <a:pt x="560" y="361"/>
                </a:lnTo>
                <a:lnTo>
                  <a:pt x="561" y="365"/>
                </a:lnTo>
                <a:lnTo>
                  <a:pt x="561" y="368"/>
                </a:lnTo>
                <a:lnTo>
                  <a:pt x="562" y="369"/>
                </a:lnTo>
                <a:lnTo>
                  <a:pt x="563" y="368"/>
                </a:lnTo>
                <a:lnTo>
                  <a:pt x="563" y="367"/>
                </a:lnTo>
                <a:lnTo>
                  <a:pt x="564" y="367"/>
                </a:lnTo>
                <a:lnTo>
                  <a:pt x="564" y="366"/>
                </a:lnTo>
                <a:lnTo>
                  <a:pt x="565" y="367"/>
                </a:lnTo>
                <a:lnTo>
                  <a:pt x="565" y="368"/>
                </a:lnTo>
                <a:lnTo>
                  <a:pt x="566" y="369"/>
                </a:lnTo>
                <a:lnTo>
                  <a:pt x="566" y="367"/>
                </a:lnTo>
                <a:lnTo>
                  <a:pt x="567" y="366"/>
                </a:lnTo>
                <a:lnTo>
                  <a:pt x="567" y="367"/>
                </a:lnTo>
                <a:lnTo>
                  <a:pt x="568" y="369"/>
                </a:lnTo>
                <a:lnTo>
                  <a:pt x="568" y="370"/>
                </a:lnTo>
                <a:lnTo>
                  <a:pt x="569" y="370"/>
                </a:lnTo>
                <a:lnTo>
                  <a:pt x="570" y="370"/>
                </a:lnTo>
                <a:lnTo>
                  <a:pt x="570" y="369"/>
                </a:lnTo>
                <a:lnTo>
                  <a:pt x="571" y="368"/>
                </a:lnTo>
                <a:lnTo>
                  <a:pt x="571" y="365"/>
                </a:lnTo>
                <a:lnTo>
                  <a:pt x="572" y="364"/>
                </a:lnTo>
                <a:lnTo>
                  <a:pt x="572" y="365"/>
                </a:lnTo>
                <a:lnTo>
                  <a:pt x="573" y="366"/>
                </a:lnTo>
                <a:lnTo>
                  <a:pt x="573" y="368"/>
                </a:lnTo>
                <a:lnTo>
                  <a:pt x="574" y="369"/>
                </a:lnTo>
                <a:lnTo>
                  <a:pt x="575" y="370"/>
                </a:lnTo>
                <a:lnTo>
                  <a:pt x="576" y="370"/>
                </a:lnTo>
                <a:lnTo>
                  <a:pt x="577" y="369"/>
                </a:lnTo>
                <a:lnTo>
                  <a:pt x="578" y="367"/>
                </a:lnTo>
                <a:lnTo>
                  <a:pt x="578" y="360"/>
                </a:lnTo>
                <a:lnTo>
                  <a:pt x="579" y="359"/>
                </a:lnTo>
                <a:lnTo>
                  <a:pt x="579" y="364"/>
                </a:lnTo>
                <a:lnTo>
                  <a:pt x="580" y="362"/>
                </a:lnTo>
                <a:lnTo>
                  <a:pt x="580" y="364"/>
                </a:lnTo>
                <a:lnTo>
                  <a:pt x="581" y="367"/>
                </a:lnTo>
                <a:lnTo>
                  <a:pt x="581" y="369"/>
                </a:lnTo>
                <a:lnTo>
                  <a:pt x="582" y="369"/>
                </a:lnTo>
                <a:lnTo>
                  <a:pt x="582" y="370"/>
                </a:lnTo>
                <a:lnTo>
                  <a:pt x="583" y="369"/>
                </a:lnTo>
                <a:lnTo>
                  <a:pt x="583" y="370"/>
                </a:lnTo>
                <a:lnTo>
                  <a:pt x="584" y="369"/>
                </a:lnTo>
                <a:lnTo>
                  <a:pt x="585" y="369"/>
                </a:lnTo>
                <a:lnTo>
                  <a:pt x="585" y="370"/>
                </a:lnTo>
                <a:lnTo>
                  <a:pt x="586" y="370"/>
                </a:lnTo>
                <a:lnTo>
                  <a:pt x="587" y="370"/>
                </a:lnTo>
                <a:lnTo>
                  <a:pt x="588" y="369"/>
                </a:lnTo>
                <a:lnTo>
                  <a:pt x="589" y="369"/>
                </a:lnTo>
                <a:lnTo>
                  <a:pt x="590" y="369"/>
                </a:lnTo>
                <a:lnTo>
                  <a:pt x="591" y="369"/>
                </a:lnTo>
                <a:lnTo>
                  <a:pt x="592" y="369"/>
                </a:lnTo>
                <a:lnTo>
                  <a:pt x="592" y="368"/>
                </a:lnTo>
                <a:lnTo>
                  <a:pt x="593" y="367"/>
                </a:lnTo>
                <a:lnTo>
                  <a:pt x="594" y="367"/>
                </a:lnTo>
                <a:lnTo>
                  <a:pt x="594" y="368"/>
                </a:lnTo>
                <a:lnTo>
                  <a:pt x="595" y="367"/>
                </a:lnTo>
                <a:lnTo>
                  <a:pt x="595" y="364"/>
                </a:lnTo>
                <a:lnTo>
                  <a:pt x="596" y="365"/>
                </a:lnTo>
                <a:lnTo>
                  <a:pt x="596" y="366"/>
                </a:lnTo>
                <a:lnTo>
                  <a:pt x="597" y="359"/>
                </a:lnTo>
                <a:lnTo>
                  <a:pt x="597" y="304"/>
                </a:lnTo>
                <a:lnTo>
                  <a:pt x="598" y="257"/>
                </a:lnTo>
                <a:lnTo>
                  <a:pt x="598" y="182"/>
                </a:lnTo>
                <a:lnTo>
                  <a:pt x="599" y="240"/>
                </a:lnTo>
                <a:lnTo>
                  <a:pt x="599" y="361"/>
                </a:lnTo>
                <a:lnTo>
                  <a:pt x="600" y="367"/>
                </a:lnTo>
                <a:lnTo>
                  <a:pt x="600" y="368"/>
                </a:lnTo>
                <a:lnTo>
                  <a:pt x="601" y="368"/>
                </a:lnTo>
                <a:lnTo>
                  <a:pt x="601" y="365"/>
                </a:lnTo>
                <a:lnTo>
                  <a:pt x="602" y="364"/>
                </a:lnTo>
                <a:lnTo>
                  <a:pt x="602" y="367"/>
                </a:lnTo>
                <a:lnTo>
                  <a:pt x="603" y="368"/>
                </a:lnTo>
                <a:lnTo>
                  <a:pt x="603" y="365"/>
                </a:lnTo>
                <a:lnTo>
                  <a:pt x="604" y="364"/>
                </a:lnTo>
                <a:lnTo>
                  <a:pt x="604" y="366"/>
                </a:lnTo>
                <a:lnTo>
                  <a:pt x="605" y="367"/>
                </a:lnTo>
                <a:lnTo>
                  <a:pt x="605" y="369"/>
                </a:lnTo>
                <a:lnTo>
                  <a:pt x="606" y="369"/>
                </a:lnTo>
                <a:lnTo>
                  <a:pt x="607" y="369"/>
                </a:lnTo>
                <a:lnTo>
                  <a:pt x="608" y="369"/>
                </a:lnTo>
                <a:lnTo>
                  <a:pt x="608" y="370"/>
                </a:lnTo>
                <a:lnTo>
                  <a:pt x="609" y="369"/>
                </a:lnTo>
                <a:lnTo>
                  <a:pt x="609" y="370"/>
                </a:lnTo>
                <a:lnTo>
                  <a:pt x="610" y="370"/>
                </a:lnTo>
                <a:lnTo>
                  <a:pt x="611" y="370"/>
                </a:lnTo>
                <a:lnTo>
                  <a:pt x="611" y="369"/>
                </a:lnTo>
                <a:lnTo>
                  <a:pt x="612" y="367"/>
                </a:lnTo>
                <a:lnTo>
                  <a:pt x="612" y="363"/>
                </a:lnTo>
                <a:lnTo>
                  <a:pt x="613" y="357"/>
                </a:lnTo>
                <a:lnTo>
                  <a:pt x="613" y="331"/>
                </a:lnTo>
                <a:lnTo>
                  <a:pt x="614" y="327"/>
                </a:lnTo>
                <a:lnTo>
                  <a:pt x="614" y="343"/>
                </a:lnTo>
                <a:lnTo>
                  <a:pt x="615" y="360"/>
                </a:lnTo>
                <a:lnTo>
                  <a:pt x="615" y="369"/>
                </a:lnTo>
                <a:lnTo>
                  <a:pt x="616" y="369"/>
                </a:lnTo>
                <a:lnTo>
                  <a:pt x="617" y="370"/>
                </a:lnTo>
                <a:lnTo>
                  <a:pt x="617" y="369"/>
                </a:lnTo>
                <a:lnTo>
                  <a:pt x="618" y="368"/>
                </a:lnTo>
                <a:lnTo>
                  <a:pt x="618" y="364"/>
                </a:lnTo>
                <a:lnTo>
                  <a:pt x="619" y="359"/>
                </a:lnTo>
                <a:lnTo>
                  <a:pt x="619" y="361"/>
                </a:lnTo>
                <a:lnTo>
                  <a:pt x="620" y="365"/>
                </a:lnTo>
                <a:lnTo>
                  <a:pt x="620" y="368"/>
                </a:lnTo>
                <a:lnTo>
                  <a:pt x="621" y="366"/>
                </a:lnTo>
                <a:lnTo>
                  <a:pt x="621" y="348"/>
                </a:lnTo>
                <a:lnTo>
                  <a:pt x="622" y="324"/>
                </a:lnTo>
                <a:lnTo>
                  <a:pt x="622" y="338"/>
                </a:lnTo>
                <a:lnTo>
                  <a:pt x="623" y="358"/>
                </a:lnTo>
                <a:lnTo>
                  <a:pt x="623" y="369"/>
                </a:lnTo>
                <a:lnTo>
                  <a:pt x="624" y="369"/>
                </a:lnTo>
                <a:lnTo>
                  <a:pt x="625" y="369"/>
                </a:lnTo>
                <a:lnTo>
                  <a:pt x="625" y="368"/>
                </a:lnTo>
                <a:lnTo>
                  <a:pt x="626" y="367"/>
                </a:lnTo>
                <a:lnTo>
                  <a:pt x="626" y="368"/>
                </a:lnTo>
                <a:lnTo>
                  <a:pt x="627" y="369"/>
                </a:lnTo>
                <a:lnTo>
                  <a:pt x="628" y="369"/>
                </a:lnTo>
                <a:lnTo>
                  <a:pt x="628" y="370"/>
                </a:lnTo>
                <a:lnTo>
                  <a:pt x="629" y="370"/>
                </a:lnTo>
                <a:lnTo>
                  <a:pt x="630" y="370"/>
                </a:lnTo>
                <a:lnTo>
                  <a:pt x="630" y="369"/>
                </a:lnTo>
                <a:lnTo>
                  <a:pt x="631" y="369"/>
                </a:lnTo>
                <a:lnTo>
                  <a:pt x="631" y="370"/>
                </a:lnTo>
                <a:lnTo>
                  <a:pt x="632" y="369"/>
                </a:lnTo>
                <a:lnTo>
                  <a:pt x="633" y="369"/>
                </a:lnTo>
                <a:lnTo>
                  <a:pt x="633" y="368"/>
                </a:lnTo>
                <a:lnTo>
                  <a:pt x="634" y="368"/>
                </a:lnTo>
                <a:lnTo>
                  <a:pt x="634" y="369"/>
                </a:lnTo>
                <a:lnTo>
                  <a:pt x="635" y="368"/>
                </a:lnTo>
                <a:lnTo>
                  <a:pt x="636" y="368"/>
                </a:lnTo>
                <a:lnTo>
                  <a:pt x="636" y="365"/>
                </a:lnTo>
                <a:lnTo>
                  <a:pt x="637" y="354"/>
                </a:lnTo>
                <a:lnTo>
                  <a:pt x="637" y="263"/>
                </a:lnTo>
                <a:lnTo>
                  <a:pt x="638" y="186"/>
                </a:lnTo>
                <a:lnTo>
                  <a:pt x="638" y="84"/>
                </a:lnTo>
                <a:lnTo>
                  <a:pt x="639" y="201"/>
                </a:lnTo>
                <a:lnTo>
                  <a:pt x="639" y="364"/>
                </a:lnTo>
                <a:lnTo>
                  <a:pt x="640" y="367"/>
                </a:lnTo>
                <a:lnTo>
                  <a:pt x="640" y="369"/>
                </a:lnTo>
                <a:lnTo>
                  <a:pt x="641" y="369"/>
                </a:lnTo>
                <a:lnTo>
                  <a:pt x="641" y="370"/>
                </a:lnTo>
                <a:lnTo>
                  <a:pt x="642" y="369"/>
                </a:lnTo>
                <a:lnTo>
                  <a:pt x="643" y="369"/>
                </a:lnTo>
                <a:lnTo>
                  <a:pt x="644" y="369"/>
                </a:lnTo>
                <a:lnTo>
                  <a:pt x="644" y="366"/>
                </a:lnTo>
                <a:lnTo>
                  <a:pt x="645" y="359"/>
                </a:lnTo>
                <a:lnTo>
                  <a:pt x="645" y="353"/>
                </a:lnTo>
                <a:lnTo>
                  <a:pt x="646" y="361"/>
                </a:lnTo>
                <a:lnTo>
                  <a:pt x="646" y="369"/>
                </a:lnTo>
                <a:lnTo>
                  <a:pt x="647" y="369"/>
                </a:lnTo>
                <a:lnTo>
                  <a:pt x="647" y="366"/>
                </a:lnTo>
                <a:lnTo>
                  <a:pt x="648" y="364"/>
                </a:lnTo>
                <a:lnTo>
                  <a:pt x="648" y="366"/>
                </a:lnTo>
                <a:lnTo>
                  <a:pt x="649" y="367"/>
                </a:lnTo>
                <a:lnTo>
                  <a:pt x="649" y="369"/>
                </a:lnTo>
                <a:lnTo>
                  <a:pt x="650" y="370"/>
                </a:lnTo>
                <a:lnTo>
                  <a:pt x="651" y="370"/>
                </a:lnTo>
                <a:lnTo>
                  <a:pt x="652" y="370"/>
                </a:lnTo>
                <a:lnTo>
                  <a:pt x="652" y="369"/>
                </a:lnTo>
                <a:lnTo>
                  <a:pt x="653" y="369"/>
                </a:lnTo>
                <a:lnTo>
                  <a:pt x="653" y="368"/>
                </a:lnTo>
                <a:lnTo>
                  <a:pt x="654" y="368"/>
                </a:lnTo>
                <a:lnTo>
                  <a:pt x="655" y="369"/>
                </a:lnTo>
                <a:lnTo>
                  <a:pt x="656" y="369"/>
                </a:lnTo>
                <a:lnTo>
                  <a:pt x="656" y="367"/>
                </a:lnTo>
                <a:lnTo>
                  <a:pt x="657" y="368"/>
                </a:lnTo>
                <a:lnTo>
                  <a:pt x="657" y="369"/>
                </a:lnTo>
                <a:lnTo>
                  <a:pt x="658" y="368"/>
                </a:lnTo>
                <a:lnTo>
                  <a:pt x="658" y="365"/>
                </a:lnTo>
                <a:lnTo>
                  <a:pt x="659" y="364"/>
                </a:lnTo>
                <a:lnTo>
                  <a:pt x="659" y="365"/>
                </a:lnTo>
                <a:lnTo>
                  <a:pt x="660" y="364"/>
                </a:lnTo>
                <a:lnTo>
                  <a:pt x="660" y="344"/>
                </a:lnTo>
                <a:lnTo>
                  <a:pt x="661" y="318"/>
                </a:lnTo>
                <a:lnTo>
                  <a:pt x="661" y="340"/>
                </a:lnTo>
                <a:lnTo>
                  <a:pt x="662" y="360"/>
                </a:lnTo>
                <a:lnTo>
                  <a:pt x="662" y="366"/>
                </a:lnTo>
                <a:lnTo>
                  <a:pt x="663" y="367"/>
                </a:lnTo>
                <a:lnTo>
                  <a:pt x="663" y="369"/>
                </a:lnTo>
                <a:lnTo>
                  <a:pt x="664" y="369"/>
                </a:lnTo>
                <a:lnTo>
                  <a:pt x="664" y="368"/>
                </a:lnTo>
                <a:lnTo>
                  <a:pt x="665" y="367"/>
                </a:lnTo>
                <a:lnTo>
                  <a:pt x="665" y="368"/>
                </a:lnTo>
                <a:lnTo>
                  <a:pt x="666" y="368"/>
                </a:lnTo>
                <a:lnTo>
                  <a:pt x="666" y="369"/>
                </a:lnTo>
                <a:lnTo>
                  <a:pt x="667" y="368"/>
                </a:lnTo>
                <a:lnTo>
                  <a:pt x="667" y="367"/>
                </a:lnTo>
                <a:lnTo>
                  <a:pt x="668" y="364"/>
                </a:lnTo>
                <a:lnTo>
                  <a:pt x="668" y="335"/>
                </a:lnTo>
                <a:lnTo>
                  <a:pt x="669" y="303"/>
                </a:lnTo>
                <a:lnTo>
                  <a:pt x="669" y="264"/>
                </a:lnTo>
                <a:lnTo>
                  <a:pt x="670" y="317"/>
                </a:lnTo>
                <a:lnTo>
                  <a:pt x="670" y="364"/>
                </a:lnTo>
                <a:lnTo>
                  <a:pt x="671" y="366"/>
                </a:lnTo>
                <a:lnTo>
                  <a:pt x="671" y="367"/>
                </a:lnTo>
                <a:lnTo>
                  <a:pt x="672" y="368"/>
                </a:lnTo>
                <a:lnTo>
                  <a:pt x="673" y="368"/>
                </a:lnTo>
                <a:lnTo>
                  <a:pt x="674" y="368"/>
                </a:lnTo>
                <a:lnTo>
                  <a:pt x="674" y="369"/>
                </a:lnTo>
                <a:lnTo>
                  <a:pt x="675" y="369"/>
                </a:lnTo>
                <a:lnTo>
                  <a:pt x="676" y="369"/>
                </a:lnTo>
                <a:lnTo>
                  <a:pt x="677" y="369"/>
                </a:lnTo>
                <a:lnTo>
                  <a:pt x="678" y="369"/>
                </a:lnTo>
                <a:lnTo>
                  <a:pt x="679" y="369"/>
                </a:lnTo>
                <a:lnTo>
                  <a:pt x="680" y="369"/>
                </a:lnTo>
                <a:lnTo>
                  <a:pt x="681" y="369"/>
                </a:lnTo>
                <a:lnTo>
                  <a:pt x="682" y="369"/>
                </a:lnTo>
                <a:lnTo>
                  <a:pt x="683" y="369"/>
                </a:lnTo>
                <a:lnTo>
                  <a:pt x="683" y="366"/>
                </a:lnTo>
                <a:lnTo>
                  <a:pt x="684" y="357"/>
                </a:lnTo>
                <a:lnTo>
                  <a:pt x="684" y="311"/>
                </a:lnTo>
                <a:lnTo>
                  <a:pt x="685" y="318"/>
                </a:lnTo>
                <a:lnTo>
                  <a:pt x="685" y="362"/>
                </a:lnTo>
                <a:lnTo>
                  <a:pt x="686" y="364"/>
                </a:lnTo>
                <a:lnTo>
                  <a:pt x="687" y="366"/>
                </a:lnTo>
                <a:lnTo>
                  <a:pt x="687" y="368"/>
                </a:lnTo>
                <a:lnTo>
                  <a:pt x="688" y="368"/>
                </a:lnTo>
                <a:lnTo>
                  <a:pt x="688" y="369"/>
                </a:lnTo>
                <a:lnTo>
                  <a:pt x="689" y="369"/>
                </a:lnTo>
                <a:lnTo>
                  <a:pt x="690" y="369"/>
                </a:lnTo>
                <a:lnTo>
                  <a:pt x="690" y="368"/>
                </a:lnTo>
                <a:lnTo>
                  <a:pt x="691" y="364"/>
                </a:lnTo>
                <a:lnTo>
                  <a:pt x="691" y="362"/>
                </a:lnTo>
                <a:lnTo>
                  <a:pt x="692" y="363"/>
                </a:lnTo>
                <a:lnTo>
                  <a:pt x="692" y="366"/>
                </a:lnTo>
                <a:lnTo>
                  <a:pt x="693" y="366"/>
                </a:lnTo>
                <a:lnTo>
                  <a:pt x="693" y="368"/>
                </a:lnTo>
                <a:lnTo>
                  <a:pt x="694" y="368"/>
                </a:lnTo>
                <a:lnTo>
                  <a:pt x="694" y="369"/>
                </a:lnTo>
                <a:lnTo>
                  <a:pt x="695" y="368"/>
                </a:lnTo>
                <a:lnTo>
                  <a:pt x="696" y="368"/>
                </a:lnTo>
                <a:lnTo>
                  <a:pt x="697" y="367"/>
                </a:lnTo>
                <a:lnTo>
                  <a:pt x="697" y="366"/>
                </a:lnTo>
                <a:lnTo>
                  <a:pt x="698" y="368"/>
                </a:lnTo>
                <a:lnTo>
                  <a:pt x="699" y="368"/>
                </a:lnTo>
                <a:lnTo>
                  <a:pt x="699" y="369"/>
                </a:lnTo>
                <a:lnTo>
                  <a:pt x="700" y="369"/>
                </a:lnTo>
                <a:lnTo>
                  <a:pt x="701" y="369"/>
                </a:lnTo>
                <a:lnTo>
                  <a:pt x="702" y="369"/>
                </a:lnTo>
                <a:lnTo>
                  <a:pt x="703" y="369"/>
                </a:lnTo>
                <a:lnTo>
                  <a:pt x="704" y="369"/>
                </a:lnTo>
                <a:lnTo>
                  <a:pt x="704" y="367"/>
                </a:lnTo>
                <a:lnTo>
                  <a:pt x="705" y="367"/>
                </a:lnTo>
                <a:lnTo>
                  <a:pt x="705" y="368"/>
                </a:lnTo>
                <a:lnTo>
                  <a:pt x="706" y="368"/>
                </a:lnTo>
                <a:lnTo>
                  <a:pt x="707" y="368"/>
                </a:lnTo>
                <a:lnTo>
                  <a:pt x="708" y="368"/>
                </a:lnTo>
                <a:lnTo>
                  <a:pt x="708" y="366"/>
                </a:lnTo>
                <a:lnTo>
                  <a:pt x="709" y="367"/>
                </a:lnTo>
                <a:lnTo>
                  <a:pt x="709" y="369"/>
                </a:lnTo>
                <a:lnTo>
                  <a:pt x="710" y="369"/>
                </a:lnTo>
                <a:lnTo>
                  <a:pt x="711" y="368"/>
                </a:lnTo>
                <a:lnTo>
                  <a:pt x="712" y="367"/>
                </a:lnTo>
                <a:lnTo>
                  <a:pt x="713" y="366"/>
                </a:lnTo>
                <a:lnTo>
                  <a:pt x="713" y="367"/>
                </a:lnTo>
                <a:lnTo>
                  <a:pt x="714" y="368"/>
                </a:lnTo>
                <a:lnTo>
                  <a:pt x="715" y="369"/>
                </a:lnTo>
                <a:lnTo>
                  <a:pt x="716" y="369"/>
                </a:lnTo>
                <a:lnTo>
                  <a:pt x="717" y="369"/>
                </a:lnTo>
                <a:lnTo>
                  <a:pt x="718" y="369"/>
                </a:lnTo>
                <a:lnTo>
                  <a:pt x="718" y="367"/>
                </a:lnTo>
                <a:lnTo>
                  <a:pt x="719" y="367"/>
                </a:lnTo>
                <a:lnTo>
                  <a:pt x="719" y="368"/>
                </a:lnTo>
                <a:lnTo>
                  <a:pt x="720" y="368"/>
                </a:lnTo>
                <a:lnTo>
                  <a:pt x="721" y="367"/>
                </a:lnTo>
                <a:lnTo>
                  <a:pt x="722" y="368"/>
                </a:lnTo>
                <a:lnTo>
                  <a:pt x="723" y="367"/>
                </a:lnTo>
                <a:lnTo>
                  <a:pt x="723" y="366"/>
                </a:lnTo>
                <a:lnTo>
                  <a:pt x="724" y="367"/>
                </a:lnTo>
                <a:lnTo>
                  <a:pt x="724" y="368"/>
                </a:lnTo>
                <a:lnTo>
                  <a:pt x="725" y="365"/>
                </a:lnTo>
                <a:lnTo>
                  <a:pt x="725" y="357"/>
                </a:lnTo>
                <a:lnTo>
                  <a:pt x="726" y="329"/>
                </a:lnTo>
                <a:lnTo>
                  <a:pt x="726" y="298"/>
                </a:lnTo>
                <a:lnTo>
                  <a:pt x="727" y="334"/>
                </a:lnTo>
                <a:lnTo>
                  <a:pt x="727" y="358"/>
                </a:lnTo>
                <a:lnTo>
                  <a:pt x="728" y="359"/>
                </a:lnTo>
                <a:lnTo>
                  <a:pt x="728" y="353"/>
                </a:lnTo>
                <a:lnTo>
                  <a:pt x="729" y="345"/>
                </a:lnTo>
                <a:lnTo>
                  <a:pt x="729" y="310"/>
                </a:lnTo>
                <a:lnTo>
                  <a:pt x="730" y="268"/>
                </a:lnTo>
                <a:lnTo>
                  <a:pt x="730" y="218"/>
                </a:lnTo>
                <a:lnTo>
                  <a:pt x="731" y="310"/>
                </a:lnTo>
                <a:lnTo>
                  <a:pt x="731" y="345"/>
                </a:lnTo>
                <a:lnTo>
                  <a:pt x="732" y="302"/>
                </a:lnTo>
                <a:lnTo>
                  <a:pt x="732" y="258"/>
                </a:lnTo>
                <a:lnTo>
                  <a:pt x="733" y="266"/>
                </a:lnTo>
                <a:lnTo>
                  <a:pt x="733" y="359"/>
                </a:lnTo>
                <a:lnTo>
                  <a:pt x="734" y="363"/>
                </a:lnTo>
                <a:lnTo>
                  <a:pt x="734" y="364"/>
                </a:lnTo>
                <a:lnTo>
                  <a:pt x="735" y="362"/>
                </a:lnTo>
                <a:lnTo>
                  <a:pt x="735" y="355"/>
                </a:lnTo>
                <a:lnTo>
                  <a:pt x="736" y="358"/>
                </a:lnTo>
                <a:lnTo>
                  <a:pt x="736" y="365"/>
                </a:lnTo>
                <a:lnTo>
                  <a:pt x="737" y="362"/>
                </a:lnTo>
                <a:lnTo>
                  <a:pt x="737" y="332"/>
                </a:lnTo>
                <a:lnTo>
                  <a:pt x="738" y="318"/>
                </a:lnTo>
                <a:lnTo>
                  <a:pt x="738" y="353"/>
                </a:lnTo>
                <a:lnTo>
                  <a:pt x="739" y="361"/>
                </a:lnTo>
                <a:lnTo>
                  <a:pt x="739" y="364"/>
                </a:lnTo>
                <a:lnTo>
                  <a:pt x="740" y="362"/>
                </a:lnTo>
                <a:lnTo>
                  <a:pt x="740" y="363"/>
                </a:lnTo>
                <a:lnTo>
                  <a:pt x="741" y="364"/>
                </a:lnTo>
                <a:lnTo>
                  <a:pt x="741" y="365"/>
                </a:lnTo>
                <a:lnTo>
                  <a:pt x="742" y="366"/>
                </a:lnTo>
                <a:lnTo>
                  <a:pt x="742" y="365"/>
                </a:lnTo>
                <a:lnTo>
                  <a:pt x="743" y="365"/>
                </a:lnTo>
                <a:lnTo>
                  <a:pt x="743" y="364"/>
                </a:lnTo>
                <a:lnTo>
                  <a:pt x="744" y="364"/>
                </a:lnTo>
                <a:lnTo>
                  <a:pt x="744" y="365"/>
                </a:lnTo>
                <a:lnTo>
                  <a:pt x="745" y="364"/>
                </a:lnTo>
                <a:lnTo>
                  <a:pt x="745" y="365"/>
                </a:lnTo>
                <a:lnTo>
                  <a:pt x="746" y="366"/>
                </a:lnTo>
                <a:lnTo>
                  <a:pt x="747" y="366"/>
                </a:lnTo>
                <a:lnTo>
                  <a:pt x="748" y="367"/>
                </a:lnTo>
                <a:lnTo>
                  <a:pt x="749" y="367"/>
                </a:lnTo>
                <a:lnTo>
                  <a:pt x="750" y="367"/>
                </a:lnTo>
                <a:lnTo>
                  <a:pt x="751" y="367"/>
                </a:lnTo>
                <a:lnTo>
                  <a:pt x="752" y="367"/>
                </a:lnTo>
                <a:lnTo>
                  <a:pt x="752" y="368"/>
                </a:lnTo>
                <a:lnTo>
                  <a:pt x="753" y="368"/>
                </a:lnTo>
                <a:lnTo>
                  <a:pt x="753" y="367"/>
                </a:lnTo>
                <a:lnTo>
                  <a:pt x="754" y="367"/>
                </a:lnTo>
                <a:lnTo>
                  <a:pt x="754" y="368"/>
                </a:lnTo>
                <a:lnTo>
                  <a:pt x="755" y="367"/>
                </a:lnTo>
                <a:lnTo>
                  <a:pt x="756" y="367"/>
                </a:lnTo>
                <a:lnTo>
                  <a:pt x="757" y="368"/>
                </a:lnTo>
                <a:lnTo>
                  <a:pt x="758" y="368"/>
                </a:lnTo>
                <a:lnTo>
                  <a:pt x="758" y="367"/>
                </a:lnTo>
                <a:lnTo>
                  <a:pt x="759" y="365"/>
                </a:lnTo>
                <a:lnTo>
                  <a:pt x="759" y="362"/>
                </a:lnTo>
                <a:lnTo>
                  <a:pt x="760" y="365"/>
                </a:lnTo>
                <a:lnTo>
                  <a:pt x="760" y="366"/>
                </a:lnTo>
                <a:lnTo>
                  <a:pt x="761" y="366"/>
                </a:lnTo>
                <a:lnTo>
                  <a:pt x="761" y="367"/>
                </a:lnTo>
                <a:lnTo>
                  <a:pt x="762" y="368"/>
                </a:lnTo>
                <a:lnTo>
                  <a:pt x="762" y="367"/>
                </a:lnTo>
                <a:lnTo>
                  <a:pt x="763" y="367"/>
                </a:lnTo>
                <a:lnTo>
                  <a:pt x="763" y="368"/>
                </a:lnTo>
                <a:lnTo>
                  <a:pt x="764" y="368"/>
                </a:lnTo>
                <a:lnTo>
                  <a:pt x="765" y="368"/>
                </a:lnTo>
                <a:lnTo>
                  <a:pt x="766" y="367"/>
                </a:lnTo>
                <a:lnTo>
                  <a:pt x="766" y="362"/>
                </a:lnTo>
                <a:lnTo>
                  <a:pt x="767" y="361"/>
                </a:lnTo>
                <a:lnTo>
                  <a:pt x="767" y="363"/>
                </a:lnTo>
                <a:lnTo>
                  <a:pt x="768" y="365"/>
                </a:lnTo>
                <a:lnTo>
                  <a:pt x="768" y="367"/>
                </a:lnTo>
                <a:lnTo>
                  <a:pt x="769" y="367"/>
                </a:lnTo>
                <a:lnTo>
                  <a:pt x="769" y="368"/>
                </a:lnTo>
                <a:lnTo>
                  <a:pt x="770" y="368"/>
                </a:lnTo>
                <a:lnTo>
                  <a:pt x="770" y="365"/>
                </a:lnTo>
                <a:lnTo>
                  <a:pt x="771" y="363"/>
                </a:lnTo>
                <a:lnTo>
                  <a:pt x="771" y="364"/>
                </a:lnTo>
                <a:lnTo>
                  <a:pt x="772" y="366"/>
                </a:lnTo>
                <a:lnTo>
                  <a:pt x="772" y="367"/>
                </a:lnTo>
                <a:lnTo>
                  <a:pt x="773" y="366"/>
                </a:lnTo>
                <a:lnTo>
                  <a:pt x="773" y="367"/>
                </a:lnTo>
                <a:lnTo>
                  <a:pt x="774" y="365"/>
                </a:lnTo>
                <a:lnTo>
                  <a:pt x="774" y="355"/>
                </a:lnTo>
                <a:lnTo>
                  <a:pt x="775" y="351"/>
                </a:lnTo>
                <a:lnTo>
                  <a:pt x="775" y="363"/>
                </a:lnTo>
                <a:lnTo>
                  <a:pt x="776" y="365"/>
                </a:lnTo>
                <a:lnTo>
                  <a:pt x="776" y="362"/>
                </a:lnTo>
                <a:lnTo>
                  <a:pt x="777" y="364"/>
                </a:lnTo>
                <a:lnTo>
                  <a:pt x="777" y="366"/>
                </a:lnTo>
                <a:lnTo>
                  <a:pt x="778" y="367"/>
                </a:lnTo>
                <a:lnTo>
                  <a:pt x="779" y="367"/>
                </a:lnTo>
                <a:lnTo>
                  <a:pt x="779" y="366"/>
                </a:lnTo>
                <a:lnTo>
                  <a:pt x="780" y="365"/>
                </a:lnTo>
                <a:lnTo>
                  <a:pt x="780" y="364"/>
                </a:lnTo>
                <a:lnTo>
                  <a:pt x="781" y="364"/>
                </a:lnTo>
                <a:lnTo>
                  <a:pt x="781" y="365"/>
                </a:lnTo>
                <a:lnTo>
                  <a:pt x="782" y="362"/>
                </a:lnTo>
                <a:lnTo>
                  <a:pt x="782" y="363"/>
                </a:lnTo>
                <a:lnTo>
                  <a:pt x="783" y="366"/>
                </a:lnTo>
                <a:lnTo>
                  <a:pt x="783" y="365"/>
                </a:lnTo>
                <a:lnTo>
                  <a:pt x="784" y="363"/>
                </a:lnTo>
                <a:lnTo>
                  <a:pt x="784" y="360"/>
                </a:lnTo>
                <a:lnTo>
                  <a:pt x="785" y="358"/>
                </a:lnTo>
                <a:lnTo>
                  <a:pt x="785" y="360"/>
                </a:lnTo>
                <a:lnTo>
                  <a:pt x="786" y="361"/>
                </a:lnTo>
                <a:lnTo>
                  <a:pt x="786" y="362"/>
                </a:lnTo>
                <a:lnTo>
                  <a:pt x="787" y="359"/>
                </a:lnTo>
                <a:lnTo>
                  <a:pt x="787" y="363"/>
                </a:lnTo>
                <a:lnTo>
                  <a:pt x="788" y="365"/>
                </a:lnTo>
                <a:lnTo>
                  <a:pt x="788" y="362"/>
                </a:lnTo>
                <a:lnTo>
                  <a:pt x="789" y="360"/>
                </a:lnTo>
                <a:lnTo>
                  <a:pt x="789" y="365"/>
                </a:lnTo>
                <a:lnTo>
                  <a:pt x="790" y="367"/>
                </a:lnTo>
                <a:lnTo>
                  <a:pt x="791" y="367"/>
                </a:lnTo>
                <a:lnTo>
                  <a:pt x="792" y="367"/>
                </a:lnTo>
                <a:lnTo>
                  <a:pt x="792" y="366"/>
                </a:lnTo>
                <a:lnTo>
                  <a:pt x="793" y="366"/>
                </a:lnTo>
                <a:lnTo>
                  <a:pt x="793" y="365"/>
                </a:lnTo>
                <a:lnTo>
                  <a:pt x="794" y="366"/>
                </a:lnTo>
                <a:lnTo>
                  <a:pt x="794" y="367"/>
                </a:lnTo>
                <a:lnTo>
                  <a:pt x="795" y="367"/>
                </a:lnTo>
                <a:lnTo>
                  <a:pt x="795" y="364"/>
                </a:lnTo>
                <a:lnTo>
                  <a:pt x="796" y="362"/>
                </a:lnTo>
                <a:lnTo>
                  <a:pt x="796" y="361"/>
                </a:lnTo>
                <a:lnTo>
                  <a:pt x="797" y="363"/>
                </a:lnTo>
                <a:lnTo>
                  <a:pt x="797" y="366"/>
                </a:lnTo>
                <a:lnTo>
                  <a:pt x="798" y="367"/>
                </a:lnTo>
                <a:lnTo>
                  <a:pt x="799" y="367"/>
                </a:lnTo>
                <a:lnTo>
                  <a:pt x="800" y="367"/>
                </a:lnTo>
                <a:lnTo>
                  <a:pt x="801" y="367"/>
                </a:lnTo>
                <a:lnTo>
                  <a:pt x="802" y="367"/>
                </a:lnTo>
                <a:lnTo>
                  <a:pt x="803" y="367"/>
                </a:lnTo>
                <a:lnTo>
                  <a:pt x="804" y="367"/>
                </a:lnTo>
                <a:lnTo>
                  <a:pt x="804" y="366"/>
                </a:lnTo>
                <a:lnTo>
                  <a:pt x="805" y="366"/>
                </a:lnTo>
                <a:lnTo>
                  <a:pt x="805" y="367"/>
                </a:lnTo>
                <a:lnTo>
                  <a:pt x="806" y="365"/>
                </a:lnTo>
                <a:lnTo>
                  <a:pt x="807" y="366"/>
                </a:lnTo>
                <a:lnTo>
                  <a:pt x="808" y="366"/>
                </a:lnTo>
                <a:lnTo>
                  <a:pt x="809" y="366"/>
                </a:lnTo>
                <a:lnTo>
                  <a:pt x="809" y="365"/>
                </a:lnTo>
                <a:lnTo>
                  <a:pt x="810" y="364"/>
                </a:lnTo>
                <a:lnTo>
                  <a:pt x="810" y="366"/>
                </a:lnTo>
                <a:lnTo>
                  <a:pt x="811" y="366"/>
                </a:lnTo>
                <a:lnTo>
                  <a:pt x="811" y="367"/>
                </a:lnTo>
                <a:lnTo>
                  <a:pt x="812" y="367"/>
                </a:lnTo>
                <a:lnTo>
                  <a:pt x="812" y="366"/>
                </a:lnTo>
                <a:lnTo>
                  <a:pt x="813" y="366"/>
                </a:lnTo>
                <a:lnTo>
                  <a:pt x="813" y="365"/>
                </a:lnTo>
                <a:lnTo>
                  <a:pt x="814" y="366"/>
                </a:lnTo>
                <a:lnTo>
                  <a:pt x="814" y="365"/>
                </a:lnTo>
                <a:lnTo>
                  <a:pt x="815" y="362"/>
                </a:lnTo>
                <a:lnTo>
                  <a:pt x="815" y="354"/>
                </a:lnTo>
                <a:lnTo>
                  <a:pt x="816" y="349"/>
                </a:lnTo>
                <a:lnTo>
                  <a:pt x="816" y="358"/>
                </a:lnTo>
                <a:lnTo>
                  <a:pt x="817" y="350"/>
                </a:lnTo>
                <a:lnTo>
                  <a:pt x="817" y="343"/>
                </a:lnTo>
                <a:lnTo>
                  <a:pt x="818" y="361"/>
                </a:lnTo>
                <a:lnTo>
                  <a:pt x="818" y="364"/>
                </a:lnTo>
                <a:lnTo>
                  <a:pt x="819" y="362"/>
                </a:lnTo>
                <a:lnTo>
                  <a:pt x="819" y="355"/>
                </a:lnTo>
                <a:lnTo>
                  <a:pt x="820" y="335"/>
                </a:lnTo>
                <a:lnTo>
                  <a:pt x="820" y="353"/>
                </a:lnTo>
                <a:lnTo>
                  <a:pt x="821" y="364"/>
                </a:lnTo>
                <a:lnTo>
                  <a:pt x="821" y="365"/>
                </a:lnTo>
                <a:lnTo>
                  <a:pt x="822" y="364"/>
                </a:lnTo>
                <a:lnTo>
                  <a:pt x="822" y="366"/>
                </a:lnTo>
                <a:lnTo>
                  <a:pt x="823" y="364"/>
                </a:lnTo>
                <a:lnTo>
                  <a:pt x="823" y="358"/>
                </a:lnTo>
                <a:lnTo>
                  <a:pt x="824" y="356"/>
                </a:lnTo>
                <a:lnTo>
                  <a:pt x="824" y="326"/>
                </a:lnTo>
                <a:lnTo>
                  <a:pt x="825" y="330"/>
                </a:lnTo>
                <a:lnTo>
                  <a:pt x="825" y="362"/>
                </a:lnTo>
                <a:lnTo>
                  <a:pt x="826" y="364"/>
                </a:lnTo>
                <a:lnTo>
                  <a:pt x="826" y="363"/>
                </a:lnTo>
                <a:lnTo>
                  <a:pt x="827" y="363"/>
                </a:lnTo>
                <a:lnTo>
                  <a:pt x="827" y="356"/>
                </a:lnTo>
                <a:lnTo>
                  <a:pt x="828" y="354"/>
                </a:lnTo>
                <a:lnTo>
                  <a:pt x="828" y="360"/>
                </a:lnTo>
                <a:lnTo>
                  <a:pt x="829" y="364"/>
                </a:lnTo>
                <a:lnTo>
                  <a:pt x="829" y="365"/>
                </a:lnTo>
                <a:lnTo>
                  <a:pt x="830" y="365"/>
                </a:lnTo>
                <a:lnTo>
                  <a:pt x="830" y="366"/>
                </a:lnTo>
                <a:lnTo>
                  <a:pt x="831" y="365"/>
                </a:lnTo>
                <a:lnTo>
                  <a:pt x="832" y="365"/>
                </a:lnTo>
                <a:lnTo>
                  <a:pt x="833" y="364"/>
                </a:lnTo>
                <a:lnTo>
                  <a:pt x="834" y="365"/>
                </a:lnTo>
                <a:lnTo>
                  <a:pt x="835" y="366"/>
                </a:lnTo>
                <a:lnTo>
                  <a:pt x="835" y="365"/>
                </a:lnTo>
                <a:lnTo>
                  <a:pt x="836" y="365"/>
                </a:lnTo>
                <a:lnTo>
                  <a:pt x="836" y="362"/>
                </a:lnTo>
                <a:lnTo>
                  <a:pt x="837" y="353"/>
                </a:lnTo>
                <a:lnTo>
                  <a:pt x="837" y="323"/>
                </a:lnTo>
                <a:lnTo>
                  <a:pt x="838" y="288"/>
                </a:lnTo>
                <a:lnTo>
                  <a:pt x="838" y="352"/>
                </a:lnTo>
                <a:lnTo>
                  <a:pt x="839" y="360"/>
                </a:lnTo>
                <a:lnTo>
                  <a:pt x="839" y="361"/>
                </a:lnTo>
                <a:lnTo>
                  <a:pt x="840" y="363"/>
                </a:lnTo>
                <a:lnTo>
                  <a:pt x="840" y="364"/>
                </a:lnTo>
                <a:lnTo>
                  <a:pt x="841" y="364"/>
                </a:lnTo>
                <a:lnTo>
                  <a:pt x="842" y="365"/>
                </a:lnTo>
                <a:lnTo>
                  <a:pt x="843" y="365"/>
                </a:lnTo>
                <a:lnTo>
                  <a:pt x="844" y="366"/>
                </a:lnTo>
                <a:lnTo>
                  <a:pt x="845" y="365"/>
                </a:lnTo>
                <a:lnTo>
                  <a:pt x="845" y="364"/>
                </a:lnTo>
                <a:lnTo>
                  <a:pt x="846" y="364"/>
                </a:lnTo>
                <a:lnTo>
                  <a:pt x="846" y="365"/>
                </a:lnTo>
                <a:lnTo>
                  <a:pt x="847" y="365"/>
                </a:lnTo>
                <a:lnTo>
                  <a:pt x="848" y="365"/>
                </a:lnTo>
                <a:lnTo>
                  <a:pt x="849" y="365"/>
                </a:lnTo>
                <a:lnTo>
                  <a:pt x="850" y="365"/>
                </a:lnTo>
                <a:lnTo>
                  <a:pt x="851" y="365"/>
                </a:lnTo>
                <a:lnTo>
                  <a:pt x="852" y="366"/>
                </a:lnTo>
                <a:lnTo>
                  <a:pt x="852" y="365"/>
                </a:lnTo>
                <a:lnTo>
                  <a:pt x="853" y="365"/>
                </a:lnTo>
                <a:lnTo>
                  <a:pt x="854" y="365"/>
                </a:lnTo>
                <a:lnTo>
                  <a:pt x="855" y="365"/>
                </a:lnTo>
                <a:lnTo>
                  <a:pt x="855" y="364"/>
                </a:lnTo>
                <a:lnTo>
                  <a:pt x="856" y="364"/>
                </a:lnTo>
                <a:lnTo>
                  <a:pt x="856" y="363"/>
                </a:lnTo>
                <a:lnTo>
                  <a:pt x="857" y="364"/>
                </a:lnTo>
                <a:lnTo>
                  <a:pt x="857" y="358"/>
                </a:lnTo>
                <a:lnTo>
                  <a:pt x="858" y="334"/>
                </a:lnTo>
                <a:lnTo>
                  <a:pt x="858" y="346"/>
                </a:lnTo>
                <a:lnTo>
                  <a:pt x="859" y="362"/>
                </a:lnTo>
                <a:lnTo>
                  <a:pt x="859" y="358"/>
                </a:lnTo>
                <a:lnTo>
                  <a:pt x="860" y="354"/>
                </a:lnTo>
                <a:lnTo>
                  <a:pt x="860" y="361"/>
                </a:lnTo>
                <a:lnTo>
                  <a:pt x="861" y="363"/>
                </a:lnTo>
                <a:lnTo>
                  <a:pt x="861" y="364"/>
                </a:lnTo>
                <a:lnTo>
                  <a:pt x="862" y="364"/>
                </a:lnTo>
                <a:lnTo>
                  <a:pt x="862" y="360"/>
                </a:lnTo>
                <a:lnTo>
                  <a:pt x="863" y="352"/>
                </a:lnTo>
                <a:lnTo>
                  <a:pt x="863" y="337"/>
                </a:lnTo>
                <a:lnTo>
                  <a:pt x="864" y="338"/>
                </a:lnTo>
                <a:lnTo>
                  <a:pt x="864" y="361"/>
                </a:lnTo>
                <a:lnTo>
                  <a:pt x="865" y="363"/>
                </a:lnTo>
                <a:lnTo>
                  <a:pt x="865" y="361"/>
                </a:lnTo>
                <a:lnTo>
                  <a:pt x="866" y="355"/>
                </a:lnTo>
                <a:lnTo>
                  <a:pt x="866" y="359"/>
                </a:lnTo>
                <a:lnTo>
                  <a:pt x="867" y="362"/>
                </a:lnTo>
                <a:lnTo>
                  <a:pt x="867" y="359"/>
                </a:lnTo>
                <a:lnTo>
                  <a:pt x="868" y="358"/>
                </a:lnTo>
                <a:lnTo>
                  <a:pt x="868" y="363"/>
                </a:lnTo>
                <a:lnTo>
                  <a:pt x="869" y="363"/>
                </a:lnTo>
                <a:lnTo>
                  <a:pt x="869" y="364"/>
                </a:lnTo>
                <a:lnTo>
                  <a:pt x="870" y="363"/>
                </a:lnTo>
                <a:lnTo>
                  <a:pt x="870" y="362"/>
                </a:lnTo>
                <a:lnTo>
                  <a:pt x="871" y="362"/>
                </a:lnTo>
                <a:lnTo>
                  <a:pt x="871" y="363"/>
                </a:lnTo>
                <a:lnTo>
                  <a:pt x="872" y="363"/>
                </a:lnTo>
                <a:lnTo>
                  <a:pt x="873" y="363"/>
                </a:lnTo>
                <a:lnTo>
                  <a:pt x="873" y="364"/>
                </a:lnTo>
                <a:lnTo>
                  <a:pt x="874" y="364"/>
                </a:lnTo>
                <a:lnTo>
                  <a:pt x="875" y="364"/>
                </a:lnTo>
                <a:lnTo>
                  <a:pt x="876" y="364"/>
                </a:lnTo>
                <a:lnTo>
                  <a:pt x="877" y="364"/>
                </a:lnTo>
                <a:lnTo>
                  <a:pt x="878" y="364"/>
                </a:lnTo>
                <a:lnTo>
                  <a:pt x="879" y="364"/>
                </a:lnTo>
                <a:lnTo>
                  <a:pt x="879" y="362"/>
                </a:lnTo>
                <a:lnTo>
                  <a:pt x="880" y="363"/>
                </a:lnTo>
                <a:lnTo>
                  <a:pt x="880" y="362"/>
                </a:lnTo>
                <a:lnTo>
                  <a:pt x="881" y="361"/>
                </a:lnTo>
                <a:lnTo>
                  <a:pt x="882" y="359"/>
                </a:lnTo>
                <a:lnTo>
                  <a:pt x="882" y="353"/>
                </a:lnTo>
                <a:lnTo>
                  <a:pt x="883" y="357"/>
                </a:lnTo>
                <a:lnTo>
                  <a:pt x="883" y="361"/>
                </a:lnTo>
                <a:lnTo>
                  <a:pt x="884" y="361"/>
                </a:lnTo>
                <a:lnTo>
                  <a:pt x="884" y="362"/>
                </a:lnTo>
                <a:lnTo>
                  <a:pt x="885" y="362"/>
                </a:lnTo>
                <a:lnTo>
                  <a:pt x="885" y="363"/>
                </a:lnTo>
                <a:lnTo>
                  <a:pt x="886" y="363"/>
                </a:lnTo>
                <a:lnTo>
                  <a:pt x="886" y="362"/>
                </a:lnTo>
                <a:lnTo>
                  <a:pt x="887" y="361"/>
                </a:lnTo>
                <a:lnTo>
                  <a:pt x="887" y="360"/>
                </a:lnTo>
                <a:lnTo>
                  <a:pt x="888" y="362"/>
                </a:lnTo>
                <a:lnTo>
                  <a:pt x="889" y="363"/>
                </a:lnTo>
                <a:lnTo>
                  <a:pt x="889" y="362"/>
                </a:lnTo>
                <a:lnTo>
                  <a:pt x="890" y="362"/>
                </a:lnTo>
                <a:lnTo>
                  <a:pt x="891" y="362"/>
                </a:lnTo>
                <a:lnTo>
                  <a:pt x="892" y="362"/>
                </a:lnTo>
                <a:lnTo>
                  <a:pt x="893" y="362"/>
                </a:lnTo>
                <a:lnTo>
                  <a:pt x="894" y="362"/>
                </a:lnTo>
                <a:lnTo>
                  <a:pt x="895" y="362"/>
                </a:lnTo>
                <a:lnTo>
                  <a:pt x="896" y="362"/>
                </a:lnTo>
                <a:lnTo>
                  <a:pt x="897" y="362"/>
                </a:lnTo>
                <a:lnTo>
                  <a:pt x="898" y="362"/>
                </a:lnTo>
                <a:lnTo>
                  <a:pt x="898" y="361"/>
                </a:lnTo>
                <a:lnTo>
                  <a:pt x="899" y="361"/>
                </a:lnTo>
                <a:lnTo>
                  <a:pt x="900" y="361"/>
                </a:lnTo>
                <a:lnTo>
                  <a:pt x="901" y="361"/>
                </a:lnTo>
                <a:lnTo>
                  <a:pt x="901" y="362"/>
                </a:lnTo>
                <a:lnTo>
                  <a:pt x="902" y="362"/>
                </a:lnTo>
                <a:lnTo>
                  <a:pt x="903" y="362"/>
                </a:lnTo>
                <a:lnTo>
                  <a:pt x="903" y="361"/>
                </a:lnTo>
                <a:lnTo>
                  <a:pt x="904" y="361"/>
                </a:lnTo>
                <a:lnTo>
                  <a:pt x="905" y="361"/>
                </a:lnTo>
                <a:lnTo>
                  <a:pt x="906" y="361"/>
                </a:lnTo>
                <a:lnTo>
                  <a:pt x="907" y="361"/>
                </a:lnTo>
                <a:lnTo>
                  <a:pt x="908" y="361"/>
                </a:lnTo>
                <a:lnTo>
                  <a:pt x="909" y="361"/>
                </a:lnTo>
                <a:lnTo>
                  <a:pt x="909" y="359"/>
                </a:lnTo>
                <a:lnTo>
                  <a:pt x="910" y="359"/>
                </a:lnTo>
                <a:lnTo>
                  <a:pt x="910" y="358"/>
                </a:lnTo>
                <a:lnTo>
                  <a:pt x="911" y="359"/>
                </a:lnTo>
                <a:lnTo>
                  <a:pt x="912" y="359"/>
                </a:lnTo>
                <a:lnTo>
                  <a:pt x="913" y="360"/>
                </a:lnTo>
                <a:lnTo>
                  <a:pt x="914" y="360"/>
                </a:lnTo>
                <a:lnTo>
                  <a:pt x="915" y="360"/>
                </a:lnTo>
                <a:lnTo>
                  <a:pt x="916" y="360"/>
                </a:lnTo>
                <a:lnTo>
                  <a:pt x="916" y="359"/>
                </a:lnTo>
                <a:lnTo>
                  <a:pt x="917" y="359"/>
                </a:lnTo>
                <a:lnTo>
                  <a:pt x="918" y="359"/>
                </a:lnTo>
                <a:lnTo>
                  <a:pt x="919" y="358"/>
                </a:lnTo>
                <a:lnTo>
                  <a:pt x="920" y="358"/>
                </a:lnTo>
                <a:lnTo>
                  <a:pt x="921" y="359"/>
                </a:lnTo>
                <a:lnTo>
                  <a:pt x="921" y="358"/>
                </a:lnTo>
                <a:lnTo>
                  <a:pt x="922" y="358"/>
                </a:lnTo>
                <a:lnTo>
                  <a:pt x="922" y="359"/>
                </a:lnTo>
                <a:lnTo>
                  <a:pt x="923" y="358"/>
                </a:lnTo>
                <a:lnTo>
                  <a:pt x="924" y="359"/>
                </a:lnTo>
                <a:lnTo>
                  <a:pt x="925" y="359"/>
                </a:lnTo>
                <a:lnTo>
                  <a:pt x="925" y="358"/>
                </a:lnTo>
                <a:lnTo>
                  <a:pt x="926" y="358"/>
                </a:lnTo>
                <a:lnTo>
                  <a:pt x="927" y="357"/>
                </a:lnTo>
                <a:lnTo>
                  <a:pt x="927" y="358"/>
                </a:lnTo>
                <a:lnTo>
                  <a:pt x="928" y="358"/>
                </a:lnTo>
                <a:lnTo>
                  <a:pt x="929" y="358"/>
                </a:lnTo>
                <a:lnTo>
                  <a:pt x="930" y="358"/>
                </a:lnTo>
                <a:lnTo>
                  <a:pt x="930" y="359"/>
                </a:lnTo>
                <a:lnTo>
                  <a:pt x="931" y="358"/>
                </a:lnTo>
                <a:lnTo>
                  <a:pt x="932" y="359"/>
                </a:lnTo>
                <a:lnTo>
                  <a:pt x="933" y="359"/>
                </a:lnTo>
                <a:lnTo>
                  <a:pt x="933" y="360"/>
                </a:lnTo>
                <a:lnTo>
                  <a:pt x="934" y="359"/>
                </a:lnTo>
                <a:lnTo>
                  <a:pt x="935" y="359"/>
                </a:lnTo>
                <a:lnTo>
                  <a:pt x="935" y="360"/>
                </a:lnTo>
                <a:lnTo>
                  <a:pt x="936" y="360"/>
                </a:lnTo>
                <a:lnTo>
                  <a:pt x="937" y="359"/>
                </a:lnTo>
                <a:lnTo>
                  <a:pt x="938" y="360"/>
                </a:lnTo>
                <a:lnTo>
                  <a:pt x="939" y="360"/>
                </a:lnTo>
                <a:lnTo>
                  <a:pt x="939" y="361"/>
                </a:lnTo>
                <a:lnTo>
                  <a:pt x="940" y="360"/>
                </a:lnTo>
                <a:lnTo>
                  <a:pt x="941" y="360"/>
                </a:lnTo>
                <a:lnTo>
                  <a:pt x="941" y="359"/>
                </a:lnTo>
                <a:lnTo>
                  <a:pt x="942" y="359"/>
                </a:lnTo>
                <a:lnTo>
                  <a:pt x="942" y="360"/>
                </a:lnTo>
                <a:lnTo>
                  <a:pt x="943" y="359"/>
                </a:lnTo>
                <a:lnTo>
                  <a:pt x="943" y="358"/>
                </a:lnTo>
                <a:lnTo>
                  <a:pt x="944" y="358"/>
                </a:lnTo>
                <a:lnTo>
                  <a:pt x="945" y="359"/>
                </a:lnTo>
                <a:lnTo>
                  <a:pt x="946" y="359"/>
                </a:lnTo>
                <a:lnTo>
                  <a:pt x="947" y="359"/>
                </a:lnTo>
                <a:lnTo>
                  <a:pt x="948" y="359"/>
                </a:lnTo>
                <a:lnTo>
                  <a:pt x="949" y="359"/>
                </a:lnTo>
                <a:lnTo>
                  <a:pt x="949" y="350"/>
                </a:lnTo>
                <a:lnTo>
                  <a:pt x="950" y="325"/>
                </a:lnTo>
                <a:lnTo>
                  <a:pt x="951" y="279"/>
                </a:lnTo>
                <a:lnTo>
                  <a:pt x="951" y="241"/>
                </a:lnTo>
                <a:lnTo>
                  <a:pt x="952" y="162"/>
                </a:lnTo>
                <a:lnTo>
                  <a:pt x="952" y="0"/>
                </a:lnTo>
                <a:lnTo>
                  <a:pt x="953" y="155"/>
                </a:lnTo>
                <a:lnTo>
                  <a:pt x="953" y="338"/>
                </a:lnTo>
                <a:lnTo>
                  <a:pt x="954" y="349"/>
                </a:lnTo>
                <a:lnTo>
                  <a:pt x="954" y="351"/>
                </a:lnTo>
                <a:lnTo>
                  <a:pt x="955" y="354"/>
                </a:lnTo>
                <a:lnTo>
                  <a:pt x="955" y="355"/>
                </a:lnTo>
                <a:lnTo>
                  <a:pt x="956" y="356"/>
                </a:lnTo>
                <a:lnTo>
                  <a:pt x="957" y="358"/>
                </a:lnTo>
                <a:lnTo>
                  <a:pt x="957" y="357"/>
                </a:lnTo>
                <a:lnTo>
                  <a:pt x="958" y="357"/>
                </a:lnTo>
                <a:lnTo>
                  <a:pt x="959" y="357"/>
                </a:lnTo>
                <a:lnTo>
                  <a:pt x="959" y="358"/>
                </a:lnTo>
                <a:lnTo>
                  <a:pt x="960" y="356"/>
                </a:lnTo>
                <a:lnTo>
                  <a:pt x="960" y="358"/>
                </a:lnTo>
                <a:lnTo>
                  <a:pt x="961" y="359"/>
                </a:lnTo>
                <a:lnTo>
                  <a:pt x="962" y="360"/>
                </a:lnTo>
                <a:lnTo>
                  <a:pt x="963" y="359"/>
                </a:lnTo>
                <a:lnTo>
                  <a:pt x="964" y="359"/>
                </a:lnTo>
                <a:lnTo>
                  <a:pt x="964" y="360"/>
                </a:lnTo>
                <a:lnTo>
                  <a:pt x="965" y="360"/>
                </a:lnTo>
                <a:lnTo>
                  <a:pt x="965" y="361"/>
                </a:lnTo>
                <a:lnTo>
                  <a:pt x="966" y="361"/>
                </a:lnTo>
                <a:lnTo>
                  <a:pt x="967" y="361"/>
                </a:lnTo>
                <a:lnTo>
                  <a:pt x="968" y="361"/>
                </a:lnTo>
                <a:lnTo>
                  <a:pt x="968" y="360"/>
                </a:lnTo>
                <a:lnTo>
                  <a:pt x="969" y="360"/>
                </a:lnTo>
                <a:lnTo>
                  <a:pt x="970" y="361"/>
                </a:lnTo>
                <a:lnTo>
                  <a:pt x="971" y="362"/>
                </a:lnTo>
                <a:lnTo>
                  <a:pt x="972" y="361"/>
                </a:lnTo>
                <a:lnTo>
                  <a:pt x="973" y="360"/>
                </a:lnTo>
                <a:lnTo>
                  <a:pt x="973" y="362"/>
                </a:lnTo>
                <a:lnTo>
                  <a:pt x="974" y="362"/>
                </a:lnTo>
                <a:lnTo>
                  <a:pt x="975" y="363"/>
                </a:lnTo>
                <a:lnTo>
                  <a:pt x="975" y="362"/>
                </a:lnTo>
                <a:lnTo>
                  <a:pt x="976" y="363"/>
                </a:lnTo>
                <a:lnTo>
                  <a:pt x="977" y="363"/>
                </a:lnTo>
                <a:lnTo>
                  <a:pt x="978" y="362"/>
                </a:lnTo>
                <a:lnTo>
                  <a:pt x="979" y="362"/>
                </a:lnTo>
                <a:lnTo>
                  <a:pt x="980" y="362"/>
                </a:lnTo>
                <a:lnTo>
                  <a:pt x="980" y="361"/>
                </a:lnTo>
                <a:lnTo>
                  <a:pt x="981" y="361"/>
                </a:lnTo>
                <a:lnTo>
                  <a:pt x="981" y="363"/>
                </a:lnTo>
                <a:lnTo>
                  <a:pt x="982" y="363"/>
                </a:lnTo>
                <a:lnTo>
                  <a:pt x="983" y="363"/>
                </a:lnTo>
                <a:lnTo>
                  <a:pt x="984" y="363"/>
                </a:lnTo>
                <a:lnTo>
                  <a:pt x="984" y="364"/>
                </a:lnTo>
                <a:lnTo>
                  <a:pt x="985" y="364"/>
                </a:lnTo>
                <a:lnTo>
                  <a:pt x="986" y="363"/>
                </a:lnTo>
                <a:lnTo>
                  <a:pt x="986" y="362"/>
                </a:lnTo>
                <a:lnTo>
                  <a:pt x="987" y="362"/>
                </a:lnTo>
                <a:lnTo>
                  <a:pt x="987" y="363"/>
                </a:lnTo>
                <a:lnTo>
                  <a:pt x="988" y="364"/>
                </a:lnTo>
                <a:lnTo>
                  <a:pt x="989" y="363"/>
                </a:lnTo>
                <a:lnTo>
                  <a:pt x="990" y="363"/>
                </a:lnTo>
                <a:lnTo>
                  <a:pt x="990" y="362"/>
                </a:lnTo>
                <a:lnTo>
                  <a:pt x="991" y="362"/>
                </a:lnTo>
                <a:lnTo>
                  <a:pt x="991" y="363"/>
                </a:lnTo>
                <a:lnTo>
                  <a:pt x="992" y="363"/>
                </a:lnTo>
              </a:path>
            </a:pathLst>
          </a:custGeom>
          <a:noFill/>
          <a:ln w="0">
            <a:solidFill>
              <a:srgbClr val="800000"/>
            </a:solidFill>
            <a:prstDash val="solid"/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31" name="Rectangle 255"/>
          <p:cNvSpPr>
            <a:spLocks noChangeArrowheads="1"/>
          </p:cNvSpPr>
          <p:nvPr/>
        </p:nvSpPr>
        <p:spPr bwMode="auto">
          <a:xfrm>
            <a:off x="1701800" y="3767138"/>
            <a:ext cx="20002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4.01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32" name="Rectangle 256"/>
          <p:cNvSpPr>
            <a:spLocks noChangeArrowheads="1"/>
          </p:cNvSpPr>
          <p:nvPr/>
        </p:nvSpPr>
        <p:spPr bwMode="auto">
          <a:xfrm>
            <a:off x="6880226" y="3709988"/>
            <a:ext cx="25717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4.43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33" name="Rectangle 257"/>
          <p:cNvSpPr>
            <a:spLocks noChangeArrowheads="1"/>
          </p:cNvSpPr>
          <p:nvPr/>
        </p:nvSpPr>
        <p:spPr bwMode="auto">
          <a:xfrm>
            <a:off x="2613026" y="3825875"/>
            <a:ext cx="200025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5.84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34" name="Rectangle 258"/>
          <p:cNvSpPr>
            <a:spLocks noChangeArrowheads="1"/>
          </p:cNvSpPr>
          <p:nvPr/>
        </p:nvSpPr>
        <p:spPr bwMode="auto">
          <a:xfrm>
            <a:off x="1882775" y="4170364"/>
            <a:ext cx="20002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4.38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35" name="Rectangle 259"/>
          <p:cNvSpPr>
            <a:spLocks noChangeArrowheads="1"/>
          </p:cNvSpPr>
          <p:nvPr/>
        </p:nvSpPr>
        <p:spPr bwMode="auto">
          <a:xfrm>
            <a:off x="4997450" y="4229100"/>
            <a:ext cx="257175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0.66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36" name="Rectangle 260"/>
          <p:cNvSpPr>
            <a:spLocks noChangeArrowheads="1"/>
          </p:cNvSpPr>
          <p:nvPr/>
        </p:nvSpPr>
        <p:spPr bwMode="auto">
          <a:xfrm>
            <a:off x="3927476" y="4516438"/>
            <a:ext cx="20002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8.46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37" name="Rectangle 261"/>
          <p:cNvSpPr>
            <a:spLocks noChangeArrowheads="1"/>
          </p:cNvSpPr>
          <p:nvPr/>
        </p:nvSpPr>
        <p:spPr bwMode="auto">
          <a:xfrm>
            <a:off x="4757738" y="4862514"/>
            <a:ext cx="25717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0.18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38" name="Rectangle 262"/>
          <p:cNvSpPr>
            <a:spLocks noChangeArrowheads="1"/>
          </p:cNvSpPr>
          <p:nvPr/>
        </p:nvSpPr>
        <p:spPr bwMode="auto">
          <a:xfrm>
            <a:off x="5548314" y="5092700"/>
            <a:ext cx="257175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1.76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39" name="Rectangle 263"/>
          <p:cNvSpPr>
            <a:spLocks noChangeArrowheads="1"/>
          </p:cNvSpPr>
          <p:nvPr/>
        </p:nvSpPr>
        <p:spPr bwMode="auto">
          <a:xfrm>
            <a:off x="2093913" y="5092700"/>
            <a:ext cx="200025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4.55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0" name="Rectangle 264"/>
          <p:cNvSpPr>
            <a:spLocks noChangeArrowheads="1"/>
          </p:cNvSpPr>
          <p:nvPr/>
        </p:nvSpPr>
        <p:spPr bwMode="auto">
          <a:xfrm>
            <a:off x="2955926" y="5099050"/>
            <a:ext cx="200025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6.52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1" name="Rectangle 265"/>
          <p:cNvSpPr>
            <a:spLocks noChangeArrowheads="1"/>
          </p:cNvSpPr>
          <p:nvPr/>
        </p:nvSpPr>
        <p:spPr bwMode="auto">
          <a:xfrm>
            <a:off x="3187700" y="5208588"/>
            <a:ext cx="20002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6.73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2" name="Rectangle 266"/>
          <p:cNvSpPr>
            <a:spLocks noChangeArrowheads="1"/>
          </p:cNvSpPr>
          <p:nvPr/>
        </p:nvSpPr>
        <p:spPr bwMode="auto">
          <a:xfrm>
            <a:off x="3567113" y="5208588"/>
            <a:ext cx="20002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7.74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3" name="Rectangle 267"/>
          <p:cNvSpPr>
            <a:spLocks noChangeArrowheads="1"/>
          </p:cNvSpPr>
          <p:nvPr/>
        </p:nvSpPr>
        <p:spPr bwMode="auto">
          <a:xfrm>
            <a:off x="4283075" y="5272089"/>
            <a:ext cx="20002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9.34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4" name="Rectangle 268"/>
          <p:cNvSpPr>
            <a:spLocks noChangeArrowheads="1"/>
          </p:cNvSpPr>
          <p:nvPr/>
        </p:nvSpPr>
        <p:spPr bwMode="auto">
          <a:xfrm>
            <a:off x="5705475" y="5380038"/>
            <a:ext cx="25717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1.79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5" name="Rectangle 269"/>
          <p:cNvSpPr>
            <a:spLocks noChangeArrowheads="1"/>
          </p:cNvSpPr>
          <p:nvPr/>
        </p:nvSpPr>
        <p:spPr bwMode="auto">
          <a:xfrm>
            <a:off x="5183189" y="5322888"/>
            <a:ext cx="25717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1.03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6" name="Rectangle 270"/>
          <p:cNvSpPr>
            <a:spLocks noChangeArrowheads="1"/>
          </p:cNvSpPr>
          <p:nvPr/>
        </p:nvSpPr>
        <p:spPr bwMode="auto">
          <a:xfrm>
            <a:off x="6196013" y="5495925"/>
            <a:ext cx="257175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3.05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7" name="Rectangle 271"/>
          <p:cNvSpPr>
            <a:spLocks noChangeArrowheads="1"/>
          </p:cNvSpPr>
          <p:nvPr/>
        </p:nvSpPr>
        <p:spPr bwMode="auto">
          <a:xfrm>
            <a:off x="4513264" y="5502275"/>
            <a:ext cx="200025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9.47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8" name="Rectangle 272"/>
          <p:cNvSpPr>
            <a:spLocks noChangeArrowheads="1"/>
          </p:cNvSpPr>
          <p:nvPr/>
        </p:nvSpPr>
        <p:spPr bwMode="auto">
          <a:xfrm>
            <a:off x="3449639" y="5553075"/>
            <a:ext cx="200025" cy="122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7.50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49" name="Rectangle 273"/>
          <p:cNvSpPr>
            <a:spLocks noChangeArrowheads="1"/>
          </p:cNvSpPr>
          <p:nvPr/>
        </p:nvSpPr>
        <p:spPr bwMode="auto">
          <a:xfrm>
            <a:off x="5376864" y="5618163"/>
            <a:ext cx="25717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1.21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50" name="Rectangle 274"/>
          <p:cNvSpPr>
            <a:spLocks noChangeArrowheads="1"/>
          </p:cNvSpPr>
          <p:nvPr/>
        </p:nvSpPr>
        <p:spPr bwMode="auto">
          <a:xfrm>
            <a:off x="2368550" y="5611814"/>
            <a:ext cx="20002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5.34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51" name="Rectangle 275"/>
          <p:cNvSpPr>
            <a:spLocks noChangeArrowheads="1"/>
          </p:cNvSpPr>
          <p:nvPr/>
        </p:nvSpPr>
        <p:spPr bwMode="auto">
          <a:xfrm>
            <a:off x="6016625" y="5726114"/>
            <a:ext cx="25717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2.89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53" name="Rectangle 277"/>
          <p:cNvSpPr>
            <a:spLocks noChangeArrowheads="1"/>
          </p:cNvSpPr>
          <p:nvPr/>
        </p:nvSpPr>
        <p:spPr bwMode="auto">
          <a:xfrm>
            <a:off x="6388100" y="5726114"/>
            <a:ext cx="25717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13.30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50454" name="Rectangle 278"/>
          <p:cNvSpPr>
            <a:spLocks noChangeArrowheads="1"/>
          </p:cNvSpPr>
          <p:nvPr/>
        </p:nvSpPr>
        <p:spPr bwMode="auto">
          <a:xfrm>
            <a:off x="3763964" y="5310188"/>
            <a:ext cx="200025" cy="122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8.01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cs typeface="+mn-cs"/>
            </a:endParaRPr>
          </a:p>
        </p:txBody>
      </p:sp>
      <p:sp>
        <p:nvSpPr>
          <p:cNvPr id="1022231" name="Rectangle 279"/>
          <p:cNvSpPr>
            <a:spLocks noChangeArrowheads="1"/>
          </p:cNvSpPr>
          <p:nvPr/>
        </p:nvSpPr>
        <p:spPr bwMode="auto">
          <a:xfrm>
            <a:off x="1346200" y="3198814"/>
            <a:ext cx="114300" cy="2879725"/>
          </a:xfrm>
          <a:prstGeom prst="rect">
            <a:avLst/>
          </a:prstGeom>
          <a:solidFill>
            <a:srgbClr val="0033CC">
              <a:alpha val="50195"/>
            </a:srgbClr>
          </a:solidFill>
          <a:ln w="9525">
            <a:noFill/>
            <a:miter lim="800000"/>
            <a:headEnd/>
            <a:tailEnd/>
          </a:ln>
        </p:spPr>
        <p:txBody>
          <a:bodyPr wrap="none" lIns="91435" tIns="45718" rIns="91435" bIns="45718" anchor="ctr"/>
          <a:lstStyle/>
          <a:p>
            <a:pPr marL="0" marR="0" lvl="0" indent="0" defTabSz="91440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grpSp>
        <p:nvGrpSpPr>
          <p:cNvPr id="2" name="Group 280"/>
          <p:cNvGrpSpPr>
            <a:grpSpLocks/>
          </p:cNvGrpSpPr>
          <p:nvPr/>
        </p:nvGrpSpPr>
        <p:grpSpPr bwMode="auto">
          <a:xfrm>
            <a:off x="1403350" y="1816099"/>
            <a:ext cx="1785938" cy="1171574"/>
            <a:chOff x="884" y="1144"/>
            <a:chExt cx="1125" cy="738"/>
          </a:xfrm>
        </p:grpSpPr>
        <p:pic>
          <p:nvPicPr>
            <p:cNvPr id="50476" name="Picture 281"/>
            <p:cNvPicPr>
              <a:picLocks noChangeAspect="1" noChangeArrowheads="1"/>
            </p:cNvPicPr>
            <p:nvPr/>
          </p:nvPicPr>
          <p:blipFill>
            <a:blip r:embed="rId4" cstate="print"/>
            <a:srcRect t="6990" r="53979"/>
            <a:stretch>
              <a:fillRect/>
            </a:stretch>
          </p:blipFill>
          <p:spPr bwMode="auto">
            <a:xfrm>
              <a:off x="993" y="1144"/>
              <a:ext cx="907" cy="5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0477" name="Text Box 282"/>
            <p:cNvSpPr txBox="1">
              <a:spLocks noChangeArrowheads="1"/>
            </p:cNvSpPr>
            <p:nvPr/>
          </p:nvSpPr>
          <p:spPr bwMode="auto">
            <a:xfrm>
              <a:off x="884" y="1688"/>
              <a:ext cx="1125" cy="1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marL="0" marR="0" lvl="0" indent="0" algn="ctr" defTabSz="91440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>
                  <a:ln>
                    <a:noFill/>
                  </a:ln>
                  <a:solidFill>
                    <a:srgbClr val="FFFFCC"/>
                  </a:solidFill>
                  <a:effectLst/>
                  <a:uLnTx/>
                  <a:uFillTx/>
                  <a:latin typeface="Verdana" pitchFamily="34" charset="0"/>
                  <a:cs typeface="+mn-cs"/>
                </a:rPr>
                <a:t>Mass spectrum</a:t>
              </a:r>
            </a:p>
          </p:txBody>
        </p:sp>
        <p:sp>
          <p:nvSpPr>
            <p:cNvPr id="50478" name="Text Box 283"/>
            <p:cNvSpPr txBox="1">
              <a:spLocks noChangeArrowheads="1"/>
            </p:cNvSpPr>
            <p:nvPr/>
          </p:nvSpPr>
          <p:spPr bwMode="auto">
            <a:xfrm>
              <a:off x="1320" y="1180"/>
              <a:ext cx="617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marL="0" marR="0" lvl="0" indent="0" algn="ctr" defTabSz="91440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1B5691"/>
                  </a:solidFill>
                  <a:effectLst/>
                  <a:uLnTx/>
                  <a:uFillTx/>
                  <a:latin typeface="Verdana" pitchFamily="34" charset="0"/>
                  <a:cs typeface="+mn-cs"/>
                </a:rPr>
                <a:t>3.17 min</a:t>
              </a:r>
            </a:p>
          </p:txBody>
        </p:sp>
      </p:grpSp>
      <p:sp>
        <p:nvSpPr>
          <p:cNvPr id="1022236" name="Text Box 284"/>
          <p:cNvSpPr txBox="1">
            <a:spLocks noChangeArrowheads="1"/>
          </p:cNvSpPr>
          <p:nvPr/>
        </p:nvSpPr>
        <p:spPr bwMode="auto">
          <a:xfrm>
            <a:off x="7196138" y="1120775"/>
            <a:ext cx="195421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5" tIns="45718" rIns="91435" bIns="45718">
            <a:spAutoFit/>
          </a:bodyPr>
          <a:lstStyle/>
          <a:p>
            <a:pPr marL="0" marR="0" lvl="0" indent="0" defTabSz="91440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sng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cs typeface="+mn-cs"/>
              </a:rPr>
              <a:t>Biochemical          Amount</a:t>
            </a:r>
          </a:p>
        </p:txBody>
      </p:sp>
      <p:grpSp>
        <p:nvGrpSpPr>
          <p:cNvPr id="3" name="Group 285"/>
          <p:cNvGrpSpPr>
            <a:grpSpLocks/>
          </p:cNvGrpSpPr>
          <p:nvPr/>
        </p:nvGrpSpPr>
        <p:grpSpPr bwMode="auto">
          <a:xfrm>
            <a:off x="7280276" y="1355724"/>
            <a:ext cx="1863725" cy="215901"/>
            <a:chOff x="4586" y="854"/>
            <a:chExt cx="1174" cy="136"/>
          </a:xfrm>
        </p:grpSpPr>
        <p:sp>
          <p:nvSpPr>
            <p:cNvPr id="50474" name="Text Box 286"/>
            <p:cNvSpPr txBox="1">
              <a:spLocks noChangeArrowheads="1"/>
            </p:cNvSpPr>
            <p:nvPr/>
          </p:nvSpPr>
          <p:spPr bwMode="auto">
            <a:xfrm>
              <a:off x="4586" y="854"/>
              <a:ext cx="430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marL="0" marR="0" lvl="0" indent="0" defTabSz="91440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cs typeface="+mn-cs"/>
                </a:rPr>
                <a:t>cholesterol</a:t>
              </a:r>
            </a:p>
          </p:txBody>
        </p:sp>
        <p:sp>
          <p:nvSpPr>
            <p:cNvPr id="50475" name="Text Box 287"/>
            <p:cNvSpPr txBox="1">
              <a:spLocks noChangeArrowheads="1"/>
            </p:cNvSpPr>
            <p:nvPr/>
          </p:nvSpPr>
          <p:spPr bwMode="auto">
            <a:xfrm>
              <a:off x="5407" y="854"/>
              <a:ext cx="353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marL="0" marR="0" lvl="0" indent="0" algn="r" defTabSz="91440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cs typeface="+mn-cs"/>
                </a:rPr>
                <a:t>143,789</a:t>
              </a:r>
            </a:p>
          </p:txBody>
        </p:sp>
      </p:grpSp>
      <p:sp>
        <p:nvSpPr>
          <p:cNvPr id="1022240" name="Rectangle 288"/>
          <p:cNvSpPr>
            <a:spLocks noChangeArrowheads="1"/>
          </p:cNvSpPr>
          <p:nvPr/>
        </p:nvSpPr>
        <p:spPr bwMode="auto">
          <a:xfrm>
            <a:off x="7221538" y="2901950"/>
            <a:ext cx="1922462" cy="114300"/>
          </a:xfrm>
          <a:prstGeom prst="rect">
            <a:avLst/>
          </a:prstGeom>
          <a:noFill/>
          <a:ln w="19050" algn="ctr">
            <a:solidFill>
              <a:srgbClr val="FF0000"/>
            </a:solidFill>
            <a:miter lim="800000"/>
            <a:headEnd/>
            <a:tailEnd/>
          </a:ln>
        </p:spPr>
        <p:txBody>
          <a:bodyPr wrap="none" lIns="91435" tIns="45718" rIns="91435" bIns="45718" anchor="ctr"/>
          <a:lstStyle/>
          <a:p>
            <a:pPr marL="0" marR="0" lvl="0" indent="0" defTabSz="91440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1022241" name="Rectangle 289"/>
          <p:cNvSpPr>
            <a:spLocks noChangeArrowheads="1"/>
          </p:cNvSpPr>
          <p:nvPr/>
        </p:nvSpPr>
        <p:spPr bwMode="auto">
          <a:xfrm>
            <a:off x="7221538" y="4513263"/>
            <a:ext cx="1922462" cy="114300"/>
          </a:xfrm>
          <a:prstGeom prst="rect">
            <a:avLst/>
          </a:prstGeom>
          <a:noFill/>
          <a:ln w="19050" algn="ctr">
            <a:solidFill>
              <a:srgbClr val="FF0000"/>
            </a:solidFill>
            <a:miter lim="800000"/>
            <a:headEnd/>
            <a:tailEnd/>
          </a:ln>
        </p:spPr>
        <p:txBody>
          <a:bodyPr wrap="none" lIns="91435" tIns="45718" rIns="91435" bIns="45718" anchor="ctr"/>
          <a:lstStyle/>
          <a:p>
            <a:pPr marL="0" marR="0" lvl="0" indent="0" defTabSz="91440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1022242" name="Rectangle 290"/>
          <p:cNvSpPr>
            <a:spLocks noChangeArrowheads="1"/>
          </p:cNvSpPr>
          <p:nvPr/>
        </p:nvSpPr>
        <p:spPr bwMode="auto">
          <a:xfrm>
            <a:off x="7221538" y="4916488"/>
            <a:ext cx="1922462" cy="114300"/>
          </a:xfrm>
          <a:prstGeom prst="rect">
            <a:avLst/>
          </a:prstGeom>
          <a:noFill/>
          <a:ln w="19050" algn="ctr">
            <a:solidFill>
              <a:srgbClr val="FF0000"/>
            </a:solidFill>
            <a:miter lim="800000"/>
            <a:headEnd/>
            <a:tailEnd/>
          </a:ln>
        </p:spPr>
        <p:txBody>
          <a:bodyPr wrap="none" lIns="91435" tIns="45718" rIns="91435" bIns="45718" anchor="ctr"/>
          <a:lstStyle/>
          <a:p>
            <a:pPr marL="0" marR="0" lvl="0" indent="0" defTabSz="91440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grpSp>
        <p:nvGrpSpPr>
          <p:cNvPr id="4" name="Group 291"/>
          <p:cNvGrpSpPr>
            <a:grpSpLocks/>
          </p:cNvGrpSpPr>
          <p:nvPr/>
        </p:nvGrpSpPr>
        <p:grpSpPr bwMode="auto">
          <a:xfrm>
            <a:off x="3132139" y="1643063"/>
            <a:ext cx="3571875" cy="1460499"/>
            <a:chOff x="1973" y="1035"/>
            <a:chExt cx="2250" cy="920"/>
          </a:xfrm>
        </p:grpSpPr>
        <p:sp>
          <p:nvSpPr>
            <p:cNvPr id="50467" name="AutoShape 292"/>
            <p:cNvSpPr>
              <a:spLocks noChangeArrowheads="1"/>
            </p:cNvSpPr>
            <p:nvPr/>
          </p:nvSpPr>
          <p:spPr bwMode="auto">
            <a:xfrm>
              <a:off x="2263" y="1035"/>
              <a:ext cx="581" cy="726"/>
            </a:xfrm>
            <a:prstGeom prst="can">
              <a:avLst>
                <a:gd name="adj" fmla="val 31239"/>
              </a:avLst>
            </a:prstGeom>
            <a:solidFill>
              <a:schemeClr val="accent4">
                <a:lumMod val="40000"/>
                <a:lumOff val="60000"/>
              </a:schemeClr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marL="0" marR="0" lvl="0" indent="0" algn="ctr" defTabSz="91440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1F497D">
                      <a:lumMod val="50000"/>
                    </a:srgbClr>
                  </a:solidFill>
                  <a:effectLst/>
                  <a:uLnTx/>
                  <a:uFillTx/>
                  <a:latin typeface="Arial" charset="0"/>
                  <a:cs typeface="+mn-cs"/>
                </a:rPr>
                <a:t>Database</a:t>
              </a:r>
            </a:p>
            <a:p>
              <a:pPr marL="0" marR="0" lvl="0" indent="0" algn="ctr" defTabSz="91440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1F497D">
                      <a:lumMod val="50000"/>
                    </a:srgbClr>
                  </a:solidFill>
                  <a:effectLst/>
                  <a:uLnTx/>
                  <a:uFillTx/>
                  <a:latin typeface="Arial" charset="0"/>
                  <a:cs typeface="+mn-cs"/>
                </a:rPr>
                <a:t>of</a:t>
              </a:r>
            </a:p>
            <a:p>
              <a:pPr marL="0" marR="0" lvl="0" indent="0" algn="ctr" defTabSz="91440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1F497D">
                      <a:lumMod val="50000"/>
                    </a:srgbClr>
                  </a:solidFill>
                  <a:effectLst/>
                  <a:uLnTx/>
                  <a:uFillTx/>
                  <a:latin typeface="Arial" charset="0"/>
                  <a:cs typeface="+mn-cs"/>
                </a:rPr>
                <a:t>standards</a:t>
              </a:r>
            </a:p>
          </p:txBody>
        </p:sp>
        <p:sp>
          <p:nvSpPr>
            <p:cNvPr id="50468" name="AutoShape 293"/>
            <p:cNvSpPr>
              <a:spLocks noChangeArrowheads="1"/>
            </p:cNvSpPr>
            <p:nvPr/>
          </p:nvSpPr>
          <p:spPr bwMode="auto">
            <a:xfrm>
              <a:off x="1973" y="1289"/>
              <a:ext cx="218" cy="254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FFCC"/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pPr marL="0" marR="0" lvl="0" indent="0" defTabSz="91440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3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ahoma" pitchFamily="34" charset="0"/>
                <a:cs typeface="+mn-cs"/>
              </a:endParaRPr>
            </a:p>
          </p:txBody>
        </p:sp>
        <p:grpSp>
          <p:nvGrpSpPr>
            <p:cNvPr id="5" name="Group 294"/>
            <p:cNvGrpSpPr>
              <a:grpSpLocks/>
            </p:cNvGrpSpPr>
            <p:nvPr/>
          </p:nvGrpSpPr>
          <p:grpSpPr bwMode="auto">
            <a:xfrm>
              <a:off x="3098" y="1144"/>
              <a:ext cx="1125" cy="811"/>
              <a:chOff x="3098" y="1144"/>
              <a:chExt cx="1125" cy="811"/>
            </a:xfrm>
          </p:grpSpPr>
          <p:pic>
            <p:nvPicPr>
              <p:cNvPr id="50471" name="Picture 295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t="6990" r="53979"/>
              <a:stretch>
                <a:fillRect/>
              </a:stretch>
            </p:blipFill>
            <p:spPr bwMode="auto">
              <a:xfrm>
                <a:off x="3207" y="1144"/>
                <a:ext cx="907" cy="50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0472" name="Text Box 296"/>
              <p:cNvSpPr txBox="1">
                <a:spLocks noChangeArrowheads="1"/>
              </p:cNvSpPr>
              <p:nvPr/>
            </p:nvSpPr>
            <p:spPr bwMode="auto">
              <a:xfrm>
                <a:off x="3643" y="1144"/>
                <a:ext cx="471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1B5691"/>
                    </a:solidFill>
                    <a:effectLst/>
                    <a:uLnTx/>
                    <a:uFillTx/>
                    <a:latin typeface="Verdana" pitchFamily="34" charset="0"/>
                    <a:cs typeface="+mn-cs"/>
                  </a:rPr>
                  <a:t>cholesterol</a:t>
                </a:r>
              </a:p>
            </p:txBody>
          </p:sp>
          <p:sp>
            <p:nvSpPr>
              <p:cNvPr id="50473" name="Text Box 297"/>
              <p:cNvSpPr txBox="1">
                <a:spLocks noChangeArrowheads="1"/>
              </p:cNvSpPr>
              <p:nvPr/>
            </p:nvSpPr>
            <p:spPr bwMode="auto">
              <a:xfrm>
                <a:off x="3098" y="1761"/>
                <a:ext cx="1125" cy="19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FFFFCC"/>
                    </a:solidFill>
                    <a:effectLst/>
                    <a:uLnTx/>
                    <a:uFillTx/>
                    <a:latin typeface="Verdana" pitchFamily="34" charset="0"/>
                    <a:cs typeface="+mn-cs"/>
                  </a:rPr>
                  <a:t>Biochemical ID</a:t>
                </a:r>
              </a:p>
            </p:txBody>
          </p:sp>
        </p:grpSp>
        <p:sp>
          <p:nvSpPr>
            <p:cNvPr id="50470" name="AutoShape 298"/>
            <p:cNvSpPr>
              <a:spLocks noChangeArrowheads="1"/>
            </p:cNvSpPr>
            <p:nvPr/>
          </p:nvSpPr>
          <p:spPr bwMode="auto">
            <a:xfrm>
              <a:off x="2916" y="1289"/>
              <a:ext cx="255" cy="254"/>
            </a:xfrm>
            <a:prstGeom prst="rightArrow">
              <a:avLst>
                <a:gd name="adj1" fmla="val 50000"/>
                <a:gd name="adj2" fmla="val 25098"/>
              </a:avLst>
            </a:prstGeom>
            <a:solidFill>
              <a:srgbClr val="FFFFCC"/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pPr marL="0" marR="0" lvl="0" indent="0" defTabSz="91440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3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ahoma" pitchFamily="34" charset="0"/>
                <a:cs typeface="+mn-cs"/>
              </a:endParaRPr>
            </a:p>
          </p:txBody>
        </p:sp>
      </p:grpSp>
      <p:sp>
        <p:nvSpPr>
          <p:cNvPr id="1022251" name="Line 299"/>
          <p:cNvSpPr>
            <a:spLocks noChangeShapeType="1"/>
          </p:cNvSpPr>
          <p:nvPr/>
        </p:nvSpPr>
        <p:spPr bwMode="auto">
          <a:xfrm flipV="1">
            <a:off x="6645275" y="1585914"/>
            <a:ext cx="692150" cy="633412"/>
          </a:xfrm>
          <a:prstGeom prst="line">
            <a:avLst/>
          </a:prstGeom>
          <a:noFill/>
          <a:ln w="76200">
            <a:solidFill>
              <a:schemeClr val="accent1"/>
            </a:solidFill>
            <a:round/>
            <a:headEnd/>
            <a:tailEnd type="triangle" w="med" len="med"/>
          </a:ln>
        </p:spPr>
        <p:txBody>
          <a:bodyPr lIns="91435" tIns="45718" rIns="91435" bIns="45718" anchor="ctr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64" name="Rectangle 300"/>
          <p:cNvSpPr>
            <a:spLocks noChangeArrowheads="1"/>
          </p:cNvSpPr>
          <p:nvPr/>
        </p:nvSpPr>
        <p:spPr bwMode="auto">
          <a:xfrm>
            <a:off x="7221538" y="0"/>
            <a:ext cx="1922462" cy="1123950"/>
          </a:xfrm>
          <a:prstGeom prst="rect">
            <a:avLst/>
          </a:prstGeom>
          <a:solidFill>
            <a:srgbClr val="FFFFFF"/>
          </a:solidFill>
          <a:ln w="9525" algn="ctr">
            <a:noFill/>
            <a:miter lim="800000"/>
            <a:headEnd/>
            <a:tailEnd/>
          </a:ln>
        </p:spPr>
        <p:txBody>
          <a:bodyPr wrap="none" lIns="91435" tIns="45718" rIns="91435" bIns="45718" anchor="ctr"/>
          <a:lstStyle/>
          <a:p>
            <a:pPr marL="0" marR="0" lvl="0" indent="0" defTabSz="91440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50465" name="Line 301"/>
          <p:cNvSpPr>
            <a:spLocks noChangeShapeType="1"/>
          </p:cNvSpPr>
          <p:nvPr/>
        </p:nvSpPr>
        <p:spPr bwMode="auto">
          <a:xfrm>
            <a:off x="7221538" y="903288"/>
            <a:ext cx="1535112" cy="0"/>
          </a:xfrm>
          <a:prstGeom prst="line">
            <a:avLst/>
          </a:prstGeom>
          <a:noFill/>
          <a:ln w="28575">
            <a:solidFill>
              <a:srgbClr val="AFA87F"/>
            </a:solidFill>
            <a:round/>
            <a:headEnd/>
            <a:tailEnd/>
          </a:ln>
        </p:spPr>
        <p:txBody>
          <a:bodyPr lIns="91435" tIns="45718" rIns="91435" bIns="45718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ahoma" pitchFamily="34" charset="0"/>
              <a:cs typeface="+mn-cs"/>
            </a:endParaRPr>
          </a:p>
        </p:txBody>
      </p:sp>
      <p:sp>
        <p:nvSpPr>
          <p:cNvPr id="312" name="Rectangle 311"/>
          <p:cNvSpPr/>
          <p:nvPr/>
        </p:nvSpPr>
        <p:spPr>
          <a:xfrm>
            <a:off x="7143769" y="642918"/>
            <a:ext cx="2143140" cy="500066"/>
          </a:xfrm>
          <a:prstGeom prst="rect">
            <a:avLst/>
          </a:prstGeom>
          <a:solidFill>
            <a:srgbClr val="FFFFFF"/>
          </a:solidFill>
          <a:ln w="3175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91435" tIns="45718" rIns="91435" bIns="45718"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444877052"/>
      </p:ext>
    </p:extLst>
  </p:cSld>
  <p:clrMapOvr>
    <a:masterClrMapping/>
  </p:clrMapOvr>
  <p:transition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22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500"/>
                                        <p:tgtEl>
                                          <p:spTgt spid="10222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9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0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5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22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8" dur="500"/>
                                        <p:tgtEl>
                                          <p:spTgt spid="102223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500"/>
                            </p:stCondLst>
                            <p:childTnLst>
                              <p:par>
                                <p:cTn id="20" presetID="9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22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22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25" dur="500"/>
                                        <p:tgtEl>
                                          <p:spTgt spid="102225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9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29" dur="500"/>
                                        <p:tgtEl>
                                          <p:spTgt spid="102225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0222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63" presetClass="path" presetSubtype="0" decel="5000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2.22222E-6 1.11111E-6 L 0.61736 1.11111E-6 " pathEditMode="relative" rAng="0" ptsTypes="AA">
                                      <p:cBhvr>
                                        <p:cTn id="34" dur="3000" fill="hold"/>
                                        <p:tgtEl>
                                          <p:spTgt spid="102223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309" y="0"/>
                                    </p:animMotion>
                                  </p:childTnLst>
                                </p:cTn>
                              </p:par>
                              <p:par>
                                <p:cTn id="35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05556E-6 -2.32709E-6 L -3.05556E-6 2.02961 " pathEditMode="relative" rAng="0" ptsTypes="AA">
                                      <p:cBhvr>
                                        <p:cTn id="36" dur="3000" fill="hold"/>
                                        <p:tgtEl>
                                          <p:spTgt spid="102195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1015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23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22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41" dur="500" fill="hold"/>
                                        <p:tgtEl>
                                          <p:spTgt spid="1022242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2" dur="500" fill="hold"/>
                                        <p:tgtEl>
                                          <p:spTgt spid="1022242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3" presetID="23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22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45" dur="500" fill="hold"/>
                                        <p:tgtEl>
                                          <p:spTgt spid="102224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6" dur="500" fill="hold"/>
                                        <p:tgtEl>
                                          <p:spTgt spid="102224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7" presetID="23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22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49" dur="500" fill="hold"/>
                                        <p:tgtEl>
                                          <p:spTgt spid="102224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0" dur="500" fill="hold"/>
                                        <p:tgtEl>
                                          <p:spTgt spid="102224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22231" grpId="0" animBg="1"/>
      <p:bldP spid="1022231" grpId="1" animBg="1"/>
      <p:bldP spid="1022236" grpId="0"/>
      <p:bldP spid="1022240" grpId="0" animBg="1"/>
      <p:bldP spid="1022241" grpId="0" animBg="1"/>
      <p:bldP spid="1022242" grpId="0" animBg="1"/>
      <p:bldP spid="1022251" grpId="0" animBg="1"/>
      <p:bldP spid="1022251" grpId="1" animBg="1"/>
    </p:bld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40</a:t>
            </a:fld>
            <a:endParaRPr lang="en-US" kern="0" dirty="0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38BD2B3F-376F-473B-8322-05825F28B0BC}"/>
              </a:ext>
            </a:extLst>
          </p:cNvPr>
          <p:cNvSpPr txBox="1">
            <a:spLocks/>
          </p:cNvSpPr>
          <p:nvPr/>
        </p:nvSpPr>
        <p:spPr>
          <a:xfrm>
            <a:off x="457200" y="117756"/>
            <a:ext cx="8229600" cy="4873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/>
                </a:solidFill>
                <a:latin typeface="Montserrat" pitchFamily="2" charset="77"/>
                <a:ea typeface="+mj-ea"/>
                <a:cs typeface="+mj-cs"/>
              </a:defRPr>
            </a:lvl1pPr>
          </a:lstStyle>
          <a:p>
            <a:r>
              <a:rPr lang="en-US" sz="2800" dirty="0"/>
              <a:t>Purine Metabolism - Liver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205B2E2B-4CB3-4B9D-B6F2-1DC408EDCE80}"/>
              </a:ext>
            </a:extLst>
          </p:cNvPr>
          <p:cNvGrpSpPr/>
          <p:nvPr/>
        </p:nvGrpSpPr>
        <p:grpSpPr>
          <a:xfrm>
            <a:off x="392830" y="830368"/>
            <a:ext cx="8358341" cy="5257508"/>
            <a:chOff x="386588" y="830368"/>
            <a:chExt cx="8358341" cy="5257508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1B5BE90A-2277-4DA9-A017-867CC9E57E48}"/>
                </a:ext>
              </a:extLst>
            </p:cNvPr>
            <p:cNvGrpSpPr/>
            <p:nvPr/>
          </p:nvGrpSpPr>
          <p:grpSpPr>
            <a:xfrm>
              <a:off x="4605888" y="830368"/>
              <a:ext cx="4139041" cy="5257508"/>
              <a:chOff x="4560608" y="682780"/>
              <a:chExt cx="3897280" cy="4813332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76591416-4FEC-4893-A8B1-586348F062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560608" y="682780"/>
                <a:ext cx="3897279" cy="2939289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F059A849-42A0-4A21-824E-7852B88494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583384" y="3575872"/>
                <a:ext cx="1928661" cy="1920240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9ABF0B46-F959-4E0B-8DE2-614438609C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529227" y="3575872"/>
                <a:ext cx="1928661" cy="1920240"/>
              </a:xfrm>
              <a:prstGeom prst="rect">
                <a:avLst/>
              </a:prstGeom>
            </p:spPr>
          </p:pic>
        </p:grp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A72E649-C42C-4289-BD58-FC2F8EDCBB6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6588" y="830368"/>
              <a:ext cx="4226111" cy="525750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3154093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41</a:t>
            </a:fld>
            <a:endParaRPr lang="en-US" kern="0" dirty="0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38BD2B3F-376F-473B-8322-05825F28B0BC}"/>
              </a:ext>
            </a:extLst>
          </p:cNvPr>
          <p:cNvSpPr txBox="1">
            <a:spLocks/>
          </p:cNvSpPr>
          <p:nvPr/>
        </p:nvSpPr>
        <p:spPr>
          <a:xfrm>
            <a:off x="457200" y="117756"/>
            <a:ext cx="8229600" cy="4873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/>
                </a:solidFill>
                <a:latin typeface="Montserrat" pitchFamily="2" charset="77"/>
                <a:ea typeface="+mj-ea"/>
                <a:cs typeface="+mj-cs"/>
              </a:defRPr>
            </a:lvl1pPr>
          </a:lstStyle>
          <a:p>
            <a:r>
              <a:rPr lang="en-US" sz="2800" dirty="0"/>
              <a:t>Pyrimidine Metabolism - Liver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3142E62-F43D-4FB1-81F9-32DAECC4B1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37969" y="1337418"/>
            <a:ext cx="3243515" cy="279429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72991A7-1BD1-493E-9C0A-E2E73E7D40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1962" y="4750701"/>
            <a:ext cx="1932423" cy="192398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69E82CC-49ED-4B6D-B377-7AF481F61E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97196" y="4750701"/>
            <a:ext cx="1932423" cy="192398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D824740-6EB1-41D1-BBEA-FF4E20C645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42431" y="4750701"/>
            <a:ext cx="1932423" cy="19239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507EB76-0A1B-4B3A-B386-107CD128D87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76461" y="731644"/>
            <a:ext cx="2961508" cy="40058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6454800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42</a:t>
            </a:fld>
            <a:endParaRPr lang="en-US" kern="0" dirty="0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38BD2B3F-376F-473B-8322-05825F28B0BC}"/>
              </a:ext>
            </a:extLst>
          </p:cNvPr>
          <p:cNvSpPr txBox="1">
            <a:spLocks/>
          </p:cNvSpPr>
          <p:nvPr/>
        </p:nvSpPr>
        <p:spPr>
          <a:xfrm>
            <a:off x="457200" y="117756"/>
            <a:ext cx="8229600" cy="4873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/>
                </a:solidFill>
                <a:latin typeface="Montserrat" pitchFamily="2" charset="77"/>
                <a:ea typeface="+mj-ea"/>
                <a:cs typeface="+mj-cs"/>
              </a:defRPr>
            </a:lvl1pPr>
          </a:lstStyle>
          <a:p>
            <a:r>
              <a:rPr lang="en-US" sz="2800" dirty="0"/>
              <a:t>Purine Metabolism - Lung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0907DD2-B458-44DB-A86E-97D59A2423EF}"/>
              </a:ext>
            </a:extLst>
          </p:cNvPr>
          <p:cNvGrpSpPr/>
          <p:nvPr/>
        </p:nvGrpSpPr>
        <p:grpSpPr>
          <a:xfrm>
            <a:off x="1068198" y="633393"/>
            <a:ext cx="7007604" cy="3791210"/>
            <a:chOff x="1451295" y="683727"/>
            <a:chExt cx="7007604" cy="379121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6591416-4FEC-4893-A8B1-586348F0625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50276" y="1180829"/>
              <a:ext cx="3708623" cy="2797006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25D210F-167B-45DC-B91A-0F4F0A09540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51295" y="683727"/>
              <a:ext cx="3298981" cy="3791210"/>
            </a:xfrm>
            <a:prstGeom prst="rect">
              <a:avLst/>
            </a:prstGeom>
          </p:spPr>
        </p:pic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2E637548-76AF-445E-87A3-81C52C15405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8198" y="4438332"/>
            <a:ext cx="2204184" cy="21945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8EA945A-7569-4391-9A17-BAB59E9E5F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9908" y="4438332"/>
            <a:ext cx="2204184" cy="219456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76D7475-3D07-4D7F-B339-7B5381E2162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71618" y="4438332"/>
            <a:ext cx="2204184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3996370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43</a:t>
            </a:fld>
            <a:endParaRPr lang="en-US" kern="0" dirty="0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38BD2B3F-376F-473B-8322-05825F28B0BC}"/>
              </a:ext>
            </a:extLst>
          </p:cNvPr>
          <p:cNvSpPr txBox="1">
            <a:spLocks/>
          </p:cNvSpPr>
          <p:nvPr/>
        </p:nvSpPr>
        <p:spPr>
          <a:xfrm>
            <a:off x="457200" y="117756"/>
            <a:ext cx="8229600" cy="4873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/>
                </a:solidFill>
                <a:latin typeface="Montserrat" pitchFamily="2" charset="77"/>
                <a:ea typeface="+mj-ea"/>
                <a:cs typeface="+mj-cs"/>
              </a:defRPr>
            </a:lvl1pPr>
          </a:lstStyle>
          <a:p>
            <a:r>
              <a:rPr lang="en-US" sz="2800" dirty="0"/>
              <a:t>Pyrimidine Metabolism - Lung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A782F39-FFBF-44F2-9B77-4FC19D555553}"/>
              </a:ext>
            </a:extLst>
          </p:cNvPr>
          <p:cNvGrpSpPr/>
          <p:nvPr/>
        </p:nvGrpSpPr>
        <p:grpSpPr>
          <a:xfrm>
            <a:off x="960892" y="607750"/>
            <a:ext cx="7222217" cy="5748600"/>
            <a:chOff x="1104614" y="607750"/>
            <a:chExt cx="7222217" cy="5748600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3142E62-F43D-4FB1-81F9-32DAECC4B15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94602" y="776747"/>
              <a:ext cx="3932229" cy="3387625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C546A97-4A70-40DF-84A4-F1FE03EA6F2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04614" y="607750"/>
              <a:ext cx="3273507" cy="5748600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0F2146E-AB87-475A-8D5D-3D795E276C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94602" y="4387440"/>
              <a:ext cx="1928661" cy="192024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5D4EF1C-4C8D-485F-8F01-242337F3F0B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81689" y="4387440"/>
              <a:ext cx="1928661" cy="19202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5281735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0D0819-2BB6-4A1E-B1EC-21DF45411B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83893" y="6458660"/>
            <a:ext cx="617105" cy="365125"/>
          </a:xfrm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44</a:t>
            </a:fld>
            <a:endParaRPr lang="en-US" kern="0" dirty="0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69650595-D1D1-4797-A7C4-173ACCDD0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3528" y="24353"/>
            <a:ext cx="8640960" cy="595456"/>
          </a:xfrm>
        </p:spPr>
        <p:txBody>
          <a:bodyPr>
            <a:normAutofit/>
          </a:bodyPr>
          <a:lstStyle/>
          <a:p>
            <a:r>
              <a:rPr lang="en-US" sz="2400" dirty="0">
                <a:solidFill>
                  <a:schemeClr val="tx2"/>
                </a:solidFill>
                <a:latin typeface="Montserrat" panose="00000500000000000000" pitchFamily="2" charset="0"/>
              </a:rPr>
              <a:t>Summary Table</a:t>
            </a:r>
            <a:endParaRPr lang="en-US" sz="24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12BE7BF-EAAE-BCFA-5E81-8481D6C6B1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8668" y="562650"/>
            <a:ext cx="8071804" cy="6261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0099215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040CB2-1A7F-4F59-8A21-73EE46FA58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chemeClr val="tx2"/>
                </a:solidFill>
                <a:latin typeface="Montserrat" panose="00000500000000000000" pitchFamily="2" charset="0"/>
              </a:rPr>
              <a:t>Summary Figure - Liver</a:t>
            </a: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CF68A7-3F5B-4104-85BE-58916DC97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45</a:t>
            </a:fld>
            <a:endParaRPr lang="en-US" kern="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88D2AC9-F8A0-4173-80BE-9A9AD94F83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451" y="817253"/>
            <a:ext cx="7724354" cy="55390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5499607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9C1F6-E829-4689-BDA0-5F55432044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26844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/>
              <a:t>NAD Metabolism Summary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7951D0A3-863C-49F6-8BD2-6DC6F7813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46</a:t>
            </a:fld>
            <a:endParaRPr lang="en-US"/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A0ED8D4F-E9ED-4DA6-B47D-01EF0989E292}"/>
              </a:ext>
            </a:extLst>
          </p:cNvPr>
          <p:cNvGrpSpPr/>
          <p:nvPr/>
        </p:nvGrpSpPr>
        <p:grpSpPr>
          <a:xfrm>
            <a:off x="2224249" y="974002"/>
            <a:ext cx="4574909" cy="2386972"/>
            <a:chOff x="2201433" y="795957"/>
            <a:chExt cx="4574909" cy="238697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2080EA3-7B29-4822-9C10-BB9D3D5CB9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07026" y="1115524"/>
              <a:ext cx="4569316" cy="2067405"/>
            </a:xfrm>
            <a:prstGeom prst="rect">
              <a:avLst/>
            </a:prstGeom>
          </p:spPr>
        </p:pic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F8AC6DB3-3F54-4F8A-9470-480F7DF9E282}"/>
                </a:ext>
              </a:extLst>
            </p:cNvPr>
            <p:cNvCxnSpPr/>
            <p:nvPr/>
          </p:nvCxnSpPr>
          <p:spPr>
            <a:xfrm flipV="1">
              <a:off x="5125673" y="1996580"/>
              <a:ext cx="0" cy="19294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51E96B04-FA16-43F4-B418-BD1F52B001F1}"/>
                </a:ext>
              </a:extLst>
            </p:cNvPr>
            <p:cNvCxnSpPr/>
            <p:nvPr/>
          </p:nvCxnSpPr>
          <p:spPr>
            <a:xfrm flipV="1">
              <a:off x="5429075" y="1004581"/>
              <a:ext cx="0" cy="19294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C5AFF324-3E58-4A98-B4FC-62FB65AC7B8F}"/>
                </a:ext>
              </a:extLst>
            </p:cNvPr>
            <p:cNvCxnSpPr/>
            <p:nvPr/>
          </p:nvCxnSpPr>
          <p:spPr>
            <a:xfrm flipV="1">
              <a:off x="4486091" y="1197528"/>
              <a:ext cx="0" cy="19294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5BC1C252-F673-400D-B3BA-DC021138387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17846" y="1180751"/>
              <a:ext cx="0" cy="19294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30B99F49-8A76-4FFD-B52D-243A12ADD75F}"/>
                </a:ext>
              </a:extLst>
            </p:cNvPr>
            <p:cNvCxnSpPr>
              <a:cxnSpLocks/>
            </p:cNvCxnSpPr>
            <p:nvPr/>
          </p:nvCxnSpPr>
          <p:spPr>
            <a:xfrm>
              <a:off x="6361652" y="1021359"/>
              <a:ext cx="0" cy="192947"/>
            </a:xfrm>
            <a:prstGeom prst="straightConnector1">
              <a:avLst/>
            </a:prstGeom>
            <a:ln>
              <a:solidFill>
                <a:srgbClr val="00B050"/>
              </a:solidFill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B50EEEF4-59B3-405B-890A-E6BE055A6492}"/>
                </a:ext>
              </a:extLst>
            </p:cNvPr>
            <p:cNvCxnSpPr>
              <a:cxnSpLocks/>
            </p:cNvCxnSpPr>
            <p:nvPr/>
          </p:nvCxnSpPr>
          <p:spPr>
            <a:xfrm>
              <a:off x="2831285" y="2031080"/>
              <a:ext cx="0" cy="192947"/>
            </a:xfrm>
            <a:prstGeom prst="straightConnector1">
              <a:avLst/>
            </a:prstGeom>
            <a:ln>
              <a:solidFill>
                <a:srgbClr val="00B050"/>
              </a:solidFill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F3252F11-C502-4B14-8343-D0B426C74884}"/>
                </a:ext>
              </a:extLst>
            </p:cNvPr>
            <p:cNvCxnSpPr/>
            <p:nvPr/>
          </p:nvCxnSpPr>
          <p:spPr>
            <a:xfrm flipV="1">
              <a:off x="4823049" y="2989982"/>
              <a:ext cx="0" cy="19294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D2E1C7C-F9E7-4D4F-9C65-6DD5BC8D0D16}"/>
                </a:ext>
              </a:extLst>
            </p:cNvPr>
            <p:cNvSpPr txBox="1"/>
            <p:nvPr/>
          </p:nvSpPr>
          <p:spPr>
            <a:xfrm>
              <a:off x="2201433" y="795957"/>
              <a:ext cx="8766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Liver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2EDCAF97-81F6-413C-A618-B62BD7498785}"/>
              </a:ext>
            </a:extLst>
          </p:cNvPr>
          <p:cNvGrpSpPr/>
          <p:nvPr/>
        </p:nvGrpSpPr>
        <p:grpSpPr>
          <a:xfrm>
            <a:off x="2140895" y="3840190"/>
            <a:ext cx="4569316" cy="2388551"/>
            <a:chOff x="253733" y="3254218"/>
            <a:chExt cx="4569316" cy="2388551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93D0008B-F82E-4A53-96C5-421747EFB3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3733" y="3575364"/>
              <a:ext cx="4569316" cy="2067405"/>
            </a:xfrm>
            <a:prstGeom prst="rect">
              <a:avLst/>
            </a:prstGeom>
          </p:spPr>
        </p:pic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816F40F7-290F-4848-9C50-DEC5C1D3170F}"/>
                </a:ext>
              </a:extLst>
            </p:cNvPr>
            <p:cNvCxnSpPr/>
            <p:nvPr/>
          </p:nvCxnSpPr>
          <p:spPr>
            <a:xfrm flipV="1">
              <a:off x="3172380" y="4456420"/>
              <a:ext cx="0" cy="19294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642D4417-914B-454B-B272-C652DC9AB103}"/>
                </a:ext>
              </a:extLst>
            </p:cNvPr>
            <p:cNvCxnSpPr/>
            <p:nvPr/>
          </p:nvCxnSpPr>
          <p:spPr>
            <a:xfrm flipV="1">
              <a:off x="3475782" y="3464421"/>
              <a:ext cx="0" cy="19294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83F2BAC3-9647-4CCA-B02C-4AD398A86D66}"/>
                </a:ext>
              </a:extLst>
            </p:cNvPr>
            <p:cNvCxnSpPr>
              <a:cxnSpLocks/>
            </p:cNvCxnSpPr>
            <p:nvPr/>
          </p:nvCxnSpPr>
          <p:spPr>
            <a:xfrm>
              <a:off x="4408359" y="3481199"/>
              <a:ext cx="0" cy="192947"/>
            </a:xfrm>
            <a:prstGeom prst="straightConnector1">
              <a:avLst/>
            </a:prstGeom>
            <a:ln>
              <a:solidFill>
                <a:srgbClr val="00B050"/>
              </a:solidFill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4F0A51BF-D13B-40F6-8E99-AE53F2F89B6A}"/>
                </a:ext>
              </a:extLst>
            </p:cNvPr>
            <p:cNvCxnSpPr/>
            <p:nvPr/>
          </p:nvCxnSpPr>
          <p:spPr>
            <a:xfrm flipV="1">
              <a:off x="2869756" y="5449822"/>
              <a:ext cx="0" cy="19294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B8C7C31-E469-4887-A61E-8F30E78EB2BB}"/>
                </a:ext>
              </a:extLst>
            </p:cNvPr>
            <p:cNvSpPr txBox="1"/>
            <p:nvPr/>
          </p:nvSpPr>
          <p:spPr>
            <a:xfrm>
              <a:off x="292961" y="3254218"/>
              <a:ext cx="8766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Lung</a:t>
              </a:r>
            </a:p>
          </p:txBody>
        </p:sp>
      </p:grpSp>
      <p:sp>
        <p:nvSpPr>
          <p:cNvPr id="5" name="Rectangle 4">
            <a:extLst>
              <a:ext uri="{FF2B5EF4-FFF2-40B4-BE49-F238E27FC236}">
                <a16:creationId xmlns:a16="http://schemas.microsoft.com/office/drawing/2014/main" id="{B80AE4DE-FF64-456E-B108-6DBA494C298D}"/>
              </a:ext>
            </a:extLst>
          </p:cNvPr>
          <p:cNvSpPr/>
          <p:nvPr/>
        </p:nvSpPr>
        <p:spPr>
          <a:xfrm>
            <a:off x="2259379" y="2306972"/>
            <a:ext cx="936826" cy="4015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DD95EB2-6C73-422E-B3B4-92BDD52C9EEC}"/>
              </a:ext>
            </a:extLst>
          </p:cNvPr>
          <p:cNvSpPr/>
          <p:nvPr/>
        </p:nvSpPr>
        <p:spPr>
          <a:xfrm>
            <a:off x="3922420" y="2432782"/>
            <a:ext cx="936826" cy="4015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F52A4E4-EEA2-4F86-AE0B-3F20126D8AD5}"/>
              </a:ext>
            </a:extLst>
          </p:cNvPr>
          <p:cNvSpPr/>
          <p:nvPr/>
        </p:nvSpPr>
        <p:spPr>
          <a:xfrm>
            <a:off x="110049" y="4799896"/>
            <a:ext cx="936826" cy="4015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CEEF1DAD-7054-4E79-88E2-032F6210A0EA}"/>
              </a:ext>
            </a:extLst>
          </p:cNvPr>
          <p:cNvSpPr/>
          <p:nvPr/>
        </p:nvSpPr>
        <p:spPr>
          <a:xfrm>
            <a:off x="1764701" y="4934095"/>
            <a:ext cx="936826" cy="4015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B7107E9D-53E0-459D-8325-FE26B76720BA}"/>
              </a:ext>
            </a:extLst>
          </p:cNvPr>
          <p:cNvSpPr/>
          <p:nvPr/>
        </p:nvSpPr>
        <p:spPr>
          <a:xfrm>
            <a:off x="4511704" y="4883272"/>
            <a:ext cx="936826" cy="4015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79DC7618-619D-4D3D-A3A7-62578E245DFF}"/>
              </a:ext>
            </a:extLst>
          </p:cNvPr>
          <p:cNvSpPr/>
          <p:nvPr/>
        </p:nvSpPr>
        <p:spPr>
          <a:xfrm>
            <a:off x="6149578" y="5009082"/>
            <a:ext cx="936826" cy="4015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079665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5175253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R="0" lvl="0" algn="l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noProof="0" dirty="0">
                <a:latin typeface="+mj-lt"/>
              </a:rPr>
              <a:t>Quality Control Process</a:t>
            </a:r>
            <a:endParaRPr kumimoji="0" lang="en-US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j-lt"/>
            </a:endParaRPr>
          </a:p>
        </p:txBody>
      </p:sp>
      <p:sp>
        <p:nvSpPr>
          <p:cNvPr id="65" name="Rounded Rectangle 3399">
            <a:extLst>
              <a:ext uri="{FF2B5EF4-FFF2-40B4-BE49-F238E27FC236}">
                <a16:creationId xmlns:a16="http://schemas.microsoft.com/office/drawing/2014/main" id="{AC8DB305-8FB5-45ED-B357-3EA5747C1F23}"/>
              </a:ext>
            </a:extLst>
          </p:cNvPr>
          <p:cNvSpPr/>
          <p:nvPr/>
        </p:nvSpPr>
        <p:spPr>
          <a:xfrm>
            <a:off x="3707904" y="1556792"/>
            <a:ext cx="2016224" cy="1152128"/>
          </a:xfrm>
          <a:prstGeom prst="roundRect">
            <a:avLst>
              <a:gd name="adj" fmla="val 8133"/>
            </a:avLst>
          </a:prstGeom>
          <a:solidFill>
            <a:schemeClr val="accent6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66" name="Content Placeholder 3397">
            <a:extLst>
              <a:ext uri="{FF2B5EF4-FFF2-40B4-BE49-F238E27FC236}">
                <a16:creationId xmlns:a16="http://schemas.microsoft.com/office/drawing/2014/main" id="{B2578116-58DA-4BA9-8D0F-67C9D4EC90A0}"/>
              </a:ext>
            </a:extLst>
          </p:cNvPr>
          <p:cNvSpPr txBox="1">
            <a:spLocks/>
          </p:cNvSpPr>
          <p:nvPr/>
        </p:nvSpPr>
        <p:spPr>
          <a:xfrm>
            <a:off x="874507" y="5905555"/>
            <a:ext cx="8136904" cy="790750"/>
          </a:xfrm>
          <a:prstGeom prst="rect">
            <a:avLst/>
          </a:prstGeom>
        </p:spPr>
        <p:txBody>
          <a:bodyPr/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Montserrat" pitchFamily="2" charset="77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Montserrat" pitchFamily="2" charset="77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1800" kern="1200">
                <a:solidFill>
                  <a:schemeClr val="tx1"/>
                </a:solidFill>
                <a:latin typeface="Montserrat" pitchFamily="2" charset="77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1600" kern="1200">
                <a:solidFill>
                  <a:schemeClr val="tx1"/>
                </a:solidFill>
                <a:latin typeface="Montserrat" pitchFamily="2" charset="77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1600" kern="1200">
                <a:solidFill>
                  <a:schemeClr val="tx1"/>
                </a:solidFill>
                <a:latin typeface="Montserrat" pitchFamily="2" charset="77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itchFamily="34" charset="0"/>
              <a:buNone/>
            </a:pPr>
            <a:r>
              <a:rPr lang="en-US" sz="1800" dirty="0"/>
              <a:t>These processes allow for monitoring platform and process variability</a:t>
            </a:r>
          </a:p>
          <a:p>
            <a:endParaRPr lang="en-US" sz="1800" dirty="0"/>
          </a:p>
        </p:txBody>
      </p:sp>
      <p:sp>
        <p:nvSpPr>
          <p:cNvPr id="67" name="Text Box 286">
            <a:extLst>
              <a:ext uri="{FF2B5EF4-FFF2-40B4-BE49-F238E27FC236}">
                <a16:creationId xmlns:a16="http://schemas.microsoft.com/office/drawing/2014/main" id="{22432CBF-C486-4BF3-80EE-31ED39A8C0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4178" y="1075478"/>
            <a:ext cx="855394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baseline="0" dirty="0">
                <a:latin typeface="+mj-lt"/>
              </a:rPr>
              <a:t>1. Significant component is QC                       2. Multiple embedded QC standards in </a:t>
            </a:r>
            <a:r>
              <a:rPr lang="en-US" sz="1400" b="1" u="sng" baseline="0" dirty="0">
                <a:latin typeface="+mj-lt"/>
              </a:rPr>
              <a:t>every</a:t>
            </a:r>
            <a:r>
              <a:rPr lang="en-US" sz="1400" b="1" baseline="0" dirty="0">
                <a:latin typeface="+mj-lt"/>
              </a:rPr>
              <a:t> sample</a:t>
            </a:r>
          </a:p>
        </p:txBody>
      </p:sp>
      <p:sp>
        <p:nvSpPr>
          <p:cNvPr id="68" name="Text Box 287">
            <a:extLst>
              <a:ext uri="{FF2B5EF4-FFF2-40B4-BE49-F238E27FC236}">
                <a16:creationId xmlns:a16="http://schemas.microsoft.com/office/drawing/2014/main" id="{8E4F1DCC-70CC-4600-89DB-5C455121F4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528" y="3099155"/>
            <a:ext cx="5985998" cy="4924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baseline="0" dirty="0">
                <a:latin typeface="+mj-lt"/>
              </a:rPr>
              <a:t>3. Matrix-specific technical replicates and QC injections across a study run-day</a:t>
            </a:r>
          </a:p>
          <a:p>
            <a:endParaRPr lang="en-US" b="1" dirty="0">
              <a:latin typeface="+mj-lt"/>
            </a:endParaRPr>
          </a:p>
        </p:txBody>
      </p:sp>
      <p:sp>
        <p:nvSpPr>
          <p:cNvPr id="69" name="Rounded Rectangle 18">
            <a:extLst>
              <a:ext uri="{FF2B5EF4-FFF2-40B4-BE49-F238E27FC236}">
                <a16:creationId xmlns:a16="http://schemas.microsoft.com/office/drawing/2014/main" id="{6BB882E4-65F2-4AEE-BAE7-7061778203D2}"/>
              </a:ext>
            </a:extLst>
          </p:cNvPr>
          <p:cNvSpPr/>
          <p:nvPr/>
        </p:nvSpPr>
        <p:spPr>
          <a:xfrm>
            <a:off x="5868144" y="1556792"/>
            <a:ext cx="2808312" cy="1152128"/>
          </a:xfrm>
          <a:prstGeom prst="roundRect">
            <a:avLst>
              <a:gd name="adj" fmla="val 10693"/>
            </a:avLst>
          </a:prstGeom>
          <a:solidFill>
            <a:schemeClr val="accent6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EA582B7-CBFB-4D17-AC77-B3D48803A49A}"/>
              </a:ext>
            </a:extLst>
          </p:cNvPr>
          <p:cNvSpPr txBox="1"/>
          <p:nvPr/>
        </p:nvSpPr>
        <p:spPr>
          <a:xfrm>
            <a:off x="3779912" y="2276872"/>
            <a:ext cx="720080" cy="19262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Sample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35FA1CD-D638-45D9-B35C-1AF7DAD0A102}"/>
              </a:ext>
            </a:extLst>
          </p:cNvPr>
          <p:cNvSpPr txBox="1"/>
          <p:nvPr/>
        </p:nvSpPr>
        <p:spPr>
          <a:xfrm>
            <a:off x="4139952" y="1639686"/>
            <a:ext cx="1080120" cy="21602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+ Recovery Standards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A277ACC8-19C7-40D0-8170-35A5CB935976}"/>
              </a:ext>
            </a:extLst>
          </p:cNvPr>
          <p:cNvCxnSpPr/>
          <p:nvPr/>
        </p:nvCxnSpPr>
        <p:spPr>
          <a:xfrm>
            <a:off x="4673944" y="1938604"/>
            <a:ext cx="0" cy="216024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157EB039-411B-4DFC-BAE4-FD5FFF08C677}"/>
              </a:ext>
            </a:extLst>
          </p:cNvPr>
          <p:cNvCxnSpPr/>
          <p:nvPr/>
        </p:nvCxnSpPr>
        <p:spPr>
          <a:xfrm>
            <a:off x="4860032" y="2420888"/>
            <a:ext cx="1440160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770167F7-98BA-4175-9FBB-F930BFBA8491}"/>
              </a:ext>
            </a:extLst>
          </p:cNvPr>
          <p:cNvSpPr txBox="1"/>
          <p:nvPr/>
        </p:nvSpPr>
        <p:spPr>
          <a:xfrm>
            <a:off x="6134404" y="1661458"/>
            <a:ext cx="864096" cy="21602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+ Internal Standards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B9AD1012-1686-4F32-AA55-5E76D45CE83B}"/>
              </a:ext>
            </a:extLst>
          </p:cNvPr>
          <p:cNvCxnSpPr/>
          <p:nvPr/>
        </p:nvCxnSpPr>
        <p:spPr>
          <a:xfrm>
            <a:off x="6699582" y="2420888"/>
            <a:ext cx="360040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03E1AFC1-986F-407F-87A7-1DB81279FC0D}"/>
              </a:ext>
            </a:extLst>
          </p:cNvPr>
          <p:cNvSpPr txBox="1"/>
          <p:nvPr/>
        </p:nvSpPr>
        <p:spPr>
          <a:xfrm>
            <a:off x="7026762" y="2310492"/>
            <a:ext cx="1872208" cy="21602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n-lt"/>
                <a:ea typeface="+mj-ea"/>
                <a:cs typeface="+mj-cs"/>
              </a:rPr>
              <a:t>Injection into Instrument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870B55DF-3D34-4D77-9BA8-9D41A63F4CAF}"/>
              </a:ext>
            </a:extLst>
          </p:cNvPr>
          <p:cNvCxnSpPr/>
          <p:nvPr/>
        </p:nvCxnSpPr>
        <p:spPr>
          <a:xfrm>
            <a:off x="6546506" y="1943320"/>
            <a:ext cx="0" cy="216024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Rounded Rectangle 3416">
            <a:extLst>
              <a:ext uri="{FF2B5EF4-FFF2-40B4-BE49-F238E27FC236}">
                <a16:creationId xmlns:a16="http://schemas.microsoft.com/office/drawing/2014/main" id="{248FB185-EB79-4EBA-892F-8CC0A74CF73F}"/>
              </a:ext>
            </a:extLst>
          </p:cNvPr>
          <p:cNvSpPr/>
          <p:nvPr/>
        </p:nvSpPr>
        <p:spPr>
          <a:xfrm>
            <a:off x="578902" y="3501008"/>
            <a:ext cx="2160240" cy="2088232"/>
          </a:xfrm>
          <a:prstGeom prst="roundRect">
            <a:avLst>
              <a:gd name="adj" fmla="val 5367"/>
            </a:avLst>
          </a:prstGeom>
          <a:solidFill>
            <a:schemeClr val="accent6"/>
          </a:solidFill>
          <a:ln>
            <a:noFill/>
          </a:ln>
          <a:effectLst>
            <a:outerShdw blurRad="50800" dist="38100" algn="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>
              <a:solidFill>
                <a:schemeClr val="tx1"/>
              </a:solidFill>
            </a:endParaRPr>
          </a:p>
        </p:txBody>
      </p:sp>
      <p:sp>
        <p:nvSpPr>
          <p:cNvPr id="79" name="Flowchart: Direct Access Storage 78">
            <a:extLst>
              <a:ext uri="{FF2B5EF4-FFF2-40B4-BE49-F238E27FC236}">
                <a16:creationId xmlns:a16="http://schemas.microsoft.com/office/drawing/2014/main" id="{6570508A-11BD-4475-8A8C-661CA634244C}"/>
              </a:ext>
            </a:extLst>
          </p:cNvPr>
          <p:cNvSpPr/>
          <p:nvPr/>
        </p:nvSpPr>
        <p:spPr>
          <a:xfrm rot="16200000">
            <a:off x="4463988" y="2312876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80" name="Right Brace 79">
            <a:extLst>
              <a:ext uri="{FF2B5EF4-FFF2-40B4-BE49-F238E27FC236}">
                <a16:creationId xmlns:a16="http://schemas.microsoft.com/office/drawing/2014/main" id="{8D1BD3E6-9528-4BAA-ADFD-DBACDDDB7280}"/>
              </a:ext>
            </a:extLst>
          </p:cNvPr>
          <p:cNvSpPr/>
          <p:nvPr/>
        </p:nvSpPr>
        <p:spPr>
          <a:xfrm rot="5400000">
            <a:off x="1505632" y="3582390"/>
            <a:ext cx="162764" cy="1584176"/>
          </a:xfrm>
          <a:prstGeom prst="rightBrace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Flowchart: Direct Access Storage 80">
            <a:extLst>
              <a:ext uri="{FF2B5EF4-FFF2-40B4-BE49-F238E27FC236}">
                <a16:creationId xmlns:a16="http://schemas.microsoft.com/office/drawing/2014/main" id="{1E45F6F2-A69A-4F40-8BEB-316B10604D66}"/>
              </a:ext>
            </a:extLst>
          </p:cNvPr>
          <p:cNvSpPr/>
          <p:nvPr/>
        </p:nvSpPr>
        <p:spPr>
          <a:xfrm rot="16200000">
            <a:off x="6318618" y="2312876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82" name="Flowchart: Direct Access Storage 81">
            <a:extLst>
              <a:ext uri="{FF2B5EF4-FFF2-40B4-BE49-F238E27FC236}">
                <a16:creationId xmlns:a16="http://schemas.microsoft.com/office/drawing/2014/main" id="{2FCBF527-6698-48E5-BBCE-24B12E1E97B0}"/>
              </a:ext>
            </a:extLst>
          </p:cNvPr>
          <p:cNvSpPr/>
          <p:nvPr/>
        </p:nvSpPr>
        <p:spPr>
          <a:xfrm rot="16200000">
            <a:off x="1374336" y="4645596"/>
            <a:ext cx="432048" cy="216024"/>
          </a:xfrm>
          <a:prstGeom prst="flowChartMagneticDrum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Flowchart: Direct Access Storage 82">
            <a:extLst>
              <a:ext uri="{FF2B5EF4-FFF2-40B4-BE49-F238E27FC236}">
                <a16:creationId xmlns:a16="http://schemas.microsoft.com/office/drawing/2014/main" id="{BE8DC933-8634-4C69-96F7-5C0770B870FF}"/>
              </a:ext>
            </a:extLst>
          </p:cNvPr>
          <p:cNvSpPr/>
          <p:nvPr/>
        </p:nvSpPr>
        <p:spPr>
          <a:xfrm rot="16200000">
            <a:off x="614906" y="3681028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Flowchart: Direct Access Storage 83">
            <a:extLst>
              <a:ext uri="{FF2B5EF4-FFF2-40B4-BE49-F238E27FC236}">
                <a16:creationId xmlns:a16="http://schemas.microsoft.com/office/drawing/2014/main" id="{8CE88FD1-1E12-41AA-9DA2-0307DFBC5551}"/>
              </a:ext>
            </a:extLst>
          </p:cNvPr>
          <p:cNvSpPr/>
          <p:nvPr/>
        </p:nvSpPr>
        <p:spPr>
          <a:xfrm rot="16200000">
            <a:off x="902938" y="3681028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Flowchart: Direct Access Storage 84">
            <a:extLst>
              <a:ext uri="{FF2B5EF4-FFF2-40B4-BE49-F238E27FC236}">
                <a16:creationId xmlns:a16="http://schemas.microsoft.com/office/drawing/2014/main" id="{27DC0969-E5D2-4500-B492-73FF535ACB43}"/>
              </a:ext>
            </a:extLst>
          </p:cNvPr>
          <p:cNvSpPr/>
          <p:nvPr/>
        </p:nvSpPr>
        <p:spPr>
          <a:xfrm rot="16200000">
            <a:off x="1190970" y="3681028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Flowchart: Direct Access Storage 85">
            <a:extLst>
              <a:ext uri="{FF2B5EF4-FFF2-40B4-BE49-F238E27FC236}">
                <a16:creationId xmlns:a16="http://schemas.microsoft.com/office/drawing/2014/main" id="{76C8BE9B-D396-415A-B6CC-C86019A27CAF}"/>
              </a:ext>
            </a:extLst>
          </p:cNvPr>
          <p:cNvSpPr/>
          <p:nvPr/>
        </p:nvSpPr>
        <p:spPr>
          <a:xfrm rot="16200000">
            <a:off x="1479002" y="3681028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Flowchart: Direct Access Storage 88">
            <a:extLst>
              <a:ext uri="{FF2B5EF4-FFF2-40B4-BE49-F238E27FC236}">
                <a16:creationId xmlns:a16="http://schemas.microsoft.com/office/drawing/2014/main" id="{B91AE211-FEEA-4CC6-A38A-5FAA12AF5604}"/>
              </a:ext>
            </a:extLst>
          </p:cNvPr>
          <p:cNvSpPr/>
          <p:nvPr/>
        </p:nvSpPr>
        <p:spPr>
          <a:xfrm rot="16200000">
            <a:off x="2271090" y="3681028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1E10D23E-19E9-4A76-8375-7B01869D94CC}"/>
              </a:ext>
            </a:extLst>
          </p:cNvPr>
          <p:cNvCxnSpPr/>
          <p:nvPr/>
        </p:nvCxnSpPr>
        <p:spPr>
          <a:xfrm>
            <a:off x="1875046" y="3789040"/>
            <a:ext cx="432048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Flowchart: Direct Access Storage 90">
            <a:extLst>
              <a:ext uri="{FF2B5EF4-FFF2-40B4-BE49-F238E27FC236}">
                <a16:creationId xmlns:a16="http://schemas.microsoft.com/office/drawing/2014/main" id="{8FFD6360-615E-42B1-BD34-0FEFB5151F45}"/>
              </a:ext>
            </a:extLst>
          </p:cNvPr>
          <p:cNvSpPr/>
          <p:nvPr/>
        </p:nvSpPr>
        <p:spPr>
          <a:xfrm rot="16200000">
            <a:off x="542898" y="3897052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Flowchart: Direct Access Storage 91">
            <a:extLst>
              <a:ext uri="{FF2B5EF4-FFF2-40B4-BE49-F238E27FC236}">
                <a16:creationId xmlns:a16="http://schemas.microsoft.com/office/drawing/2014/main" id="{B8B0F2F7-265F-4156-A06C-61C4F1BA3BCA}"/>
              </a:ext>
            </a:extLst>
          </p:cNvPr>
          <p:cNvSpPr/>
          <p:nvPr/>
        </p:nvSpPr>
        <p:spPr>
          <a:xfrm rot="16200000">
            <a:off x="830930" y="3897052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Flowchart: Direct Access Storage 92">
            <a:extLst>
              <a:ext uri="{FF2B5EF4-FFF2-40B4-BE49-F238E27FC236}">
                <a16:creationId xmlns:a16="http://schemas.microsoft.com/office/drawing/2014/main" id="{C4B80392-FDC1-4B4C-A5B5-8B00FD48C5CC}"/>
              </a:ext>
            </a:extLst>
          </p:cNvPr>
          <p:cNvSpPr/>
          <p:nvPr/>
        </p:nvSpPr>
        <p:spPr>
          <a:xfrm rot="16200000">
            <a:off x="1118962" y="3897052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Flowchart: Direct Access Storage 93">
            <a:extLst>
              <a:ext uri="{FF2B5EF4-FFF2-40B4-BE49-F238E27FC236}">
                <a16:creationId xmlns:a16="http://schemas.microsoft.com/office/drawing/2014/main" id="{7052943D-4962-4F98-A268-0FAF70AC519B}"/>
              </a:ext>
            </a:extLst>
          </p:cNvPr>
          <p:cNvSpPr/>
          <p:nvPr/>
        </p:nvSpPr>
        <p:spPr>
          <a:xfrm rot="16200000">
            <a:off x="1406994" y="3897052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Flowchart: Direct Access Storage 94">
            <a:extLst>
              <a:ext uri="{FF2B5EF4-FFF2-40B4-BE49-F238E27FC236}">
                <a16:creationId xmlns:a16="http://schemas.microsoft.com/office/drawing/2014/main" id="{6082A8A6-E0EF-497A-A470-2C42AB59434F}"/>
              </a:ext>
            </a:extLst>
          </p:cNvPr>
          <p:cNvSpPr/>
          <p:nvPr/>
        </p:nvSpPr>
        <p:spPr>
          <a:xfrm rot="16200000">
            <a:off x="2199082" y="3897052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B8050843-E26C-46DB-9102-278CEF6E5BDC}"/>
              </a:ext>
            </a:extLst>
          </p:cNvPr>
          <p:cNvCxnSpPr/>
          <p:nvPr/>
        </p:nvCxnSpPr>
        <p:spPr>
          <a:xfrm>
            <a:off x="1803038" y="4005064"/>
            <a:ext cx="432048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B6B41391-0CA6-43CE-9238-2BD9A41D8857}"/>
              </a:ext>
            </a:extLst>
          </p:cNvPr>
          <p:cNvSpPr txBox="1"/>
          <p:nvPr/>
        </p:nvSpPr>
        <p:spPr>
          <a:xfrm>
            <a:off x="722918" y="5013176"/>
            <a:ext cx="1800200" cy="50405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Equal aliquot from </a:t>
            </a:r>
            <a:r>
              <a:rPr kumimoji="0" lang="en-US" sz="1100" b="0" i="0" u="sng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ALL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experimental samples pooled as “CMTRX”</a:t>
            </a:r>
          </a:p>
        </p:txBody>
      </p:sp>
      <p:sp>
        <p:nvSpPr>
          <p:cNvPr id="98" name="Right Arrow 3499">
            <a:extLst>
              <a:ext uri="{FF2B5EF4-FFF2-40B4-BE49-F238E27FC236}">
                <a16:creationId xmlns:a16="http://schemas.microsoft.com/office/drawing/2014/main" id="{09E8D083-8EC8-4FE4-B5E1-AD21800EF5ED}"/>
              </a:ext>
            </a:extLst>
          </p:cNvPr>
          <p:cNvSpPr/>
          <p:nvPr/>
        </p:nvSpPr>
        <p:spPr>
          <a:xfrm>
            <a:off x="2915816" y="4293096"/>
            <a:ext cx="1296144" cy="504056"/>
          </a:xfrm>
          <a:prstGeom prst="rightArrow">
            <a:avLst/>
          </a:prstGeom>
          <a:solidFill>
            <a:schemeClr val="tx1">
              <a:lumMod val="75000"/>
              <a:lumOff val="25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ounded Rectangle 3500">
            <a:extLst>
              <a:ext uri="{FF2B5EF4-FFF2-40B4-BE49-F238E27FC236}">
                <a16:creationId xmlns:a16="http://schemas.microsoft.com/office/drawing/2014/main" id="{83F510DA-B915-49D6-826C-AE9E54FDECE7}"/>
              </a:ext>
            </a:extLst>
          </p:cNvPr>
          <p:cNvSpPr/>
          <p:nvPr/>
        </p:nvSpPr>
        <p:spPr>
          <a:xfrm>
            <a:off x="4388634" y="3573016"/>
            <a:ext cx="4287822" cy="2016224"/>
          </a:xfrm>
          <a:prstGeom prst="roundRect">
            <a:avLst>
              <a:gd name="adj" fmla="val 4476"/>
            </a:avLst>
          </a:prstGeom>
          <a:solidFill>
            <a:schemeClr val="accent6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100" name="Flowchart: Direct Access Storage 99">
            <a:extLst>
              <a:ext uri="{FF2B5EF4-FFF2-40B4-BE49-F238E27FC236}">
                <a16:creationId xmlns:a16="http://schemas.microsoft.com/office/drawing/2014/main" id="{B1AD6BF6-1B9D-4C41-97BC-A087B652E82A}"/>
              </a:ext>
            </a:extLst>
          </p:cNvPr>
          <p:cNvSpPr/>
          <p:nvPr/>
        </p:nvSpPr>
        <p:spPr>
          <a:xfrm rot="16200000">
            <a:off x="4535996" y="4545124"/>
            <a:ext cx="432048" cy="216024"/>
          </a:xfrm>
          <a:prstGeom prst="flowChartMagneticDrum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E1AF645D-17F2-4BFC-ABC4-0D1D0F8FF2AC}"/>
              </a:ext>
            </a:extLst>
          </p:cNvPr>
          <p:cNvCxnSpPr/>
          <p:nvPr/>
        </p:nvCxnSpPr>
        <p:spPr>
          <a:xfrm flipV="1">
            <a:off x="4758308" y="4949139"/>
            <a:ext cx="0" cy="216024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1170DE24-F05D-4D58-B812-94FC7DF92C45}"/>
              </a:ext>
            </a:extLst>
          </p:cNvPr>
          <p:cNvSpPr txBox="1"/>
          <p:nvPr/>
        </p:nvSpPr>
        <p:spPr>
          <a:xfrm>
            <a:off x="4427984" y="5139614"/>
            <a:ext cx="648072" cy="21602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CMTRX</a:t>
            </a:r>
          </a:p>
        </p:txBody>
      </p:sp>
      <p:sp>
        <p:nvSpPr>
          <p:cNvPr id="103" name="Down Arrow 3508">
            <a:extLst>
              <a:ext uri="{FF2B5EF4-FFF2-40B4-BE49-F238E27FC236}">
                <a16:creationId xmlns:a16="http://schemas.microsoft.com/office/drawing/2014/main" id="{763C5F62-A1EA-47A4-8607-F12D4C195E12}"/>
              </a:ext>
            </a:extLst>
          </p:cNvPr>
          <p:cNvSpPr/>
          <p:nvPr/>
        </p:nvSpPr>
        <p:spPr>
          <a:xfrm>
            <a:off x="4644008" y="4005064"/>
            <a:ext cx="144016" cy="360040"/>
          </a:xfrm>
          <a:prstGeom prst="downArrow">
            <a:avLst/>
          </a:prstGeom>
          <a:solidFill>
            <a:schemeClr val="bg1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8A65028D-5BA7-4DB0-AA7F-2DB25D6025A5}"/>
              </a:ext>
            </a:extLst>
          </p:cNvPr>
          <p:cNvSpPr txBox="1"/>
          <p:nvPr/>
        </p:nvSpPr>
        <p:spPr>
          <a:xfrm>
            <a:off x="4454277" y="3648075"/>
            <a:ext cx="720080" cy="21602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1</a:t>
            </a:r>
            <a:r>
              <a:rPr kumimoji="0" lang="en-US" sz="1050" b="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st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 Injection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05" name="Flowchart: Direct Access Storage 104">
            <a:extLst>
              <a:ext uri="{FF2B5EF4-FFF2-40B4-BE49-F238E27FC236}">
                <a16:creationId xmlns:a16="http://schemas.microsoft.com/office/drawing/2014/main" id="{AC1F9BFD-F96A-4280-AD06-5AC5A10C0450}"/>
              </a:ext>
            </a:extLst>
          </p:cNvPr>
          <p:cNvSpPr/>
          <p:nvPr/>
        </p:nvSpPr>
        <p:spPr>
          <a:xfrm rot="16200000">
            <a:off x="4896036" y="4545124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Flowchart: Direct Access Storage 105">
            <a:extLst>
              <a:ext uri="{FF2B5EF4-FFF2-40B4-BE49-F238E27FC236}">
                <a16:creationId xmlns:a16="http://schemas.microsoft.com/office/drawing/2014/main" id="{31B1E083-B2B5-4A2D-927C-54C9523389A2}"/>
              </a:ext>
            </a:extLst>
          </p:cNvPr>
          <p:cNvSpPr/>
          <p:nvPr/>
        </p:nvSpPr>
        <p:spPr>
          <a:xfrm rot="16200000">
            <a:off x="5184068" y="4545124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Flowchart: Direct Access Storage 106">
            <a:extLst>
              <a:ext uri="{FF2B5EF4-FFF2-40B4-BE49-F238E27FC236}">
                <a16:creationId xmlns:a16="http://schemas.microsoft.com/office/drawing/2014/main" id="{0B0601D1-58DF-46F9-AEF6-15CDE75142D0}"/>
              </a:ext>
            </a:extLst>
          </p:cNvPr>
          <p:cNvSpPr/>
          <p:nvPr/>
        </p:nvSpPr>
        <p:spPr>
          <a:xfrm rot="16200000">
            <a:off x="5472100" y="4545124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Right Brace 107">
            <a:extLst>
              <a:ext uri="{FF2B5EF4-FFF2-40B4-BE49-F238E27FC236}">
                <a16:creationId xmlns:a16="http://schemas.microsoft.com/office/drawing/2014/main" id="{F8C712BE-D5C6-40B4-8B43-B491EF0B0BF3}"/>
              </a:ext>
            </a:extLst>
          </p:cNvPr>
          <p:cNvSpPr/>
          <p:nvPr/>
        </p:nvSpPr>
        <p:spPr>
          <a:xfrm rot="5400000">
            <a:off x="5256076" y="4743570"/>
            <a:ext cx="288032" cy="648072"/>
          </a:xfrm>
          <a:prstGeom prst="rightBrace">
            <a:avLst>
              <a:gd name="adj1" fmla="val 0"/>
              <a:gd name="adj2" fmla="val 48530"/>
            </a:avLst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11DC2B63-8457-40A6-8ACA-8EB7D10F81EC}"/>
              </a:ext>
            </a:extLst>
          </p:cNvPr>
          <p:cNvSpPr txBox="1"/>
          <p:nvPr/>
        </p:nvSpPr>
        <p:spPr>
          <a:xfrm>
            <a:off x="4860032" y="5301208"/>
            <a:ext cx="1080120" cy="21602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Experimental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Samples</a:t>
            </a:r>
            <a:endParaRPr kumimoji="0" lang="en-US" sz="9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grpSp>
        <p:nvGrpSpPr>
          <p:cNvPr id="110" name="Group 3523">
            <a:extLst>
              <a:ext uri="{FF2B5EF4-FFF2-40B4-BE49-F238E27FC236}">
                <a16:creationId xmlns:a16="http://schemas.microsoft.com/office/drawing/2014/main" id="{60D8ECEA-5A58-4C75-8AC5-CCDA5540D5FB}"/>
              </a:ext>
            </a:extLst>
          </p:cNvPr>
          <p:cNvGrpSpPr/>
          <p:nvPr/>
        </p:nvGrpSpPr>
        <p:grpSpPr>
          <a:xfrm>
            <a:off x="5940152" y="4437112"/>
            <a:ext cx="216024" cy="432048"/>
            <a:chOff x="4499992" y="1988840"/>
            <a:chExt cx="216024" cy="432048"/>
          </a:xfrm>
          <a:solidFill>
            <a:schemeClr val="bg1">
              <a:lumMod val="65000"/>
            </a:schemeClr>
          </a:solidFill>
        </p:grpSpPr>
        <p:sp>
          <p:nvSpPr>
            <p:cNvPr id="111" name="Flowchart: Direct Access Storage 110">
              <a:extLst>
                <a:ext uri="{FF2B5EF4-FFF2-40B4-BE49-F238E27FC236}">
                  <a16:creationId xmlns:a16="http://schemas.microsoft.com/office/drawing/2014/main" id="{7891B7AD-DB4E-4DAA-81AE-15D5876700F2}"/>
                </a:ext>
              </a:extLst>
            </p:cNvPr>
            <p:cNvSpPr/>
            <p:nvPr/>
          </p:nvSpPr>
          <p:spPr>
            <a:xfrm rot="16200000">
              <a:off x="4391980" y="2096852"/>
              <a:ext cx="432048" cy="216024"/>
            </a:xfrm>
            <a:prstGeom prst="flowChartMagneticDrum">
              <a:avLst/>
            </a:prstGeom>
            <a:grpFill/>
            <a:ln>
              <a:solidFill>
                <a:srgbClr val="4D4D4D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Oval 111">
              <a:extLst>
                <a:ext uri="{FF2B5EF4-FFF2-40B4-BE49-F238E27FC236}">
                  <a16:creationId xmlns:a16="http://schemas.microsoft.com/office/drawing/2014/main" id="{EF70B960-74F4-45E7-8759-8C1F8D1AC9EF}"/>
                </a:ext>
              </a:extLst>
            </p:cNvPr>
            <p:cNvSpPr/>
            <p:nvPr/>
          </p:nvSpPr>
          <p:spPr>
            <a:xfrm>
              <a:off x="4499992" y="1988840"/>
              <a:ext cx="216024" cy="144016"/>
            </a:xfrm>
            <a:prstGeom prst="ellipse">
              <a:avLst/>
            </a:prstGeom>
            <a:grpFill/>
            <a:ln>
              <a:solidFill>
                <a:srgbClr val="4D4D4D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D70C288A-7299-4470-8FC3-8EB0CEF6B6A6}"/>
              </a:ext>
            </a:extLst>
          </p:cNvPr>
          <p:cNvCxnSpPr/>
          <p:nvPr/>
        </p:nvCxnSpPr>
        <p:spPr>
          <a:xfrm>
            <a:off x="6228184" y="4635558"/>
            <a:ext cx="144016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4" name="Flowchart: Direct Access Storage 113">
            <a:extLst>
              <a:ext uri="{FF2B5EF4-FFF2-40B4-BE49-F238E27FC236}">
                <a16:creationId xmlns:a16="http://schemas.microsoft.com/office/drawing/2014/main" id="{CDD31BEA-7FBF-4D68-8C54-08FD93A8BEA4}"/>
              </a:ext>
            </a:extLst>
          </p:cNvPr>
          <p:cNvSpPr/>
          <p:nvPr/>
        </p:nvSpPr>
        <p:spPr>
          <a:xfrm rot="16200000">
            <a:off x="6336196" y="4545124"/>
            <a:ext cx="432048" cy="216024"/>
          </a:xfrm>
          <a:prstGeom prst="flowChartMagneticDrum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D369761B-6BBE-4DC2-9B64-1261CE662D52}"/>
              </a:ext>
            </a:extLst>
          </p:cNvPr>
          <p:cNvCxnSpPr/>
          <p:nvPr/>
        </p:nvCxnSpPr>
        <p:spPr>
          <a:xfrm>
            <a:off x="6732240" y="4653136"/>
            <a:ext cx="144016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16" name="Group 3535">
            <a:extLst>
              <a:ext uri="{FF2B5EF4-FFF2-40B4-BE49-F238E27FC236}">
                <a16:creationId xmlns:a16="http://schemas.microsoft.com/office/drawing/2014/main" id="{C097F636-50A1-42C2-B715-01F71EE09C76}"/>
              </a:ext>
            </a:extLst>
          </p:cNvPr>
          <p:cNvGrpSpPr/>
          <p:nvPr/>
        </p:nvGrpSpPr>
        <p:grpSpPr>
          <a:xfrm>
            <a:off x="6948264" y="4437112"/>
            <a:ext cx="216024" cy="432048"/>
            <a:chOff x="4499992" y="1988840"/>
            <a:chExt cx="216024" cy="432048"/>
          </a:xfrm>
          <a:solidFill>
            <a:schemeClr val="bg1">
              <a:lumMod val="65000"/>
            </a:schemeClr>
          </a:solidFill>
        </p:grpSpPr>
        <p:sp>
          <p:nvSpPr>
            <p:cNvPr id="117" name="Flowchart: Direct Access Storage 116">
              <a:extLst>
                <a:ext uri="{FF2B5EF4-FFF2-40B4-BE49-F238E27FC236}">
                  <a16:creationId xmlns:a16="http://schemas.microsoft.com/office/drawing/2014/main" id="{A9F21430-A409-4616-A0F2-550A65C9FE7F}"/>
                </a:ext>
              </a:extLst>
            </p:cNvPr>
            <p:cNvSpPr/>
            <p:nvPr/>
          </p:nvSpPr>
          <p:spPr>
            <a:xfrm rot="16200000">
              <a:off x="4391980" y="2096852"/>
              <a:ext cx="432048" cy="216024"/>
            </a:xfrm>
            <a:prstGeom prst="flowChartMagneticDrum">
              <a:avLst/>
            </a:prstGeom>
            <a:grpFill/>
            <a:ln>
              <a:solidFill>
                <a:srgbClr val="4D4D4D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" name="Oval 117">
              <a:extLst>
                <a:ext uri="{FF2B5EF4-FFF2-40B4-BE49-F238E27FC236}">
                  <a16:creationId xmlns:a16="http://schemas.microsoft.com/office/drawing/2014/main" id="{823D9A20-C4C6-4CFF-8FC3-87FEF4E86585}"/>
                </a:ext>
              </a:extLst>
            </p:cNvPr>
            <p:cNvSpPr/>
            <p:nvPr/>
          </p:nvSpPr>
          <p:spPr>
            <a:xfrm>
              <a:off x="4499992" y="1988840"/>
              <a:ext cx="216024" cy="144016"/>
            </a:xfrm>
            <a:prstGeom prst="ellipse">
              <a:avLst/>
            </a:prstGeom>
            <a:grpFill/>
            <a:ln>
              <a:solidFill>
                <a:srgbClr val="4D4D4D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9" name="Flowchart: Direct Access Storage 118">
            <a:extLst>
              <a:ext uri="{FF2B5EF4-FFF2-40B4-BE49-F238E27FC236}">
                <a16:creationId xmlns:a16="http://schemas.microsoft.com/office/drawing/2014/main" id="{8B02781D-458E-4790-94FB-5B8B76B66610}"/>
              </a:ext>
            </a:extLst>
          </p:cNvPr>
          <p:cNvSpPr/>
          <p:nvPr/>
        </p:nvSpPr>
        <p:spPr>
          <a:xfrm rot="16200000">
            <a:off x="7200292" y="4545124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Flowchart: Direct Access Storage 119">
            <a:extLst>
              <a:ext uri="{FF2B5EF4-FFF2-40B4-BE49-F238E27FC236}">
                <a16:creationId xmlns:a16="http://schemas.microsoft.com/office/drawing/2014/main" id="{5F54E0E6-BEBE-455E-A157-B4FC15BEAD0E}"/>
              </a:ext>
            </a:extLst>
          </p:cNvPr>
          <p:cNvSpPr/>
          <p:nvPr/>
        </p:nvSpPr>
        <p:spPr>
          <a:xfrm rot="16200000">
            <a:off x="7488324" y="4545124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Flowchart: Direct Access Storage 120">
            <a:extLst>
              <a:ext uri="{FF2B5EF4-FFF2-40B4-BE49-F238E27FC236}">
                <a16:creationId xmlns:a16="http://schemas.microsoft.com/office/drawing/2014/main" id="{542D0332-12A1-4852-BAF0-E9E2EB576B54}"/>
              </a:ext>
            </a:extLst>
          </p:cNvPr>
          <p:cNvSpPr/>
          <p:nvPr/>
        </p:nvSpPr>
        <p:spPr>
          <a:xfrm rot="16200000">
            <a:off x="7776356" y="4545124"/>
            <a:ext cx="432048" cy="216024"/>
          </a:xfrm>
          <a:prstGeom prst="flowChartMagneticDrum">
            <a:avLst/>
          </a:prstGeom>
          <a:solidFill>
            <a:srgbClr val="92D050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Flowchart: Direct Access Storage 121">
            <a:extLst>
              <a:ext uri="{FF2B5EF4-FFF2-40B4-BE49-F238E27FC236}">
                <a16:creationId xmlns:a16="http://schemas.microsoft.com/office/drawing/2014/main" id="{9F9E7539-ED6D-47DD-A463-508CEBBF34CB}"/>
              </a:ext>
            </a:extLst>
          </p:cNvPr>
          <p:cNvSpPr/>
          <p:nvPr/>
        </p:nvSpPr>
        <p:spPr>
          <a:xfrm rot="16200000">
            <a:off x="8064388" y="4545124"/>
            <a:ext cx="432048" cy="216024"/>
          </a:xfrm>
          <a:prstGeom prst="flowChartMagneticDrum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Down Arrow 3550">
            <a:extLst>
              <a:ext uri="{FF2B5EF4-FFF2-40B4-BE49-F238E27FC236}">
                <a16:creationId xmlns:a16="http://schemas.microsoft.com/office/drawing/2014/main" id="{3FBCA128-892F-4AD6-90A5-4FA834105701}"/>
              </a:ext>
            </a:extLst>
          </p:cNvPr>
          <p:cNvSpPr/>
          <p:nvPr/>
        </p:nvSpPr>
        <p:spPr>
          <a:xfrm>
            <a:off x="8244408" y="4005064"/>
            <a:ext cx="144016" cy="360040"/>
          </a:xfrm>
          <a:prstGeom prst="downArrow">
            <a:avLst/>
          </a:prstGeom>
          <a:solidFill>
            <a:schemeClr val="bg1"/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279D4537-8267-4762-AE00-E9B68B9F83A6}"/>
              </a:ext>
            </a:extLst>
          </p:cNvPr>
          <p:cNvSpPr txBox="1"/>
          <p:nvPr/>
        </p:nvSpPr>
        <p:spPr>
          <a:xfrm>
            <a:off x="7956376" y="3687146"/>
            <a:ext cx="720080" cy="21602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Final</a:t>
            </a:r>
          </a:p>
          <a:p>
            <a:pPr marL="0" marR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Injection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D9969612-BF95-43C0-B369-DCAD992C2683}"/>
              </a:ext>
            </a:extLst>
          </p:cNvPr>
          <p:cNvCxnSpPr/>
          <p:nvPr/>
        </p:nvCxnSpPr>
        <p:spPr>
          <a:xfrm flipV="1">
            <a:off x="6055593" y="4923590"/>
            <a:ext cx="0" cy="216024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E2393389-47B1-4E8C-BFBD-5ECBDB24820D}"/>
              </a:ext>
            </a:extLst>
          </p:cNvPr>
          <p:cNvSpPr txBox="1"/>
          <p:nvPr/>
        </p:nvSpPr>
        <p:spPr>
          <a:xfrm>
            <a:off x="5782419" y="5211622"/>
            <a:ext cx="648072" cy="21602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rtlCol="0" anchor="ctr">
            <a:noAutofit/>
          </a:bodyPr>
          <a:lstStyle/>
          <a:p>
            <a:pPr marL="0" marR="0" indent="0" algn="ctr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Process Blank</a:t>
            </a:r>
          </a:p>
        </p:txBody>
      </p:sp>
      <p:sp>
        <p:nvSpPr>
          <p:cNvPr id="127" name="Rounded Rectangle 3399">
            <a:extLst>
              <a:ext uri="{FF2B5EF4-FFF2-40B4-BE49-F238E27FC236}">
                <a16:creationId xmlns:a16="http://schemas.microsoft.com/office/drawing/2014/main" id="{ADCDE3F8-DA1D-4CA5-88B1-44EFC2808CBA}"/>
              </a:ext>
            </a:extLst>
          </p:cNvPr>
          <p:cNvSpPr/>
          <p:nvPr/>
        </p:nvSpPr>
        <p:spPr>
          <a:xfrm>
            <a:off x="683568" y="1578652"/>
            <a:ext cx="2016224" cy="1152128"/>
          </a:xfrm>
          <a:prstGeom prst="roundRect">
            <a:avLst>
              <a:gd name="adj" fmla="val 8133"/>
            </a:avLst>
          </a:prstGeom>
          <a:solidFill>
            <a:schemeClr val="accent6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30% of samples dedicated to quality control</a:t>
            </a:r>
          </a:p>
        </p:txBody>
      </p:sp>
    </p:spTree>
  </p:cSld>
  <p:clrMapOvr>
    <a:masterClrMapping/>
  </p:clrMapOvr>
  <p:transition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R="0" lvl="0" algn="l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noProof="0" dirty="0">
                <a:latin typeface="+mj-lt"/>
              </a:rPr>
              <a:t>Platform QC and Metabolite Summary</a:t>
            </a:r>
            <a:endParaRPr kumimoji="0" lang="en-US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j-lt"/>
            </a:endParaRPr>
          </a:p>
        </p:txBody>
      </p:sp>
      <p:sp>
        <p:nvSpPr>
          <p:cNvPr id="15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6</a:t>
            </a:fld>
            <a:endParaRPr lang="en-US" kern="0" dirty="0"/>
          </a:p>
        </p:txBody>
      </p:sp>
      <p:sp>
        <p:nvSpPr>
          <p:cNvPr id="8" name="Text Box 45"/>
          <p:cNvSpPr txBox="1">
            <a:spLocks noChangeArrowheads="1"/>
          </p:cNvSpPr>
          <p:nvPr/>
        </p:nvSpPr>
        <p:spPr bwMode="auto">
          <a:xfrm>
            <a:off x="990600" y="3188873"/>
            <a:ext cx="8153400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defTabSz="457200" fontAlgn="auto">
              <a:spcAft>
                <a:spcPts val="0"/>
              </a:spcAft>
            </a:pPr>
            <a:r>
              <a:rPr lang="en-US" sz="1050" baseline="0" dirty="0">
                <a:solidFill>
                  <a:srgbClr val="4F9FCC"/>
                </a:solidFill>
                <a:latin typeface="+mj-lt"/>
                <a:ea typeface="+mj-ea"/>
                <a:cs typeface="+mj-cs"/>
              </a:rPr>
              <a:t>Internal Standards</a:t>
            </a:r>
            <a:r>
              <a:rPr lang="en-US" sz="1050" baseline="0" dirty="0">
                <a:solidFill>
                  <a:srgbClr val="0000FF"/>
                </a:solidFill>
                <a:latin typeface="+mj-lt"/>
                <a:ea typeface="+mj-ea"/>
                <a:cs typeface="+mj-cs"/>
              </a:rPr>
              <a:t>: </a:t>
            </a:r>
            <a:r>
              <a:rPr lang="en-US" sz="1050" baseline="0" dirty="0">
                <a:solidFill>
                  <a:sysClr val="windowText" lastClr="000000"/>
                </a:solidFill>
                <a:latin typeface="+mj-lt"/>
                <a:ea typeface="+mj-ea"/>
                <a:cs typeface="+mj-cs"/>
              </a:rPr>
              <a:t>standards spiked into each of the study samples prior to injection into the MS instrument</a:t>
            </a:r>
          </a:p>
          <a:p>
            <a:pPr defTabSz="457200" fontAlgn="auto">
              <a:spcAft>
                <a:spcPts val="0"/>
              </a:spcAft>
            </a:pPr>
            <a:r>
              <a:rPr lang="en-US" sz="1050" baseline="0" dirty="0">
                <a:solidFill>
                  <a:srgbClr val="4F9FCC"/>
                </a:solidFill>
                <a:latin typeface="+mj-lt"/>
                <a:ea typeface="+mj-ea"/>
                <a:cs typeface="+mj-cs"/>
              </a:rPr>
              <a:t>Endogenous Metabolites</a:t>
            </a:r>
            <a:r>
              <a:rPr lang="en-US" sz="1050" baseline="0" dirty="0">
                <a:solidFill>
                  <a:srgbClr val="0000FF"/>
                </a:solidFill>
                <a:latin typeface="+mj-lt"/>
                <a:ea typeface="+mj-ea"/>
                <a:cs typeface="+mj-cs"/>
              </a:rPr>
              <a:t>: </a:t>
            </a:r>
            <a:r>
              <a:rPr lang="en-US" sz="1050" baseline="0" dirty="0">
                <a:solidFill>
                  <a:sysClr val="windowText" lastClr="000000"/>
                </a:solidFill>
                <a:latin typeface="+mj-lt"/>
                <a:ea typeface="+mj-ea"/>
                <a:cs typeface="+mj-cs"/>
              </a:rPr>
              <a:t>from CMTRX samples – technical replicates created from a small portion of experimental samples</a:t>
            </a:r>
          </a:p>
        </p:txBody>
      </p:sp>
      <p:sp>
        <p:nvSpPr>
          <p:cNvPr id="10" name="Text Box 23"/>
          <p:cNvSpPr txBox="1">
            <a:spLocks noChangeArrowheads="1"/>
          </p:cNvSpPr>
          <p:nvPr/>
        </p:nvSpPr>
        <p:spPr bwMode="auto">
          <a:xfrm>
            <a:off x="2816899" y="1081984"/>
            <a:ext cx="334437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 fontAlgn="auto">
              <a:spcAft>
                <a:spcPts val="0"/>
              </a:spcAft>
            </a:pPr>
            <a:r>
              <a:rPr lang="en-US" sz="1600" b="1" cap="all" baseline="0" dirty="0">
                <a:solidFill>
                  <a:srgbClr val="4F9FCC"/>
                </a:solidFill>
                <a:latin typeface="+mj-lt"/>
                <a:ea typeface="+mj-ea"/>
                <a:cs typeface="+mj-cs"/>
              </a:rPr>
              <a:t>Data Quality and Precision</a:t>
            </a:r>
          </a:p>
        </p:txBody>
      </p:sp>
      <p:sp>
        <p:nvSpPr>
          <p:cNvPr id="11" name="Text Box 69"/>
          <p:cNvSpPr txBox="1">
            <a:spLocks noChangeArrowheads="1"/>
          </p:cNvSpPr>
          <p:nvPr/>
        </p:nvSpPr>
        <p:spPr bwMode="auto">
          <a:xfrm>
            <a:off x="450488" y="3733905"/>
            <a:ext cx="80772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400" b="1" i="1" baseline="0" dirty="0">
                <a:latin typeface="+mj-lt"/>
              </a:rPr>
              <a:t>These data are within Metabolon’s QC specifications.</a:t>
            </a:r>
          </a:p>
        </p:txBody>
      </p:sp>
      <p:sp>
        <p:nvSpPr>
          <p:cNvPr id="13" name="Text Box 23"/>
          <p:cNvSpPr txBox="1">
            <a:spLocks noChangeArrowheads="1"/>
          </p:cNvSpPr>
          <p:nvPr/>
        </p:nvSpPr>
        <p:spPr bwMode="auto">
          <a:xfrm>
            <a:off x="3193243" y="4415000"/>
            <a:ext cx="293618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 fontAlgn="auto">
              <a:spcAft>
                <a:spcPts val="0"/>
              </a:spcAft>
            </a:pPr>
            <a:r>
              <a:rPr lang="en-US" sz="1600" b="1" cap="all" baseline="0" dirty="0">
                <a:solidFill>
                  <a:srgbClr val="4F9FCC"/>
                </a:solidFill>
                <a:latin typeface="+mj-lt"/>
                <a:ea typeface="+mj-ea"/>
                <a:cs typeface="+mj-cs"/>
              </a:rPr>
              <a:t>Number of Metabolites</a:t>
            </a:r>
          </a:p>
        </p:txBody>
      </p:sp>
      <p:graphicFrame>
        <p:nvGraphicFramePr>
          <p:cNvPr id="9" name="Table 8"/>
          <p:cNvGraphicFramePr>
            <a:graphicFrameLocks noGrp="1"/>
          </p:cNvGraphicFramePr>
          <p:nvPr/>
        </p:nvGraphicFramePr>
        <p:xfrm>
          <a:off x="2237777" y="4767356"/>
          <a:ext cx="4502620" cy="1432560"/>
        </p:xfrm>
        <a:graphic>
          <a:graphicData uri="http://schemas.openxmlformats.org/drawingml/2006/table">
            <a:tbl>
              <a:tblPr firstRow="1" bandRow="1">
                <a:tableStyleId>{5A111915-BE36-4E01-A7E5-04B1672EAD32}</a:tableStyleId>
              </a:tblPr>
              <a:tblGrid>
                <a:gridCol w="18458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52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957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95775">
                  <a:extLst>
                    <a:ext uri="{9D8B030D-6E8A-4147-A177-3AD203B41FA5}">
                      <a16:colId xmlns:a16="http://schemas.microsoft.com/office/drawing/2014/main" val="3682997556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etabolite Classific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iver 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ung 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eart 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400" b="1" i="1" dirty="0">
                          <a:latin typeface="Arial" pitchFamily="34" charset="0"/>
                          <a:cs typeface="Arial" pitchFamily="34" charset="0"/>
                        </a:rPr>
                        <a:t>Tot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Arial" pitchFamily="34" charset="0"/>
                          <a:cs typeface="Arial" pitchFamily="34" charset="0"/>
                        </a:rPr>
                        <a:t>11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Arial" pitchFamily="34" charset="0"/>
                          <a:cs typeface="Arial" pitchFamily="34" charset="0"/>
                        </a:rPr>
                        <a:t>93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latin typeface="Arial" pitchFamily="34" charset="0"/>
                          <a:cs typeface="Arial" pitchFamily="34" charset="0"/>
                        </a:rPr>
                        <a:t>73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400" i="0" dirty="0">
                          <a:latin typeface="Arial" pitchFamily="34" charset="0"/>
                          <a:cs typeface="Arial" pitchFamily="34" charset="0"/>
                        </a:rPr>
                        <a:t>Named/Identifie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dirty="0">
                          <a:latin typeface="Arial" pitchFamily="34" charset="0"/>
                          <a:cs typeface="Arial" pitchFamily="34" charset="0"/>
                        </a:rPr>
                        <a:t>97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dirty="0">
                          <a:latin typeface="Arial" pitchFamily="34" charset="0"/>
                          <a:cs typeface="Arial" pitchFamily="34" charset="0"/>
                        </a:rPr>
                        <a:t>85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dirty="0">
                          <a:latin typeface="Arial" pitchFamily="34" charset="0"/>
                          <a:cs typeface="Arial" pitchFamily="34" charset="0"/>
                        </a:rPr>
                        <a:t>67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itchFamily="34" charset="0"/>
                          <a:cs typeface="Arial" pitchFamily="34" charset="0"/>
                        </a:rPr>
                        <a:t>Unname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dirty="0">
                          <a:latin typeface="Arial" pitchFamily="34" charset="0"/>
                          <a:cs typeface="Arial" pitchFamily="34" charset="0"/>
                        </a:rPr>
                        <a:t>12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dirty="0">
                          <a:latin typeface="Arial" pitchFamily="34" charset="0"/>
                          <a:cs typeface="Arial" pitchFamily="34" charset="0"/>
                        </a:rPr>
                        <a:t>8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dirty="0">
                          <a:latin typeface="Arial" pitchFamily="34" charset="0"/>
                          <a:cs typeface="Arial" pitchFamily="34" charset="0"/>
                        </a:rPr>
                        <a:t>5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/>
        </p:nvGraphicFramePr>
        <p:xfrm>
          <a:off x="1619358" y="1420538"/>
          <a:ext cx="5739461" cy="1368152"/>
        </p:xfrm>
        <a:graphic>
          <a:graphicData uri="http://schemas.openxmlformats.org/drawingml/2006/table">
            <a:tbl>
              <a:tblPr firstRow="1" bandRow="1">
                <a:tableStyleId>{5A111915-BE36-4E01-A7E5-04B1672EAD32}</a:tableStyleId>
              </a:tblPr>
              <a:tblGrid>
                <a:gridCol w="23290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770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134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81348">
                  <a:extLst>
                    <a:ext uri="{9D8B030D-6E8A-4147-A177-3AD203B41FA5}">
                      <a16:colId xmlns:a16="http://schemas.microsoft.com/office/drawing/2014/main" val="2135142472"/>
                    </a:ext>
                  </a:extLst>
                </a:gridCol>
              </a:tblGrid>
              <a:tr h="289479">
                <a:tc rowSpan="2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Quality Control Sample (Matrix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edian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RSD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947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iver 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ung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eart 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9479">
                <a:tc>
                  <a:txBody>
                    <a:bodyPr/>
                    <a:lstStyle/>
                    <a:p>
                      <a:pPr algn="ctr"/>
                      <a:r>
                        <a:rPr lang="en-US" sz="1400" i="0" dirty="0">
                          <a:latin typeface="Arial" pitchFamily="34" charset="0"/>
                          <a:cs typeface="Arial" pitchFamily="34" charset="0"/>
                        </a:rPr>
                        <a:t>Internal Standar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itchFamily="34" charset="0"/>
                          <a:cs typeface="Arial" pitchFamily="34" charset="0"/>
                        </a:rPr>
                        <a:t>4%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latin typeface="Arial" pitchFamily="34" charset="0"/>
                          <a:cs typeface="Arial" pitchFamily="34" charset="0"/>
                        </a:rPr>
                        <a:t>3%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itchFamily="34" charset="0"/>
                          <a:cs typeface="Arial" pitchFamily="34" charset="0"/>
                        </a:rPr>
                        <a:t>4%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53752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itchFamily="34" charset="0"/>
                          <a:cs typeface="Arial" pitchFamily="34" charset="0"/>
                        </a:rPr>
                        <a:t>Endogenous Metabolit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itchFamily="34" charset="0"/>
                          <a:cs typeface="Arial" pitchFamily="34" charset="0"/>
                        </a:rPr>
                        <a:t>6%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latin typeface="Arial" pitchFamily="34" charset="0"/>
                          <a:cs typeface="Arial" pitchFamily="34" charset="0"/>
                        </a:rPr>
                        <a:t>6%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itchFamily="34" charset="0"/>
                          <a:cs typeface="Arial" pitchFamily="34" charset="0"/>
                        </a:rPr>
                        <a:t>7%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</p:cSld>
  <p:clrMapOvr>
    <a:masterClrMapping/>
  </p:clrMapOvr>
  <p:transition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R="0" lvl="0" algn="l" defTabSz="4572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noProof="0" dirty="0">
                <a:latin typeface="Montserrat" panose="00000500000000000000" pitchFamily="2" charset="0"/>
              </a:rPr>
              <a:t>Statistical Analyses </a:t>
            </a:r>
            <a:endParaRPr kumimoji="0" lang="en-US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Montserrat" panose="00000500000000000000" pitchFamily="2" charset="0"/>
            </a:endParaRPr>
          </a:p>
        </p:txBody>
      </p:sp>
      <p:sp>
        <p:nvSpPr>
          <p:cNvPr id="8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6C792B38-A63E-4947-B2D7-C2DB94F3F465}" type="slidenum">
              <a:rPr lang="en-US" kern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7</a:t>
            </a:fld>
            <a:endParaRPr lang="en-US" kern="0" dirty="0"/>
          </a:p>
        </p:txBody>
      </p:sp>
      <p:sp>
        <p:nvSpPr>
          <p:cNvPr id="10" name="Text Box 55"/>
          <p:cNvSpPr txBox="1">
            <a:spLocks noChangeArrowheads="1"/>
          </p:cNvSpPr>
          <p:nvPr/>
        </p:nvSpPr>
        <p:spPr bwMode="auto">
          <a:xfrm>
            <a:off x="395536" y="980728"/>
            <a:ext cx="8458200" cy="15081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457200" fontAlgn="auto">
              <a:spcAft>
                <a:spcPts val="0"/>
              </a:spcAft>
              <a:buFont typeface="Wingdings" pitchFamily="2" charset="2"/>
              <a:buChar char="§"/>
            </a:pPr>
            <a:r>
              <a:rPr lang="en-US" baseline="0" dirty="0">
                <a:solidFill>
                  <a:sysClr val="windowText" lastClr="000000"/>
                </a:solidFill>
                <a:latin typeface="+mj-lt"/>
                <a:ea typeface="+mj-ea"/>
                <a:cs typeface="+mj-cs"/>
              </a:rPr>
              <a:t> </a:t>
            </a:r>
            <a:r>
              <a:rPr lang="en-US" baseline="0" dirty="0">
                <a:solidFill>
                  <a:srgbClr val="4F9FCC"/>
                </a:solidFill>
                <a:latin typeface="+mj-lt"/>
                <a:ea typeface="+mj-ea"/>
                <a:cs typeface="+mj-cs"/>
              </a:rPr>
              <a:t>Welch’s two sample t-test </a:t>
            </a:r>
            <a:r>
              <a:rPr lang="en-US" baseline="0" dirty="0">
                <a:solidFill>
                  <a:sysClr val="windowText" lastClr="000000"/>
                </a:solidFill>
                <a:latin typeface="+mj-lt"/>
                <a:ea typeface="+mj-ea"/>
                <a:cs typeface="+mj-cs"/>
              </a:rPr>
              <a:t>was used to determine whether the means of two populations were different.</a:t>
            </a:r>
          </a:p>
          <a:p>
            <a:pPr defTabSz="457200" fontAlgn="auto">
              <a:spcAft>
                <a:spcPts val="0"/>
              </a:spcAft>
            </a:pPr>
            <a:endParaRPr lang="en-US" sz="1050" baseline="0" dirty="0">
              <a:solidFill>
                <a:sysClr val="windowText" lastClr="000000"/>
              </a:solidFill>
              <a:latin typeface="+mj-lt"/>
              <a:ea typeface="+mj-ea"/>
              <a:cs typeface="+mj-cs"/>
            </a:endParaRPr>
          </a:p>
          <a:p>
            <a:pPr defTabSz="457200" fontAlgn="auto">
              <a:spcAft>
                <a:spcPts val="0"/>
              </a:spcAft>
            </a:pPr>
            <a:r>
              <a:rPr lang="en-US" sz="1400" baseline="0" dirty="0">
                <a:solidFill>
                  <a:sysClr val="windowText" lastClr="000000"/>
                </a:solidFill>
                <a:latin typeface="+mj-lt"/>
                <a:ea typeface="+mj-ea"/>
                <a:cs typeface="+mj-cs"/>
              </a:rPr>
              <a:t>        </a:t>
            </a:r>
            <a:r>
              <a:rPr lang="en-US" sz="1400" baseline="0" dirty="0">
                <a:solidFill>
                  <a:schemeClr val="bg1">
                    <a:lumMod val="10000"/>
                  </a:schemeClr>
                </a:solidFill>
                <a:latin typeface="+mj-lt"/>
                <a:ea typeface="+mj-ea"/>
                <a:cs typeface="+mj-cs"/>
              </a:rPr>
              <a:t>p-value: evidence that the means are different (smaller is better)</a:t>
            </a:r>
          </a:p>
          <a:p>
            <a:pPr defTabSz="457200" fontAlgn="auto">
              <a:spcAft>
                <a:spcPts val="0"/>
              </a:spcAft>
              <a:buFont typeface="Wingdings" pitchFamily="2" charset="2"/>
              <a:buNone/>
            </a:pPr>
            <a:r>
              <a:rPr lang="en-US" sz="1400" baseline="0" dirty="0">
                <a:solidFill>
                  <a:schemeClr val="bg1">
                    <a:lumMod val="10000"/>
                  </a:schemeClr>
                </a:solidFill>
                <a:latin typeface="+mj-lt"/>
                <a:ea typeface="+mj-ea"/>
                <a:cs typeface="+mj-cs"/>
              </a:rPr>
              <a:t>        q-value: estimate of the false discovery rate (smaller is better)</a:t>
            </a:r>
          </a:p>
          <a:p>
            <a:pPr defTabSz="457200" fontAlgn="auto">
              <a:spcAft>
                <a:spcPts val="0"/>
              </a:spcAft>
              <a:buFont typeface="Wingdings" pitchFamily="2" charset="2"/>
              <a:buNone/>
            </a:pPr>
            <a:r>
              <a:rPr lang="en-US" sz="1400" baseline="0" dirty="0">
                <a:solidFill>
                  <a:schemeClr val="bg1">
                    <a:lumMod val="10000"/>
                  </a:schemeClr>
                </a:solidFill>
                <a:latin typeface="+mj-lt"/>
                <a:ea typeface="+mj-ea"/>
                <a:cs typeface="+mj-cs"/>
              </a:rPr>
              <a:t>        p≤0.05 was taken as significant</a:t>
            </a:r>
          </a:p>
        </p:txBody>
      </p:sp>
      <p:sp>
        <p:nvSpPr>
          <p:cNvPr id="13" name="Text Box 23"/>
          <p:cNvSpPr txBox="1">
            <a:spLocks noChangeArrowheads="1"/>
          </p:cNvSpPr>
          <p:nvPr/>
        </p:nvSpPr>
        <p:spPr bwMode="auto">
          <a:xfrm>
            <a:off x="3251082" y="2514600"/>
            <a:ext cx="246330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 fontAlgn="auto">
              <a:spcAft>
                <a:spcPts val="0"/>
              </a:spcAft>
            </a:pPr>
            <a:r>
              <a:rPr lang="en-US" sz="1600" b="1" baseline="0" dirty="0">
                <a:solidFill>
                  <a:srgbClr val="4F9FCC"/>
                </a:solidFill>
                <a:latin typeface="+mj-lt"/>
                <a:ea typeface="+mj-ea"/>
                <a:cs typeface="+mj-cs"/>
              </a:rPr>
              <a:t>Sample Statistics Table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b="28945"/>
          <a:stretch/>
        </p:blipFill>
        <p:spPr>
          <a:xfrm>
            <a:off x="899592" y="4739862"/>
            <a:ext cx="7344816" cy="100935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6965715-8290-4CA6-B54A-75E2E88E4AD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03423" y="2821799"/>
            <a:ext cx="6537155" cy="1886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6282512"/>
      </p:ext>
    </p:extLst>
  </p:cSld>
  <p:clrMapOvr>
    <a:masterClrMapping/>
  </p:clrMapOvr>
  <p:transition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977D811-AA6C-4288-B3A8-90AE8824DB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4094" y="1329697"/>
            <a:ext cx="4028610" cy="3972696"/>
          </a:xfrm>
          <a:prstGeom prst="rect">
            <a:avLst/>
          </a:prstGeom>
        </p:spPr>
      </p:pic>
      <p:sp>
        <p:nvSpPr>
          <p:cNvPr id="41" name="Title 40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3000" dirty="0"/>
              <a:t>Data Display - Liver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8</a:t>
            </a:fld>
            <a:endParaRPr lang="en-US"/>
          </a:p>
        </p:txBody>
      </p:sp>
      <p:grpSp>
        <p:nvGrpSpPr>
          <p:cNvPr id="24" name="Group 32">
            <a:extLst>
              <a:ext uri="{FF2B5EF4-FFF2-40B4-BE49-F238E27FC236}">
                <a16:creationId xmlns:a16="http://schemas.microsoft.com/office/drawing/2014/main" id="{1B8303C4-4EFA-4355-B7B0-63EAEBB7BC2F}"/>
              </a:ext>
            </a:extLst>
          </p:cNvPr>
          <p:cNvGrpSpPr/>
          <p:nvPr/>
        </p:nvGrpSpPr>
        <p:grpSpPr>
          <a:xfrm>
            <a:off x="418091" y="1295400"/>
            <a:ext cx="3834283" cy="4602235"/>
            <a:chOff x="867565" y="1290317"/>
            <a:chExt cx="5293800" cy="4602235"/>
          </a:xfrm>
        </p:grpSpPr>
        <p:sp>
          <p:nvSpPr>
            <p:cNvPr id="25" name="Text Box 6">
              <a:extLst>
                <a:ext uri="{FF2B5EF4-FFF2-40B4-BE49-F238E27FC236}">
                  <a16:creationId xmlns:a16="http://schemas.microsoft.com/office/drawing/2014/main" id="{844780FB-B234-4414-B966-6BA221FDB7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47624" y="1290317"/>
              <a:ext cx="2674058" cy="369332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b="1" i="1" dirty="0">
                  <a:solidFill>
                    <a:srgbClr val="4D4D4D"/>
                  </a:solidFill>
                  <a:cs typeface="Arial" pitchFamily="34" charset="0"/>
                </a:rPr>
                <a:t>Metabolite Name</a:t>
              </a:r>
              <a:endParaRPr lang="en-US" b="1" i="1" dirty="0">
                <a:solidFill>
                  <a:srgbClr val="4D4D4D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 Box 4">
              <a:extLst>
                <a:ext uri="{FF2B5EF4-FFF2-40B4-BE49-F238E27FC236}">
                  <a16:creationId xmlns:a16="http://schemas.microsoft.com/office/drawing/2014/main" id="{D1C7A9BA-6D1C-41DF-8F9D-2C795014D634}"/>
                </a:ext>
              </a:extLst>
            </p:cNvPr>
            <p:cNvSpPr txBox="1">
              <a:spLocks noChangeAspect="1" noChangeArrowheads="1"/>
            </p:cNvSpPr>
            <p:nvPr/>
          </p:nvSpPr>
          <p:spPr bwMode="auto">
            <a:xfrm>
              <a:off x="867565" y="2495793"/>
              <a:ext cx="461666" cy="15899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vert270" wrap="none">
              <a:spAutoFit/>
            </a:bodyPr>
            <a:lstStyle/>
            <a:p>
              <a:pPr algn="ctr"/>
              <a:r>
                <a:rPr lang="en-US" b="1" i="1" dirty="0">
                  <a:solidFill>
                    <a:srgbClr val="4D4D4D"/>
                  </a:solidFill>
                  <a:cs typeface="Arial" pitchFamily="34" charset="0"/>
                </a:rPr>
                <a:t>Scaled Intensity</a:t>
              </a:r>
              <a:endParaRPr lang="en-US" sz="1400" b="1" i="1" dirty="0">
                <a:solidFill>
                  <a:srgbClr val="4D4D4D"/>
                </a:solidFill>
                <a:cs typeface="Arial" pitchFamily="34" charset="0"/>
              </a:endParaRPr>
            </a:p>
          </p:txBody>
        </p:sp>
        <p:sp>
          <p:nvSpPr>
            <p:cNvPr id="27" name="Text Box 4">
              <a:extLst>
                <a:ext uri="{FF2B5EF4-FFF2-40B4-BE49-F238E27FC236}">
                  <a16:creationId xmlns:a16="http://schemas.microsoft.com/office/drawing/2014/main" id="{6234519A-C378-40C4-A8C7-5A3A23042E43}"/>
                </a:ext>
              </a:extLst>
            </p:cNvPr>
            <p:cNvSpPr txBox="1">
              <a:spLocks noChangeAspect="1" noChangeArrowheads="1"/>
            </p:cNvSpPr>
            <p:nvPr/>
          </p:nvSpPr>
          <p:spPr bwMode="auto">
            <a:xfrm>
              <a:off x="3207941" y="5523220"/>
              <a:ext cx="2953424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b="1" i="1" dirty="0">
                  <a:solidFill>
                    <a:srgbClr val="4D4D4D"/>
                  </a:solidFill>
                  <a:cs typeface="Arial" pitchFamily="34" charset="0"/>
                </a:rPr>
                <a:t>Group</a:t>
              </a:r>
              <a:endParaRPr lang="en-US" sz="1400" b="1" i="1" dirty="0">
                <a:solidFill>
                  <a:srgbClr val="4D4D4D"/>
                </a:solidFill>
                <a:cs typeface="Arial" pitchFamily="34" charset="0"/>
              </a:endParaRP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B67C08E3-46E8-4744-A238-60072230F567}"/>
              </a:ext>
            </a:extLst>
          </p:cNvPr>
          <p:cNvGrpSpPr/>
          <p:nvPr/>
        </p:nvGrpSpPr>
        <p:grpSpPr>
          <a:xfrm>
            <a:off x="5410200" y="1295400"/>
            <a:ext cx="2981326" cy="3950550"/>
            <a:chOff x="5410200" y="1295400"/>
            <a:chExt cx="2981326" cy="3950550"/>
          </a:xfrm>
        </p:grpSpPr>
        <p:grpSp>
          <p:nvGrpSpPr>
            <p:cNvPr id="29" name="Group 32">
              <a:extLst>
                <a:ext uri="{FF2B5EF4-FFF2-40B4-BE49-F238E27FC236}">
                  <a16:creationId xmlns:a16="http://schemas.microsoft.com/office/drawing/2014/main" id="{702A7F57-67E4-470D-8820-FB619734C1E3}"/>
                </a:ext>
              </a:extLst>
            </p:cNvPr>
            <p:cNvGrpSpPr/>
            <p:nvPr/>
          </p:nvGrpSpPr>
          <p:grpSpPr>
            <a:xfrm>
              <a:off x="5410200" y="1295400"/>
              <a:ext cx="2981326" cy="3950550"/>
              <a:chOff x="5811343" y="-464020"/>
              <a:chExt cx="2499687" cy="3950550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9B07D999-3F6A-4210-B245-AA0190FC9EA8}"/>
                  </a:ext>
                </a:extLst>
              </p:cNvPr>
              <p:cNvSpPr/>
              <p:nvPr/>
            </p:nvSpPr>
            <p:spPr>
              <a:xfrm>
                <a:off x="5811343" y="-120630"/>
                <a:ext cx="2499687" cy="360716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Text Box 6">
                <a:extLst>
                  <a:ext uri="{FF2B5EF4-FFF2-40B4-BE49-F238E27FC236}">
                    <a16:creationId xmlns:a16="http://schemas.microsoft.com/office/drawing/2014/main" id="{F84C0FE5-7D92-4FFD-8CA0-2D24DD03219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31295" y="-464020"/>
                <a:ext cx="1732777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b="1" i="1" dirty="0">
                    <a:solidFill>
                      <a:srgbClr val="4D4D4D"/>
                    </a:solidFill>
                    <a:cs typeface="Arial" pitchFamily="34" charset="0"/>
                  </a:rPr>
                  <a:t>Box Plot Legend</a:t>
                </a:r>
              </a:p>
            </p:txBody>
          </p:sp>
        </p:grpSp>
        <p:pic>
          <p:nvPicPr>
            <p:cNvPr id="30" name="Picture 2">
              <a:extLst>
                <a:ext uri="{FF2B5EF4-FFF2-40B4-BE49-F238E27FC236}">
                  <a16:creationId xmlns:a16="http://schemas.microsoft.com/office/drawing/2014/main" id="{800030F6-9499-430D-B779-18D137A9937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068080" y="1744984"/>
              <a:ext cx="1282706" cy="33610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33" name="Rectangle 112">
            <a:extLst>
              <a:ext uri="{FF2B5EF4-FFF2-40B4-BE49-F238E27FC236}">
                <a16:creationId xmlns:a16="http://schemas.microsoft.com/office/drawing/2014/main" id="{044D6C35-2773-4526-9092-038A936C6D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76546" y="2681910"/>
            <a:ext cx="152400" cy="152400"/>
          </a:xfrm>
          <a:prstGeom prst="rect">
            <a:avLst/>
          </a:prstGeom>
          <a:solidFill>
            <a:srgbClr val="D3D3D3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50" b="1" i="1">
              <a:solidFill>
                <a:srgbClr val="4D4D4D"/>
              </a:solidFill>
            </a:endParaRPr>
          </a:p>
        </p:txBody>
      </p:sp>
      <p:sp>
        <p:nvSpPr>
          <p:cNvPr id="34" name="Rectangle 114">
            <a:extLst>
              <a:ext uri="{FF2B5EF4-FFF2-40B4-BE49-F238E27FC236}">
                <a16:creationId xmlns:a16="http://schemas.microsoft.com/office/drawing/2014/main" id="{142E48AE-6E52-4AF2-B2B4-5B7360D702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8890" y="2690299"/>
            <a:ext cx="251672" cy="1461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en-US" sz="950" b="1" i="1" dirty="0">
                <a:solidFill>
                  <a:srgbClr val="4D4D4D"/>
                </a:solidFill>
                <a:latin typeface="+mn-lt"/>
              </a:rPr>
              <a:t>PBS</a:t>
            </a:r>
          </a:p>
        </p:txBody>
      </p:sp>
      <p:sp>
        <p:nvSpPr>
          <p:cNvPr id="35" name="Rectangle 112">
            <a:extLst>
              <a:ext uri="{FF2B5EF4-FFF2-40B4-BE49-F238E27FC236}">
                <a16:creationId xmlns:a16="http://schemas.microsoft.com/office/drawing/2014/main" id="{5F07509C-95C9-4F07-8422-86687A6881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76546" y="2946539"/>
            <a:ext cx="152400" cy="152400"/>
          </a:xfrm>
          <a:prstGeom prst="rect">
            <a:avLst/>
          </a:prstGeom>
          <a:solidFill>
            <a:srgbClr val="228B2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50" b="1" i="1">
              <a:solidFill>
                <a:srgbClr val="4D4D4D"/>
              </a:solidFill>
            </a:endParaRPr>
          </a:p>
        </p:txBody>
      </p:sp>
      <p:sp>
        <p:nvSpPr>
          <p:cNvPr id="36" name="Rectangle 114">
            <a:extLst>
              <a:ext uri="{FF2B5EF4-FFF2-40B4-BE49-F238E27FC236}">
                <a16:creationId xmlns:a16="http://schemas.microsoft.com/office/drawing/2014/main" id="{00903AFE-265B-4983-A5C0-B2C81580C8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69903" y="2976300"/>
            <a:ext cx="452047" cy="1461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en-US" sz="950" b="1" i="1" dirty="0">
                <a:solidFill>
                  <a:srgbClr val="4D4D4D"/>
                </a:solidFill>
                <a:latin typeface="+mn-lt"/>
              </a:rPr>
              <a:t>TNB738</a:t>
            </a:r>
          </a:p>
        </p:txBody>
      </p:sp>
    </p:spTree>
  </p:cSld>
  <p:clrMapOvr>
    <a:masterClrMapping/>
  </p:clrMapOvr>
  <p:transition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AF807AE-C660-461B-AEF1-DA5C05B2FF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401" y="1295400"/>
            <a:ext cx="3993096" cy="4107399"/>
          </a:xfrm>
          <a:prstGeom prst="rect">
            <a:avLst/>
          </a:prstGeom>
        </p:spPr>
      </p:pic>
      <p:sp>
        <p:nvSpPr>
          <p:cNvPr id="41" name="Title 40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3000" dirty="0"/>
              <a:t>Data Display - Lung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2520C-6070-49E2-B459-CDB0BDCBA57E}" type="slidenum">
              <a:rPr lang="en-US" smtClean="0"/>
              <a:pPr/>
              <a:t>9</a:t>
            </a:fld>
            <a:endParaRPr lang="en-US"/>
          </a:p>
        </p:txBody>
      </p:sp>
      <p:grpSp>
        <p:nvGrpSpPr>
          <p:cNvPr id="24" name="Group 32">
            <a:extLst>
              <a:ext uri="{FF2B5EF4-FFF2-40B4-BE49-F238E27FC236}">
                <a16:creationId xmlns:a16="http://schemas.microsoft.com/office/drawing/2014/main" id="{1B8303C4-4EFA-4355-B7B0-63EAEBB7BC2F}"/>
              </a:ext>
            </a:extLst>
          </p:cNvPr>
          <p:cNvGrpSpPr/>
          <p:nvPr/>
        </p:nvGrpSpPr>
        <p:grpSpPr>
          <a:xfrm>
            <a:off x="418091" y="1295400"/>
            <a:ext cx="3834023" cy="4790840"/>
            <a:chOff x="867565" y="1290317"/>
            <a:chExt cx="5293441" cy="4790840"/>
          </a:xfrm>
        </p:grpSpPr>
        <p:sp>
          <p:nvSpPr>
            <p:cNvPr id="25" name="Text Box 6">
              <a:extLst>
                <a:ext uri="{FF2B5EF4-FFF2-40B4-BE49-F238E27FC236}">
                  <a16:creationId xmlns:a16="http://schemas.microsoft.com/office/drawing/2014/main" id="{844780FB-B234-4414-B966-6BA221FDB7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47624" y="1290317"/>
              <a:ext cx="2674058" cy="457200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b="1" i="1" dirty="0">
                  <a:solidFill>
                    <a:srgbClr val="4D4D4D"/>
                  </a:solidFill>
                  <a:cs typeface="Arial" pitchFamily="34" charset="0"/>
                </a:rPr>
                <a:t>Metabolite Name</a:t>
              </a:r>
              <a:endParaRPr lang="en-US" b="1" i="1" dirty="0">
                <a:solidFill>
                  <a:srgbClr val="4D4D4D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 Box 4">
              <a:extLst>
                <a:ext uri="{FF2B5EF4-FFF2-40B4-BE49-F238E27FC236}">
                  <a16:creationId xmlns:a16="http://schemas.microsoft.com/office/drawing/2014/main" id="{D1C7A9BA-6D1C-41DF-8F9D-2C795014D634}"/>
                </a:ext>
              </a:extLst>
            </p:cNvPr>
            <p:cNvSpPr txBox="1">
              <a:spLocks noChangeAspect="1" noChangeArrowheads="1"/>
            </p:cNvSpPr>
            <p:nvPr/>
          </p:nvSpPr>
          <p:spPr bwMode="auto">
            <a:xfrm>
              <a:off x="867565" y="2495793"/>
              <a:ext cx="461666" cy="15899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vert270" wrap="none">
              <a:spAutoFit/>
            </a:bodyPr>
            <a:lstStyle/>
            <a:p>
              <a:pPr algn="ctr"/>
              <a:r>
                <a:rPr lang="en-US" b="1" i="1" dirty="0">
                  <a:solidFill>
                    <a:srgbClr val="4D4D4D"/>
                  </a:solidFill>
                  <a:cs typeface="Arial" pitchFamily="34" charset="0"/>
                </a:rPr>
                <a:t>Scaled Intensity</a:t>
              </a:r>
              <a:endParaRPr lang="en-US" sz="1400" b="1" i="1" dirty="0">
                <a:solidFill>
                  <a:srgbClr val="4D4D4D"/>
                </a:solidFill>
                <a:cs typeface="Arial" pitchFamily="34" charset="0"/>
              </a:endParaRPr>
            </a:p>
          </p:txBody>
        </p:sp>
        <p:sp>
          <p:nvSpPr>
            <p:cNvPr id="27" name="Text Box 4">
              <a:extLst>
                <a:ext uri="{FF2B5EF4-FFF2-40B4-BE49-F238E27FC236}">
                  <a16:creationId xmlns:a16="http://schemas.microsoft.com/office/drawing/2014/main" id="{6234519A-C378-40C4-A8C7-5A3A23042E43}"/>
                </a:ext>
              </a:extLst>
            </p:cNvPr>
            <p:cNvSpPr txBox="1">
              <a:spLocks noChangeAspect="1" noChangeArrowheads="1"/>
            </p:cNvSpPr>
            <p:nvPr/>
          </p:nvSpPr>
          <p:spPr bwMode="auto">
            <a:xfrm>
              <a:off x="3207582" y="5711825"/>
              <a:ext cx="2953424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b="1" i="1" dirty="0">
                  <a:solidFill>
                    <a:srgbClr val="4D4D4D"/>
                  </a:solidFill>
                  <a:cs typeface="Arial" pitchFamily="34" charset="0"/>
                </a:rPr>
                <a:t>Group</a:t>
              </a:r>
              <a:endParaRPr lang="en-US" sz="1400" b="1" i="1" dirty="0">
                <a:solidFill>
                  <a:srgbClr val="4D4D4D"/>
                </a:solidFill>
                <a:cs typeface="Arial" pitchFamily="34" charset="0"/>
              </a:endParaRP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B67C08E3-46E8-4744-A238-60072230F567}"/>
              </a:ext>
            </a:extLst>
          </p:cNvPr>
          <p:cNvGrpSpPr/>
          <p:nvPr/>
        </p:nvGrpSpPr>
        <p:grpSpPr>
          <a:xfrm>
            <a:off x="5410200" y="1295400"/>
            <a:ext cx="2981326" cy="3950550"/>
            <a:chOff x="5410200" y="1295400"/>
            <a:chExt cx="2981326" cy="3950550"/>
          </a:xfrm>
        </p:grpSpPr>
        <p:grpSp>
          <p:nvGrpSpPr>
            <p:cNvPr id="29" name="Group 32">
              <a:extLst>
                <a:ext uri="{FF2B5EF4-FFF2-40B4-BE49-F238E27FC236}">
                  <a16:creationId xmlns:a16="http://schemas.microsoft.com/office/drawing/2014/main" id="{702A7F57-67E4-470D-8820-FB619734C1E3}"/>
                </a:ext>
              </a:extLst>
            </p:cNvPr>
            <p:cNvGrpSpPr/>
            <p:nvPr/>
          </p:nvGrpSpPr>
          <p:grpSpPr>
            <a:xfrm>
              <a:off x="5410200" y="1295400"/>
              <a:ext cx="2981326" cy="3950550"/>
              <a:chOff x="5811343" y="-464020"/>
              <a:chExt cx="2499687" cy="3950550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9B07D999-3F6A-4210-B245-AA0190FC9EA8}"/>
                  </a:ext>
                </a:extLst>
              </p:cNvPr>
              <p:cNvSpPr/>
              <p:nvPr/>
            </p:nvSpPr>
            <p:spPr>
              <a:xfrm>
                <a:off x="5811343" y="-120630"/>
                <a:ext cx="2499687" cy="360716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Text Box 6">
                <a:extLst>
                  <a:ext uri="{FF2B5EF4-FFF2-40B4-BE49-F238E27FC236}">
                    <a16:creationId xmlns:a16="http://schemas.microsoft.com/office/drawing/2014/main" id="{F84C0FE5-7D92-4FFD-8CA0-2D24DD03219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31295" y="-464020"/>
                <a:ext cx="1732777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b="1" i="1" dirty="0">
                    <a:solidFill>
                      <a:srgbClr val="4D4D4D"/>
                    </a:solidFill>
                    <a:cs typeface="Arial" pitchFamily="34" charset="0"/>
                  </a:rPr>
                  <a:t>Box Plot Legend</a:t>
                </a:r>
              </a:p>
            </p:txBody>
          </p:sp>
        </p:grpSp>
        <p:pic>
          <p:nvPicPr>
            <p:cNvPr id="30" name="Picture 2">
              <a:extLst>
                <a:ext uri="{FF2B5EF4-FFF2-40B4-BE49-F238E27FC236}">
                  <a16:creationId xmlns:a16="http://schemas.microsoft.com/office/drawing/2014/main" id="{800030F6-9499-430D-B779-18D137A9937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068080" y="1744984"/>
              <a:ext cx="1282706" cy="33610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33" name="Rectangle 112">
            <a:extLst>
              <a:ext uri="{FF2B5EF4-FFF2-40B4-BE49-F238E27FC236}">
                <a16:creationId xmlns:a16="http://schemas.microsoft.com/office/drawing/2014/main" id="{044D6C35-2773-4526-9092-038A936C6D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76546" y="2681910"/>
            <a:ext cx="152400" cy="152400"/>
          </a:xfrm>
          <a:prstGeom prst="rect">
            <a:avLst/>
          </a:prstGeom>
          <a:solidFill>
            <a:srgbClr val="D3D3D3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50" b="1" i="1">
              <a:solidFill>
                <a:srgbClr val="4D4D4D"/>
              </a:solidFill>
            </a:endParaRPr>
          </a:p>
        </p:txBody>
      </p:sp>
      <p:sp>
        <p:nvSpPr>
          <p:cNvPr id="34" name="Rectangle 114">
            <a:extLst>
              <a:ext uri="{FF2B5EF4-FFF2-40B4-BE49-F238E27FC236}">
                <a16:creationId xmlns:a16="http://schemas.microsoft.com/office/drawing/2014/main" id="{142E48AE-6E52-4AF2-B2B4-5B7360D702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8890" y="2690299"/>
            <a:ext cx="251672" cy="1461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en-US" sz="950" b="1" i="1" dirty="0">
                <a:solidFill>
                  <a:srgbClr val="4D4D4D"/>
                </a:solidFill>
                <a:latin typeface="+mn-lt"/>
              </a:rPr>
              <a:t>PBS</a:t>
            </a:r>
          </a:p>
        </p:txBody>
      </p:sp>
      <p:sp>
        <p:nvSpPr>
          <p:cNvPr id="35" name="Rectangle 112">
            <a:extLst>
              <a:ext uri="{FF2B5EF4-FFF2-40B4-BE49-F238E27FC236}">
                <a16:creationId xmlns:a16="http://schemas.microsoft.com/office/drawing/2014/main" id="{5F07509C-95C9-4F07-8422-86687A6881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76546" y="2946539"/>
            <a:ext cx="152400" cy="152400"/>
          </a:xfrm>
          <a:prstGeom prst="rect">
            <a:avLst/>
          </a:prstGeom>
          <a:solidFill>
            <a:srgbClr val="4169E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950" b="1" i="1">
              <a:solidFill>
                <a:srgbClr val="4D4D4D"/>
              </a:solidFill>
            </a:endParaRPr>
          </a:p>
        </p:txBody>
      </p:sp>
      <p:sp>
        <p:nvSpPr>
          <p:cNvPr id="36" name="Rectangle 114">
            <a:extLst>
              <a:ext uri="{FF2B5EF4-FFF2-40B4-BE49-F238E27FC236}">
                <a16:creationId xmlns:a16="http://schemas.microsoft.com/office/drawing/2014/main" id="{00903AFE-265B-4983-A5C0-B2C81580C8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69903" y="2976300"/>
            <a:ext cx="452047" cy="1461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en-US" sz="950" b="1" i="1" dirty="0">
                <a:solidFill>
                  <a:srgbClr val="4D4D4D"/>
                </a:solidFill>
                <a:latin typeface="+mn-lt"/>
              </a:rPr>
              <a:t>TNB738</a:t>
            </a:r>
          </a:p>
        </p:txBody>
      </p:sp>
    </p:spTree>
    <p:extLst>
      <p:ext uri="{BB962C8B-B14F-4D97-AF65-F5344CB8AC3E}">
        <p14:creationId xmlns:p14="http://schemas.microsoft.com/office/powerpoint/2010/main" val="2280303726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New Master">
  <a:themeElements>
    <a:clrScheme name="Metabolon 2020 3">
      <a:dk1>
        <a:srgbClr val="001D38"/>
      </a:dk1>
      <a:lt1>
        <a:srgbClr val="FFFFFF"/>
      </a:lt1>
      <a:dk2>
        <a:srgbClr val="001D37"/>
      </a:dk2>
      <a:lt2>
        <a:srgbClr val="F1FAFB"/>
      </a:lt2>
      <a:accent1>
        <a:srgbClr val="001D37"/>
      </a:accent1>
      <a:accent2>
        <a:srgbClr val="28496E"/>
      </a:accent2>
      <a:accent3>
        <a:srgbClr val="FF4F57"/>
      </a:accent3>
      <a:accent4>
        <a:srgbClr val="855DA3"/>
      </a:accent4>
      <a:accent5>
        <a:srgbClr val="FCA750"/>
      </a:accent5>
      <a:accent6>
        <a:srgbClr val="D3DEE6"/>
      </a:accent6>
      <a:hlink>
        <a:srgbClr val="FF4F57"/>
      </a:hlink>
      <a:folHlink>
        <a:srgbClr val="28496E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Metabolon-2020-Corporate</Template>
  <TotalTime>15490</TotalTime>
  <Words>681</Words>
  <Application>Microsoft Office PowerPoint</Application>
  <PresentationFormat>On-screen Show (4:3)</PresentationFormat>
  <Paragraphs>239</Paragraphs>
  <Slides>47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7</vt:i4>
      </vt:variant>
    </vt:vector>
  </HeadingPairs>
  <TitlesOfParts>
    <vt:vector size="55" baseType="lpstr">
      <vt:lpstr>Arial</vt:lpstr>
      <vt:lpstr>Calibri</vt:lpstr>
      <vt:lpstr>Corbel</vt:lpstr>
      <vt:lpstr>Montserrat</vt:lpstr>
      <vt:lpstr>Tahoma</vt:lpstr>
      <vt:lpstr>Verdana</vt:lpstr>
      <vt:lpstr>Wingdings</vt:lpstr>
      <vt:lpstr>New Master</vt:lpstr>
      <vt:lpstr>PowerPoint Presentation</vt:lpstr>
      <vt:lpstr>Study Overview</vt:lpstr>
      <vt:lpstr>Metabolon Platform Technology</vt:lpstr>
      <vt:lpstr>Automated Metabolite Identification</vt:lpstr>
      <vt:lpstr>Quality Control Process</vt:lpstr>
      <vt:lpstr>Platform QC and Metabolite Summary</vt:lpstr>
      <vt:lpstr>Statistical Analyses </vt:lpstr>
      <vt:lpstr>Data Display - Liver</vt:lpstr>
      <vt:lpstr>Data Display - Lung</vt:lpstr>
      <vt:lpstr>Interpretation of data</vt:lpstr>
      <vt:lpstr>Principal Component Analysis - Liver</vt:lpstr>
      <vt:lpstr>Principal Component Analysis - Lung</vt:lpstr>
      <vt:lpstr>Statistical Summary Counts</vt:lpstr>
      <vt:lpstr>Nicotinate and Nicotinamide Metabolism - Liver</vt:lpstr>
      <vt:lpstr>Nicotinate and Nicotinamide Metabolism - Lung</vt:lpstr>
      <vt:lpstr>Glycolysis and Glycogen Metabolism - Liver</vt:lpstr>
      <vt:lpstr>Glycolysis and Glycogen Metabolism - Lung</vt:lpstr>
      <vt:lpstr>PowerPoint Presentation</vt:lpstr>
      <vt:lpstr>PowerPoint Presentation</vt:lpstr>
      <vt:lpstr>Fatty Acid Metabolism - Liver</vt:lpstr>
      <vt:lpstr>Fatty Acid Metabolism - Lung</vt:lpstr>
      <vt:lpstr>Omega-oxidation - Liver</vt:lpstr>
      <vt:lpstr>Omega-oxidation - Lung</vt:lpstr>
      <vt:lpstr>Sugar Metabolism - Liver</vt:lpstr>
      <vt:lpstr>Sugar Metabolism - Lung</vt:lpstr>
      <vt:lpstr>Complex Lipid Metabolism - Liver</vt:lpstr>
      <vt:lpstr>Complex Lipid Metabolism - Lung</vt:lpstr>
      <vt:lpstr>Bile Acid Metabolism - Liver</vt:lpstr>
      <vt:lpstr>Bile Acid Metabolism - Lung</vt:lpstr>
      <vt:lpstr>Ceramide Metabolism - Liver</vt:lpstr>
      <vt:lpstr>Ceramide Metabolism - Lung</vt:lpstr>
      <vt:lpstr>Plasmalogen Metabolism - Liver</vt:lpstr>
      <vt:lpstr>Plasmalogen Metabolism - Lung</vt:lpstr>
      <vt:lpstr>Indicators of Redox Homeostasis - Liver</vt:lpstr>
      <vt:lpstr>Indicators of Redox Homeostasis - Lung</vt:lpstr>
      <vt:lpstr>Readouts of Inflammation - Liver</vt:lpstr>
      <vt:lpstr>Readouts of Inflammation - Lung</vt:lpstr>
      <vt:lpstr>Markers of Protein Homeostasis - Liver</vt:lpstr>
      <vt:lpstr>Markers of Protein Homeostasis - Lung</vt:lpstr>
      <vt:lpstr>PowerPoint Presentation</vt:lpstr>
      <vt:lpstr>PowerPoint Presentation</vt:lpstr>
      <vt:lpstr>PowerPoint Presentation</vt:lpstr>
      <vt:lpstr>PowerPoint Presentation</vt:lpstr>
      <vt:lpstr>Summary Table</vt:lpstr>
      <vt:lpstr>Summary Figure - Liver</vt:lpstr>
      <vt:lpstr>NAD Metabolism Summary</vt:lpstr>
      <vt:lpstr>PowerPoint Presentation</vt:lpstr>
    </vt:vector>
  </TitlesOfParts>
  <Manager/>
  <Company>Metabolon, Inc.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subject/>
  <dc:creator>kboyd</dc:creator>
  <cp:keywords/>
  <dc:description/>
  <cp:lastModifiedBy>Pranjali Dalvi</cp:lastModifiedBy>
  <cp:revision>424</cp:revision>
  <dcterms:created xsi:type="dcterms:W3CDTF">2012-12-17T15:48:44Z</dcterms:created>
  <dcterms:modified xsi:type="dcterms:W3CDTF">2025-10-07T16:45:57Z</dcterms:modified>
  <cp:category/>
</cp:coreProperties>
</file>